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9"/>
  </p:notesMasterIdLst>
  <p:sldIdLst>
    <p:sldId id="301" r:id="rId2"/>
    <p:sldId id="256" r:id="rId3"/>
    <p:sldId id="305" r:id="rId4"/>
    <p:sldId id="257" r:id="rId5"/>
    <p:sldId id="258" r:id="rId6"/>
    <p:sldId id="259" r:id="rId7"/>
    <p:sldId id="260" r:id="rId8"/>
    <p:sldId id="267" r:id="rId9"/>
    <p:sldId id="304" r:id="rId10"/>
    <p:sldId id="268" r:id="rId11"/>
    <p:sldId id="269" r:id="rId12"/>
    <p:sldId id="270" r:id="rId13"/>
    <p:sldId id="271" r:id="rId14"/>
    <p:sldId id="274" r:id="rId15"/>
    <p:sldId id="272" r:id="rId16"/>
    <p:sldId id="273" r:id="rId17"/>
    <p:sldId id="275" r:id="rId18"/>
    <p:sldId id="278" r:id="rId19"/>
    <p:sldId id="296" r:id="rId20"/>
    <p:sldId id="303" r:id="rId21"/>
    <p:sldId id="276" r:id="rId22"/>
    <p:sldId id="277" r:id="rId23"/>
    <p:sldId id="279" r:id="rId24"/>
    <p:sldId id="282" r:id="rId25"/>
    <p:sldId id="281" r:id="rId26"/>
    <p:sldId id="280" r:id="rId27"/>
    <p:sldId id="288" r:id="rId28"/>
    <p:sldId id="284" r:id="rId29"/>
    <p:sldId id="285" r:id="rId30"/>
    <p:sldId id="287" r:id="rId31"/>
    <p:sldId id="290" r:id="rId32"/>
    <p:sldId id="291" r:id="rId33"/>
    <p:sldId id="292" r:id="rId34"/>
    <p:sldId id="289" r:id="rId35"/>
    <p:sldId id="294" r:id="rId36"/>
    <p:sldId id="295" r:id="rId37"/>
    <p:sldId id="286" r:id="rId38"/>
    <p:sldId id="297" r:id="rId39"/>
    <p:sldId id="261" r:id="rId40"/>
    <p:sldId id="262" r:id="rId41"/>
    <p:sldId id="263" r:id="rId42"/>
    <p:sldId id="264" r:id="rId43"/>
    <p:sldId id="265" r:id="rId44"/>
    <p:sldId id="266" r:id="rId45"/>
    <p:sldId id="298" r:id="rId46"/>
    <p:sldId id="299" r:id="rId47"/>
    <p:sldId id="300" r:id="rId48"/>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278" autoAdjust="0"/>
    <p:restoredTop sz="94660"/>
  </p:normalViewPr>
  <p:slideViewPr>
    <p:cSldViewPr snapToGrid="0">
      <p:cViewPr varScale="1">
        <p:scale>
          <a:sx n="87" d="100"/>
          <a:sy n="87" d="100"/>
        </p:scale>
        <p:origin x="653"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8" Type="http://schemas.openxmlformats.org/officeDocument/2006/relationships/slide" Target="slides/slide7.xml"/><Relationship Id="rId51"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uan I M" userId="bac78a7562c495f3" providerId="LiveId" clId="{D6991BAF-2496-404A-B98F-5C0804AEFB7A}"/>
    <pc:docChg chg="modSld">
      <pc:chgData name="Juan I M" userId="bac78a7562c495f3" providerId="LiveId" clId="{D6991BAF-2496-404A-B98F-5C0804AEFB7A}" dt="2019-04-14T14:55:34.173" v="0" actId="6549"/>
      <pc:docMkLst>
        <pc:docMk/>
      </pc:docMkLst>
      <pc:sldChg chg="modSp">
        <pc:chgData name="Juan I M" userId="bac78a7562c495f3" providerId="LiveId" clId="{D6991BAF-2496-404A-B98F-5C0804AEFB7A}" dt="2019-04-14T14:55:34.173" v="0" actId="6549"/>
        <pc:sldMkLst>
          <pc:docMk/>
          <pc:sldMk cId="475207030" sldId="301"/>
        </pc:sldMkLst>
        <pc:spChg chg="mod">
          <ac:chgData name="Juan I M" userId="bac78a7562c495f3" providerId="LiveId" clId="{D6991BAF-2496-404A-B98F-5C0804AEFB7A}" dt="2019-04-14T14:55:34.173" v="0" actId="6549"/>
          <ac:spMkLst>
            <pc:docMk/>
            <pc:sldMk cId="475207030" sldId="301"/>
            <ac:spMk id="14" creationId="{0DF261E0-794C-4AE7-BB9C-8066C249C6DF}"/>
          </ac:spMkLst>
        </pc:spChg>
      </pc:sldChg>
    </pc:docChg>
  </pc:docChgLst>
  <pc:docChgLst>
    <pc:chgData name="Juan I M" userId="bac78a7562c495f3" providerId="LiveId" clId="{2F9B7228-859A-41CD-826C-A1142C9353FC}"/>
    <pc:docChg chg="undo custSel modSld">
      <pc:chgData name="Juan I M" userId="bac78a7562c495f3" providerId="LiveId" clId="{2F9B7228-859A-41CD-826C-A1142C9353FC}" dt="2019-02-27T09:54:46.362" v="295" actId="1076"/>
      <pc:docMkLst>
        <pc:docMk/>
      </pc:docMkLst>
      <pc:sldChg chg="addSp delSp modSp">
        <pc:chgData name="Juan I M" userId="bac78a7562c495f3" providerId="LiveId" clId="{2F9B7228-859A-41CD-826C-A1142C9353FC}" dt="2019-02-27T09:54:46.362" v="295" actId="1076"/>
        <pc:sldMkLst>
          <pc:docMk/>
          <pc:sldMk cId="475207030" sldId="301"/>
        </pc:sldMkLst>
        <pc:spChg chg="mod">
          <ac:chgData name="Juan I M" userId="bac78a7562c495f3" providerId="LiveId" clId="{2F9B7228-859A-41CD-826C-A1142C9353FC}" dt="2019-01-23T12:42:38.470" v="5"/>
          <ac:spMkLst>
            <pc:docMk/>
            <pc:sldMk cId="475207030" sldId="301"/>
            <ac:spMk id="4" creationId="{EACDDA15-11A0-45AC-9EAB-7A1D35FAF964}"/>
          </ac:spMkLst>
        </pc:spChg>
        <pc:spChg chg="mod">
          <ac:chgData name="Juan I M" userId="bac78a7562c495f3" providerId="LiveId" clId="{2F9B7228-859A-41CD-826C-A1142C9353FC}" dt="2019-01-23T13:38:24.227" v="6" actId="6549"/>
          <ac:spMkLst>
            <pc:docMk/>
            <pc:sldMk cId="475207030" sldId="301"/>
            <ac:spMk id="14" creationId="{0DF261E0-794C-4AE7-BB9C-8066C249C6DF}"/>
          </ac:spMkLst>
        </pc:spChg>
        <pc:spChg chg="mod topLvl">
          <ac:chgData name="Juan I M" userId="bac78a7562c495f3" providerId="LiveId" clId="{2F9B7228-859A-41CD-826C-A1142C9353FC}" dt="2019-02-27T09:54:07.450" v="283" actId="165"/>
          <ac:spMkLst>
            <pc:docMk/>
            <pc:sldMk cId="475207030" sldId="301"/>
            <ac:spMk id="32" creationId="{BED8F742-0F8A-46FA-A993-BC7E2035C2BA}"/>
          </ac:spMkLst>
        </pc:spChg>
        <pc:spChg chg="mod topLvl">
          <ac:chgData name="Juan I M" userId="bac78a7562c495f3" providerId="LiveId" clId="{2F9B7228-859A-41CD-826C-A1142C9353FC}" dt="2019-02-27T09:54:07.450" v="283" actId="165"/>
          <ac:spMkLst>
            <pc:docMk/>
            <pc:sldMk cId="475207030" sldId="301"/>
            <ac:spMk id="33" creationId="{9D079C06-F4D7-43B1-B22B-1794FECCD828}"/>
          </ac:spMkLst>
        </pc:spChg>
        <pc:spChg chg="mod topLvl">
          <ac:chgData name="Juan I M" userId="bac78a7562c495f3" providerId="LiveId" clId="{2F9B7228-859A-41CD-826C-A1142C9353FC}" dt="2019-02-27T09:54:07.450" v="283" actId="165"/>
          <ac:spMkLst>
            <pc:docMk/>
            <pc:sldMk cId="475207030" sldId="301"/>
            <ac:spMk id="34" creationId="{07C0298F-4792-4B26-9EED-9958B124552C}"/>
          </ac:spMkLst>
        </pc:spChg>
        <pc:spChg chg="mod topLvl">
          <ac:chgData name="Juan I M" userId="bac78a7562c495f3" providerId="LiveId" clId="{2F9B7228-859A-41CD-826C-A1142C9353FC}" dt="2019-02-27T09:54:07.450" v="283" actId="165"/>
          <ac:spMkLst>
            <pc:docMk/>
            <pc:sldMk cId="475207030" sldId="301"/>
            <ac:spMk id="35" creationId="{BC5B370D-9D58-4CF9-89D6-4F4B22195D22}"/>
          </ac:spMkLst>
        </pc:spChg>
        <pc:spChg chg="mod topLvl">
          <ac:chgData name="Juan I M" userId="bac78a7562c495f3" providerId="LiveId" clId="{2F9B7228-859A-41CD-826C-A1142C9353FC}" dt="2019-02-27T09:54:07.450" v="283" actId="165"/>
          <ac:spMkLst>
            <pc:docMk/>
            <pc:sldMk cId="475207030" sldId="301"/>
            <ac:spMk id="36" creationId="{1958D76B-3258-4061-BA4A-547DE6362ACA}"/>
          </ac:spMkLst>
        </pc:spChg>
        <pc:spChg chg="mod topLvl">
          <ac:chgData name="Juan I M" userId="bac78a7562c495f3" providerId="LiveId" clId="{2F9B7228-859A-41CD-826C-A1142C9353FC}" dt="2019-02-27T09:54:07.450" v="283" actId="165"/>
          <ac:spMkLst>
            <pc:docMk/>
            <pc:sldMk cId="475207030" sldId="301"/>
            <ac:spMk id="37" creationId="{40178FEA-9F53-4502-ADC9-F37A558A6AE6}"/>
          </ac:spMkLst>
        </pc:spChg>
        <pc:spChg chg="mod topLvl">
          <ac:chgData name="Juan I M" userId="bac78a7562c495f3" providerId="LiveId" clId="{2F9B7228-859A-41CD-826C-A1142C9353FC}" dt="2019-02-27T09:54:07.450" v="283" actId="165"/>
          <ac:spMkLst>
            <pc:docMk/>
            <pc:sldMk cId="475207030" sldId="301"/>
            <ac:spMk id="40" creationId="{4D80A3F6-41C0-4AF3-A1D5-320ABE8152F7}"/>
          </ac:spMkLst>
        </pc:spChg>
        <pc:spChg chg="mod topLvl">
          <ac:chgData name="Juan I M" userId="bac78a7562c495f3" providerId="LiveId" clId="{2F9B7228-859A-41CD-826C-A1142C9353FC}" dt="2019-02-27T09:54:07.450" v="283" actId="165"/>
          <ac:spMkLst>
            <pc:docMk/>
            <pc:sldMk cId="475207030" sldId="301"/>
            <ac:spMk id="41" creationId="{19227E14-A307-47A6-8605-091C836056C7}"/>
          </ac:spMkLst>
        </pc:spChg>
        <pc:grpChg chg="del mod">
          <ac:chgData name="Juan I M" userId="bac78a7562c495f3" providerId="LiveId" clId="{2F9B7228-859A-41CD-826C-A1142C9353FC}" dt="2019-02-27T09:54:07.450" v="283" actId="165"/>
          <ac:grpSpMkLst>
            <pc:docMk/>
            <pc:sldMk cId="475207030" sldId="301"/>
            <ac:grpSpMk id="50" creationId="{5856B0F0-5D4C-4CD2-AD1B-8BAC21144F9C}"/>
          </ac:grpSpMkLst>
        </pc:grpChg>
        <pc:picChg chg="mod topLvl">
          <ac:chgData name="Juan I M" userId="bac78a7562c495f3" providerId="LiveId" clId="{2F9B7228-859A-41CD-826C-A1142C9353FC}" dt="2019-02-27T09:54:46.362" v="295" actId="1076"/>
          <ac:picMkLst>
            <pc:docMk/>
            <pc:sldMk cId="475207030" sldId="301"/>
            <ac:picMk id="8" creationId="{FBDCEFDA-A0F8-473E-9036-F0344F9A335B}"/>
          </ac:picMkLst>
        </pc:picChg>
        <pc:picChg chg="add del mod">
          <ac:chgData name="Juan I M" userId="bac78a7562c495f3" providerId="LiveId" clId="{2F9B7228-859A-41CD-826C-A1142C9353FC}" dt="2019-02-27T09:54:18.975" v="287" actId="478"/>
          <ac:picMkLst>
            <pc:docMk/>
            <pc:sldMk cId="475207030" sldId="301"/>
            <ac:picMk id="52" creationId="{CAF69D4D-E0B6-4B79-855A-4B22DDF01F88}"/>
          </ac:picMkLst>
        </pc:picChg>
      </pc:sldChg>
    </pc:docChg>
  </pc:docChgLst>
  <pc:docChgLst>
    <pc:chgData name="Juan I M" userId="bac78a7562c495f3" providerId="LiveId" clId="{3BFE4D46-2F45-4506-9F99-01901B3F68DD}"/>
    <pc:docChg chg="modSld">
      <pc:chgData name="Juan I M" userId="bac78a7562c495f3" providerId="LiveId" clId="{3BFE4D46-2F45-4506-9F99-01901B3F68DD}" dt="2019-05-08T15:28:28.758" v="82" actId="1076"/>
      <pc:docMkLst>
        <pc:docMk/>
      </pc:docMkLst>
      <pc:sldChg chg="modSp">
        <pc:chgData name="Juan I M" userId="bac78a7562c495f3" providerId="LiveId" clId="{3BFE4D46-2F45-4506-9F99-01901B3F68DD}" dt="2019-05-08T15:22:52.415" v="3" actId="20577"/>
        <pc:sldMkLst>
          <pc:docMk/>
          <pc:sldMk cId="3658177352" sldId="256"/>
        </pc:sldMkLst>
        <pc:spChg chg="mod">
          <ac:chgData name="Juan I M" userId="bac78a7562c495f3" providerId="LiveId" clId="{3BFE4D46-2F45-4506-9F99-01901B3F68DD}" dt="2019-05-08T15:22:52.415" v="3" actId="20577"/>
          <ac:spMkLst>
            <pc:docMk/>
            <pc:sldMk cId="3658177352" sldId="256"/>
            <ac:spMk id="6" creationId="{74AF234C-E168-4284-B2E9-FEA4C9837CB3}"/>
          </ac:spMkLst>
        </pc:spChg>
      </pc:sldChg>
      <pc:sldChg chg="modSp">
        <pc:chgData name="Juan I M" userId="bac78a7562c495f3" providerId="LiveId" clId="{3BFE4D46-2F45-4506-9F99-01901B3F68DD}" dt="2019-05-08T15:23:04.379" v="7" actId="20577"/>
        <pc:sldMkLst>
          <pc:docMk/>
          <pc:sldMk cId="4038468760" sldId="257"/>
        </pc:sldMkLst>
        <pc:spChg chg="mod">
          <ac:chgData name="Juan I M" userId="bac78a7562c495f3" providerId="LiveId" clId="{3BFE4D46-2F45-4506-9F99-01901B3F68DD}" dt="2019-05-08T15:23:04.379" v="7" actId="20577"/>
          <ac:spMkLst>
            <pc:docMk/>
            <pc:sldMk cId="4038468760" sldId="257"/>
            <ac:spMk id="6" creationId="{74AF234C-E168-4284-B2E9-FEA4C9837CB3}"/>
          </ac:spMkLst>
        </pc:spChg>
      </pc:sldChg>
      <pc:sldChg chg="modSp">
        <pc:chgData name="Juan I M" userId="bac78a7562c495f3" providerId="LiveId" clId="{3BFE4D46-2F45-4506-9F99-01901B3F68DD}" dt="2019-05-08T15:23:09.755" v="9" actId="20577"/>
        <pc:sldMkLst>
          <pc:docMk/>
          <pc:sldMk cId="1510401756" sldId="258"/>
        </pc:sldMkLst>
        <pc:spChg chg="mod">
          <ac:chgData name="Juan I M" userId="bac78a7562c495f3" providerId="LiveId" clId="{3BFE4D46-2F45-4506-9F99-01901B3F68DD}" dt="2019-05-08T15:23:09.755" v="9" actId="20577"/>
          <ac:spMkLst>
            <pc:docMk/>
            <pc:sldMk cId="1510401756" sldId="258"/>
            <ac:spMk id="6" creationId="{74AF234C-E168-4284-B2E9-FEA4C9837CB3}"/>
          </ac:spMkLst>
        </pc:spChg>
      </pc:sldChg>
      <pc:sldChg chg="modSp">
        <pc:chgData name="Juan I M" userId="bac78a7562c495f3" providerId="LiveId" clId="{3BFE4D46-2F45-4506-9F99-01901B3F68DD}" dt="2019-05-08T15:23:14.833" v="11" actId="20577"/>
        <pc:sldMkLst>
          <pc:docMk/>
          <pc:sldMk cId="2993831642" sldId="259"/>
        </pc:sldMkLst>
        <pc:spChg chg="mod">
          <ac:chgData name="Juan I M" userId="bac78a7562c495f3" providerId="LiveId" clId="{3BFE4D46-2F45-4506-9F99-01901B3F68DD}" dt="2019-05-08T15:23:14.833" v="11" actId="20577"/>
          <ac:spMkLst>
            <pc:docMk/>
            <pc:sldMk cId="2993831642" sldId="259"/>
            <ac:spMk id="6" creationId="{74AF234C-E168-4284-B2E9-FEA4C9837CB3}"/>
          </ac:spMkLst>
        </pc:spChg>
      </pc:sldChg>
      <pc:sldChg chg="modSp">
        <pc:chgData name="Juan I M" userId="bac78a7562c495f3" providerId="LiveId" clId="{3BFE4D46-2F45-4506-9F99-01901B3F68DD}" dt="2019-05-08T15:23:23.004" v="13" actId="20577"/>
        <pc:sldMkLst>
          <pc:docMk/>
          <pc:sldMk cId="1581646177" sldId="260"/>
        </pc:sldMkLst>
        <pc:spChg chg="mod">
          <ac:chgData name="Juan I M" userId="bac78a7562c495f3" providerId="LiveId" clId="{3BFE4D46-2F45-4506-9F99-01901B3F68DD}" dt="2019-05-08T15:23:23.004" v="13" actId="20577"/>
          <ac:spMkLst>
            <pc:docMk/>
            <pc:sldMk cId="1581646177" sldId="260"/>
            <ac:spMk id="6" creationId="{74AF234C-E168-4284-B2E9-FEA4C9837CB3}"/>
          </ac:spMkLst>
        </pc:spChg>
      </pc:sldChg>
      <pc:sldChg chg="modSp">
        <pc:chgData name="Juan I M" userId="bac78a7562c495f3" providerId="LiveId" clId="{3BFE4D46-2F45-4506-9F99-01901B3F68DD}" dt="2019-05-08T15:27:32.057" v="65" actId="20577"/>
        <pc:sldMkLst>
          <pc:docMk/>
          <pc:sldMk cId="844193767" sldId="261"/>
        </pc:sldMkLst>
        <pc:spChg chg="mod">
          <ac:chgData name="Juan I M" userId="bac78a7562c495f3" providerId="LiveId" clId="{3BFE4D46-2F45-4506-9F99-01901B3F68DD}" dt="2019-05-08T15:27:32.057" v="65" actId="20577"/>
          <ac:spMkLst>
            <pc:docMk/>
            <pc:sldMk cId="844193767" sldId="261"/>
            <ac:spMk id="6" creationId="{74AF234C-E168-4284-B2E9-FEA4C9837CB3}"/>
          </ac:spMkLst>
        </pc:spChg>
      </pc:sldChg>
      <pc:sldChg chg="modSp">
        <pc:chgData name="Juan I M" userId="bac78a7562c495f3" providerId="LiveId" clId="{3BFE4D46-2F45-4506-9F99-01901B3F68DD}" dt="2019-05-08T15:27:35.929" v="67" actId="20577"/>
        <pc:sldMkLst>
          <pc:docMk/>
          <pc:sldMk cId="4185045580" sldId="262"/>
        </pc:sldMkLst>
        <pc:spChg chg="mod">
          <ac:chgData name="Juan I M" userId="bac78a7562c495f3" providerId="LiveId" clId="{3BFE4D46-2F45-4506-9F99-01901B3F68DD}" dt="2019-05-08T15:27:35.929" v="67" actId="20577"/>
          <ac:spMkLst>
            <pc:docMk/>
            <pc:sldMk cId="4185045580" sldId="262"/>
            <ac:spMk id="6" creationId="{74AF234C-E168-4284-B2E9-FEA4C9837CB3}"/>
          </ac:spMkLst>
        </pc:spChg>
      </pc:sldChg>
      <pc:sldChg chg="modSp">
        <pc:chgData name="Juan I M" userId="bac78a7562c495f3" providerId="LiveId" clId="{3BFE4D46-2F45-4506-9F99-01901B3F68DD}" dt="2019-05-08T15:27:52.157" v="69" actId="20577"/>
        <pc:sldMkLst>
          <pc:docMk/>
          <pc:sldMk cId="196933938" sldId="263"/>
        </pc:sldMkLst>
        <pc:spChg chg="mod">
          <ac:chgData name="Juan I M" userId="bac78a7562c495f3" providerId="LiveId" clId="{3BFE4D46-2F45-4506-9F99-01901B3F68DD}" dt="2019-05-08T15:27:52.157" v="69" actId="20577"/>
          <ac:spMkLst>
            <pc:docMk/>
            <pc:sldMk cId="196933938" sldId="263"/>
            <ac:spMk id="6" creationId="{74AF234C-E168-4284-B2E9-FEA4C9837CB3}"/>
          </ac:spMkLst>
        </pc:spChg>
      </pc:sldChg>
      <pc:sldChg chg="modSp">
        <pc:chgData name="Juan I M" userId="bac78a7562c495f3" providerId="LiveId" clId="{3BFE4D46-2F45-4506-9F99-01901B3F68DD}" dt="2019-05-08T15:28:02.176" v="71" actId="20577"/>
        <pc:sldMkLst>
          <pc:docMk/>
          <pc:sldMk cId="1099329530" sldId="264"/>
        </pc:sldMkLst>
        <pc:spChg chg="mod">
          <ac:chgData name="Juan I M" userId="bac78a7562c495f3" providerId="LiveId" clId="{3BFE4D46-2F45-4506-9F99-01901B3F68DD}" dt="2019-05-08T15:28:02.176" v="71" actId="20577"/>
          <ac:spMkLst>
            <pc:docMk/>
            <pc:sldMk cId="1099329530" sldId="264"/>
            <ac:spMk id="6" creationId="{74AF234C-E168-4284-B2E9-FEA4C9837CB3}"/>
          </ac:spMkLst>
        </pc:spChg>
      </pc:sldChg>
      <pc:sldChg chg="modSp">
        <pc:chgData name="Juan I M" userId="bac78a7562c495f3" providerId="LiveId" clId="{3BFE4D46-2F45-4506-9F99-01901B3F68DD}" dt="2019-05-08T15:28:06.612" v="73" actId="20577"/>
        <pc:sldMkLst>
          <pc:docMk/>
          <pc:sldMk cId="763850688" sldId="265"/>
        </pc:sldMkLst>
        <pc:spChg chg="mod">
          <ac:chgData name="Juan I M" userId="bac78a7562c495f3" providerId="LiveId" clId="{3BFE4D46-2F45-4506-9F99-01901B3F68DD}" dt="2019-05-08T15:28:06.612" v="73" actId="20577"/>
          <ac:spMkLst>
            <pc:docMk/>
            <pc:sldMk cId="763850688" sldId="265"/>
            <ac:spMk id="6" creationId="{74AF234C-E168-4284-B2E9-FEA4C9837CB3}"/>
          </ac:spMkLst>
        </pc:spChg>
      </pc:sldChg>
      <pc:sldChg chg="modSp">
        <pc:chgData name="Juan I M" userId="bac78a7562c495f3" providerId="LiveId" clId="{3BFE4D46-2F45-4506-9F99-01901B3F68DD}" dt="2019-05-08T15:28:10.071" v="75" actId="20577"/>
        <pc:sldMkLst>
          <pc:docMk/>
          <pc:sldMk cId="884365357" sldId="266"/>
        </pc:sldMkLst>
        <pc:spChg chg="mod">
          <ac:chgData name="Juan I M" userId="bac78a7562c495f3" providerId="LiveId" clId="{3BFE4D46-2F45-4506-9F99-01901B3F68DD}" dt="2019-05-08T15:28:10.071" v="75" actId="20577"/>
          <ac:spMkLst>
            <pc:docMk/>
            <pc:sldMk cId="884365357" sldId="266"/>
            <ac:spMk id="6" creationId="{74AF234C-E168-4284-B2E9-FEA4C9837CB3}"/>
          </ac:spMkLst>
        </pc:spChg>
      </pc:sldChg>
      <pc:sldChg chg="modSp">
        <pc:chgData name="Juan I M" userId="bac78a7562c495f3" providerId="LiveId" clId="{3BFE4D46-2F45-4506-9F99-01901B3F68DD}" dt="2019-05-08T15:23:28.819" v="17" actId="20577"/>
        <pc:sldMkLst>
          <pc:docMk/>
          <pc:sldMk cId="2817419278" sldId="267"/>
        </pc:sldMkLst>
        <pc:spChg chg="mod">
          <ac:chgData name="Juan I M" userId="bac78a7562c495f3" providerId="LiveId" clId="{3BFE4D46-2F45-4506-9F99-01901B3F68DD}" dt="2019-05-08T15:23:28.819" v="17" actId="20577"/>
          <ac:spMkLst>
            <pc:docMk/>
            <pc:sldMk cId="2817419278" sldId="267"/>
            <ac:spMk id="6" creationId="{74AF234C-E168-4284-B2E9-FEA4C9837CB3}"/>
          </ac:spMkLst>
        </pc:spChg>
      </pc:sldChg>
      <pc:sldChg chg="modSp">
        <pc:chgData name="Juan I M" userId="bac78a7562c495f3" providerId="LiveId" clId="{3BFE4D46-2F45-4506-9F99-01901B3F68DD}" dt="2019-05-08T15:23:42.006" v="19" actId="20577"/>
        <pc:sldMkLst>
          <pc:docMk/>
          <pc:sldMk cId="3018624806" sldId="268"/>
        </pc:sldMkLst>
        <pc:spChg chg="mod">
          <ac:chgData name="Juan I M" userId="bac78a7562c495f3" providerId="LiveId" clId="{3BFE4D46-2F45-4506-9F99-01901B3F68DD}" dt="2019-05-08T15:23:42.006" v="19" actId="20577"/>
          <ac:spMkLst>
            <pc:docMk/>
            <pc:sldMk cId="3018624806" sldId="268"/>
            <ac:spMk id="6" creationId="{74AF234C-E168-4284-B2E9-FEA4C9837CB3}"/>
          </ac:spMkLst>
        </pc:spChg>
      </pc:sldChg>
      <pc:sldChg chg="modSp">
        <pc:chgData name="Juan I M" userId="bac78a7562c495f3" providerId="LiveId" clId="{3BFE4D46-2F45-4506-9F99-01901B3F68DD}" dt="2019-05-08T15:23:46.663" v="20" actId="20577"/>
        <pc:sldMkLst>
          <pc:docMk/>
          <pc:sldMk cId="2604737063" sldId="269"/>
        </pc:sldMkLst>
        <pc:spChg chg="mod">
          <ac:chgData name="Juan I M" userId="bac78a7562c495f3" providerId="LiveId" clId="{3BFE4D46-2F45-4506-9F99-01901B3F68DD}" dt="2019-05-08T15:23:46.663" v="20" actId="20577"/>
          <ac:spMkLst>
            <pc:docMk/>
            <pc:sldMk cId="2604737063" sldId="269"/>
            <ac:spMk id="6" creationId="{74AF234C-E168-4284-B2E9-FEA4C9837CB3}"/>
          </ac:spMkLst>
        </pc:spChg>
      </pc:sldChg>
      <pc:sldChg chg="modSp">
        <pc:chgData name="Juan I M" userId="bac78a7562c495f3" providerId="LiveId" clId="{3BFE4D46-2F45-4506-9F99-01901B3F68DD}" dt="2019-05-08T15:23:52.476" v="21" actId="20577"/>
        <pc:sldMkLst>
          <pc:docMk/>
          <pc:sldMk cId="456505916" sldId="270"/>
        </pc:sldMkLst>
        <pc:spChg chg="mod">
          <ac:chgData name="Juan I M" userId="bac78a7562c495f3" providerId="LiveId" clId="{3BFE4D46-2F45-4506-9F99-01901B3F68DD}" dt="2019-05-08T15:23:52.476" v="21" actId="20577"/>
          <ac:spMkLst>
            <pc:docMk/>
            <pc:sldMk cId="456505916" sldId="270"/>
            <ac:spMk id="6" creationId="{74AF234C-E168-4284-B2E9-FEA4C9837CB3}"/>
          </ac:spMkLst>
        </pc:spChg>
      </pc:sldChg>
      <pc:sldChg chg="modSp">
        <pc:chgData name="Juan I M" userId="bac78a7562c495f3" providerId="LiveId" clId="{3BFE4D46-2F45-4506-9F99-01901B3F68DD}" dt="2019-05-08T15:23:59.618" v="22" actId="20577"/>
        <pc:sldMkLst>
          <pc:docMk/>
          <pc:sldMk cId="176892429" sldId="271"/>
        </pc:sldMkLst>
        <pc:spChg chg="mod">
          <ac:chgData name="Juan I M" userId="bac78a7562c495f3" providerId="LiveId" clId="{3BFE4D46-2F45-4506-9F99-01901B3F68DD}" dt="2019-05-08T15:23:59.618" v="22" actId="20577"/>
          <ac:spMkLst>
            <pc:docMk/>
            <pc:sldMk cId="176892429" sldId="271"/>
            <ac:spMk id="6" creationId="{74AF234C-E168-4284-B2E9-FEA4C9837CB3}"/>
          </ac:spMkLst>
        </pc:spChg>
      </pc:sldChg>
      <pc:sldChg chg="modSp">
        <pc:chgData name="Juan I M" userId="bac78a7562c495f3" providerId="LiveId" clId="{3BFE4D46-2F45-4506-9F99-01901B3F68DD}" dt="2019-05-08T15:24:46.940" v="24" actId="20577"/>
        <pc:sldMkLst>
          <pc:docMk/>
          <pc:sldMk cId="280600842" sldId="272"/>
        </pc:sldMkLst>
        <pc:spChg chg="mod">
          <ac:chgData name="Juan I M" userId="bac78a7562c495f3" providerId="LiveId" clId="{3BFE4D46-2F45-4506-9F99-01901B3F68DD}" dt="2019-05-08T15:24:46.940" v="24" actId="20577"/>
          <ac:spMkLst>
            <pc:docMk/>
            <pc:sldMk cId="280600842" sldId="272"/>
            <ac:spMk id="6" creationId="{74AF234C-E168-4284-B2E9-FEA4C9837CB3}"/>
          </ac:spMkLst>
        </pc:spChg>
      </pc:sldChg>
      <pc:sldChg chg="modSp">
        <pc:chgData name="Juan I M" userId="bac78a7562c495f3" providerId="LiveId" clId="{3BFE4D46-2F45-4506-9F99-01901B3F68DD}" dt="2019-05-08T15:24:53.252" v="27" actId="20577"/>
        <pc:sldMkLst>
          <pc:docMk/>
          <pc:sldMk cId="164518199" sldId="273"/>
        </pc:sldMkLst>
        <pc:spChg chg="mod">
          <ac:chgData name="Juan I M" userId="bac78a7562c495f3" providerId="LiveId" clId="{3BFE4D46-2F45-4506-9F99-01901B3F68DD}" dt="2019-05-08T15:24:53.252" v="27" actId="20577"/>
          <ac:spMkLst>
            <pc:docMk/>
            <pc:sldMk cId="164518199" sldId="273"/>
            <ac:spMk id="6" creationId="{74AF234C-E168-4284-B2E9-FEA4C9837CB3}"/>
          </ac:spMkLst>
        </pc:spChg>
      </pc:sldChg>
      <pc:sldChg chg="modSp">
        <pc:chgData name="Juan I M" userId="bac78a7562c495f3" providerId="LiveId" clId="{3BFE4D46-2F45-4506-9F99-01901B3F68DD}" dt="2019-05-08T15:24:33.658" v="23" actId="20577"/>
        <pc:sldMkLst>
          <pc:docMk/>
          <pc:sldMk cId="3829761077" sldId="274"/>
        </pc:sldMkLst>
        <pc:spChg chg="mod">
          <ac:chgData name="Juan I M" userId="bac78a7562c495f3" providerId="LiveId" clId="{3BFE4D46-2F45-4506-9F99-01901B3F68DD}" dt="2019-05-08T15:24:33.658" v="23" actId="20577"/>
          <ac:spMkLst>
            <pc:docMk/>
            <pc:sldMk cId="3829761077" sldId="274"/>
            <ac:spMk id="6" creationId="{74AF234C-E168-4284-B2E9-FEA4C9837CB3}"/>
          </ac:spMkLst>
        </pc:spChg>
      </pc:sldChg>
      <pc:sldChg chg="modSp">
        <pc:chgData name="Juan I M" userId="bac78a7562c495f3" providerId="LiveId" clId="{3BFE4D46-2F45-4506-9F99-01901B3F68DD}" dt="2019-05-08T15:24:59.786" v="28" actId="20577"/>
        <pc:sldMkLst>
          <pc:docMk/>
          <pc:sldMk cId="1861529701" sldId="275"/>
        </pc:sldMkLst>
        <pc:spChg chg="mod">
          <ac:chgData name="Juan I M" userId="bac78a7562c495f3" providerId="LiveId" clId="{3BFE4D46-2F45-4506-9F99-01901B3F68DD}" dt="2019-05-08T15:24:59.786" v="28" actId="20577"/>
          <ac:spMkLst>
            <pc:docMk/>
            <pc:sldMk cId="1861529701" sldId="275"/>
            <ac:spMk id="6" creationId="{74AF234C-E168-4284-B2E9-FEA4C9837CB3}"/>
          </ac:spMkLst>
        </pc:spChg>
      </pc:sldChg>
      <pc:sldChg chg="modSp">
        <pc:chgData name="Juan I M" userId="bac78a7562c495f3" providerId="LiveId" clId="{3BFE4D46-2F45-4506-9F99-01901B3F68DD}" dt="2019-05-08T15:25:46.244" v="34" actId="20577"/>
        <pc:sldMkLst>
          <pc:docMk/>
          <pc:sldMk cId="1478658471" sldId="276"/>
        </pc:sldMkLst>
        <pc:spChg chg="mod">
          <ac:chgData name="Juan I M" userId="bac78a7562c495f3" providerId="LiveId" clId="{3BFE4D46-2F45-4506-9F99-01901B3F68DD}" dt="2019-05-08T15:25:46.244" v="34" actId="20577"/>
          <ac:spMkLst>
            <pc:docMk/>
            <pc:sldMk cId="1478658471" sldId="276"/>
            <ac:spMk id="6" creationId="{74AF234C-E168-4284-B2E9-FEA4C9837CB3}"/>
          </ac:spMkLst>
        </pc:spChg>
      </pc:sldChg>
      <pc:sldChg chg="modSp">
        <pc:chgData name="Juan I M" userId="bac78a7562c495f3" providerId="LiveId" clId="{3BFE4D46-2F45-4506-9F99-01901B3F68DD}" dt="2019-05-08T15:25:51.055" v="35" actId="20577"/>
        <pc:sldMkLst>
          <pc:docMk/>
          <pc:sldMk cId="589002473" sldId="277"/>
        </pc:sldMkLst>
        <pc:spChg chg="mod">
          <ac:chgData name="Juan I M" userId="bac78a7562c495f3" providerId="LiveId" clId="{3BFE4D46-2F45-4506-9F99-01901B3F68DD}" dt="2019-05-08T15:25:51.055" v="35" actId="20577"/>
          <ac:spMkLst>
            <pc:docMk/>
            <pc:sldMk cId="589002473" sldId="277"/>
            <ac:spMk id="6" creationId="{74AF234C-E168-4284-B2E9-FEA4C9837CB3}"/>
          </ac:spMkLst>
        </pc:spChg>
      </pc:sldChg>
      <pc:sldChg chg="modSp">
        <pc:chgData name="Juan I M" userId="bac78a7562c495f3" providerId="LiveId" clId="{3BFE4D46-2F45-4506-9F99-01901B3F68DD}" dt="2019-05-08T15:25:22.850" v="31" actId="20577"/>
        <pc:sldMkLst>
          <pc:docMk/>
          <pc:sldMk cId="1082141724" sldId="278"/>
        </pc:sldMkLst>
        <pc:spChg chg="mod">
          <ac:chgData name="Juan I M" userId="bac78a7562c495f3" providerId="LiveId" clId="{3BFE4D46-2F45-4506-9F99-01901B3F68DD}" dt="2019-05-08T15:25:22.850" v="31" actId="20577"/>
          <ac:spMkLst>
            <pc:docMk/>
            <pc:sldMk cId="1082141724" sldId="278"/>
            <ac:spMk id="6" creationId="{74AF234C-E168-4284-B2E9-FEA4C9837CB3}"/>
          </ac:spMkLst>
        </pc:spChg>
      </pc:sldChg>
      <pc:sldChg chg="modSp">
        <pc:chgData name="Juan I M" userId="bac78a7562c495f3" providerId="LiveId" clId="{3BFE4D46-2F45-4506-9F99-01901B3F68DD}" dt="2019-05-08T15:25:56.556" v="36" actId="20577"/>
        <pc:sldMkLst>
          <pc:docMk/>
          <pc:sldMk cId="1573485103" sldId="279"/>
        </pc:sldMkLst>
        <pc:spChg chg="mod">
          <ac:chgData name="Juan I M" userId="bac78a7562c495f3" providerId="LiveId" clId="{3BFE4D46-2F45-4506-9F99-01901B3F68DD}" dt="2019-05-08T15:25:56.556" v="36" actId="20577"/>
          <ac:spMkLst>
            <pc:docMk/>
            <pc:sldMk cId="1573485103" sldId="279"/>
            <ac:spMk id="6" creationId="{74AF234C-E168-4284-B2E9-FEA4C9837CB3}"/>
          </ac:spMkLst>
        </pc:spChg>
      </pc:sldChg>
      <pc:sldChg chg="modSp">
        <pc:chgData name="Juan I M" userId="bac78a7562c495f3" providerId="LiveId" clId="{3BFE4D46-2F45-4506-9F99-01901B3F68DD}" dt="2019-05-08T15:26:12.510" v="39" actId="20577"/>
        <pc:sldMkLst>
          <pc:docMk/>
          <pc:sldMk cId="508756162" sldId="280"/>
        </pc:sldMkLst>
        <pc:spChg chg="mod">
          <ac:chgData name="Juan I M" userId="bac78a7562c495f3" providerId="LiveId" clId="{3BFE4D46-2F45-4506-9F99-01901B3F68DD}" dt="2019-05-08T15:26:12.510" v="39" actId="20577"/>
          <ac:spMkLst>
            <pc:docMk/>
            <pc:sldMk cId="508756162" sldId="280"/>
            <ac:spMk id="6" creationId="{74AF234C-E168-4284-B2E9-FEA4C9837CB3}"/>
          </ac:spMkLst>
        </pc:spChg>
      </pc:sldChg>
      <pc:sldChg chg="modSp">
        <pc:chgData name="Juan I M" userId="bac78a7562c495f3" providerId="LiveId" clId="{3BFE4D46-2F45-4506-9F99-01901B3F68DD}" dt="2019-05-08T15:26:07.087" v="38" actId="20577"/>
        <pc:sldMkLst>
          <pc:docMk/>
          <pc:sldMk cId="2501079779" sldId="281"/>
        </pc:sldMkLst>
        <pc:spChg chg="mod">
          <ac:chgData name="Juan I M" userId="bac78a7562c495f3" providerId="LiveId" clId="{3BFE4D46-2F45-4506-9F99-01901B3F68DD}" dt="2019-05-08T15:26:07.087" v="38" actId="20577"/>
          <ac:spMkLst>
            <pc:docMk/>
            <pc:sldMk cId="2501079779" sldId="281"/>
            <ac:spMk id="6" creationId="{74AF234C-E168-4284-B2E9-FEA4C9837CB3}"/>
          </ac:spMkLst>
        </pc:spChg>
      </pc:sldChg>
      <pc:sldChg chg="modSp">
        <pc:chgData name="Juan I M" userId="bac78a7562c495f3" providerId="LiveId" clId="{3BFE4D46-2F45-4506-9F99-01901B3F68DD}" dt="2019-05-08T15:26:01.336" v="37" actId="20577"/>
        <pc:sldMkLst>
          <pc:docMk/>
          <pc:sldMk cId="2057399617" sldId="282"/>
        </pc:sldMkLst>
        <pc:spChg chg="mod">
          <ac:chgData name="Juan I M" userId="bac78a7562c495f3" providerId="LiveId" clId="{3BFE4D46-2F45-4506-9F99-01901B3F68DD}" dt="2019-05-08T15:26:01.336" v="37" actId="20577"/>
          <ac:spMkLst>
            <pc:docMk/>
            <pc:sldMk cId="2057399617" sldId="282"/>
            <ac:spMk id="6" creationId="{74AF234C-E168-4284-B2E9-FEA4C9837CB3}"/>
          </ac:spMkLst>
        </pc:spChg>
      </pc:sldChg>
      <pc:sldChg chg="modSp">
        <pc:chgData name="Juan I M" userId="bac78a7562c495f3" providerId="LiveId" clId="{3BFE4D46-2F45-4506-9F99-01901B3F68DD}" dt="2019-05-08T15:26:27.321" v="43" actId="20577"/>
        <pc:sldMkLst>
          <pc:docMk/>
          <pc:sldMk cId="1066935660" sldId="284"/>
        </pc:sldMkLst>
        <pc:spChg chg="mod">
          <ac:chgData name="Juan I M" userId="bac78a7562c495f3" providerId="LiveId" clId="{3BFE4D46-2F45-4506-9F99-01901B3F68DD}" dt="2019-05-08T15:26:27.321" v="43" actId="20577"/>
          <ac:spMkLst>
            <pc:docMk/>
            <pc:sldMk cId="1066935660" sldId="284"/>
            <ac:spMk id="6" creationId="{74AF234C-E168-4284-B2E9-FEA4C9837CB3}"/>
          </ac:spMkLst>
        </pc:spChg>
      </pc:sldChg>
      <pc:sldChg chg="modSp">
        <pc:chgData name="Juan I M" userId="bac78a7562c495f3" providerId="LiveId" clId="{3BFE4D46-2F45-4506-9F99-01901B3F68DD}" dt="2019-05-08T15:26:36.323" v="45" actId="20577"/>
        <pc:sldMkLst>
          <pc:docMk/>
          <pc:sldMk cId="1309087768" sldId="285"/>
        </pc:sldMkLst>
        <pc:spChg chg="mod">
          <ac:chgData name="Juan I M" userId="bac78a7562c495f3" providerId="LiveId" clId="{3BFE4D46-2F45-4506-9F99-01901B3F68DD}" dt="2019-05-08T15:26:36.323" v="45" actId="20577"/>
          <ac:spMkLst>
            <pc:docMk/>
            <pc:sldMk cId="1309087768" sldId="285"/>
            <ac:spMk id="6" creationId="{74AF234C-E168-4284-B2E9-FEA4C9837CB3}"/>
          </ac:spMkLst>
        </pc:spChg>
      </pc:sldChg>
      <pc:sldChg chg="modSp">
        <pc:chgData name="Juan I M" userId="bac78a7562c495f3" providerId="LiveId" clId="{3BFE4D46-2F45-4506-9F99-01901B3F68DD}" dt="2019-05-08T15:27:23.559" v="61" actId="20577"/>
        <pc:sldMkLst>
          <pc:docMk/>
          <pc:sldMk cId="3289139080" sldId="286"/>
        </pc:sldMkLst>
        <pc:spChg chg="mod">
          <ac:chgData name="Juan I M" userId="bac78a7562c495f3" providerId="LiveId" clId="{3BFE4D46-2F45-4506-9F99-01901B3F68DD}" dt="2019-05-08T15:27:23.559" v="61" actId="20577"/>
          <ac:spMkLst>
            <pc:docMk/>
            <pc:sldMk cId="3289139080" sldId="286"/>
            <ac:spMk id="6" creationId="{74AF234C-E168-4284-B2E9-FEA4C9837CB3}"/>
          </ac:spMkLst>
        </pc:spChg>
      </pc:sldChg>
      <pc:sldChg chg="modSp">
        <pc:chgData name="Juan I M" userId="bac78a7562c495f3" providerId="LiveId" clId="{3BFE4D46-2F45-4506-9F99-01901B3F68DD}" dt="2019-05-08T15:26:41.384" v="47" actId="20577"/>
        <pc:sldMkLst>
          <pc:docMk/>
          <pc:sldMk cId="3954353154" sldId="287"/>
        </pc:sldMkLst>
        <pc:spChg chg="mod">
          <ac:chgData name="Juan I M" userId="bac78a7562c495f3" providerId="LiveId" clId="{3BFE4D46-2F45-4506-9F99-01901B3F68DD}" dt="2019-05-08T15:26:41.384" v="47" actId="20577"/>
          <ac:spMkLst>
            <pc:docMk/>
            <pc:sldMk cId="3954353154" sldId="287"/>
            <ac:spMk id="6" creationId="{74AF234C-E168-4284-B2E9-FEA4C9837CB3}"/>
          </ac:spMkLst>
        </pc:spChg>
      </pc:sldChg>
      <pc:sldChg chg="modSp">
        <pc:chgData name="Juan I M" userId="bac78a7562c495f3" providerId="LiveId" clId="{3BFE4D46-2F45-4506-9F99-01901B3F68DD}" dt="2019-05-08T15:26:22.728" v="41" actId="20577"/>
        <pc:sldMkLst>
          <pc:docMk/>
          <pc:sldMk cId="1530714850" sldId="288"/>
        </pc:sldMkLst>
        <pc:spChg chg="mod">
          <ac:chgData name="Juan I M" userId="bac78a7562c495f3" providerId="LiveId" clId="{3BFE4D46-2F45-4506-9F99-01901B3F68DD}" dt="2019-05-08T15:26:22.728" v="41" actId="20577"/>
          <ac:spMkLst>
            <pc:docMk/>
            <pc:sldMk cId="1530714850" sldId="288"/>
            <ac:spMk id="6" creationId="{74AF234C-E168-4284-B2E9-FEA4C9837CB3}"/>
          </ac:spMkLst>
        </pc:spChg>
      </pc:sldChg>
      <pc:sldChg chg="modSp">
        <pc:chgData name="Juan I M" userId="bac78a7562c495f3" providerId="LiveId" clId="{3BFE4D46-2F45-4506-9F99-01901B3F68DD}" dt="2019-05-08T15:26:58.556" v="55" actId="20577"/>
        <pc:sldMkLst>
          <pc:docMk/>
          <pc:sldMk cId="556432707" sldId="289"/>
        </pc:sldMkLst>
        <pc:spChg chg="mod">
          <ac:chgData name="Juan I M" userId="bac78a7562c495f3" providerId="LiveId" clId="{3BFE4D46-2F45-4506-9F99-01901B3F68DD}" dt="2019-05-08T15:26:58.556" v="55" actId="20577"/>
          <ac:spMkLst>
            <pc:docMk/>
            <pc:sldMk cId="556432707" sldId="289"/>
            <ac:spMk id="6" creationId="{74AF234C-E168-4284-B2E9-FEA4C9837CB3}"/>
          </ac:spMkLst>
        </pc:spChg>
      </pc:sldChg>
      <pc:sldChg chg="modSp">
        <pc:chgData name="Juan I M" userId="bac78a7562c495f3" providerId="LiveId" clId="{3BFE4D46-2F45-4506-9F99-01901B3F68DD}" dt="2019-05-08T15:26:46.041" v="49" actId="20577"/>
        <pc:sldMkLst>
          <pc:docMk/>
          <pc:sldMk cId="3719366282" sldId="290"/>
        </pc:sldMkLst>
        <pc:spChg chg="mod">
          <ac:chgData name="Juan I M" userId="bac78a7562c495f3" providerId="LiveId" clId="{3BFE4D46-2F45-4506-9F99-01901B3F68DD}" dt="2019-05-08T15:26:46.041" v="49" actId="20577"/>
          <ac:spMkLst>
            <pc:docMk/>
            <pc:sldMk cId="3719366282" sldId="290"/>
            <ac:spMk id="6" creationId="{74AF234C-E168-4284-B2E9-FEA4C9837CB3}"/>
          </ac:spMkLst>
        </pc:spChg>
      </pc:sldChg>
      <pc:sldChg chg="modSp">
        <pc:chgData name="Juan I M" userId="bac78a7562c495f3" providerId="LiveId" clId="{3BFE4D46-2F45-4506-9F99-01901B3F68DD}" dt="2019-05-08T15:26:50.384" v="51" actId="20577"/>
        <pc:sldMkLst>
          <pc:docMk/>
          <pc:sldMk cId="1259787142" sldId="291"/>
        </pc:sldMkLst>
        <pc:spChg chg="mod">
          <ac:chgData name="Juan I M" userId="bac78a7562c495f3" providerId="LiveId" clId="{3BFE4D46-2F45-4506-9F99-01901B3F68DD}" dt="2019-05-08T15:26:50.384" v="51" actId="20577"/>
          <ac:spMkLst>
            <pc:docMk/>
            <pc:sldMk cId="1259787142" sldId="291"/>
            <ac:spMk id="6" creationId="{74AF234C-E168-4284-B2E9-FEA4C9837CB3}"/>
          </ac:spMkLst>
        </pc:spChg>
      </pc:sldChg>
      <pc:sldChg chg="modSp">
        <pc:chgData name="Juan I M" userId="bac78a7562c495f3" providerId="LiveId" clId="{3BFE4D46-2F45-4506-9F99-01901B3F68DD}" dt="2019-05-08T15:26:54.603" v="53" actId="20577"/>
        <pc:sldMkLst>
          <pc:docMk/>
          <pc:sldMk cId="2067063013" sldId="292"/>
        </pc:sldMkLst>
        <pc:spChg chg="mod">
          <ac:chgData name="Juan I M" userId="bac78a7562c495f3" providerId="LiveId" clId="{3BFE4D46-2F45-4506-9F99-01901B3F68DD}" dt="2019-05-08T15:26:54.603" v="53" actId="20577"/>
          <ac:spMkLst>
            <pc:docMk/>
            <pc:sldMk cId="2067063013" sldId="292"/>
            <ac:spMk id="6" creationId="{74AF234C-E168-4284-B2E9-FEA4C9837CB3}"/>
          </ac:spMkLst>
        </pc:spChg>
      </pc:sldChg>
      <pc:sldChg chg="modSp">
        <pc:chgData name="Juan I M" userId="bac78a7562c495f3" providerId="LiveId" clId="{3BFE4D46-2F45-4506-9F99-01901B3F68DD}" dt="2019-05-08T15:27:06.525" v="57" actId="20577"/>
        <pc:sldMkLst>
          <pc:docMk/>
          <pc:sldMk cId="675220642" sldId="294"/>
        </pc:sldMkLst>
        <pc:spChg chg="mod">
          <ac:chgData name="Juan I M" userId="bac78a7562c495f3" providerId="LiveId" clId="{3BFE4D46-2F45-4506-9F99-01901B3F68DD}" dt="2019-05-08T15:27:06.525" v="57" actId="20577"/>
          <ac:spMkLst>
            <pc:docMk/>
            <pc:sldMk cId="675220642" sldId="294"/>
            <ac:spMk id="6" creationId="{74AF234C-E168-4284-B2E9-FEA4C9837CB3}"/>
          </ac:spMkLst>
        </pc:spChg>
      </pc:sldChg>
      <pc:sldChg chg="modSp">
        <pc:chgData name="Juan I M" userId="bac78a7562c495f3" providerId="LiveId" clId="{3BFE4D46-2F45-4506-9F99-01901B3F68DD}" dt="2019-05-08T15:27:13.338" v="59" actId="20577"/>
        <pc:sldMkLst>
          <pc:docMk/>
          <pc:sldMk cId="1679503701" sldId="295"/>
        </pc:sldMkLst>
        <pc:spChg chg="mod">
          <ac:chgData name="Juan I M" userId="bac78a7562c495f3" providerId="LiveId" clId="{3BFE4D46-2F45-4506-9F99-01901B3F68DD}" dt="2019-05-08T15:27:13.338" v="59" actId="20577"/>
          <ac:spMkLst>
            <pc:docMk/>
            <pc:sldMk cId="1679503701" sldId="295"/>
            <ac:spMk id="6" creationId="{74AF234C-E168-4284-B2E9-FEA4C9837CB3}"/>
          </ac:spMkLst>
        </pc:spChg>
      </pc:sldChg>
      <pc:sldChg chg="modSp">
        <pc:chgData name="Juan I M" userId="bac78a7562c495f3" providerId="LiveId" clId="{3BFE4D46-2F45-4506-9F99-01901B3F68DD}" dt="2019-05-08T15:25:28.163" v="32" actId="20577"/>
        <pc:sldMkLst>
          <pc:docMk/>
          <pc:sldMk cId="2351877273" sldId="296"/>
        </pc:sldMkLst>
        <pc:spChg chg="mod">
          <ac:chgData name="Juan I M" userId="bac78a7562c495f3" providerId="LiveId" clId="{3BFE4D46-2F45-4506-9F99-01901B3F68DD}" dt="2019-05-08T15:25:28.163" v="32" actId="20577"/>
          <ac:spMkLst>
            <pc:docMk/>
            <pc:sldMk cId="2351877273" sldId="296"/>
            <ac:spMk id="6" creationId="{74AF234C-E168-4284-B2E9-FEA4C9837CB3}"/>
          </ac:spMkLst>
        </pc:spChg>
      </pc:sldChg>
      <pc:sldChg chg="modSp">
        <pc:chgData name="Juan I M" userId="bac78a7562c495f3" providerId="LiveId" clId="{3BFE4D46-2F45-4506-9F99-01901B3F68DD}" dt="2019-05-08T15:27:28.008" v="63" actId="20577"/>
        <pc:sldMkLst>
          <pc:docMk/>
          <pc:sldMk cId="2917180100" sldId="297"/>
        </pc:sldMkLst>
        <pc:spChg chg="mod">
          <ac:chgData name="Juan I M" userId="bac78a7562c495f3" providerId="LiveId" clId="{3BFE4D46-2F45-4506-9F99-01901B3F68DD}" dt="2019-05-08T15:27:28.008" v="63" actId="20577"/>
          <ac:spMkLst>
            <pc:docMk/>
            <pc:sldMk cId="2917180100" sldId="297"/>
            <ac:spMk id="6" creationId="{74AF234C-E168-4284-B2E9-FEA4C9837CB3}"/>
          </ac:spMkLst>
        </pc:spChg>
      </pc:sldChg>
      <pc:sldChg chg="modSp">
        <pc:chgData name="Juan I M" userId="bac78a7562c495f3" providerId="LiveId" clId="{3BFE4D46-2F45-4506-9F99-01901B3F68DD}" dt="2019-05-08T15:28:14.494" v="77" actId="20577"/>
        <pc:sldMkLst>
          <pc:docMk/>
          <pc:sldMk cId="1605343243" sldId="298"/>
        </pc:sldMkLst>
        <pc:spChg chg="mod">
          <ac:chgData name="Juan I M" userId="bac78a7562c495f3" providerId="LiveId" clId="{3BFE4D46-2F45-4506-9F99-01901B3F68DD}" dt="2019-05-08T15:28:14.494" v="77" actId="20577"/>
          <ac:spMkLst>
            <pc:docMk/>
            <pc:sldMk cId="1605343243" sldId="298"/>
            <ac:spMk id="6" creationId="{74AF234C-E168-4284-B2E9-FEA4C9837CB3}"/>
          </ac:spMkLst>
        </pc:spChg>
      </pc:sldChg>
      <pc:sldChg chg="modSp">
        <pc:chgData name="Juan I M" userId="bac78a7562c495f3" providerId="LiveId" clId="{3BFE4D46-2F45-4506-9F99-01901B3F68DD}" dt="2019-05-08T15:28:18.886" v="79" actId="20577"/>
        <pc:sldMkLst>
          <pc:docMk/>
          <pc:sldMk cId="2990729078" sldId="299"/>
        </pc:sldMkLst>
        <pc:spChg chg="mod">
          <ac:chgData name="Juan I M" userId="bac78a7562c495f3" providerId="LiveId" clId="{3BFE4D46-2F45-4506-9F99-01901B3F68DD}" dt="2019-05-08T15:28:18.886" v="79" actId="20577"/>
          <ac:spMkLst>
            <pc:docMk/>
            <pc:sldMk cId="2990729078" sldId="299"/>
            <ac:spMk id="6" creationId="{74AF234C-E168-4284-B2E9-FEA4C9837CB3}"/>
          </ac:spMkLst>
        </pc:spChg>
      </pc:sldChg>
      <pc:sldChg chg="modSp">
        <pc:chgData name="Juan I M" userId="bac78a7562c495f3" providerId="LiveId" clId="{3BFE4D46-2F45-4506-9F99-01901B3F68DD}" dt="2019-05-08T15:28:28.758" v="82" actId="1076"/>
        <pc:sldMkLst>
          <pc:docMk/>
          <pc:sldMk cId="2496161767" sldId="300"/>
        </pc:sldMkLst>
        <pc:spChg chg="mod">
          <ac:chgData name="Juan I M" userId="bac78a7562c495f3" providerId="LiveId" clId="{3BFE4D46-2F45-4506-9F99-01901B3F68DD}" dt="2019-05-08T15:28:25.290" v="81" actId="20577"/>
          <ac:spMkLst>
            <pc:docMk/>
            <pc:sldMk cId="2496161767" sldId="300"/>
            <ac:spMk id="6" creationId="{74AF234C-E168-4284-B2E9-FEA4C9837CB3}"/>
          </ac:spMkLst>
        </pc:spChg>
        <pc:spChg chg="mod">
          <ac:chgData name="Juan I M" userId="bac78a7562c495f3" providerId="LiveId" clId="{3BFE4D46-2F45-4506-9F99-01901B3F68DD}" dt="2019-05-08T15:28:28.758" v="82" actId="1076"/>
          <ac:spMkLst>
            <pc:docMk/>
            <pc:sldMk cId="2496161767" sldId="300"/>
            <ac:spMk id="13" creationId="{EBE4BA38-1600-4D87-A3A4-4534CBD9C640}"/>
          </ac:spMkLst>
        </pc:spChg>
      </pc:sldChg>
      <pc:sldChg chg="modSp">
        <pc:chgData name="Juan I M" userId="bac78a7562c495f3" providerId="LiveId" clId="{3BFE4D46-2F45-4506-9F99-01901B3F68DD}" dt="2019-05-08T15:22:45.479" v="1" actId="20577"/>
        <pc:sldMkLst>
          <pc:docMk/>
          <pc:sldMk cId="475207030" sldId="301"/>
        </pc:sldMkLst>
        <pc:spChg chg="mod">
          <ac:chgData name="Juan I M" userId="bac78a7562c495f3" providerId="LiveId" clId="{3BFE4D46-2F45-4506-9F99-01901B3F68DD}" dt="2019-05-08T15:22:45.479" v="1" actId="20577"/>
          <ac:spMkLst>
            <pc:docMk/>
            <pc:sldMk cId="475207030" sldId="301"/>
            <ac:spMk id="14" creationId="{0DF261E0-794C-4AE7-BB9C-8066C249C6DF}"/>
          </ac:spMkLst>
        </pc:spChg>
      </pc:sldChg>
      <pc:sldChg chg="modSp">
        <pc:chgData name="Juan I M" userId="bac78a7562c495f3" providerId="LiveId" clId="{3BFE4D46-2F45-4506-9F99-01901B3F68DD}" dt="2019-05-08T15:25:32.070" v="33" actId="20577"/>
        <pc:sldMkLst>
          <pc:docMk/>
          <pc:sldMk cId="2345967337" sldId="303"/>
        </pc:sldMkLst>
        <pc:spChg chg="mod">
          <ac:chgData name="Juan I M" userId="bac78a7562c495f3" providerId="LiveId" clId="{3BFE4D46-2F45-4506-9F99-01901B3F68DD}" dt="2019-05-08T15:25:32.070" v="33" actId="20577"/>
          <ac:spMkLst>
            <pc:docMk/>
            <pc:sldMk cId="2345967337" sldId="303"/>
            <ac:spMk id="6" creationId="{74AF234C-E168-4284-B2E9-FEA4C9837CB3}"/>
          </ac:spMkLst>
        </pc:spChg>
      </pc:sldChg>
      <pc:sldChg chg="modSp">
        <pc:chgData name="Juan I M" userId="bac78a7562c495f3" providerId="LiveId" clId="{3BFE4D46-2F45-4506-9F99-01901B3F68DD}" dt="2019-05-08T15:23:34.179" v="18" actId="20577"/>
        <pc:sldMkLst>
          <pc:docMk/>
          <pc:sldMk cId="274423081" sldId="304"/>
        </pc:sldMkLst>
        <pc:spChg chg="mod">
          <ac:chgData name="Juan I M" userId="bac78a7562c495f3" providerId="LiveId" clId="{3BFE4D46-2F45-4506-9F99-01901B3F68DD}" dt="2019-05-08T15:23:34.179" v="18" actId="20577"/>
          <ac:spMkLst>
            <pc:docMk/>
            <pc:sldMk cId="274423081" sldId="304"/>
            <ac:spMk id="6" creationId="{74AF234C-E168-4284-B2E9-FEA4C9837CB3}"/>
          </ac:spMkLst>
        </pc:spChg>
      </pc:sldChg>
      <pc:sldChg chg="modSp">
        <pc:chgData name="Juan I M" userId="bac78a7562c495f3" providerId="LiveId" clId="{3BFE4D46-2F45-4506-9F99-01901B3F68DD}" dt="2019-05-08T15:22:59.341" v="5" actId="20577"/>
        <pc:sldMkLst>
          <pc:docMk/>
          <pc:sldMk cId="3248992996" sldId="305"/>
        </pc:sldMkLst>
        <pc:spChg chg="mod">
          <ac:chgData name="Juan I M" userId="bac78a7562c495f3" providerId="LiveId" clId="{3BFE4D46-2F45-4506-9F99-01901B3F68DD}" dt="2019-05-08T15:22:59.341" v="5" actId="20577"/>
          <ac:spMkLst>
            <pc:docMk/>
            <pc:sldMk cId="3248992996" sldId="305"/>
            <ac:spMk id="6" creationId="{74AF234C-E168-4284-B2E9-FEA4C9837CB3}"/>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8ED1EC6-1ADA-4B7D-8D9B-2A10C6EC033F}" type="datetimeFigureOut">
              <a:rPr lang="en-GB" smtClean="0"/>
              <a:t>08/05/2019</a:t>
            </a:fld>
            <a:endParaRPr lang="en-GB"/>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A8A0204-D87E-4A40-B1EA-DDD19387476A}" type="slidenum">
              <a:rPr lang="en-GB" smtClean="0"/>
              <a:t>‹Nº›</a:t>
            </a:fld>
            <a:endParaRPr lang="en-GB"/>
          </a:p>
        </p:txBody>
      </p:sp>
    </p:spTree>
    <p:extLst>
      <p:ext uri="{BB962C8B-B14F-4D97-AF65-F5344CB8AC3E}">
        <p14:creationId xmlns:p14="http://schemas.microsoft.com/office/powerpoint/2010/main" val="28411886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280F3FD-ECC2-4385-AB56-5CE114305C10}"/>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n-GB"/>
          </a:p>
        </p:txBody>
      </p:sp>
      <p:sp>
        <p:nvSpPr>
          <p:cNvPr id="3" name="Subtítulo 2">
            <a:extLst>
              <a:ext uri="{FF2B5EF4-FFF2-40B4-BE49-F238E27FC236}">
                <a16:creationId xmlns:a16="http://schemas.microsoft.com/office/drawing/2014/main" id="{6A41ED78-1D8F-462F-AEDD-74F161CE477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n-GB"/>
          </a:p>
        </p:txBody>
      </p:sp>
      <p:sp>
        <p:nvSpPr>
          <p:cNvPr id="4" name="Marcador de fecha 3">
            <a:extLst>
              <a:ext uri="{FF2B5EF4-FFF2-40B4-BE49-F238E27FC236}">
                <a16:creationId xmlns:a16="http://schemas.microsoft.com/office/drawing/2014/main" id="{4319EE4D-7696-4EDD-B221-D09798D7BA72}"/>
              </a:ext>
            </a:extLst>
          </p:cNvPr>
          <p:cNvSpPr>
            <a:spLocks noGrp="1"/>
          </p:cNvSpPr>
          <p:nvPr>
            <p:ph type="dt" sz="half" idx="10"/>
          </p:nvPr>
        </p:nvSpPr>
        <p:spPr/>
        <p:txBody>
          <a:bodyPr/>
          <a:lstStyle/>
          <a:p>
            <a:fld id="{3914C398-ACB8-4587-950A-20C173721DD7}" type="datetime1">
              <a:rPr lang="en-GB" smtClean="0"/>
              <a:t>08/05/2019</a:t>
            </a:fld>
            <a:endParaRPr lang="en-GB"/>
          </a:p>
        </p:txBody>
      </p:sp>
      <p:sp>
        <p:nvSpPr>
          <p:cNvPr id="5" name="Marcador de pie de página 4">
            <a:extLst>
              <a:ext uri="{FF2B5EF4-FFF2-40B4-BE49-F238E27FC236}">
                <a16:creationId xmlns:a16="http://schemas.microsoft.com/office/drawing/2014/main" id="{6A623C75-9F1C-4CB8-949D-00F8F8367859}"/>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0EE678C6-07EC-478C-AAA3-E049E6824D8A}"/>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9246486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4685800-4852-44AB-B3E8-219597A1259E}"/>
              </a:ext>
            </a:extLst>
          </p:cNvPr>
          <p:cNvSpPr>
            <a:spLocks noGrp="1"/>
          </p:cNvSpPr>
          <p:nvPr>
            <p:ph type="title"/>
          </p:nvPr>
        </p:nvSpPr>
        <p:spPr/>
        <p:txBody>
          <a:bodyPr/>
          <a:lstStyle/>
          <a:p>
            <a:r>
              <a:rPr lang="es-ES"/>
              <a:t>Haga clic para modificar el estilo de título del patrón</a:t>
            </a:r>
            <a:endParaRPr lang="en-GB"/>
          </a:p>
        </p:txBody>
      </p:sp>
      <p:sp>
        <p:nvSpPr>
          <p:cNvPr id="3" name="Marcador de texto vertical 2">
            <a:extLst>
              <a:ext uri="{FF2B5EF4-FFF2-40B4-BE49-F238E27FC236}">
                <a16:creationId xmlns:a16="http://schemas.microsoft.com/office/drawing/2014/main" id="{7629F9EB-63BC-4330-8F6C-947F432C0139}"/>
              </a:ext>
            </a:extLst>
          </p:cNvPr>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a:extLst>
              <a:ext uri="{FF2B5EF4-FFF2-40B4-BE49-F238E27FC236}">
                <a16:creationId xmlns:a16="http://schemas.microsoft.com/office/drawing/2014/main" id="{DB5F139B-7CB0-4470-B4E7-2788E1E2103E}"/>
              </a:ext>
            </a:extLst>
          </p:cNvPr>
          <p:cNvSpPr>
            <a:spLocks noGrp="1"/>
          </p:cNvSpPr>
          <p:nvPr>
            <p:ph type="dt" sz="half" idx="10"/>
          </p:nvPr>
        </p:nvSpPr>
        <p:spPr/>
        <p:txBody>
          <a:bodyPr/>
          <a:lstStyle/>
          <a:p>
            <a:fld id="{92E92BC7-C466-4DD8-9469-6ECDD4B2D8D2}" type="datetime1">
              <a:rPr lang="en-GB" smtClean="0"/>
              <a:t>08/05/2019</a:t>
            </a:fld>
            <a:endParaRPr lang="en-GB"/>
          </a:p>
        </p:txBody>
      </p:sp>
      <p:sp>
        <p:nvSpPr>
          <p:cNvPr id="5" name="Marcador de pie de página 4">
            <a:extLst>
              <a:ext uri="{FF2B5EF4-FFF2-40B4-BE49-F238E27FC236}">
                <a16:creationId xmlns:a16="http://schemas.microsoft.com/office/drawing/2014/main" id="{9EF556E0-E0C1-43B8-9BB5-DD45B090FAAC}"/>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0D5337C8-4870-4E18-AA42-6D36C940D3DC}"/>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33041565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78B6152F-50A2-490B-864F-BECDB52DEC0D}"/>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n-GB"/>
          </a:p>
        </p:txBody>
      </p:sp>
      <p:sp>
        <p:nvSpPr>
          <p:cNvPr id="3" name="Marcador de texto vertical 2">
            <a:extLst>
              <a:ext uri="{FF2B5EF4-FFF2-40B4-BE49-F238E27FC236}">
                <a16:creationId xmlns:a16="http://schemas.microsoft.com/office/drawing/2014/main" id="{B23E2B47-1BD0-4C49-AD5C-2844821BF8F4}"/>
              </a:ext>
            </a:extLst>
          </p:cNvPr>
          <p:cNvSpPr>
            <a:spLocks noGrp="1"/>
          </p:cNvSpPr>
          <p:nvPr>
            <p:ph type="body" orient="vert" idx="1"/>
          </p:nvPr>
        </p:nvSpPr>
        <p:spPr>
          <a:xfrm>
            <a:off x="838200" y="365125"/>
            <a:ext cx="7734300" cy="5811838"/>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a:extLst>
              <a:ext uri="{FF2B5EF4-FFF2-40B4-BE49-F238E27FC236}">
                <a16:creationId xmlns:a16="http://schemas.microsoft.com/office/drawing/2014/main" id="{7A436BCE-D9F7-48B6-8C01-E3ECE93AD4F8}"/>
              </a:ext>
            </a:extLst>
          </p:cNvPr>
          <p:cNvSpPr>
            <a:spLocks noGrp="1"/>
          </p:cNvSpPr>
          <p:nvPr>
            <p:ph type="dt" sz="half" idx="10"/>
          </p:nvPr>
        </p:nvSpPr>
        <p:spPr/>
        <p:txBody>
          <a:bodyPr/>
          <a:lstStyle/>
          <a:p>
            <a:fld id="{ADA65BB3-896E-4626-8B92-1F56E3C26677}" type="datetime1">
              <a:rPr lang="en-GB" smtClean="0"/>
              <a:t>08/05/2019</a:t>
            </a:fld>
            <a:endParaRPr lang="en-GB"/>
          </a:p>
        </p:txBody>
      </p:sp>
      <p:sp>
        <p:nvSpPr>
          <p:cNvPr id="5" name="Marcador de pie de página 4">
            <a:extLst>
              <a:ext uri="{FF2B5EF4-FFF2-40B4-BE49-F238E27FC236}">
                <a16:creationId xmlns:a16="http://schemas.microsoft.com/office/drawing/2014/main" id="{FA8E21F3-5FC4-4FBC-BE4B-010AF42C222E}"/>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A2A255AE-42A3-41AC-92BA-602F72E921B4}"/>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29202827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B51C333-415E-4990-8745-5B70B75CB0C1}"/>
              </a:ext>
            </a:extLst>
          </p:cNvPr>
          <p:cNvSpPr>
            <a:spLocks noGrp="1"/>
          </p:cNvSpPr>
          <p:nvPr>
            <p:ph type="title"/>
          </p:nvPr>
        </p:nvSpPr>
        <p:spPr/>
        <p:txBody>
          <a:bodyPr/>
          <a:lstStyle/>
          <a:p>
            <a:r>
              <a:rPr lang="es-ES"/>
              <a:t>Haga clic para modificar el estilo de título del patrón</a:t>
            </a:r>
            <a:endParaRPr lang="en-GB"/>
          </a:p>
        </p:txBody>
      </p:sp>
      <p:sp>
        <p:nvSpPr>
          <p:cNvPr id="3" name="Marcador de contenido 2">
            <a:extLst>
              <a:ext uri="{FF2B5EF4-FFF2-40B4-BE49-F238E27FC236}">
                <a16:creationId xmlns:a16="http://schemas.microsoft.com/office/drawing/2014/main" id="{E191AB1C-6EBD-475B-998A-3C523C3A88D2}"/>
              </a:ext>
            </a:extLst>
          </p:cNvPr>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a:extLst>
              <a:ext uri="{FF2B5EF4-FFF2-40B4-BE49-F238E27FC236}">
                <a16:creationId xmlns:a16="http://schemas.microsoft.com/office/drawing/2014/main" id="{EA42C685-721C-4555-BA31-756750AE41FA}"/>
              </a:ext>
            </a:extLst>
          </p:cNvPr>
          <p:cNvSpPr>
            <a:spLocks noGrp="1"/>
          </p:cNvSpPr>
          <p:nvPr>
            <p:ph type="dt" sz="half" idx="10"/>
          </p:nvPr>
        </p:nvSpPr>
        <p:spPr/>
        <p:txBody>
          <a:bodyPr/>
          <a:lstStyle/>
          <a:p>
            <a:fld id="{789A6E7B-6218-47ED-895F-ADA27DA70168}" type="datetime1">
              <a:rPr lang="en-GB" smtClean="0"/>
              <a:t>08/05/2019</a:t>
            </a:fld>
            <a:endParaRPr lang="en-GB"/>
          </a:p>
        </p:txBody>
      </p:sp>
      <p:sp>
        <p:nvSpPr>
          <p:cNvPr id="5" name="Marcador de pie de página 4">
            <a:extLst>
              <a:ext uri="{FF2B5EF4-FFF2-40B4-BE49-F238E27FC236}">
                <a16:creationId xmlns:a16="http://schemas.microsoft.com/office/drawing/2014/main" id="{40E23DD5-B180-4E60-A2BE-4507C9A1E196}"/>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F0A2FBDD-496B-4977-BEAF-D67DF38122B4}"/>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37183117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D01CFFC-A95E-49BE-9B19-E8AD2E554D4F}"/>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n-GB"/>
          </a:p>
        </p:txBody>
      </p:sp>
      <p:sp>
        <p:nvSpPr>
          <p:cNvPr id="3" name="Marcador de texto 2">
            <a:extLst>
              <a:ext uri="{FF2B5EF4-FFF2-40B4-BE49-F238E27FC236}">
                <a16:creationId xmlns:a16="http://schemas.microsoft.com/office/drawing/2014/main" id="{25A4710F-999F-492C-A7D9-67BC1E9827F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a:t>
            </a:r>
          </a:p>
        </p:txBody>
      </p:sp>
      <p:sp>
        <p:nvSpPr>
          <p:cNvPr id="4" name="Marcador de fecha 3">
            <a:extLst>
              <a:ext uri="{FF2B5EF4-FFF2-40B4-BE49-F238E27FC236}">
                <a16:creationId xmlns:a16="http://schemas.microsoft.com/office/drawing/2014/main" id="{3D0784F2-0F83-4DC2-B81E-9908A4810308}"/>
              </a:ext>
            </a:extLst>
          </p:cNvPr>
          <p:cNvSpPr>
            <a:spLocks noGrp="1"/>
          </p:cNvSpPr>
          <p:nvPr>
            <p:ph type="dt" sz="half" idx="10"/>
          </p:nvPr>
        </p:nvSpPr>
        <p:spPr/>
        <p:txBody>
          <a:bodyPr/>
          <a:lstStyle/>
          <a:p>
            <a:fld id="{D6811A63-5C46-4647-904E-E27C42CAE986}" type="datetime1">
              <a:rPr lang="en-GB" smtClean="0"/>
              <a:t>08/05/2019</a:t>
            </a:fld>
            <a:endParaRPr lang="en-GB"/>
          </a:p>
        </p:txBody>
      </p:sp>
      <p:sp>
        <p:nvSpPr>
          <p:cNvPr id="5" name="Marcador de pie de página 4">
            <a:extLst>
              <a:ext uri="{FF2B5EF4-FFF2-40B4-BE49-F238E27FC236}">
                <a16:creationId xmlns:a16="http://schemas.microsoft.com/office/drawing/2014/main" id="{FCDB8B3D-0C25-41A3-B9CA-98CCC996EB27}"/>
              </a:ext>
            </a:extLst>
          </p:cNvPr>
          <p:cNvSpPr>
            <a:spLocks noGrp="1"/>
          </p:cNvSpPr>
          <p:nvPr>
            <p:ph type="ftr" sz="quarter" idx="11"/>
          </p:nvPr>
        </p:nvSpPr>
        <p:spPr/>
        <p:txBody>
          <a:bodyPr/>
          <a:lstStyle/>
          <a:p>
            <a:endParaRPr lang="en-GB"/>
          </a:p>
        </p:txBody>
      </p:sp>
      <p:sp>
        <p:nvSpPr>
          <p:cNvPr id="6" name="Marcador de número de diapositiva 5">
            <a:extLst>
              <a:ext uri="{FF2B5EF4-FFF2-40B4-BE49-F238E27FC236}">
                <a16:creationId xmlns:a16="http://schemas.microsoft.com/office/drawing/2014/main" id="{2DD26CF9-CE59-46B2-AE41-245B6F1267B0}"/>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2371019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854E0ED-954B-41B8-AF0A-CA007D4829A4}"/>
              </a:ext>
            </a:extLst>
          </p:cNvPr>
          <p:cNvSpPr>
            <a:spLocks noGrp="1"/>
          </p:cNvSpPr>
          <p:nvPr>
            <p:ph type="title"/>
          </p:nvPr>
        </p:nvSpPr>
        <p:spPr/>
        <p:txBody>
          <a:bodyPr/>
          <a:lstStyle/>
          <a:p>
            <a:r>
              <a:rPr lang="es-ES"/>
              <a:t>Haga clic para modificar el estilo de título del patrón</a:t>
            </a:r>
            <a:endParaRPr lang="en-GB"/>
          </a:p>
        </p:txBody>
      </p:sp>
      <p:sp>
        <p:nvSpPr>
          <p:cNvPr id="3" name="Marcador de contenido 2">
            <a:extLst>
              <a:ext uri="{FF2B5EF4-FFF2-40B4-BE49-F238E27FC236}">
                <a16:creationId xmlns:a16="http://schemas.microsoft.com/office/drawing/2014/main" id="{EB6DA002-0309-4688-99E7-13E0BC6C6617}"/>
              </a:ext>
            </a:extLst>
          </p:cNvPr>
          <p:cNvSpPr>
            <a:spLocks noGrp="1"/>
          </p:cNvSpPr>
          <p:nvPr>
            <p:ph sz="half" idx="1"/>
          </p:nvPr>
        </p:nvSpPr>
        <p:spPr>
          <a:xfrm>
            <a:off x="838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contenido 3">
            <a:extLst>
              <a:ext uri="{FF2B5EF4-FFF2-40B4-BE49-F238E27FC236}">
                <a16:creationId xmlns:a16="http://schemas.microsoft.com/office/drawing/2014/main" id="{0D3C48FD-F5DA-40B4-8369-725A0BA0C03F}"/>
              </a:ext>
            </a:extLst>
          </p:cNvPr>
          <p:cNvSpPr>
            <a:spLocks noGrp="1"/>
          </p:cNvSpPr>
          <p:nvPr>
            <p:ph sz="half" idx="2"/>
          </p:nvPr>
        </p:nvSpPr>
        <p:spPr>
          <a:xfrm>
            <a:off x="6172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5" name="Marcador de fecha 4">
            <a:extLst>
              <a:ext uri="{FF2B5EF4-FFF2-40B4-BE49-F238E27FC236}">
                <a16:creationId xmlns:a16="http://schemas.microsoft.com/office/drawing/2014/main" id="{B93A1722-C980-485C-92C7-D493D6D0BC7B}"/>
              </a:ext>
            </a:extLst>
          </p:cNvPr>
          <p:cNvSpPr>
            <a:spLocks noGrp="1"/>
          </p:cNvSpPr>
          <p:nvPr>
            <p:ph type="dt" sz="half" idx="10"/>
          </p:nvPr>
        </p:nvSpPr>
        <p:spPr/>
        <p:txBody>
          <a:bodyPr/>
          <a:lstStyle/>
          <a:p>
            <a:fld id="{F9B82664-F3F6-44EC-8251-C00D07FA8855}" type="datetime1">
              <a:rPr lang="en-GB" smtClean="0"/>
              <a:t>08/05/2019</a:t>
            </a:fld>
            <a:endParaRPr lang="en-GB"/>
          </a:p>
        </p:txBody>
      </p:sp>
      <p:sp>
        <p:nvSpPr>
          <p:cNvPr id="6" name="Marcador de pie de página 5">
            <a:extLst>
              <a:ext uri="{FF2B5EF4-FFF2-40B4-BE49-F238E27FC236}">
                <a16:creationId xmlns:a16="http://schemas.microsoft.com/office/drawing/2014/main" id="{01E01D5A-CCBF-437F-8EA0-AFAE8FAAA014}"/>
              </a:ext>
            </a:extLst>
          </p:cNvPr>
          <p:cNvSpPr>
            <a:spLocks noGrp="1"/>
          </p:cNvSpPr>
          <p:nvPr>
            <p:ph type="ftr" sz="quarter" idx="11"/>
          </p:nvPr>
        </p:nvSpPr>
        <p:spPr/>
        <p:txBody>
          <a:bodyPr/>
          <a:lstStyle/>
          <a:p>
            <a:endParaRPr lang="en-GB"/>
          </a:p>
        </p:txBody>
      </p:sp>
      <p:sp>
        <p:nvSpPr>
          <p:cNvPr id="7" name="Marcador de número de diapositiva 6">
            <a:extLst>
              <a:ext uri="{FF2B5EF4-FFF2-40B4-BE49-F238E27FC236}">
                <a16:creationId xmlns:a16="http://schemas.microsoft.com/office/drawing/2014/main" id="{2F3117AA-3783-48C7-8AF2-073005586747}"/>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22479944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2F95BB12-48B2-4A28-A743-F2F28CB6C2A2}"/>
              </a:ext>
            </a:extLst>
          </p:cNvPr>
          <p:cNvSpPr>
            <a:spLocks noGrp="1"/>
          </p:cNvSpPr>
          <p:nvPr>
            <p:ph type="title"/>
          </p:nvPr>
        </p:nvSpPr>
        <p:spPr>
          <a:xfrm>
            <a:off x="839788" y="365125"/>
            <a:ext cx="10515600" cy="1325563"/>
          </a:xfrm>
        </p:spPr>
        <p:txBody>
          <a:bodyPr/>
          <a:lstStyle/>
          <a:p>
            <a:r>
              <a:rPr lang="es-ES"/>
              <a:t>Haga clic para modificar el estilo de título del patrón</a:t>
            </a:r>
            <a:endParaRPr lang="en-GB"/>
          </a:p>
        </p:txBody>
      </p:sp>
      <p:sp>
        <p:nvSpPr>
          <p:cNvPr id="3" name="Marcador de texto 2">
            <a:extLst>
              <a:ext uri="{FF2B5EF4-FFF2-40B4-BE49-F238E27FC236}">
                <a16:creationId xmlns:a16="http://schemas.microsoft.com/office/drawing/2014/main" id="{CA9F5A89-3998-4641-846F-7779F248DFC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4" name="Marcador de contenido 3">
            <a:extLst>
              <a:ext uri="{FF2B5EF4-FFF2-40B4-BE49-F238E27FC236}">
                <a16:creationId xmlns:a16="http://schemas.microsoft.com/office/drawing/2014/main" id="{912B245C-C497-4AA2-8C97-899C3B34F1F5}"/>
              </a:ext>
            </a:extLst>
          </p:cNvPr>
          <p:cNvSpPr>
            <a:spLocks noGrp="1"/>
          </p:cNvSpPr>
          <p:nvPr>
            <p:ph sz="half" idx="2"/>
          </p:nvPr>
        </p:nvSpPr>
        <p:spPr>
          <a:xfrm>
            <a:off x="839788" y="2505075"/>
            <a:ext cx="5157787"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5" name="Marcador de texto 4">
            <a:extLst>
              <a:ext uri="{FF2B5EF4-FFF2-40B4-BE49-F238E27FC236}">
                <a16:creationId xmlns:a16="http://schemas.microsoft.com/office/drawing/2014/main" id="{060A8F88-B5A5-4F6A-A203-B4F68BEFE70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6" name="Marcador de contenido 5">
            <a:extLst>
              <a:ext uri="{FF2B5EF4-FFF2-40B4-BE49-F238E27FC236}">
                <a16:creationId xmlns:a16="http://schemas.microsoft.com/office/drawing/2014/main" id="{7DDB1E4A-3584-4803-A529-2F2E692C7434}"/>
              </a:ext>
            </a:extLst>
          </p:cNvPr>
          <p:cNvSpPr>
            <a:spLocks noGrp="1"/>
          </p:cNvSpPr>
          <p:nvPr>
            <p:ph sz="quarter" idx="4"/>
          </p:nvPr>
        </p:nvSpPr>
        <p:spPr>
          <a:xfrm>
            <a:off x="6172200" y="2505075"/>
            <a:ext cx="5183188"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7" name="Marcador de fecha 6">
            <a:extLst>
              <a:ext uri="{FF2B5EF4-FFF2-40B4-BE49-F238E27FC236}">
                <a16:creationId xmlns:a16="http://schemas.microsoft.com/office/drawing/2014/main" id="{E3903FC3-57EB-4822-99EE-69A1DB058B30}"/>
              </a:ext>
            </a:extLst>
          </p:cNvPr>
          <p:cNvSpPr>
            <a:spLocks noGrp="1"/>
          </p:cNvSpPr>
          <p:nvPr>
            <p:ph type="dt" sz="half" idx="10"/>
          </p:nvPr>
        </p:nvSpPr>
        <p:spPr/>
        <p:txBody>
          <a:bodyPr/>
          <a:lstStyle/>
          <a:p>
            <a:fld id="{F8031A0A-C979-486F-AF24-9097B552293C}" type="datetime1">
              <a:rPr lang="en-GB" smtClean="0"/>
              <a:t>08/05/2019</a:t>
            </a:fld>
            <a:endParaRPr lang="en-GB"/>
          </a:p>
        </p:txBody>
      </p:sp>
      <p:sp>
        <p:nvSpPr>
          <p:cNvPr id="8" name="Marcador de pie de página 7">
            <a:extLst>
              <a:ext uri="{FF2B5EF4-FFF2-40B4-BE49-F238E27FC236}">
                <a16:creationId xmlns:a16="http://schemas.microsoft.com/office/drawing/2014/main" id="{1176E117-09F0-4165-97F8-35BDC711FDC9}"/>
              </a:ext>
            </a:extLst>
          </p:cNvPr>
          <p:cNvSpPr>
            <a:spLocks noGrp="1"/>
          </p:cNvSpPr>
          <p:nvPr>
            <p:ph type="ftr" sz="quarter" idx="11"/>
          </p:nvPr>
        </p:nvSpPr>
        <p:spPr/>
        <p:txBody>
          <a:bodyPr/>
          <a:lstStyle/>
          <a:p>
            <a:endParaRPr lang="en-GB"/>
          </a:p>
        </p:txBody>
      </p:sp>
      <p:sp>
        <p:nvSpPr>
          <p:cNvPr id="9" name="Marcador de número de diapositiva 8">
            <a:extLst>
              <a:ext uri="{FF2B5EF4-FFF2-40B4-BE49-F238E27FC236}">
                <a16:creationId xmlns:a16="http://schemas.microsoft.com/office/drawing/2014/main" id="{249A5A22-79EA-4AFD-8F78-9475FBFFE9ED}"/>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18939910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ABB4FCCF-6F55-4525-A8BF-D610D2A4FEA0}"/>
              </a:ext>
            </a:extLst>
          </p:cNvPr>
          <p:cNvSpPr>
            <a:spLocks noGrp="1"/>
          </p:cNvSpPr>
          <p:nvPr>
            <p:ph type="title"/>
          </p:nvPr>
        </p:nvSpPr>
        <p:spPr/>
        <p:txBody>
          <a:bodyPr/>
          <a:lstStyle/>
          <a:p>
            <a:r>
              <a:rPr lang="es-ES"/>
              <a:t>Haga clic para modificar el estilo de título del patrón</a:t>
            </a:r>
            <a:endParaRPr lang="en-GB"/>
          </a:p>
        </p:txBody>
      </p:sp>
      <p:sp>
        <p:nvSpPr>
          <p:cNvPr id="3" name="Marcador de fecha 2">
            <a:extLst>
              <a:ext uri="{FF2B5EF4-FFF2-40B4-BE49-F238E27FC236}">
                <a16:creationId xmlns:a16="http://schemas.microsoft.com/office/drawing/2014/main" id="{DCA54B41-33BC-430E-B1C8-887EF5DD76F0}"/>
              </a:ext>
            </a:extLst>
          </p:cNvPr>
          <p:cNvSpPr>
            <a:spLocks noGrp="1"/>
          </p:cNvSpPr>
          <p:nvPr>
            <p:ph type="dt" sz="half" idx="10"/>
          </p:nvPr>
        </p:nvSpPr>
        <p:spPr/>
        <p:txBody>
          <a:bodyPr/>
          <a:lstStyle/>
          <a:p>
            <a:fld id="{8C5B61BB-2568-44A3-8135-3DB8CDA23F25}" type="datetime1">
              <a:rPr lang="en-GB" smtClean="0"/>
              <a:t>08/05/2019</a:t>
            </a:fld>
            <a:endParaRPr lang="en-GB"/>
          </a:p>
        </p:txBody>
      </p:sp>
      <p:sp>
        <p:nvSpPr>
          <p:cNvPr id="4" name="Marcador de pie de página 3">
            <a:extLst>
              <a:ext uri="{FF2B5EF4-FFF2-40B4-BE49-F238E27FC236}">
                <a16:creationId xmlns:a16="http://schemas.microsoft.com/office/drawing/2014/main" id="{1B7B3923-D968-467B-898B-A9DFC9169823}"/>
              </a:ext>
            </a:extLst>
          </p:cNvPr>
          <p:cNvSpPr>
            <a:spLocks noGrp="1"/>
          </p:cNvSpPr>
          <p:nvPr>
            <p:ph type="ftr" sz="quarter" idx="11"/>
          </p:nvPr>
        </p:nvSpPr>
        <p:spPr/>
        <p:txBody>
          <a:bodyPr/>
          <a:lstStyle/>
          <a:p>
            <a:endParaRPr lang="en-GB"/>
          </a:p>
        </p:txBody>
      </p:sp>
      <p:sp>
        <p:nvSpPr>
          <p:cNvPr id="5" name="Marcador de número de diapositiva 4">
            <a:extLst>
              <a:ext uri="{FF2B5EF4-FFF2-40B4-BE49-F238E27FC236}">
                <a16:creationId xmlns:a16="http://schemas.microsoft.com/office/drawing/2014/main" id="{A1492792-FCA4-4488-B9F7-27FE97A772CD}"/>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37246395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C31F11D0-353F-4B46-A02B-6D37682BEF6A}"/>
              </a:ext>
            </a:extLst>
          </p:cNvPr>
          <p:cNvSpPr>
            <a:spLocks noGrp="1"/>
          </p:cNvSpPr>
          <p:nvPr>
            <p:ph type="dt" sz="half" idx="10"/>
          </p:nvPr>
        </p:nvSpPr>
        <p:spPr/>
        <p:txBody>
          <a:bodyPr/>
          <a:lstStyle/>
          <a:p>
            <a:fld id="{0C7708F0-45D8-4F3C-8AD4-9CF704F28C39}" type="datetime1">
              <a:rPr lang="en-GB" smtClean="0"/>
              <a:t>08/05/2019</a:t>
            </a:fld>
            <a:endParaRPr lang="en-GB"/>
          </a:p>
        </p:txBody>
      </p:sp>
      <p:sp>
        <p:nvSpPr>
          <p:cNvPr id="3" name="Marcador de pie de página 2">
            <a:extLst>
              <a:ext uri="{FF2B5EF4-FFF2-40B4-BE49-F238E27FC236}">
                <a16:creationId xmlns:a16="http://schemas.microsoft.com/office/drawing/2014/main" id="{90907240-EB3C-4050-A825-CC439EA0DB48}"/>
              </a:ext>
            </a:extLst>
          </p:cNvPr>
          <p:cNvSpPr>
            <a:spLocks noGrp="1"/>
          </p:cNvSpPr>
          <p:nvPr>
            <p:ph type="ftr" sz="quarter" idx="11"/>
          </p:nvPr>
        </p:nvSpPr>
        <p:spPr/>
        <p:txBody>
          <a:bodyPr/>
          <a:lstStyle/>
          <a:p>
            <a:endParaRPr lang="en-GB"/>
          </a:p>
        </p:txBody>
      </p:sp>
      <p:sp>
        <p:nvSpPr>
          <p:cNvPr id="4" name="Marcador de número de diapositiva 3">
            <a:extLst>
              <a:ext uri="{FF2B5EF4-FFF2-40B4-BE49-F238E27FC236}">
                <a16:creationId xmlns:a16="http://schemas.microsoft.com/office/drawing/2014/main" id="{AAD96C2B-3F47-441B-B975-1189B2D73708}"/>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27147252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AA12DF5A-C621-40A7-AEAF-77D7E9C89DB7}"/>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n-GB"/>
          </a:p>
        </p:txBody>
      </p:sp>
      <p:sp>
        <p:nvSpPr>
          <p:cNvPr id="3" name="Marcador de contenido 2">
            <a:extLst>
              <a:ext uri="{FF2B5EF4-FFF2-40B4-BE49-F238E27FC236}">
                <a16:creationId xmlns:a16="http://schemas.microsoft.com/office/drawing/2014/main" id="{CB90FEC4-256F-4F5C-B777-8F207A4567C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texto 3">
            <a:extLst>
              <a:ext uri="{FF2B5EF4-FFF2-40B4-BE49-F238E27FC236}">
                <a16:creationId xmlns:a16="http://schemas.microsoft.com/office/drawing/2014/main" id="{E4946583-B01A-4084-B7D8-E53E26E8187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54018B04-FE85-442D-82C6-ACDB1FD4EE2A}"/>
              </a:ext>
            </a:extLst>
          </p:cNvPr>
          <p:cNvSpPr>
            <a:spLocks noGrp="1"/>
          </p:cNvSpPr>
          <p:nvPr>
            <p:ph type="dt" sz="half" idx="10"/>
          </p:nvPr>
        </p:nvSpPr>
        <p:spPr/>
        <p:txBody>
          <a:bodyPr/>
          <a:lstStyle/>
          <a:p>
            <a:fld id="{D1913E67-B83A-437B-90A9-4C7D5C1ECA06}" type="datetime1">
              <a:rPr lang="en-GB" smtClean="0"/>
              <a:t>08/05/2019</a:t>
            </a:fld>
            <a:endParaRPr lang="en-GB"/>
          </a:p>
        </p:txBody>
      </p:sp>
      <p:sp>
        <p:nvSpPr>
          <p:cNvPr id="6" name="Marcador de pie de página 5">
            <a:extLst>
              <a:ext uri="{FF2B5EF4-FFF2-40B4-BE49-F238E27FC236}">
                <a16:creationId xmlns:a16="http://schemas.microsoft.com/office/drawing/2014/main" id="{3A810B56-E0B6-420B-9ED5-5AEB49EFDF21}"/>
              </a:ext>
            </a:extLst>
          </p:cNvPr>
          <p:cNvSpPr>
            <a:spLocks noGrp="1"/>
          </p:cNvSpPr>
          <p:nvPr>
            <p:ph type="ftr" sz="quarter" idx="11"/>
          </p:nvPr>
        </p:nvSpPr>
        <p:spPr/>
        <p:txBody>
          <a:bodyPr/>
          <a:lstStyle/>
          <a:p>
            <a:endParaRPr lang="en-GB"/>
          </a:p>
        </p:txBody>
      </p:sp>
      <p:sp>
        <p:nvSpPr>
          <p:cNvPr id="7" name="Marcador de número de diapositiva 6">
            <a:extLst>
              <a:ext uri="{FF2B5EF4-FFF2-40B4-BE49-F238E27FC236}">
                <a16:creationId xmlns:a16="http://schemas.microsoft.com/office/drawing/2014/main" id="{498782FC-8BC3-47FC-8ACB-FC66787F152C}"/>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39012706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184F9EA-5406-47A5-9257-203242A1B6B1}"/>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n-GB"/>
          </a:p>
        </p:txBody>
      </p:sp>
      <p:sp>
        <p:nvSpPr>
          <p:cNvPr id="3" name="Marcador de posición de imagen 2">
            <a:extLst>
              <a:ext uri="{FF2B5EF4-FFF2-40B4-BE49-F238E27FC236}">
                <a16:creationId xmlns:a16="http://schemas.microsoft.com/office/drawing/2014/main" id="{44BDF645-06EE-4AB2-B068-04C05F25FFC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Marcador de texto 3">
            <a:extLst>
              <a:ext uri="{FF2B5EF4-FFF2-40B4-BE49-F238E27FC236}">
                <a16:creationId xmlns:a16="http://schemas.microsoft.com/office/drawing/2014/main" id="{C55EB4C1-C072-48B9-8473-9A56A349204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4E56E86D-E9F2-44AF-850D-89714E5F2259}"/>
              </a:ext>
            </a:extLst>
          </p:cNvPr>
          <p:cNvSpPr>
            <a:spLocks noGrp="1"/>
          </p:cNvSpPr>
          <p:nvPr>
            <p:ph type="dt" sz="half" idx="10"/>
          </p:nvPr>
        </p:nvSpPr>
        <p:spPr/>
        <p:txBody>
          <a:bodyPr/>
          <a:lstStyle/>
          <a:p>
            <a:fld id="{97CFB3BF-5400-4ACD-8199-A2D84FAAA4DE}" type="datetime1">
              <a:rPr lang="en-GB" smtClean="0"/>
              <a:t>08/05/2019</a:t>
            </a:fld>
            <a:endParaRPr lang="en-GB"/>
          </a:p>
        </p:txBody>
      </p:sp>
      <p:sp>
        <p:nvSpPr>
          <p:cNvPr id="6" name="Marcador de pie de página 5">
            <a:extLst>
              <a:ext uri="{FF2B5EF4-FFF2-40B4-BE49-F238E27FC236}">
                <a16:creationId xmlns:a16="http://schemas.microsoft.com/office/drawing/2014/main" id="{EA3C24A7-C533-4A8E-B1E6-55E9A8427ACD}"/>
              </a:ext>
            </a:extLst>
          </p:cNvPr>
          <p:cNvSpPr>
            <a:spLocks noGrp="1"/>
          </p:cNvSpPr>
          <p:nvPr>
            <p:ph type="ftr" sz="quarter" idx="11"/>
          </p:nvPr>
        </p:nvSpPr>
        <p:spPr/>
        <p:txBody>
          <a:bodyPr/>
          <a:lstStyle/>
          <a:p>
            <a:endParaRPr lang="en-GB"/>
          </a:p>
        </p:txBody>
      </p:sp>
      <p:sp>
        <p:nvSpPr>
          <p:cNvPr id="7" name="Marcador de número de diapositiva 6">
            <a:extLst>
              <a:ext uri="{FF2B5EF4-FFF2-40B4-BE49-F238E27FC236}">
                <a16:creationId xmlns:a16="http://schemas.microsoft.com/office/drawing/2014/main" id="{6947F3EF-2A33-4E33-BBFB-323E6A0AAC6D}"/>
              </a:ext>
            </a:extLst>
          </p:cNvPr>
          <p:cNvSpPr>
            <a:spLocks noGrp="1"/>
          </p:cNvSpPr>
          <p:nvPr>
            <p:ph type="sldNum" sz="quarter" idx="12"/>
          </p:nvPr>
        </p:nvSpPr>
        <p:spPr/>
        <p:txBody>
          <a:bodyPr/>
          <a:lstStyle/>
          <a:p>
            <a:fld id="{192579BF-C6FD-43AD-A8B9-573B46B983AA}" type="slidenum">
              <a:rPr lang="en-GB" smtClean="0"/>
              <a:t>‹Nº›</a:t>
            </a:fld>
            <a:endParaRPr lang="en-GB"/>
          </a:p>
        </p:txBody>
      </p:sp>
    </p:spTree>
    <p:extLst>
      <p:ext uri="{BB962C8B-B14F-4D97-AF65-F5344CB8AC3E}">
        <p14:creationId xmlns:p14="http://schemas.microsoft.com/office/powerpoint/2010/main" val="6324621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BBEA3FC7-084B-4917-826C-48BD041A2E0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n-GB"/>
          </a:p>
        </p:txBody>
      </p:sp>
      <p:sp>
        <p:nvSpPr>
          <p:cNvPr id="3" name="Marcador de texto 2">
            <a:extLst>
              <a:ext uri="{FF2B5EF4-FFF2-40B4-BE49-F238E27FC236}">
                <a16:creationId xmlns:a16="http://schemas.microsoft.com/office/drawing/2014/main" id="{B0E95AD2-171E-413B-BE02-AFF7547A421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4" name="Marcador de fecha 3">
            <a:extLst>
              <a:ext uri="{FF2B5EF4-FFF2-40B4-BE49-F238E27FC236}">
                <a16:creationId xmlns:a16="http://schemas.microsoft.com/office/drawing/2014/main" id="{52C7BAD7-37BC-4BDE-915A-D4D8A903FDD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A734366-5E73-46C7-ABFC-C14653397C18}" type="datetime1">
              <a:rPr lang="en-GB" smtClean="0"/>
              <a:t>08/05/2019</a:t>
            </a:fld>
            <a:endParaRPr lang="en-GB"/>
          </a:p>
        </p:txBody>
      </p:sp>
      <p:sp>
        <p:nvSpPr>
          <p:cNvPr id="5" name="Marcador de pie de página 4">
            <a:extLst>
              <a:ext uri="{FF2B5EF4-FFF2-40B4-BE49-F238E27FC236}">
                <a16:creationId xmlns:a16="http://schemas.microsoft.com/office/drawing/2014/main" id="{8C71B302-6188-4EAA-8F8F-FDFEDD7563E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Marcador de número de diapositiva 5">
            <a:extLst>
              <a:ext uri="{FF2B5EF4-FFF2-40B4-BE49-F238E27FC236}">
                <a16:creationId xmlns:a16="http://schemas.microsoft.com/office/drawing/2014/main" id="{C67CAB49-DE5F-4810-B839-0392AC7B459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92579BF-C6FD-43AD-A8B9-573B46B983AA}" type="slidenum">
              <a:rPr lang="en-GB" smtClean="0"/>
              <a:t>‹Nº›</a:t>
            </a:fld>
            <a:endParaRPr lang="en-GB"/>
          </a:p>
        </p:txBody>
      </p:sp>
    </p:spTree>
    <p:extLst>
      <p:ext uri="{BB962C8B-B14F-4D97-AF65-F5344CB8AC3E}">
        <p14:creationId xmlns:p14="http://schemas.microsoft.com/office/powerpoint/2010/main" val="5333943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3" Type="http://schemas.openxmlformats.org/officeDocument/2006/relationships/image" Target="../media/image2.png"/><Relationship Id="rId7" Type="http://schemas.openxmlformats.org/officeDocument/2006/relationships/image" Target="../media/image4.png"/><Relationship Id="rId2" Type="http://schemas.openxmlformats.org/officeDocument/2006/relationships/image" Target="../media/image1.png"/><Relationship Id="rId1" Type="http://schemas.openxmlformats.org/officeDocument/2006/relationships/slideLayout" Target="../slideLayouts/slideLayout2.xml"/><Relationship Id="rId6" Type="http://schemas.microsoft.com/office/2007/relationships/hdphoto" Target="../media/hdphoto2.wdp"/><Relationship Id="rId5" Type="http://schemas.openxmlformats.org/officeDocument/2006/relationships/image" Target="../media/image3.png"/><Relationship Id="rId4" Type="http://schemas.microsoft.com/office/2007/relationships/hdphoto" Target="../media/hdphoto1.wdp"/></Relationships>
</file>

<file path=ppt/slides/_rels/slide10.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3.jpe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15.jpe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16.jpe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image" Target="../media/image17.jpeg"/><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image" Target="../media/image18.jpeg"/><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image" Target="../media/image19.jpeg"/><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21.jpeg"/><Relationship Id="rId2" Type="http://schemas.openxmlformats.org/officeDocument/2006/relationships/image" Target="../media/image20.jpeg"/><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3" Type="http://schemas.openxmlformats.org/officeDocument/2006/relationships/image" Target="../media/image23.jpeg"/><Relationship Id="rId2" Type="http://schemas.openxmlformats.org/officeDocument/2006/relationships/image" Target="../media/image22.jpeg"/><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image" Target="../media/image24.jpeg"/><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image" Target="../media/image25.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image" Target="../media/image26.jpeg"/><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image" Target="../media/image27.jpeg"/><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image" Target="../media/image28.jpeg"/><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image" Target="../media/image29.jpeg"/><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image" Target="../media/image30.jpeg"/><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image" Target="../media/image31.jpeg"/><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image" Target="../media/image32.jpeg"/><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image" Target="../media/image33.jpeg"/><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image" Target="../media/image34.jpeg"/><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2" Type="http://schemas.openxmlformats.org/officeDocument/2006/relationships/image" Target="../media/image35.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2" Type="http://schemas.openxmlformats.org/officeDocument/2006/relationships/image" Target="../media/image36.jpeg"/><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2" Type="http://schemas.openxmlformats.org/officeDocument/2006/relationships/image" Target="../media/image37.jpeg"/><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2" Type="http://schemas.openxmlformats.org/officeDocument/2006/relationships/image" Target="../media/image38.jpeg"/><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image" Target="../media/image39.jpeg"/><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2" Type="http://schemas.openxmlformats.org/officeDocument/2006/relationships/image" Target="../media/image40.jpeg"/><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3" Type="http://schemas.openxmlformats.org/officeDocument/2006/relationships/image" Target="../media/image42.jpeg"/><Relationship Id="rId2" Type="http://schemas.openxmlformats.org/officeDocument/2006/relationships/image" Target="../media/image41.jpeg"/><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2" Type="http://schemas.openxmlformats.org/officeDocument/2006/relationships/image" Target="../media/image43.jpeg"/><Relationship Id="rId1" Type="http://schemas.openxmlformats.org/officeDocument/2006/relationships/slideLayout" Target="../slideLayouts/slideLayout1.xml"/></Relationships>
</file>

<file path=ppt/slides/_rels/slide37.xml.rels><?xml version="1.0" encoding="UTF-8" standalone="yes"?>
<Relationships xmlns="http://schemas.openxmlformats.org/package/2006/relationships"><Relationship Id="rId2" Type="http://schemas.openxmlformats.org/officeDocument/2006/relationships/image" Target="../media/image44.jpeg"/><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image" Target="../media/image45.jpeg"/><Relationship Id="rId1" Type="http://schemas.openxmlformats.org/officeDocument/2006/relationships/slideLayout" Target="../slideLayouts/slideLayout1.xml"/><Relationship Id="rId4" Type="http://schemas.microsoft.com/office/2007/relationships/hdphoto" Target="../media/hdphoto4.wdp"/></Relationships>
</file>

<file path=ppt/slides/_rels/slide39.xml.rels><?xml version="1.0" encoding="UTF-8" standalone="yes"?>
<Relationships xmlns="http://schemas.openxmlformats.org/package/2006/relationships"><Relationship Id="rId2" Type="http://schemas.openxmlformats.org/officeDocument/2006/relationships/image" Target="../media/image47.jpe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2" Type="http://schemas.openxmlformats.org/officeDocument/2006/relationships/image" Target="../media/image48.jpeg"/><Relationship Id="rId1" Type="http://schemas.openxmlformats.org/officeDocument/2006/relationships/slideLayout" Target="../slideLayouts/slideLayout1.xml"/></Relationships>
</file>

<file path=ppt/slides/_rels/slide41.xml.rels><?xml version="1.0" encoding="UTF-8" standalone="yes"?>
<Relationships xmlns="http://schemas.openxmlformats.org/package/2006/relationships"><Relationship Id="rId2" Type="http://schemas.openxmlformats.org/officeDocument/2006/relationships/image" Target="../media/image49.jpeg"/><Relationship Id="rId1" Type="http://schemas.openxmlformats.org/officeDocument/2006/relationships/slideLayout" Target="../slideLayouts/slideLayout1.xml"/></Relationships>
</file>

<file path=ppt/slides/_rels/slide42.xml.rels><?xml version="1.0" encoding="UTF-8" standalone="yes"?>
<Relationships xmlns="http://schemas.openxmlformats.org/package/2006/relationships"><Relationship Id="rId2" Type="http://schemas.openxmlformats.org/officeDocument/2006/relationships/image" Target="../media/image50.jpeg"/><Relationship Id="rId1" Type="http://schemas.openxmlformats.org/officeDocument/2006/relationships/slideLayout" Target="../slideLayouts/slideLayout1.xml"/></Relationships>
</file>

<file path=ppt/slides/_rels/slide43.xml.rels><?xml version="1.0" encoding="UTF-8" standalone="yes"?>
<Relationships xmlns="http://schemas.openxmlformats.org/package/2006/relationships"><Relationship Id="rId3" Type="http://schemas.openxmlformats.org/officeDocument/2006/relationships/image" Target="../media/image52.jpeg"/><Relationship Id="rId2" Type="http://schemas.openxmlformats.org/officeDocument/2006/relationships/image" Target="../media/image51.jpeg"/><Relationship Id="rId1" Type="http://schemas.openxmlformats.org/officeDocument/2006/relationships/slideLayout" Target="../slideLayouts/slideLayout1.xml"/></Relationships>
</file>

<file path=ppt/slides/_rels/slide44.xml.rels><?xml version="1.0" encoding="UTF-8" standalone="yes"?>
<Relationships xmlns="http://schemas.openxmlformats.org/package/2006/relationships"><Relationship Id="rId2" Type="http://schemas.openxmlformats.org/officeDocument/2006/relationships/image" Target="../media/image53.jpeg"/><Relationship Id="rId1" Type="http://schemas.openxmlformats.org/officeDocument/2006/relationships/slideLayout" Target="../slideLayouts/slideLayout1.xml"/></Relationships>
</file>

<file path=ppt/slides/_rels/slide45.xml.rels><?xml version="1.0" encoding="UTF-8" standalone="yes"?>
<Relationships xmlns="http://schemas.openxmlformats.org/package/2006/relationships"><Relationship Id="rId2" Type="http://schemas.openxmlformats.org/officeDocument/2006/relationships/image" Target="../media/image54.jpeg"/><Relationship Id="rId1" Type="http://schemas.openxmlformats.org/officeDocument/2006/relationships/slideLayout" Target="../slideLayouts/slideLayout1.xml"/></Relationships>
</file>

<file path=ppt/slides/_rels/slide46.xml.rels><?xml version="1.0" encoding="UTF-8" standalone="yes"?>
<Relationships xmlns="http://schemas.openxmlformats.org/package/2006/relationships"><Relationship Id="rId3" Type="http://schemas.openxmlformats.org/officeDocument/2006/relationships/image" Target="../media/image56.jpeg"/><Relationship Id="rId2" Type="http://schemas.openxmlformats.org/officeDocument/2006/relationships/image" Target="../media/image55.jpeg"/><Relationship Id="rId1" Type="http://schemas.openxmlformats.org/officeDocument/2006/relationships/slideLayout" Target="../slideLayouts/slideLayout1.xml"/></Relationships>
</file>

<file path=ppt/slides/_rels/slide47.xml.rels><?xml version="1.0" encoding="UTF-8" standalone="yes"?>
<Relationships xmlns="http://schemas.openxmlformats.org/package/2006/relationships"><Relationship Id="rId3" Type="http://schemas.openxmlformats.org/officeDocument/2006/relationships/image" Target="../media/image58.jpeg"/><Relationship Id="rId2" Type="http://schemas.openxmlformats.org/officeDocument/2006/relationships/image" Target="../media/image57.jpe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3">
            <a:extLst>
              <a:ext uri="{FF2B5EF4-FFF2-40B4-BE49-F238E27FC236}">
                <a16:creationId xmlns:a16="http://schemas.microsoft.com/office/drawing/2014/main" id="{EACDDA15-11A0-45AC-9EAB-7A1D35FAF964}"/>
              </a:ext>
            </a:extLst>
          </p:cNvPr>
          <p:cNvSpPr txBox="1"/>
          <p:nvPr/>
        </p:nvSpPr>
        <p:spPr>
          <a:xfrm>
            <a:off x="0" y="-4226"/>
            <a:ext cx="4985147" cy="338554"/>
          </a:xfrm>
          <a:prstGeom prst="rect">
            <a:avLst/>
          </a:prstGeom>
          <a:noFill/>
        </p:spPr>
        <p:txBody>
          <a:bodyPr wrap="none" rtlCol="0">
            <a:spAutoFit/>
          </a:bodyPr>
          <a:lstStyle/>
          <a:p>
            <a:r>
              <a:rPr lang="en-GB" sz="1600" b="1" dirty="0">
                <a:latin typeface="+mj-lt"/>
              </a:rPr>
              <a:t>Supporting Information 1 – General views of Cova Foradada</a:t>
            </a:r>
          </a:p>
        </p:txBody>
      </p:sp>
      <p:sp>
        <p:nvSpPr>
          <p:cNvPr id="14" name="CuadroTexto 13">
            <a:extLst>
              <a:ext uri="{FF2B5EF4-FFF2-40B4-BE49-F238E27FC236}">
                <a16:creationId xmlns:a16="http://schemas.microsoft.com/office/drawing/2014/main" id="{0DF261E0-794C-4AE7-BB9C-8066C249C6DF}"/>
              </a:ext>
            </a:extLst>
          </p:cNvPr>
          <p:cNvSpPr txBox="1"/>
          <p:nvPr/>
        </p:nvSpPr>
        <p:spPr>
          <a:xfrm>
            <a:off x="287020" y="440538"/>
            <a:ext cx="679994" cy="369332"/>
          </a:xfrm>
          <a:prstGeom prst="rect">
            <a:avLst/>
          </a:prstGeom>
          <a:noFill/>
        </p:spPr>
        <p:txBody>
          <a:bodyPr wrap="none" rtlCol="0">
            <a:spAutoFit/>
          </a:bodyPr>
          <a:lstStyle/>
          <a:p>
            <a:r>
              <a:rPr lang="en-GB" b="1" dirty="0">
                <a:latin typeface="+mj-lt"/>
              </a:rPr>
              <a:t>Fig. A</a:t>
            </a:r>
          </a:p>
        </p:txBody>
      </p:sp>
      <p:sp>
        <p:nvSpPr>
          <p:cNvPr id="15" name="CuadroTexto 14">
            <a:extLst>
              <a:ext uri="{FF2B5EF4-FFF2-40B4-BE49-F238E27FC236}">
                <a16:creationId xmlns:a16="http://schemas.microsoft.com/office/drawing/2014/main" id="{29C98754-07CF-4ACF-BF80-C7FCA21BE0C8}"/>
              </a:ext>
            </a:extLst>
          </p:cNvPr>
          <p:cNvSpPr txBox="1"/>
          <p:nvPr/>
        </p:nvSpPr>
        <p:spPr>
          <a:xfrm>
            <a:off x="287019" y="889529"/>
            <a:ext cx="6021183" cy="523220"/>
          </a:xfrm>
          <a:prstGeom prst="rect">
            <a:avLst/>
          </a:prstGeom>
          <a:noFill/>
        </p:spPr>
        <p:txBody>
          <a:bodyPr wrap="square" rtlCol="0">
            <a:spAutoFit/>
          </a:bodyPr>
          <a:lstStyle/>
          <a:p>
            <a:pPr algn="just"/>
            <a:r>
              <a:rPr lang="en-GB" sz="1400" dirty="0"/>
              <a:t>3D model of Cova Foradada volume. Top (</a:t>
            </a:r>
            <a:r>
              <a:rPr lang="en-GB" sz="1400" b="1" dirty="0"/>
              <a:t>a</a:t>
            </a:r>
            <a:r>
              <a:rPr lang="en-GB" sz="1400" dirty="0"/>
              <a:t>), frontal (</a:t>
            </a:r>
            <a:r>
              <a:rPr lang="en-GB" sz="1400" b="1" dirty="0"/>
              <a:t>b</a:t>
            </a:r>
            <a:r>
              <a:rPr lang="en-GB" sz="1400" dirty="0"/>
              <a:t>) and  back (</a:t>
            </a:r>
            <a:r>
              <a:rPr lang="en-GB" sz="1400" b="1" dirty="0"/>
              <a:t>c</a:t>
            </a:r>
            <a:r>
              <a:rPr lang="en-GB" sz="1400" dirty="0"/>
              <a:t>) views view with relative height colour scale, ranging from red (highest) to blue (lowest)</a:t>
            </a:r>
          </a:p>
        </p:txBody>
      </p:sp>
      <p:pic>
        <p:nvPicPr>
          <p:cNvPr id="17" name="Imagen 16">
            <a:extLst>
              <a:ext uri="{FF2B5EF4-FFF2-40B4-BE49-F238E27FC236}">
                <a16:creationId xmlns:a16="http://schemas.microsoft.com/office/drawing/2014/main" id="{D1AF0400-C91D-4322-8DA1-E3F3A2C24E7B}"/>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a:off x="10855146" y="1234763"/>
            <a:ext cx="1243357" cy="4104000"/>
          </a:xfrm>
          <a:prstGeom prst="rect">
            <a:avLst/>
          </a:prstGeom>
        </p:spPr>
      </p:pic>
      <p:sp>
        <p:nvSpPr>
          <p:cNvPr id="18" name="CuadroTexto 17">
            <a:extLst>
              <a:ext uri="{FF2B5EF4-FFF2-40B4-BE49-F238E27FC236}">
                <a16:creationId xmlns:a16="http://schemas.microsoft.com/office/drawing/2014/main" id="{4A7EA8E4-FD56-4E2D-98A0-80BC59259C9E}"/>
              </a:ext>
            </a:extLst>
          </p:cNvPr>
          <p:cNvSpPr txBox="1"/>
          <p:nvPr/>
        </p:nvSpPr>
        <p:spPr>
          <a:xfrm>
            <a:off x="319238" y="1692869"/>
            <a:ext cx="365806" cy="369332"/>
          </a:xfrm>
          <a:prstGeom prst="rect">
            <a:avLst/>
          </a:prstGeom>
          <a:noFill/>
        </p:spPr>
        <p:txBody>
          <a:bodyPr wrap="none" rtlCol="0">
            <a:spAutoFit/>
          </a:bodyPr>
          <a:lstStyle/>
          <a:p>
            <a:r>
              <a:rPr lang="en-GB" b="1" dirty="0">
                <a:latin typeface="+mj-lt"/>
              </a:rPr>
              <a:t>a)</a:t>
            </a:r>
          </a:p>
        </p:txBody>
      </p:sp>
      <p:sp>
        <p:nvSpPr>
          <p:cNvPr id="19" name="CuadroTexto 18">
            <a:extLst>
              <a:ext uri="{FF2B5EF4-FFF2-40B4-BE49-F238E27FC236}">
                <a16:creationId xmlns:a16="http://schemas.microsoft.com/office/drawing/2014/main" id="{B3DBB1B1-1681-4DCB-A0AA-10177D14B1A1}"/>
              </a:ext>
            </a:extLst>
          </p:cNvPr>
          <p:cNvSpPr txBox="1"/>
          <p:nvPr/>
        </p:nvSpPr>
        <p:spPr>
          <a:xfrm>
            <a:off x="5163820" y="1640634"/>
            <a:ext cx="377026" cy="369332"/>
          </a:xfrm>
          <a:prstGeom prst="rect">
            <a:avLst/>
          </a:prstGeom>
          <a:noFill/>
        </p:spPr>
        <p:txBody>
          <a:bodyPr wrap="none" rtlCol="0">
            <a:spAutoFit/>
          </a:bodyPr>
          <a:lstStyle/>
          <a:p>
            <a:r>
              <a:rPr lang="en-GB" b="1" dirty="0">
                <a:latin typeface="+mj-lt"/>
              </a:rPr>
              <a:t>b)</a:t>
            </a:r>
          </a:p>
        </p:txBody>
      </p:sp>
      <p:sp>
        <p:nvSpPr>
          <p:cNvPr id="20" name="CuadroTexto 19">
            <a:extLst>
              <a:ext uri="{FF2B5EF4-FFF2-40B4-BE49-F238E27FC236}">
                <a16:creationId xmlns:a16="http://schemas.microsoft.com/office/drawing/2014/main" id="{A55E6644-1163-4AAD-A8D3-3470AA954EE1}"/>
              </a:ext>
            </a:extLst>
          </p:cNvPr>
          <p:cNvSpPr txBox="1"/>
          <p:nvPr/>
        </p:nvSpPr>
        <p:spPr>
          <a:xfrm>
            <a:off x="5163820" y="3746773"/>
            <a:ext cx="352982" cy="369332"/>
          </a:xfrm>
          <a:prstGeom prst="rect">
            <a:avLst/>
          </a:prstGeom>
          <a:noFill/>
        </p:spPr>
        <p:txBody>
          <a:bodyPr wrap="none" rtlCol="0">
            <a:spAutoFit/>
          </a:bodyPr>
          <a:lstStyle/>
          <a:p>
            <a:r>
              <a:rPr lang="en-GB" b="1" dirty="0">
                <a:latin typeface="+mj-lt"/>
              </a:rPr>
              <a:t>c)</a:t>
            </a:r>
          </a:p>
        </p:txBody>
      </p:sp>
      <p:sp>
        <p:nvSpPr>
          <p:cNvPr id="2" name="Marcador de número de diapositiva 1">
            <a:extLst>
              <a:ext uri="{FF2B5EF4-FFF2-40B4-BE49-F238E27FC236}">
                <a16:creationId xmlns:a16="http://schemas.microsoft.com/office/drawing/2014/main" id="{78F800C9-359C-4A2E-BF7F-839156C09CEE}"/>
              </a:ext>
            </a:extLst>
          </p:cNvPr>
          <p:cNvSpPr>
            <a:spLocks noGrp="1"/>
          </p:cNvSpPr>
          <p:nvPr>
            <p:ph type="sldNum" sz="quarter" idx="12"/>
          </p:nvPr>
        </p:nvSpPr>
        <p:spPr>
          <a:xfrm>
            <a:off x="11696697" y="6371729"/>
            <a:ext cx="315806" cy="365125"/>
          </a:xfrm>
        </p:spPr>
        <p:txBody>
          <a:bodyPr/>
          <a:lstStyle/>
          <a:p>
            <a:fld id="{192579BF-C6FD-43AD-A8B9-573B46B983AA}" type="slidenum">
              <a:rPr lang="en-GB" sz="1800" smtClean="0">
                <a:latin typeface="+mj-lt"/>
              </a:rPr>
              <a:t>1</a:t>
            </a:fld>
            <a:endParaRPr lang="en-GB" sz="1800" dirty="0">
              <a:latin typeface="+mj-lt"/>
            </a:endParaRPr>
          </a:p>
        </p:txBody>
      </p:sp>
      <p:cxnSp>
        <p:nvCxnSpPr>
          <p:cNvPr id="6" name="Conector recto 5">
            <a:extLst>
              <a:ext uri="{FF2B5EF4-FFF2-40B4-BE49-F238E27FC236}">
                <a16:creationId xmlns:a16="http://schemas.microsoft.com/office/drawing/2014/main" id="{2D5E5E88-64E3-4B0C-B5B9-F102F808619A}"/>
              </a:ext>
            </a:extLst>
          </p:cNvPr>
          <p:cNvCxnSpPr>
            <a:cxnSpLocks/>
          </p:cNvCxnSpPr>
          <p:nvPr/>
        </p:nvCxnSpPr>
        <p:spPr>
          <a:xfrm>
            <a:off x="365760" y="854693"/>
            <a:ext cx="5826034"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38" name="CuadroTexto 37">
            <a:extLst>
              <a:ext uri="{FF2B5EF4-FFF2-40B4-BE49-F238E27FC236}">
                <a16:creationId xmlns:a16="http://schemas.microsoft.com/office/drawing/2014/main" id="{468D051E-0E13-4256-91C7-D8FA812876FD}"/>
              </a:ext>
            </a:extLst>
          </p:cNvPr>
          <p:cNvSpPr txBox="1"/>
          <p:nvPr/>
        </p:nvSpPr>
        <p:spPr>
          <a:xfrm>
            <a:off x="8569683" y="31904"/>
            <a:ext cx="3643241" cy="276999"/>
          </a:xfrm>
          <a:prstGeom prst="rect">
            <a:avLst/>
          </a:prstGeom>
          <a:noFill/>
        </p:spPr>
        <p:txBody>
          <a:bodyPr wrap="none" rtlCol="0">
            <a:spAutoFit/>
          </a:bodyPr>
          <a:lstStyle/>
          <a:p>
            <a:r>
              <a:rPr lang="en-GB" sz="1200" dirty="0">
                <a:solidFill>
                  <a:schemeClr val="bg1">
                    <a:lumMod val="50000"/>
                  </a:schemeClr>
                </a:solidFill>
                <a:latin typeface="+mj-lt"/>
              </a:rPr>
              <a:t>Heading and title of the Cova </a:t>
            </a:r>
            <a:r>
              <a:rPr lang="en-GB" sz="1200" dirty="0" err="1">
                <a:solidFill>
                  <a:schemeClr val="bg1">
                    <a:lumMod val="50000"/>
                  </a:schemeClr>
                </a:solidFill>
                <a:latin typeface="+mj-lt"/>
              </a:rPr>
              <a:t>Foradada</a:t>
            </a:r>
            <a:r>
              <a:rPr lang="en-GB" sz="1200" dirty="0">
                <a:solidFill>
                  <a:schemeClr val="bg1">
                    <a:lumMod val="50000"/>
                  </a:schemeClr>
                </a:solidFill>
                <a:latin typeface="+mj-lt"/>
              </a:rPr>
              <a:t> article - example</a:t>
            </a:r>
          </a:p>
        </p:txBody>
      </p:sp>
      <p:grpSp>
        <p:nvGrpSpPr>
          <p:cNvPr id="13" name="Grupo 12">
            <a:extLst>
              <a:ext uri="{FF2B5EF4-FFF2-40B4-BE49-F238E27FC236}">
                <a16:creationId xmlns:a16="http://schemas.microsoft.com/office/drawing/2014/main" id="{DD0633D2-0E3A-4AF6-B175-114F74ECE042}"/>
              </a:ext>
            </a:extLst>
          </p:cNvPr>
          <p:cNvGrpSpPr/>
          <p:nvPr/>
        </p:nvGrpSpPr>
        <p:grpSpPr>
          <a:xfrm>
            <a:off x="703681" y="1550675"/>
            <a:ext cx="4421237" cy="5250317"/>
            <a:chOff x="994657" y="1553153"/>
            <a:chExt cx="4421237" cy="5250317"/>
          </a:xfrm>
        </p:grpSpPr>
        <p:pic>
          <p:nvPicPr>
            <p:cNvPr id="3" name="Imagen 2" descr="Imagen que contiene texto, mapa&#10;&#10;Descripción generada automáticamente">
              <a:extLst>
                <a:ext uri="{FF2B5EF4-FFF2-40B4-BE49-F238E27FC236}">
                  <a16:creationId xmlns:a16="http://schemas.microsoft.com/office/drawing/2014/main" id="{CA160EB5-0258-494F-ABD6-7D283D6E369F}"/>
                </a:ext>
              </a:extLst>
            </p:cNvPr>
            <p:cNvPicPr>
              <a:picLocks noChangeAspect="1"/>
            </p:cNvPicPr>
            <p:nvPr/>
          </p:nvPicPr>
          <p:blipFill rotWithShape="1">
            <a:blip r:embed="rId3" cstate="screen">
              <a:extLst>
                <a:ext uri="{BEBA8EAE-BF5A-486C-A8C5-ECC9F3942E4B}">
                  <a14:imgProps xmlns:a14="http://schemas.microsoft.com/office/drawing/2010/main">
                    <a14:imgLayer r:embed="rId4">
                      <a14:imgEffect>
                        <a14:backgroundRemoval t="0" b="100000" l="0" r="100000">
                          <a14:foregroundMark x1="74626" y1="55239" x2="74626" y2="55239"/>
                          <a14:foregroundMark x1="74875" y1="71734" x2="74875" y2="71734"/>
                          <a14:foregroundMark x1="36689" y1="94955" x2="36689" y2="94955"/>
                          <a14:foregroundMark x1="36938" y1="3946" x2="36938" y2="3946"/>
                        </a14:backgroundRemoval>
                      </a14:imgEffect>
                    </a14:imgLayer>
                  </a14:imgProps>
                </a:ext>
                <a:ext uri="{28A0092B-C50C-407E-A947-70E740481C1C}">
                  <a14:useLocalDpi xmlns:a14="http://schemas.microsoft.com/office/drawing/2010/main"/>
                </a:ext>
              </a:extLst>
            </a:blip>
            <a:srcRect/>
            <a:stretch/>
          </p:blipFill>
          <p:spPr>
            <a:xfrm>
              <a:off x="996217" y="1553153"/>
              <a:ext cx="3949431" cy="5078943"/>
            </a:xfrm>
            <a:prstGeom prst="rect">
              <a:avLst/>
            </a:prstGeom>
          </p:spPr>
        </p:pic>
        <p:sp>
          <p:nvSpPr>
            <p:cNvPr id="12" name="Abrir corchete 11">
              <a:extLst>
                <a:ext uri="{FF2B5EF4-FFF2-40B4-BE49-F238E27FC236}">
                  <a16:creationId xmlns:a16="http://schemas.microsoft.com/office/drawing/2014/main" id="{B2FEB658-1BD9-48D2-8C18-B2D6CFD3AFC0}"/>
                </a:ext>
              </a:extLst>
            </p:cNvPr>
            <p:cNvSpPr/>
            <p:nvPr/>
          </p:nvSpPr>
          <p:spPr>
            <a:xfrm rot="3459213">
              <a:off x="1662594" y="1563107"/>
              <a:ext cx="45719" cy="1018932"/>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21" name="Abrir corchete 20">
              <a:extLst>
                <a:ext uri="{FF2B5EF4-FFF2-40B4-BE49-F238E27FC236}">
                  <a16:creationId xmlns:a16="http://schemas.microsoft.com/office/drawing/2014/main" id="{3A91692D-B54F-4198-B081-37FA7763A5F6}"/>
                </a:ext>
              </a:extLst>
            </p:cNvPr>
            <p:cNvSpPr/>
            <p:nvPr/>
          </p:nvSpPr>
          <p:spPr>
            <a:xfrm>
              <a:off x="2410216" y="4551492"/>
              <a:ext cx="45719" cy="865897"/>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22" name="Abrir corchete 21">
              <a:extLst>
                <a:ext uri="{FF2B5EF4-FFF2-40B4-BE49-F238E27FC236}">
                  <a16:creationId xmlns:a16="http://schemas.microsoft.com/office/drawing/2014/main" id="{D4D2A230-D4FF-47FF-9444-7BEA108AFF55}"/>
                </a:ext>
              </a:extLst>
            </p:cNvPr>
            <p:cNvSpPr/>
            <p:nvPr/>
          </p:nvSpPr>
          <p:spPr>
            <a:xfrm rot="16200000">
              <a:off x="2730498" y="5946365"/>
              <a:ext cx="62974" cy="1118378"/>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23" name="Abrir corchete 22">
              <a:extLst>
                <a:ext uri="{FF2B5EF4-FFF2-40B4-BE49-F238E27FC236}">
                  <a16:creationId xmlns:a16="http://schemas.microsoft.com/office/drawing/2014/main" id="{FF1917C2-FBD8-4A55-A056-3E7A5C401591}"/>
                </a:ext>
              </a:extLst>
            </p:cNvPr>
            <p:cNvSpPr/>
            <p:nvPr/>
          </p:nvSpPr>
          <p:spPr>
            <a:xfrm rot="10800000">
              <a:off x="4581852" y="4657114"/>
              <a:ext cx="45719" cy="1234728"/>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24" name="Abrir corchete 23">
              <a:extLst>
                <a:ext uri="{FF2B5EF4-FFF2-40B4-BE49-F238E27FC236}">
                  <a16:creationId xmlns:a16="http://schemas.microsoft.com/office/drawing/2014/main" id="{9CE009B3-1F3D-48CE-8519-4FB5F66A6F5A}"/>
                </a:ext>
              </a:extLst>
            </p:cNvPr>
            <p:cNvSpPr/>
            <p:nvPr/>
          </p:nvSpPr>
          <p:spPr>
            <a:xfrm rot="8023921">
              <a:off x="3255917" y="2598203"/>
              <a:ext cx="45719" cy="1846066"/>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27" name="CuadroTexto 26">
              <a:extLst>
                <a:ext uri="{FF2B5EF4-FFF2-40B4-BE49-F238E27FC236}">
                  <a16:creationId xmlns:a16="http://schemas.microsoft.com/office/drawing/2014/main" id="{DE16B8BA-D84F-43FA-93E7-CA4AC5091E72}"/>
                </a:ext>
              </a:extLst>
            </p:cNvPr>
            <p:cNvSpPr txBox="1"/>
            <p:nvPr/>
          </p:nvSpPr>
          <p:spPr>
            <a:xfrm>
              <a:off x="4622688" y="5043645"/>
              <a:ext cx="793206" cy="461665"/>
            </a:xfrm>
            <a:prstGeom prst="rect">
              <a:avLst/>
            </a:prstGeom>
            <a:noFill/>
          </p:spPr>
          <p:txBody>
            <a:bodyPr wrap="square" rtlCol="0">
              <a:spAutoFit/>
            </a:bodyPr>
            <a:lstStyle/>
            <a:p>
              <a:r>
                <a:rPr lang="en-GB" sz="1200" dirty="0">
                  <a:latin typeface="+mj-lt"/>
                </a:rPr>
                <a:t>Lower</a:t>
              </a:r>
            </a:p>
            <a:p>
              <a:r>
                <a:rPr lang="en-GB" sz="1200" dirty="0">
                  <a:latin typeface="+mj-lt"/>
                </a:rPr>
                <a:t>entrance</a:t>
              </a:r>
            </a:p>
          </p:txBody>
        </p:sp>
        <p:sp>
          <p:nvSpPr>
            <p:cNvPr id="28" name="CuadroTexto 27">
              <a:extLst>
                <a:ext uri="{FF2B5EF4-FFF2-40B4-BE49-F238E27FC236}">
                  <a16:creationId xmlns:a16="http://schemas.microsoft.com/office/drawing/2014/main" id="{E8140ACC-BCDA-496F-A142-341E861AA854}"/>
                </a:ext>
              </a:extLst>
            </p:cNvPr>
            <p:cNvSpPr txBox="1"/>
            <p:nvPr/>
          </p:nvSpPr>
          <p:spPr>
            <a:xfrm>
              <a:off x="1499702" y="4753607"/>
              <a:ext cx="910514" cy="461665"/>
            </a:xfrm>
            <a:prstGeom prst="rect">
              <a:avLst/>
            </a:prstGeom>
            <a:noFill/>
          </p:spPr>
          <p:txBody>
            <a:bodyPr wrap="square" rtlCol="0">
              <a:spAutoFit/>
            </a:bodyPr>
            <a:lstStyle/>
            <a:p>
              <a:pPr algn="r"/>
              <a:r>
                <a:rPr lang="en-GB" sz="1200" dirty="0">
                  <a:latin typeface="+mj-lt"/>
                </a:rPr>
                <a:t>Excavation</a:t>
              </a:r>
            </a:p>
            <a:p>
              <a:pPr algn="r"/>
              <a:r>
                <a:rPr lang="en-GB" sz="1200" dirty="0">
                  <a:latin typeface="+mj-lt"/>
                </a:rPr>
                <a:t>hall</a:t>
              </a:r>
            </a:p>
          </p:txBody>
        </p:sp>
        <p:sp>
          <p:nvSpPr>
            <p:cNvPr id="30" name="CuadroTexto 29">
              <a:extLst>
                <a:ext uri="{FF2B5EF4-FFF2-40B4-BE49-F238E27FC236}">
                  <a16:creationId xmlns:a16="http://schemas.microsoft.com/office/drawing/2014/main" id="{681FEB0B-F961-4651-A74F-8D1E09E9643A}"/>
                </a:ext>
              </a:extLst>
            </p:cNvPr>
            <p:cNvSpPr txBox="1"/>
            <p:nvPr/>
          </p:nvSpPr>
          <p:spPr>
            <a:xfrm>
              <a:off x="2306728" y="6526471"/>
              <a:ext cx="910514" cy="276999"/>
            </a:xfrm>
            <a:prstGeom prst="rect">
              <a:avLst/>
            </a:prstGeom>
            <a:noFill/>
          </p:spPr>
          <p:txBody>
            <a:bodyPr wrap="square" rtlCol="0">
              <a:spAutoFit/>
            </a:bodyPr>
            <a:lstStyle/>
            <a:p>
              <a:pPr algn="ctr"/>
              <a:r>
                <a:rPr lang="en-GB" sz="1200" dirty="0">
                  <a:latin typeface="+mj-lt"/>
                </a:rPr>
                <a:t>SW gallery</a:t>
              </a:r>
            </a:p>
          </p:txBody>
        </p:sp>
        <p:sp>
          <p:nvSpPr>
            <p:cNvPr id="31" name="CuadroTexto 30">
              <a:extLst>
                <a:ext uri="{FF2B5EF4-FFF2-40B4-BE49-F238E27FC236}">
                  <a16:creationId xmlns:a16="http://schemas.microsoft.com/office/drawing/2014/main" id="{62BB1CF0-E862-425E-B822-82976830CBFC}"/>
                </a:ext>
              </a:extLst>
            </p:cNvPr>
            <p:cNvSpPr txBox="1"/>
            <p:nvPr/>
          </p:nvSpPr>
          <p:spPr>
            <a:xfrm>
              <a:off x="3161030" y="2997364"/>
              <a:ext cx="910514" cy="461665"/>
            </a:xfrm>
            <a:prstGeom prst="rect">
              <a:avLst/>
            </a:prstGeom>
            <a:noFill/>
          </p:spPr>
          <p:txBody>
            <a:bodyPr wrap="square" rtlCol="0">
              <a:spAutoFit/>
            </a:bodyPr>
            <a:lstStyle/>
            <a:p>
              <a:r>
                <a:rPr lang="en-GB" sz="1200" dirty="0">
                  <a:latin typeface="+mj-lt"/>
                </a:rPr>
                <a:t>Travertine slope</a:t>
              </a:r>
            </a:p>
          </p:txBody>
        </p:sp>
        <p:sp>
          <p:nvSpPr>
            <p:cNvPr id="39" name="CuadroTexto 38">
              <a:extLst>
                <a:ext uri="{FF2B5EF4-FFF2-40B4-BE49-F238E27FC236}">
                  <a16:creationId xmlns:a16="http://schemas.microsoft.com/office/drawing/2014/main" id="{47D80158-E019-40B7-A8B0-88836B92AD58}"/>
                </a:ext>
              </a:extLst>
            </p:cNvPr>
            <p:cNvSpPr txBox="1"/>
            <p:nvPr/>
          </p:nvSpPr>
          <p:spPr>
            <a:xfrm>
              <a:off x="994657" y="1625169"/>
              <a:ext cx="738499" cy="461665"/>
            </a:xfrm>
            <a:prstGeom prst="rect">
              <a:avLst/>
            </a:prstGeom>
            <a:noFill/>
          </p:spPr>
          <p:txBody>
            <a:bodyPr wrap="square" rtlCol="0">
              <a:spAutoFit/>
            </a:bodyPr>
            <a:lstStyle/>
            <a:p>
              <a:pPr algn="r"/>
              <a:r>
                <a:rPr lang="en-GB" sz="1200" dirty="0">
                  <a:latin typeface="+mj-lt"/>
                </a:rPr>
                <a:t>Upper</a:t>
              </a:r>
            </a:p>
            <a:p>
              <a:pPr algn="r"/>
              <a:r>
                <a:rPr lang="en-GB" sz="1200" dirty="0">
                  <a:latin typeface="+mj-lt"/>
                </a:rPr>
                <a:t>entrance</a:t>
              </a:r>
            </a:p>
          </p:txBody>
        </p:sp>
      </p:grpSp>
      <p:pic>
        <p:nvPicPr>
          <p:cNvPr id="8" name="Imagen 7">
            <a:extLst>
              <a:ext uri="{FF2B5EF4-FFF2-40B4-BE49-F238E27FC236}">
                <a16:creationId xmlns:a16="http://schemas.microsoft.com/office/drawing/2014/main" id="{FBDCEFDA-A0F8-473E-9036-F0344F9A335B}"/>
              </a:ext>
            </a:extLst>
          </p:cNvPr>
          <p:cNvPicPr>
            <a:picLocks noChangeAspect="1"/>
          </p:cNvPicPr>
          <p:nvPr/>
        </p:nvPicPr>
        <p:blipFill rotWithShape="1">
          <a:blip r:embed="rId5" cstate="screen">
            <a:extLst>
              <a:ext uri="{BEBA8EAE-BF5A-486C-A8C5-ECC9F3942E4B}">
                <a14:imgProps xmlns:a14="http://schemas.microsoft.com/office/drawing/2010/main">
                  <a14:imgLayer r:embed="rId6">
                    <a14:imgEffect>
                      <a14:backgroundRemoval t="0" b="100000" l="0" r="100000"/>
                    </a14:imgEffect>
                  </a14:imgLayer>
                </a14:imgProps>
              </a:ext>
              <a:ext uri="{28A0092B-C50C-407E-A947-70E740481C1C}">
                <a14:useLocalDpi xmlns:a14="http://schemas.microsoft.com/office/drawing/2010/main"/>
              </a:ext>
            </a:extLst>
          </a:blip>
          <a:srcRect/>
          <a:stretch/>
        </p:blipFill>
        <p:spPr>
          <a:xfrm>
            <a:off x="5756212" y="548289"/>
            <a:ext cx="4797133" cy="2930579"/>
          </a:xfrm>
          <a:prstGeom prst="rect">
            <a:avLst/>
          </a:prstGeom>
        </p:spPr>
      </p:pic>
      <p:sp>
        <p:nvSpPr>
          <p:cNvPr id="32" name="CuadroTexto 31">
            <a:extLst>
              <a:ext uri="{FF2B5EF4-FFF2-40B4-BE49-F238E27FC236}">
                <a16:creationId xmlns:a16="http://schemas.microsoft.com/office/drawing/2014/main" id="{BED8F742-0F8A-46FA-A993-BC7E2035C2BA}"/>
              </a:ext>
            </a:extLst>
          </p:cNvPr>
          <p:cNvSpPr txBox="1"/>
          <p:nvPr/>
        </p:nvSpPr>
        <p:spPr>
          <a:xfrm>
            <a:off x="5994604" y="1255708"/>
            <a:ext cx="793206" cy="461665"/>
          </a:xfrm>
          <a:prstGeom prst="rect">
            <a:avLst/>
          </a:prstGeom>
          <a:noFill/>
        </p:spPr>
        <p:txBody>
          <a:bodyPr wrap="square" rtlCol="0">
            <a:spAutoFit/>
          </a:bodyPr>
          <a:lstStyle/>
          <a:p>
            <a:pPr algn="r"/>
            <a:r>
              <a:rPr lang="en-GB" sz="1200" dirty="0">
                <a:latin typeface="+mj-lt"/>
              </a:rPr>
              <a:t>Lower</a:t>
            </a:r>
          </a:p>
          <a:p>
            <a:pPr algn="r"/>
            <a:r>
              <a:rPr lang="en-GB" sz="1200" dirty="0">
                <a:latin typeface="+mj-lt"/>
              </a:rPr>
              <a:t>entrance</a:t>
            </a:r>
          </a:p>
        </p:txBody>
      </p:sp>
      <p:sp>
        <p:nvSpPr>
          <p:cNvPr id="33" name="Abrir corchete 32">
            <a:extLst>
              <a:ext uri="{FF2B5EF4-FFF2-40B4-BE49-F238E27FC236}">
                <a16:creationId xmlns:a16="http://schemas.microsoft.com/office/drawing/2014/main" id="{9D079C06-F4D7-43B1-B22B-1794FECCD828}"/>
              </a:ext>
            </a:extLst>
          </p:cNvPr>
          <p:cNvSpPr/>
          <p:nvPr/>
        </p:nvSpPr>
        <p:spPr>
          <a:xfrm rot="3459213">
            <a:off x="6674671" y="1312211"/>
            <a:ext cx="45719" cy="832940"/>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34" name="Abrir corchete 33">
            <a:extLst>
              <a:ext uri="{FF2B5EF4-FFF2-40B4-BE49-F238E27FC236}">
                <a16:creationId xmlns:a16="http://schemas.microsoft.com/office/drawing/2014/main" id="{07C0298F-4792-4B26-9EED-9958B124552C}"/>
              </a:ext>
            </a:extLst>
          </p:cNvPr>
          <p:cNvSpPr/>
          <p:nvPr/>
        </p:nvSpPr>
        <p:spPr>
          <a:xfrm rot="3696004">
            <a:off x="8020375" y="314972"/>
            <a:ext cx="45719" cy="1642929"/>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35" name="CuadroTexto 34">
            <a:extLst>
              <a:ext uri="{FF2B5EF4-FFF2-40B4-BE49-F238E27FC236}">
                <a16:creationId xmlns:a16="http://schemas.microsoft.com/office/drawing/2014/main" id="{BC5B370D-9D58-4CF9-89D6-4F4B22195D22}"/>
              </a:ext>
            </a:extLst>
          </p:cNvPr>
          <p:cNvSpPr txBox="1"/>
          <p:nvPr/>
        </p:nvSpPr>
        <p:spPr>
          <a:xfrm>
            <a:off x="7193353" y="674771"/>
            <a:ext cx="910514" cy="461665"/>
          </a:xfrm>
          <a:prstGeom prst="rect">
            <a:avLst/>
          </a:prstGeom>
          <a:noFill/>
        </p:spPr>
        <p:txBody>
          <a:bodyPr wrap="square" rtlCol="0">
            <a:spAutoFit/>
          </a:bodyPr>
          <a:lstStyle/>
          <a:p>
            <a:pPr algn="r"/>
            <a:r>
              <a:rPr lang="en-GB" sz="1200" dirty="0">
                <a:latin typeface="+mj-lt"/>
              </a:rPr>
              <a:t>Travertine slope</a:t>
            </a:r>
          </a:p>
        </p:txBody>
      </p:sp>
      <p:sp>
        <p:nvSpPr>
          <p:cNvPr id="36" name="Abrir corchete 35">
            <a:extLst>
              <a:ext uri="{FF2B5EF4-FFF2-40B4-BE49-F238E27FC236}">
                <a16:creationId xmlns:a16="http://schemas.microsoft.com/office/drawing/2014/main" id="{1958D76B-3258-4061-BA4A-547DE6362ACA}"/>
              </a:ext>
            </a:extLst>
          </p:cNvPr>
          <p:cNvSpPr/>
          <p:nvPr/>
        </p:nvSpPr>
        <p:spPr>
          <a:xfrm rot="9237494">
            <a:off x="10296551" y="468092"/>
            <a:ext cx="45719" cy="694401"/>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37" name="CuadroTexto 36">
            <a:extLst>
              <a:ext uri="{FF2B5EF4-FFF2-40B4-BE49-F238E27FC236}">
                <a16:creationId xmlns:a16="http://schemas.microsoft.com/office/drawing/2014/main" id="{40178FEA-9F53-4502-ADC9-F37A558A6AE6}"/>
              </a:ext>
            </a:extLst>
          </p:cNvPr>
          <p:cNvSpPr txBox="1"/>
          <p:nvPr/>
        </p:nvSpPr>
        <p:spPr>
          <a:xfrm>
            <a:off x="10319410" y="493305"/>
            <a:ext cx="910513" cy="461665"/>
          </a:xfrm>
          <a:prstGeom prst="rect">
            <a:avLst/>
          </a:prstGeom>
          <a:noFill/>
        </p:spPr>
        <p:txBody>
          <a:bodyPr wrap="square" rtlCol="0">
            <a:spAutoFit/>
          </a:bodyPr>
          <a:lstStyle/>
          <a:p>
            <a:r>
              <a:rPr lang="en-GB" sz="1200" dirty="0">
                <a:latin typeface="+mj-lt"/>
              </a:rPr>
              <a:t>Upper</a:t>
            </a:r>
          </a:p>
          <a:p>
            <a:r>
              <a:rPr lang="en-GB" sz="1200" dirty="0">
                <a:latin typeface="+mj-lt"/>
              </a:rPr>
              <a:t>entrance</a:t>
            </a:r>
          </a:p>
        </p:txBody>
      </p:sp>
      <p:sp>
        <p:nvSpPr>
          <p:cNvPr id="40" name="Abrir corchete 39">
            <a:extLst>
              <a:ext uri="{FF2B5EF4-FFF2-40B4-BE49-F238E27FC236}">
                <a16:creationId xmlns:a16="http://schemas.microsoft.com/office/drawing/2014/main" id="{4D80A3F6-41C0-4AF3-A1D5-320ABE8152F7}"/>
              </a:ext>
            </a:extLst>
          </p:cNvPr>
          <p:cNvSpPr/>
          <p:nvPr/>
        </p:nvSpPr>
        <p:spPr>
          <a:xfrm rot="16200000">
            <a:off x="9686652" y="1233637"/>
            <a:ext cx="78594" cy="1395773"/>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41" name="CuadroTexto 40">
            <a:extLst>
              <a:ext uri="{FF2B5EF4-FFF2-40B4-BE49-F238E27FC236}">
                <a16:creationId xmlns:a16="http://schemas.microsoft.com/office/drawing/2014/main" id="{19227E14-A307-47A6-8605-091C836056C7}"/>
              </a:ext>
            </a:extLst>
          </p:cNvPr>
          <p:cNvSpPr txBox="1"/>
          <p:nvPr/>
        </p:nvSpPr>
        <p:spPr>
          <a:xfrm>
            <a:off x="9270693" y="1988405"/>
            <a:ext cx="910513" cy="461665"/>
          </a:xfrm>
          <a:prstGeom prst="rect">
            <a:avLst/>
          </a:prstGeom>
          <a:noFill/>
        </p:spPr>
        <p:txBody>
          <a:bodyPr wrap="square" rtlCol="0">
            <a:spAutoFit/>
          </a:bodyPr>
          <a:lstStyle/>
          <a:p>
            <a:pPr algn="ctr"/>
            <a:r>
              <a:rPr lang="en-GB" sz="1200" dirty="0">
                <a:latin typeface="+mj-lt"/>
              </a:rPr>
              <a:t>Upper</a:t>
            </a:r>
          </a:p>
          <a:p>
            <a:pPr algn="ctr"/>
            <a:r>
              <a:rPr lang="en-GB" sz="1200" dirty="0">
                <a:latin typeface="+mj-lt"/>
              </a:rPr>
              <a:t>test pit</a:t>
            </a:r>
          </a:p>
        </p:txBody>
      </p:sp>
      <p:grpSp>
        <p:nvGrpSpPr>
          <p:cNvPr id="51" name="Grupo 50">
            <a:extLst>
              <a:ext uri="{FF2B5EF4-FFF2-40B4-BE49-F238E27FC236}">
                <a16:creationId xmlns:a16="http://schemas.microsoft.com/office/drawing/2014/main" id="{977EE4C9-DC66-4AFF-92C7-FDD2AD1DBCA1}"/>
              </a:ext>
            </a:extLst>
          </p:cNvPr>
          <p:cNvGrpSpPr/>
          <p:nvPr/>
        </p:nvGrpSpPr>
        <p:grpSpPr>
          <a:xfrm>
            <a:off x="5489225" y="3288994"/>
            <a:ext cx="5185458" cy="3553597"/>
            <a:chOff x="5886031" y="3280368"/>
            <a:chExt cx="5185458" cy="3553597"/>
          </a:xfrm>
        </p:grpSpPr>
        <p:pic>
          <p:nvPicPr>
            <p:cNvPr id="10" name="Imagen 9">
              <a:extLst>
                <a:ext uri="{FF2B5EF4-FFF2-40B4-BE49-F238E27FC236}">
                  <a16:creationId xmlns:a16="http://schemas.microsoft.com/office/drawing/2014/main" id="{767D512A-9379-40C5-B89A-3CB7573B5119}"/>
                </a:ext>
              </a:extLst>
            </p:cNvPr>
            <p:cNvPicPr>
              <a:picLocks noChangeAspect="1"/>
            </p:cNvPicPr>
            <p:nvPr/>
          </p:nvPicPr>
          <p:blipFill rotWithShape="1">
            <a:blip r:embed="rId7" cstate="screen">
              <a:extLst>
                <a:ext uri="{BEBA8EAE-BF5A-486C-A8C5-ECC9F3942E4B}">
                  <a14:imgProps xmlns:a14="http://schemas.microsoft.com/office/drawing/2010/main">
                    <a14:imgLayer r:embed="rId8">
                      <a14:imgEffect>
                        <a14:backgroundRemoval t="1714" b="100000" l="1203" r="100000"/>
                      </a14:imgEffect>
                    </a14:imgLayer>
                  </a14:imgProps>
                </a:ext>
                <a:ext uri="{28A0092B-C50C-407E-A947-70E740481C1C}">
                  <a14:useLocalDpi xmlns:a14="http://schemas.microsoft.com/office/drawing/2010/main"/>
                </a:ext>
              </a:extLst>
            </a:blip>
            <a:srcRect/>
            <a:stretch/>
          </p:blipFill>
          <p:spPr>
            <a:xfrm>
              <a:off x="5886031" y="3280368"/>
              <a:ext cx="5185458" cy="3449085"/>
            </a:xfrm>
            <a:prstGeom prst="rect">
              <a:avLst/>
            </a:prstGeom>
          </p:spPr>
        </p:pic>
        <p:sp>
          <p:nvSpPr>
            <p:cNvPr id="42" name="Abrir corchete 41">
              <a:extLst>
                <a:ext uri="{FF2B5EF4-FFF2-40B4-BE49-F238E27FC236}">
                  <a16:creationId xmlns:a16="http://schemas.microsoft.com/office/drawing/2014/main" id="{87E5DDC1-2E55-4DE1-8985-5628168E1C25}"/>
                </a:ext>
              </a:extLst>
            </p:cNvPr>
            <p:cNvSpPr/>
            <p:nvPr/>
          </p:nvSpPr>
          <p:spPr>
            <a:xfrm rot="16200000">
              <a:off x="6929018" y="4448986"/>
              <a:ext cx="96178" cy="1031625"/>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43" name="CuadroTexto 42">
              <a:extLst>
                <a:ext uri="{FF2B5EF4-FFF2-40B4-BE49-F238E27FC236}">
                  <a16:creationId xmlns:a16="http://schemas.microsoft.com/office/drawing/2014/main" id="{EE5120C5-CED8-4FF8-B9FD-0E922F7D7A4A}"/>
                </a:ext>
              </a:extLst>
            </p:cNvPr>
            <p:cNvSpPr txBox="1"/>
            <p:nvPr/>
          </p:nvSpPr>
          <p:spPr>
            <a:xfrm>
              <a:off x="6521850" y="5004910"/>
              <a:ext cx="910513" cy="461665"/>
            </a:xfrm>
            <a:prstGeom prst="rect">
              <a:avLst/>
            </a:prstGeom>
            <a:noFill/>
          </p:spPr>
          <p:txBody>
            <a:bodyPr wrap="square" rtlCol="0">
              <a:spAutoFit/>
            </a:bodyPr>
            <a:lstStyle/>
            <a:p>
              <a:pPr algn="ctr"/>
              <a:r>
                <a:rPr lang="en-GB" sz="1200" dirty="0">
                  <a:latin typeface="+mj-lt"/>
                </a:rPr>
                <a:t>Upper</a:t>
              </a:r>
            </a:p>
            <a:p>
              <a:pPr algn="ctr"/>
              <a:r>
                <a:rPr lang="en-GB" sz="1200" dirty="0">
                  <a:latin typeface="+mj-lt"/>
                </a:rPr>
                <a:t>test pit</a:t>
              </a:r>
            </a:p>
          </p:txBody>
        </p:sp>
        <p:sp>
          <p:nvSpPr>
            <p:cNvPr id="44" name="Abrir corchete 43">
              <a:extLst>
                <a:ext uri="{FF2B5EF4-FFF2-40B4-BE49-F238E27FC236}">
                  <a16:creationId xmlns:a16="http://schemas.microsoft.com/office/drawing/2014/main" id="{2F3AB992-3A5B-42E9-8082-7D3E3498C4F2}"/>
                </a:ext>
              </a:extLst>
            </p:cNvPr>
            <p:cNvSpPr/>
            <p:nvPr/>
          </p:nvSpPr>
          <p:spPr>
            <a:xfrm rot="6905082">
              <a:off x="8546825" y="3357741"/>
              <a:ext cx="45719" cy="1642929"/>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45" name="CuadroTexto 44">
              <a:extLst>
                <a:ext uri="{FF2B5EF4-FFF2-40B4-BE49-F238E27FC236}">
                  <a16:creationId xmlns:a16="http://schemas.microsoft.com/office/drawing/2014/main" id="{23D8E314-0E2A-41E3-AB55-0E1E84F04994}"/>
                </a:ext>
              </a:extLst>
            </p:cNvPr>
            <p:cNvSpPr txBox="1"/>
            <p:nvPr/>
          </p:nvSpPr>
          <p:spPr>
            <a:xfrm>
              <a:off x="8475404" y="3714169"/>
              <a:ext cx="910514" cy="461665"/>
            </a:xfrm>
            <a:prstGeom prst="rect">
              <a:avLst/>
            </a:prstGeom>
            <a:noFill/>
          </p:spPr>
          <p:txBody>
            <a:bodyPr wrap="square" rtlCol="0">
              <a:spAutoFit/>
            </a:bodyPr>
            <a:lstStyle/>
            <a:p>
              <a:r>
                <a:rPr lang="en-GB" sz="1200" dirty="0">
                  <a:latin typeface="+mj-lt"/>
                </a:rPr>
                <a:t>Travertine slope</a:t>
              </a:r>
            </a:p>
          </p:txBody>
        </p:sp>
        <p:sp>
          <p:nvSpPr>
            <p:cNvPr id="46" name="Abrir corchete 45">
              <a:extLst>
                <a:ext uri="{FF2B5EF4-FFF2-40B4-BE49-F238E27FC236}">
                  <a16:creationId xmlns:a16="http://schemas.microsoft.com/office/drawing/2014/main" id="{6AD9E253-37C5-4992-AFBF-08924C34731B}"/>
                </a:ext>
              </a:extLst>
            </p:cNvPr>
            <p:cNvSpPr/>
            <p:nvPr/>
          </p:nvSpPr>
          <p:spPr>
            <a:xfrm rot="7720048">
              <a:off x="9891903" y="4289340"/>
              <a:ext cx="45719" cy="1142977"/>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47" name="CuadroTexto 46">
              <a:extLst>
                <a:ext uri="{FF2B5EF4-FFF2-40B4-BE49-F238E27FC236}">
                  <a16:creationId xmlns:a16="http://schemas.microsoft.com/office/drawing/2014/main" id="{359BB0DF-D2BD-42FC-80DC-0D6166D1BEDF}"/>
                </a:ext>
              </a:extLst>
            </p:cNvPr>
            <p:cNvSpPr txBox="1"/>
            <p:nvPr/>
          </p:nvSpPr>
          <p:spPr>
            <a:xfrm>
              <a:off x="9867142" y="4406031"/>
              <a:ext cx="793206" cy="461665"/>
            </a:xfrm>
            <a:prstGeom prst="rect">
              <a:avLst/>
            </a:prstGeom>
            <a:noFill/>
          </p:spPr>
          <p:txBody>
            <a:bodyPr wrap="square" rtlCol="0">
              <a:spAutoFit/>
            </a:bodyPr>
            <a:lstStyle/>
            <a:p>
              <a:r>
                <a:rPr lang="en-GB" sz="1200" dirty="0">
                  <a:latin typeface="+mj-lt"/>
                </a:rPr>
                <a:t>Lower</a:t>
              </a:r>
            </a:p>
            <a:p>
              <a:r>
                <a:rPr lang="en-GB" sz="1200" dirty="0">
                  <a:latin typeface="+mj-lt"/>
                </a:rPr>
                <a:t>entrance</a:t>
              </a:r>
            </a:p>
          </p:txBody>
        </p:sp>
        <p:sp>
          <p:nvSpPr>
            <p:cNvPr id="48" name="Abrir corchete 47">
              <a:extLst>
                <a:ext uri="{FF2B5EF4-FFF2-40B4-BE49-F238E27FC236}">
                  <a16:creationId xmlns:a16="http://schemas.microsoft.com/office/drawing/2014/main" id="{62BED105-3F9A-44AD-B20A-A8D704292567}"/>
                </a:ext>
              </a:extLst>
            </p:cNvPr>
            <p:cNvSpPr/>
            <p:nvPr/>
          </p:nvSpPr>
          <p:spPr>
            <a:xfrm rot="16200000">
              <a:off x="9832150" y="5765584"/>
              <a:ext cx="53783" cy="1602612"/>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49" name="CuadroTexto 48">
              <a:extLst>
                <a:ext uri="{FF2B5EF4-FFF2-40B4-BE49-F238E27FC236}">
                  <a16:creationId xmlns:a16="http://schemas.microsoft.com/office/drawing/2014/main" id="{76AFCA8E-F733-4020-9E81-B732D687C6E5}"/>
                </a:ext>
              </a:extLst>
            </p:cNvPr>
            <p:cNvSpPr txBox="1"/>
            <p:nvPr/>
          </p:nvSpPr>
          <p:spPr>
            <a:xfrm>
              <a:off x="9252732" y="6556966"/>
              <a:ext cx="1228819" cy="276999"/>
            </a:xfrm>
            <a:prstGeom prst="rect">
              <a:avLst/>
            </a:prstGeom>
            <a:noFill/>
          </p:spPr>
          <p:txBody>
            <a:bodyPr wrap="square" rtlCol="0">
              <a:spAutoFit/>
            </a:bodyPr>
            <a:lstStyle/>
            <a:p>
              <a:pPr algn="ctr"/>
              <a:r>
                <a:rPr lang="en-GB" sz="1200" dirty="0">
                  <a:latin typeface="+mj-lt"/>
                </a:rPr>
                <a:t>Excavation hall</a:t>
              </a:r>
            </a:p>
          </p:txBody>
        </p:sp>
      </p:grpSp>
    </p:spTree>
    <p:extLst>
      <p:ext uri="{BB962C8B-B14F-4D97-AF65-F5344CB8AC3E}">
        <p14:creationId xmlns:p14="http://schemas.microsoft.com/office/powerpoint/2010/main" val="47520703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CuadroTexto 18">
            <a:extLst>
              <a:ext uri="{FF2B5EF4-FFF2-40B4-BE49-F238E27FC236}">
                <a16:creationId xmlns:a16="http://schemas.microsoft.com/office/drawing/2014/main" id="{1221EC5E-20CC-4994-AE1D-5D4E3D5D2941}"/>
              </a:ext>
            </a:extLst>
          </p:cNvPr>
          <p:cNvSpPr txBox="1"/>
          <p:nvPr/>
        </p:nvSpPr>
        <p:spPr>
          <a:xfrm>
            <a:off x="536760" y="5549076"/>
            <a:ext cx="10523126" cy="954107"/>
          </a:xfrm>
          <a:prstGeom prst="rect">
            <a:avLst/>
          </a:prstGeom>
          <a:noFill/>
        </p:spPr>
        <p:txBody>
          <a:bodyPr wrap="square" rtlCol="0">
            <a:spAutoFit/>
          </a:bodyPr>
          <a:lstStyle/>
          <a:p>
            <a:pPr algn="just"/>
            <a:r>
              <a:rPr lang="en-GB" sz="1400" dirty="0"/>
              <a:t>Some of the marine pierced seashells recovered from Layer </a:t>
            </a:r>
            <a:r>
              <a:rPr lang="en-GB" sz="1400" dirty="0" err="1"/>
              <a:t>IIIn</a:t>
            </a:r>
            <a:r>
              <a:rPr lang="en-GB" sz="1400" dirty="0"/>
              <a:t>. Fig. 10a shows a complete and a fragmented specimen of </a:t>
            </a:r>
            <a:r>
              <a:rPr lang="en-GB" sz="1400" i="1" dirty="0"/>
              <a:t>Turritella </a:t>
            </a:r>
            <a:r>
              <a:rPr lang="en-GB" sz="1400" i="1" dirty="0" err="1"/>
              <a:t>comunis</a:t>
            </a:r>
            <a:r>
              <a:rPr lang="en-GB" sz="1400" dirty="0"/>
              <a:t> and a small specimen of </a:t>
            </a:r>
            <a:r>
              <a:rPr lang="en-GB" sz="1400" i="1" dirty="0" err="1"/>
              <a:t>Tritia</a:t>
            </a:r>
            <a:r>
              <a:rPr lang="en-GB" sz="1400" i="1" dirty="0"/>
              <a:t> </a:t>
            </a:r>
            <a:r>
              <a:rPr lang="en-GB" sz="1400" i="1" dirty="0" err="1"/>
              <a:t>neritea</a:t>
            </a:r>
            <a:r>
              <a:rPr lang="en-GB" sz="1400" dirty="0"/>
              <a:t>. In Fig. 10b one specimen of  </a:t>
            </a:r>
            <a:r>
              <a:rPr lang="en-GB" sz="1400" i="1" dirty="0" err="1"/>
              <a:t>Homalopoma</a:t>
            </a:r>
            <a:r>
              <a:rPr lang="en-GB" sz="1400" i="1" dirty="0"/>
              <a:t> </a:t>
            </a:r>
            <a:r>
              <a:rPr lang="en-GB" sz="1400" i="1" dirty="0" err="1"/>
              <a:t>sanguineum</a:t>
            </a:r>
            <a:r>
              <a:rPr lang="en-GB" sz="1400" i="1" dirty="0"/>
              <a:t> </a:t>
            </a:r>
            <a:r>
              <a:rPr lang="en-GB" sz="1400" dirty="0"/>
              <a:t>with the perforation faced forward.</a:t>
            </a:r>
          </a:p>
          <a:p>
            <a:pPr algn="just"/>
            <a:endParaRPr lang="en-GB" sz="1400" dirty="0"/>
          </a:p>
          <a:p>
            <a:pPr algn="just"/>
            <a:r>
              <a:rPr lang="en-GB" sz="1400" dirty="0"/>
              <a:t>Photo 2013</a:t>
            </a:r>
          </a:p>
        </p:txBody>
      </p:sp>
      <p:sp>
        <p:nvSpPr>
          <p:cNvPr id="6" name="CuadroTexto 5">
            <a:extLst>
              <a:ext uri="{FF2B5EF4-FFF2-40B4-BE49-F238E27FC236}">
                <a16:creationId xmlns:a16="http://schemas.microsoft.com/office/drawing/2014/main" id="{74AF234C-E168-4284-B2E9-FEA4C9837CB3}"/>
              </a:ext>
            </a:extLst>
          </p:cNvPr>
          <p:cNvSpPr txBox="1"/>
          <p:nvPr/>
        </p:nvSpPr>
        <p:spPr>
          <a:xfrm>
            <a:off x="536760" y="4981099"/>
            <a:ext cx="622286" cy="369332"/>
          </a:xfrm>
          <a:prstGeom prst="rect">
            <a:avLst/>
          </a:prstGeom>
          <a:noFill/>
        </p:spPr>
        <p:txBody>
          <a:bodyPr wrap="none" rtlCol="0">
            <a:spAutoFit/>
          </a:bodyPr>
          <a:lstStyle/>
          <a:p>
            <a:r>
              <a:rPr lang="en-GB" b="1" dirty="0">
                <a:latin typeface="+mj-lt"/>
              </a:rPr>
              <a:t>Fig. J</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560159" cy="338554"/>
          </a:xfrm>
          <a:prstGeom prst="rect">
            <a:avLst/>
          </a:prstGeom>
          <a:noFill/>
        </p:spPr>
        <p:txBody>
          <a:bodyPr wrap="none" rtlCol="0">
            <a:spAutoFit/>
          </a:bodyPr>
          <a:lstStyle/>
          <a:p>
            <a:r>
              <a:rPr lang="en-GB" sz="1600" b="1" dirty="0">
                <a:latin typeface="+mj-lt"/>
              </a:rPr>
              <a:t>Supporting Information 1 – Excavation of the Layer </a:t>
            </a:r>
            <a:r>
              <a:rPr lang="en-GB" sz="1600" b="1" dirty="0" err="1">
                <a:latin typeface="+mj-lt"/>
              </a:rPr>
              <a:t>IIIn</a:t>
            </a:r>
            <a:endParaRPr lang="en-GB" sz="1600" b="1" dirty="0">
              <a:latin typeface="+mj-lt"/>
            </a:endParaRPr>
          </a:p>
        </p:txBody>
      </p:sp>
      <p:pic>
        <p:nvPicPr>
          <p:cNvPr id="4" name="Imagen 3" descr="Imagen que contiene suelo, edificio, exterior, objeto&#10;&#10;Descripción generada automáticamente">
            <a:extLst>
              <a:ext uri="{FF2B5EF4-FFF2-40B4-BE49-F238E27FC236}">
                <a16:creationId xmlns:a16="http://schemas.microsoft.com/office/drawing/2014/main" id="{93EE6330-6901-4E9C-B80D-A0D1BD3C01D2}"/>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13540" y="880635"/>
            <a:ext cx="5938919" cy="3970039"/>
          </a:xfrm>
          <a:prstGeom prst="rect">
            <a:avLst/>
          </a:prstGeom>
        </p:spPr>
      </p:pic>
      <p:pic>
        <p:nvPicPr>
          <p:cNvPr id="8" name="Imagen 7" descr="Imagen que contiene interior&#10;&#10;Descripción generada automáticamente">
            <a:extLst>
              <a:ext uri="{FF2B5EF4-FFF2-40B4-BE49-F238E27FC236}">
                <a16:creationId xmlns:a16="http://schemas.microsoft.com/office/drawing/2014/main" id="{8DDF943F-75BF-4440-8618-9B4641CB187D}"/>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6156962" y="880635"/>
            <a:ext cx="5938919" cy="3970039"/>
          </a:xfrm>
          <a:prstGeom prst="rect">
            <a:avLst/>
          </a:prstGeom>
        </p:spPr>
      </p:pic>
      <p:sp>
        <p:nvSpPr>
          <p:cNvPr id="20" name="CuadroTexto 19">
            <a:extLst>
              <a:ext uri="{FF2B5EF4-FFF2-40B4-BE49-F238E27FC236}">
                <a16:creationId xmlns:a16="http://schemas.microsoft.com/office/drawing/2014/main" id="{692BD62C-CD46-4DE6-8081-010741EBB647}"/>
              </a:ext>
            </a:extLst>
          </p:cNvPr>
          <p:cNvSpPr txBox="1"/>
          <p:nvPr/>
        </p:nvSpPr>
        <p:spPr>
          <a:xfrm>
            <a:off x="101308" y="493654"/>
            <a:ext cx="365806" cy="369332"/>
          </a:xfrm>
          <a:prstGeom prst="rect">
            <a:avLst/>
          </a:prstGeom>
          <a:noFill/>
        </p:spPr>
        <p:txBody>
          <a:bodyPr wrap="none" rtlCol="0">
            <a:spAutoFit/>
          </a:bodyPr>
          <a:lstStyle/>
          <a:p>
            <a:r>
              <a:rPr lang="en-GB" b="1" dirty="0">
                <a:latin typeface="+mj-lt"/>
              </a:rPr>
              <a:t>a)</a:t>
            </a:r>
          </a:p>
        </p:txBody>
      </p:sp>
      <p:sp>
        <p:nvSpPr>
          <p:cNvPr id="21" name="CuadroTexto 20">
            <a:extLst>
              <a:ext uri="{FF2B5EF4-FFF2-40B4-BE49-F238E27FC236}">
                <a16:creationId xmlns:a16="http://schemas.microsoft.com/office/drawing/2014/main" id="{D78E80DD-AD8F-40ED-A8F0-DCC7ACE9A8E5}"/>
              </a:ext>
            </a:extLst>
          </p:cNvPr>
          <p:cNvSpPr txBox="1"/>
          <p:nvPr/>
        </p:nvSpPr>
        <p:spPr>
          <a:xfrm>
            <a:off x="6113418" y="493654"/>
            <a:ext cx="522514" cy="369332"/>
          </a:xfrm>
          <a:prstGeom prst="rect">
            <a:avLst/>
          </a:prstGeom>
          <a:noFill/>
        </p:spPr>
        <p:txBody>
          <a:bodyPr wrap="square" rtlCol="0">
            <a:spAutoFit/>
          </a:bodyPr>
          <a:lstStyle/>
          <a:p>
            <a:r>
              <a:rPr lang="en-GB" b="1" dirty="0">
                <a:latin typeface="+mj-lt"/>
              </a:rPr>
              <a:t>b)</a:t>
            </a:r>
          </a:p>
        </p:txBody>
      </p:sp>
      <p:sp>
        <p:nvSpPr>
          <p:cNvPr id="14" name="Marcador de número de diapositiva 1">
            <a:extLst>
              <a:ext uri="{FF2B5EF4-FFF2-40B4-BE49-F238E27FC236}">
                <a16:creationId xmlns:a16="http://schemas.microsoft.com/office/drawing/2014/main" id="{03A6FD76-D844-4DB0-BA07-97573ABFA732}"/>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0</a:t>
            </a:fld>
            <a:endParaRPr lang="en-GB" sz="1800" dirty="0">
              <a:latin typeface="+mj-lt"/>
            </a:endParaRPr>
          </a:p>
        </p:txBody>
      </p:sp>
      <p:cxnSp>
        <p:nvCxnSpPr>
          <p:cNvPr id="15" name="Conector recto 14">
            <a:extLst>
              <a:ext uri="{FF2B5EF4-FFF2-40B4-BE49-F238E27FC236}">
                <a16:creationId xmlns:a16="http://schemas.microsoft.com/office/drawing/2014/main" id="{379AD6D3-BFB7-4E6F-97D8-146F4F43E58D}"/>
              </a:ext>
            </a:extLst>
          </p:cNvPr>
          <p:cNvCxnSpPr>
            <a:cxnSpLocks/>
          </p:cNvCxnSpPr>
          <p:nvPr/>
        </p:nvCxnSpPr>
        <p:spPr>
          <a:xfrm>
            <a:off x="609600" y="5437604"/>
            <a:ext cx="10337074"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cxnSp>
        <p:nvCxnSpPr>
          <p:cNvPr id="18" name="Conector recto de flecha 17">
            <a:extLst>
              <a:ext uri="{FF2B5EF4-FFF2-40B4-BE49-F238E27FC236}">
                <a16:creationId xmlns:a16="http://schemas.microsoft.com/office/drawing/2014/main" id="{FC4BDC6B-3C75-40F6-ABCE-91A51FF58F12}"/>
              </a:ext>
            </a:extLst>
          </p:cNvPr>
          <p:cNvCxnSpPr>
            <a:cxnSpLocks/>
          </p:cNvCxnSpPr>
          <p:nvPr/>
        </p:nvCxnSpPr>
        <p:spPr>
          <a:xfrm>
            <a:off x="1041142" y="1687032"/>
            <a:ext cx="319234" cy="302880"/>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cxnSp>
        <p:nvCxnSpPr>
          <p:cNvPr id="22" name="Conector recto de flecha 21">
            <a:extLst>
              <a:ext uri="{FF2B5EF4-FFF2-40B4-BE49-F238E27FC236}">
                <a16:creationId xmlns:a16="http://schemas.microsoft.com/office/drawing/2014/main" id="{B994412F-F9D8-499D-ACC9-BB61B98A3CF2}"/>
              </a:ext>
            </a:extLst>
          </p:cNvPr>
          <p:cNvCxnSpPr>
            <a:cxnSpLocks/>
          </p:cNvCxnSpPr>
          <p:nvPr/>
        </p:nvCxnSpPr>
        <p:spPr>
          <a:xfrm flipV="1">
            <a:off x="1453116" y="2619473"/>
            <a:ext cx="140843" cy="421439"/>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cxnSp>
        <p:nvCxnSpPr>
          <p:cNvPr id="23" name="Conector recto de flecha 22">
            <a:extLst>
              <a:ext uri="{FF2B5EF4-FFF2-40B4-BE49-F238E27FC236}">
                <a16:creationId xmlns:a16="http://schemas.microsoft.com/office/drawing/2014/main" id="{7683CAE4-2A0A-44B7-A2C5-32B16AF368BE}"/>
              </a:ext>
            </a:extLst>
          </p:cNvPr>
          <p:cNvCxnSpPr>
            <a:cxnSpLocks/>
          </p:cNvCxnSpPr>
          <p:nvPr/>
        </p:nvCxnSpPr>
        <p:spPr>
          <a:xfrm flipH="1">
            <a:off x="2937205" y="1772093"/>
            <a:ext cx="145794" cy="416197"/>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cxnSp>
        <p:nvCxnSpPr>
          <p:cNvPr id="28" name="Conector recto de flecha 27">
            <a:extLst>
              <a:ext uri="{FF2B5EF4-FFF2-40B4-BE49-F238E27FC236}">
                <a16:creationId xmlns:a16="http://schemas.microsoft.com/office/drawing/2014/main" id="{0EE09E8F-11A6-4DD9-9C21-7DE52F9EAA7B}"/>
              </a:ext>
            </a:extLst>
          </p:cNvPr>
          <p:cNvCxnSpPr>
            <a:cxnSpLocks/>
          </p:cNvCxnSpPr>
          <p:nvPr/>
        </p:nvCxnSpPr>
        <p:spPr>
          <a:xfrm flipH="1">
            <a:off x="9059225" y="1349513"/>
            <a:ext cx="271964" cy="361506"/>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01862480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75247" y="475820"/>
            <a:ext cx="665567" cy="369332"/>
          </a:xfrm>
          <a:prstGeom prst="rect">
            <a:avLst/>
          </a:prstGeom>
          <a:noFill/>
        </p:spPr>
        <p:txBody>
          <a:bodyPr wrap="none" rtlCol="0">
            <a:spAutoFit/>
          </a:bodyPr>
          <a:lstStyle/>
          <a:p>
            <a:r>
              <a:rPr lang="en-GB" b="1" dirty="0">
                <a:latin typeface="+mj-lt"/>
              </a:rPr>
              <a:t>Fig. K</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540923" cy="338554"/>
          </a:xfrm>
          <a:prstGeom prst="rect">
            <a:avLst/>
          </a:prstGeom>
          <a:noFill/>
        </p:spPr>
        <p:txBody>
          <a:bodyPr wrap="none" rtlCol="0">
            <a:spAutoFit/>
          </a:bodyPr>
          <a:lstStyle/>
          <a:p>
            <a:r>
              <a:rPr lang="en-GB" sz="1600" b="1" dirty="0">
                <a:latin typeface="+mj-lt"/>
              </a:rPr>
              <a:t>Supporting Information 1 – Excavation of the Layer IIIc</a:t>
            </a:r>
          </a:p>
        </p:txBody>
      </p:sp>
      <p:pic>
        <p:nvPicPr>
          <p:cNvPr id="3" name="Imagen 2" descr="Imagen que contiene suelo, exterior, rock, naturaleza&#10;&#10;Descripción generada automáticamente">
            <a:extLst>
              <a:ext uri="{FF2B5EF4-FFF2-40B4-BE49-F238E27FC236}">
                <a16:creationId xmlns:a16="http://schemas.microsoft.com/office/drawing/2014/main" id="{D1C2FC5F-8244-41CF-B3A2-D136B5DBD87E}"/>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475820"/>
            <a:ext cx="8853830" cy="5880529"/>
          </a:xfrm>
          <a:prstGeom prst="rect">
            <a:avLst/>
          </a:prstGeom>
        </p:spPr>
      </p:pic>
      <p:sp>
        <p:nvSpPr>
          <p:cNvPr id="12" name="CuadroTexto 11">
            <a:extLst>
              <a:ext uri="{FF2B5EF4-FFF2-40B4-BE49-F238E27FC236}">
                <a16:creationId xmlns:a16="http://schemas.microsoft.com/office/drawing/2014/main" id="{69697543-3240-4600-A3B3-31C30507DDAC}"/>
              </a:ext>
            </a:extLst>
          </p:cNvPr>
          <p:cNvSpPr txBox="1"/>
          <p:nvPr/>
        </p:nvSpPr>
        <p:spPr>
          <a:xfrm>
            <a:off x="9175247" y="1136750"/>
            <a:ext cx="2743201" cy="3539430"/>
          </a:xfrm>
          <a:prstGeom prst="rect">
            <a:avLst/>
          </a:prstGeom>
          <a:noFill/>
        </p:spPr>
        <p:txBody>
          <a:bodyPr wrap="square" rtlCol="0">
            <a:spAutoFit/>
          </a:bodyPr>
          <a:lstStyle/>
          <a:p>
            <a:pPr algn="just"/>
            <a:r>
              <a:rPr lang="en-GB" sz="1400" dirty="0"/>
              <a:t>Layer II excavation progresses allowed to document the baseline of the erosive process.</a:t>
            </a:r>
          </a:p>
          <a:p>
            <a:pPr algn="just"/>
            <a:endParaRPr lang="en-GB" sz="1400" dirty="0"/>
          </a:p>
          <a:p>
            <a:pPr algn="just"/>
            <a:r>
              <a:rPr lang="en-GB" sz="1400" dirty="0"/>
              <a:t>Unit IIIc was preserved in all the excavation hall.</a:t>
            </a:r>
          </a:p>
          <a:p>
            <a:pPr algn="just"/>
            <a:endParaRPr lang="en-GB" sz="1400" dirty="0"/>
          </a:p>
          <a:p>
            <a:pPr algn="just"/>
            <a:r>
              <a:rPr lang="en-GB" sz="1400" dirty="0"/>
              <a:t>At the image Layer IIIc is already uncovered in squares E–F6-7. Note the progressive enlargement of the SW Gallery. An accumulation of modern depositions was discovered at the end of the gallery.</a:t>
            </a:r>
          </a:p>
          <a:p>
            <a:pPr algn="just"/>
            <a:endParaRPr lang="en-GB" sz="1400" dirty="0"/>
          </a:p>
          <a:p>
            <a:pPr algn="just"/>
            <a:r>
              <a:rPr lang="en-GB" sz="1400" dirty="0"/>
              <a:t>Photo 2013</a:t>
            </a:r>
          </a:p>
        </p:txBody>
      </p:sp>
      <p:cxnSp>
        <p:nvCxnSpPr>
          <p:cNvPr id="8" name="Conector recto 7">
            <a:extLst>
              <a:ext uri="{FF2B5EF4-FFF2-40B4-BE49-F238E27FC236}">
                <a16:creationId xmlns:a16="http://schemas.microsoft.com/office/drawing/2014/main" id="{9E32CD03-BCAC-4B9B-AEAA-B0940CE5057F}"/>
              </a:ext>
            </a:extLst>
          </p:cNvPr>
          <p:cNvCxnSpPr>
            <a:cxnSpLocks/>
          </p:cNvCxnSpPr>
          <p:nvPr/>
        </p:nvCxnSpPr>
        <p:spPr>
          <a:xfrm>
            <a:off x="9290649" y="961249"/>
            <a:ext cx="2527540"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054BEC61-1A51-44DB-8BEF-29848115C937}"/>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1</a:t>
            </a:fld>
            <a:endParaRPr lang="en-GB" sz="1800" dirty="0">
              <a:latin typeface="+mj-lt"/>
            </a:endParaRPr>
          </a:p>
        </p:txBody>
      </p:sp>
      <p:sp>
        <p:nvSpPr>
          <p:cNvPr id="11" name="Forma libre: forma 10">
            <a:extLst>
              <a:ext uri="{FF2B5EF4-FFF2-40B4-BE49-F238E27FC236}">
                <a16:creationId xmlns:a16="http://schemas.microsoft.com/office/drawing/2014/main" id="{8CC11B91-F80F-42D9-BEA2-20BE6FFA8448}"/>
              </a:ext>
            </a:extLst>
          </p:cNvPr>
          <p:cNvSpPr/>
          <p:nvPr/>
        </p:nvSpPr>
        <p:spPr>
          <a:xfrm>
            <a:off x="361507" y="3551274"/>
            <a:ext cx="3246474" cy="2239926"/>
          </a:xfrm>
          <a:custGeom>
            <a:avLst/>
            <a:gdLst>
              <a:gd name="connsiteX0" fmla="*/ 1205023 w 3246474"/>
              <a:gd name="connsiteY0" fmla="*/ 0 h 2239926"/>
              <a:gd name="connsiteX1" fmla="*/ 1368056 w 3246474"/>
              <a:gd name="connsiteY1" fmla="*/ 113414 h 2239926"/>
              <a:gd name="connsiteX2" fmla="*/ 1495646 w 3246474"/>
              <a:gd name="connsiteY2" fmla="*/ 205563 h 2239926"/>
              <a:gd name="connsiteX3" fmla="*/ 1594884 w 3246474"/>
              <a:gd name="connsiteY3" fmla="*/ 248093 h 2239926"/>
              <a:gd name="connsiteX4" fmla="*/ 1658679 w 3246474"/>
              <a:gd name="connsiteY4" fmla="*/ 255182 h 2239926"/>
              <a:gd name="connsiteX5" fmla="*/ 1687033 w 3246474"/>
              <a:gd name="connsiteY5" fmla="*/ 368596 h 2239926"/>
              <a:gd name="connsiteX6" fmla="*/ 1623237 w 3246474"/>
              <a:gd name="connsiteY6" fmla="*/ 474921 h 2239926"/>
              <a:gd name="connsiteX7" fmla="*/ 1580707 w 3246474"/>
              <a:gd name="connsiteY7" fmla="*/ 595424 h 2239926"/>
              <a:gd name="connsiteX8" fmla="*/ 1502735 w 3246474"/>
              <a:gd name="connsiteY8" fmla="*/ 751368 h 2239926"/>
              <a:gd name="connsiteX9" fmla="*/ 1403498 w 3246474"/>
              <a:gd name="connsiteY9" fmla="*/ 829340 h 2239926"/>
              <a:gd name="connsiteX10" fmla="*/ 1410586 w 3246474"/>
              <a:gd name="connsiteY10" fmla="*/ 935666 h 2239926"/>
              <a:gd name="connsiteX11" fmla="*/ 1474381 w 3246474"/>
              <a:gd name="connsiteY11" fmla="*/ 1056168 h 2239926"/>
              <a:gd name="connsiteX12" fmla="*/ 1580707 w 3246474"/>
              <a:gd name="connsiteY12" fmla="*/ 1112875 h 2239926"/>
              <a:gd name="connsiteX13" fmla="*/ 1672856 w 3246474"/>
              <a:gd name="connsiteY13" fmla="*/ 1183759 h 2239926"/>
              <a:gd name="connsiteX14" fmla="*/ 1814623 w 3246474"/>
              <a:gd name="connsiteY14" fmla="*/ 1212112 h 2239926"/>
              <a:gd name="connsiteX15" fmla="*/ 1977656 w 3246474"/>
              <a:gd name="connsiteY15" fmla="*/ 1247554 h 2239926"/>
              <a:gd name="connsiteX16" fmla="*/ 2282456 w 3246474"/>
              <a:gd name="connsiteY16" fmla="*/ 1205024 h 2239926"/>
              <a:gd name="connsiteX17" fmla="*/ 2417135 w 3246474"/>
              <a:gd name="connsiteY17" fmla="*/ 1091610 h 2239926"/>
              <a:gd name="connsiteX18" fmla="*/ 2516372 w 3246474"/>
              <a:gd name="connsiteY18" fmla="*/ 978196 h 2239926"/>
              <a:gd name="connsiteX19" fmla="*/ 2658140 w 3246474"/>
              <a:gd name="connsiteY19" fmla="*/ 1027814 h 2239926"/>
              <a:gd name="connsiteX20" fmla="*/ 2729023 w 3246474"/>
              <a:gd name="connsiteY20" fmla="*/ 971107 h 2239926"/>
              <a:gd name="connsiteX21" fmla="*/ 2821172 w 3246474"/>
              <a:gd name="connsiteY21" fmla="*/ 871870 h 2239926"/>
              <a:gd name="connsiteX22" fmla="*/ 2962940 w 3246474"/>
              <a:gd name="connsiteY22" fmla="*/ 779721 h 2239926"/>
              <a:gd name="connsiteX23" fmla="*/ 3090530 w 3246474"/>
              <a:gd name="connsiteY23" fmla="*/ 715926 h 2239926"/>
              <a:gd name="connsiteX24" fmla="*/ 3211033 w 3246474"/>
              <a:gd name="connsiteY24" fmla="*/ 666307 h 2239926"/>
              <a:gd name="connsiteX25" fmla="*/ 3246474 w 3246474"/>
              <a:gd name="connsiteY25" fmla="*/ 673396 h 2239926"/>
              <a:gd name="connsiteX26" fmla="*/ 3203944 w 3246474"/>
              <a:gd name="connsiteY26" fmla="*/ 723014 h 2239926"/>
              <a:gd name="connsiteX27" fmla="*/ 3182679 w 3246474"/>
              <a:gd name="connsiteY27" fmla="*/ 800986 h 2239926"/>
              <a:gd name="connsiteX28" fmla="*/ 3111795 w 3246474"/>
              <a:gd name="connsiteY28" fmla="*/ 850605 h 2239926"/>
              <a:gd name="connsiteX29" fmla="*/ 3069265 w 3246474"/>
              <a:gd name="connsiteY29" fmla="*/ 914400 h 2239926"/>
              <a:gd name="connsiteX30" fmla="*/ 3005470 w 3246474"/>
              <a:gd name="connsiteY30" fmla="*/ 928577 h 2239926"/>
              <a:gd name="connsiteX31" fmla="*/ 2934586 w 3246474"/>
              <a:gd name="connsiteY31" fmla="*/ 956931 h 2239926"/>
              <a:gd name="connsiteX32" fmla="*/ 2870791 w 3246474"/>
              <a:gd name="connsiteY32" fmla="*/ 1049079 h 2239926"/>
              <a:gd name="connsiteX33" fmla="*/ 2799907 w 3246474"/>
              <a:gd name="connsiteY33" fmla="*/ 1127052 h 2239926"/>
              <a:gd name="connsiteX34" fmla="*/ 2714846 w 3246474"/>
              <a:gd name="connsiteY34" fmla="*/ 1205024 h 2239926"/>
              <a:gd name="connsiteX35" fmla="*/ 2700670 w 3246474"/>
              <a:gd name="connsiteY35" fmla="*/ 1417675 h 2239926"/>
              <a:gd name="connsiteX36" fmla="*/ 2750288 w 3246474"/>
              <a:gd name="connsiteY36" fmla="*/ 1765005 h 2239926"/>
              <a:gd name="connsiteX37" fmla="*/ 2785730 w 3246474"/>
              <a:gd name="connsiteY37" fmla="*/ 1963479 h 2239926"/>
              <a:gd name="connsiteX38" fmla="*/ 2792819 w 3246474"/>
              <a:gd name="connsiteY38" fmla="*/ 2154866 h 2239926"/>
              <a:gd name="connsiteX39" fmla="*/ 2743200 w 3246474"/>
              <a:gd name="connsiteY39" fmla="*/ 2197396 h 2239926"/>
              <a:gd name="connsiteX40" fmla="*/ 2707758 w 3246474"/>
              <a:gd name="connsiteY40" fmla="*/ 2232838 h 2239926"/>
              <a:gd name="connsiteX41" fmla="*/ 2622698 w 3246474"/>
              <a:gd name="connsiteY41" fmla="*/ 2239926 h 2239926"/>
              <a:gd name="connsiteX42" fmla="*/ 2530549 w 3246474"/>
              <a:gd name="connsiteY42" fmla="*/ 2176131 h 2239926"/>
              <a:gd name="connsiteX43" fmla="*/ 2445488 w 3246474"/>
              <a:gd name="connsiteY43" fmla="*/ 2112335 h 2239926"/>
              <a:gd name="connsiteX44" fmla="*/ 2332074 w 3246474"/>
              <a:gd name="connsiteY44" fmla="*/ 2041452 h 2239926"/>
              <a:gd name="connsiteX45" fmla="*/ 2296633 w 3246474"/>
              <a:gd name="connsiteY45" fmla="*/ 2034363 h 2239926"/>
              <a:gd name="connsiteX46" fmla="*/ 2296633 w 3246474"/>
              <a:gd name="connsiteY46" fmla="*/ 1956391 h 2239926"/>
              <a:gd name="connsiteX47" fmla="*/ 2261191 w 3246474"/>
              <a:gd name="connsiteY47" fmla="*/ 1814624 h 2239926"/>
              <a:gd name="connsiteX48" fmla="*/ 2218660 w 3246474"/>
              <a:gd name="connsiteY48" fmla="*/ 1729563 h 2239926"/>
              <a:gd name="connsiteX49" fmla="*/ 2218660 w 3246474"/>
              <a:gd name="connsiteY49" fmla="*/ 1729563 h 2239926"/>
              <a:gd name="connsiteX50" fmla="*/ 2147777 w 3246474"/>
              <a:gd name="connsiteY50" fmla="*/ 1559442 h 2239926"/>
              <a:gd name="connsiteX51" fmla="*/ 2069805 w 3246474"/>
              <a:gd name="connsiteY51" fmla="*/ 1460205 h 2239926"/>
              <a:gd name="connsiteX52" fmla="*/ 1970567 w 3246474"/>
              <a:gd name="connsiteY52" fmla="*/ 1417675 h 2239926"/>
              <a:gd name="connsiteX53" fmla="*/ 1850065 w 3246474"/>
              <a:gd name="connsiteY53" fmla="*/ 1396410 h 2239926"/>
              <a:gd name="connsiteX54" fmla="*/ 1729563 w 3246474"/>
              <a:gd name="connsiteY54" fmla="*/ 1375145 h 2239926"/>
              <a:gd name="connsiteX55" fmla="*/ 1679944 w 3246474"/>
              <a:gd name="connsiteY55" fmla="*/ 1346791 h 2239926"/>
              <a:gd name="connsiteX56" fmla="*/ 1616149 w 3246474"/>
              <a:gd name="connsiteY56" fmla="*/ 1339703 h 2239926"/>
              <a:gd name="connsiteX57" fmla="*/ 1502735 w 3246474"/>
              <a:gd name="connsiteY57" fmla="*/ 1332614 h 2239926"/>
              <a:gd name="connsiteX58" fmla="*/ 1368056 w 3246474"/>
              <a:gd name="connsiteY58" fmla="*/ 1339703 h 2239926"/>
              <a:gd name="connsiteX59" fmla="*/ 1226288 w 3246474"/>
              <a:gd name="connsiteY59" fmla="*/ 1360968 h 2239926"/>
              <a:gd name="connsiteX60" fmla="*/ 1134140 w 3246474"/>
              <a:gd name="connsiteY60" fmla="*/ 1368056 h 2239926"/>
              <a:gd name="connsiteX61" fmla="*/ 914400 w 3246474"/>
              <a:gd name="connsiteY61" fmla="*/ 1346791 h 2239926"/>
              <a:gd name="connsiteX62" fmla="*/ 836428 w 3246474"/>
              <a:gd name="connsiteY62" fmla="*/ 1339703 h 2239926"/>
              <a:gd name="connsiteX63" fmla="*/ 708837 w 3246474"/>
              <a:gd name="connsiteY63" fmla="*/ 1339703 h 2239926"/>
              <a:gd name="connsiteX64" fmla="*/ 482009 w 3246474"/>
              <a:gd name="connsiteY64" fmla="*/ 1304261 h 2239926"/>
              <a:gd name="connsiteX65" fmla="*/ 318977 w 3246474"/>
              <a:gd name="connsiteY65" fmla="*/ 1275907 h 2239926"/>
              <a:gd name="connsiteX66" fmla="*/ 163033 w 3246474"/>
              <a:gd name="connsiteY66" fmla="*/ 1226289 h 2239926"/>
              <a:gd name="connsiteX67" fmla="*/ 85060 w 3246474"/>
              <a:gd name="connsiteY67" fmla="*/ 1183759 h 2239926"/>
              <a:gd name="connsiteX68" fmla="*/ 0 w 3246474"/>
              <a:gd name="connsiteY68" fmla="*/ 1148317 h 2239926"/>
              <a:gd name="connsiteX69" fmla="*/ 63795 w 3246474"/>
              <a:gd name="connsiteY69" fmla="*/ 1006549 h 2239926"/>
              <a:gd name="connsiteX70" fmla="*/ 113414 w 3246474"/>
              <a:gd name="connsiteY70" fmla="*/ 921489 h 2239926"/>
              <a:gd name="connsiteX71" fmla="*/ 184298 w 3246474"/>
              <a:gd name="connsiteY71" fmla="*/ 786810 h 2239926"/>
              <a:gd name="connsiteX72" fmla="*/ 219740 w 3246474"/>
              <a:gd name="connsiteY72" fmla="*/ 630866 h 2239926"/>
              <a:gd name="connsiteX73" fmla="*/ 347330 w 3246474"/>
              <a:gd name="connsiteY73" fmla="*/ 418214 h 2239926"/>
              <a:gd name="connsiteX74" fmla="*/ 474921 w 3246474"/>
              <a:gd name="connsiteY74" fmla="*/ 297712 h 2239926"/>
              <a:gd name="connsiteX75" fmla="*/ 800986 w 3246474"/>
              <a:gd name="connsiteY75" fmla="*/ 134679 h 2239926"/>
              <a:gd name="connsiteX76" fmla="*/ 978195 w 3246474"/>
              <a:gd name="connsiteY76" fmla="*/ 49619 h 2239926"/>
              <a:gd name="connsiteX77" fmla="*/ 1119963 w 3246474"/>
              <a:gd name="connsiteY77" fmla="*/ 14177 h 2239926"/>
              <a:gd name="connsiteX78" fmla="*/ 1205023 w 3246474"/>
              <a:gd name="connsiteY78" fmla="*/ 0 h 223992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Lst>
            <a:rect l="l" t="t" r="r" b="b"/>
            <a:pathLst>
              <a:path w="3246474" h="2239926">
                <a:moveTo>
                  <a:pt x="1205023" y="0"/>
                </a:moveTo>
                <a:lnTo>
                  <a:pt x="1368056" y="113414"/>
                </a:lnTo>
                <a:lnTo>
                  <a:pt x="1495646" y="205563"/>
                </a:lnTo>
                <a:lnTo>
                  <a:pt x="1594884" y="248093"/>
                </a:lnTo>
                <a:lnTo>
                  <a:pt x="1658679" y="255182"/>
                </a:lnTo>
                <a:lnTo>
                  <a:pt x="1687033" y="368596"/>
                </a:lnTo>
                <a:lnTo>
                  <a:pt x="1623237" y="474921"/>
                </a:lnTo>
                <a:lnTo>
                  <a:pt x="1580707" y="595424"/>
                </a:lnTo>
                <a:lnTo>
                  <a:pt x="1502735" y="751368"/>
                </a:lnTo>
                <a:lnTo>
                  <a:pt x="1403498" y="829340"/>
                </a:lnTo>
                <a:lnTo>
                  <a:pt x="1410586" y="935666"/>
                </a:lnTo>
                <a:lnTo>
                  <a:pt x="1474381" y="1056168"/>
                </a:lnTo>
                <a:lnTo>
                  <a:pt x="1580707" y="1112875"/>
                </a:lnTo>
                <a:lnTo>
                  <a:pt x="1672856" y="1183759"/>
                </a:lnTo>
                <a:lnTo>
                  <a:pt x="1814623" y="1212112"/>
                </a:lnTo>
                <a:lnTo>
                  <a:pt x="1977656" y="1247554"/>
                </a:lnTo>
                <a:lnTo>
                  <a:pt x="2282456" y="1205024"/>
                </a:lnTo>
                <a:lnTo>
                  <a:pt x="2417135" y="1091610"/>
                </a:lnTo>
                <a:lnTo>
                  <a:pt x="2516372" y="978196"/>
                </a:lnTo>
                <a:lnTo>
                  <a:pt x="2658140" y="1027814"/>
                </a:lnTo>
                <a:lnTo>
                  <a:pt x="2729023" y="971107"/>
                </a:lnTo>
                <a:lnTo>
                  <a:pt x="2821172" y="871870"/>
                </a:lnTo>
                <a:lnTo>
                  <a:pt x="2962940" y="779721"/>
                </a:lnTo>
                <a:lnTo>
                  <a:pt x="3090530" y="715926"/>
                </a:lnTo>
                <a:lnTo>
                  <a:pt x="3211033" y="666307"/>
                </a:lnTo>
                <a:lnTo>
                  <a:pt x="3246474" y="673396"/>
                </a:lnTo>
                <a:lnTo>
                  <a:pt x="3203944" y="723014"/>
                </a:lnTo>
                <a:lnTo>
                  <a:pt x="3182679" y="800986"/>
                </a:lnTo>
                <a:lnTo>
                  <a:pt x="3111795" y="850605"/>
                </a:lnTo>
                <a:lnTo>
                  <a:pt x="3069265" y="914400"/>
                </a:lnTo>
                <a:lnTo>
                  <a:pt x="3005470" y="928577"/>
                </a:lnTo>
                <a:lnTo>
                  <a:pt x="2934586" y="956931"/>
                </a:lnTo>
                <a:lnTo>
                  <a:pt x="2870791" y="1049079"/>
                </a:lnTo>
                <a:lnTo>
                  <a:pt x="2799907" y="1127052"/>
                </a:lnTo>
                <a:lnTo>
                  <a:pt x="2714846" y="1205024"/>
                </a:lnTo>
                <a:lnTo>
                  <a:pt x="2700670" y="1417675"/>
                </a:lnTo>
                <a:lnTo>
                  <a:pt x="2750288" y="1765005"/>
                </a:lnTo>
                <a:lnTo>
                  <a:pt x="2785730" y="1963479"/>
                </a:lnTo>
                <a:lnTo>
                  <a:pt x="2792819" y="2154866"/>
                </a:lnTo>
                <a:lnTo>
                  <a:pt x="2743200" y="2197396"/>
                </a:lnTo>
                <a:lnTo>
                  <a:pt x="2707758" y="2232838"/>
                </a:lnTo>
                <a:lnTo>
                  <a:pt x="2622698" y="2239926"/>
                </a:lnTo>
                <a:lnTo>
                  <a:pt x="2530549" y="2176131"/>
                </a:lnTo>
                <a:lnTo>
                  <a:pt x="2445488" y="2112335"/>
                </a:lnTo>
                <a:lnTo>
                  <a:pt x="2332074" y="2041452"/>
                </a:lnTo>
                <a:lnTo>
                  <a:pt x="2296633" y="2034363"/>
                </a:lnTo>
                <a:lnTo>
                  <a:pt x="2296633" y="1956391"/>
                </a:lnTo>
                <a:lnTo>
                  <a:pt x="2261191" y="1814624"/>
                </a:lnTo>
                <a:lnTo>
                  <a:pt x="2218660" y="1729563"/>
                </a:lnTo>
                <a:lnTo>
                  <a:pt x="2218660" y="1729563"/>
                </a:lnTo>
                <a:lnTo>
                  <a:pt x="2147777" y="1559442"/>
                </a:lnTo>
                <a:lnTo>
                  <a:pt x="2069805" y="1460205"/>
                </a:lnTo>
                <a:lnTo>
                  <a:pt x="1970567" y="1417675"/>
                </a:lnTo>
                <a:lnTo>
                  <a:pt x="1850065" y="1396410"/>
                </a:lnTo>
                <a:lnTo>
                  <a:pt x="1729563" y="1375145"/>
                </a:lnTo>
                <a:lnTo>
                  <a:pt x="1679944" y="1346791"/>
                </a:lnTo>
                <a:lnTo>
                  <a:pt x="1616149" y="1339703"/>
                </a:lnTo>
                <a:lnTo>
                  <a:pt x="1502735" y="1332614"/>
                </a:lnTo>
                <a:lnTo>
                  <a:pt x="1368056" y="1339703"/>
                </a:lnTo>
                <a:lnTo>
                  <a:pt x="1226288" y="1360968"/>
                </a:lnTo>
                <a:lnTo>
                  <a:pt x="1134140" y="1368056"/>
                </a:lnTo>
                <a:lnTo>
                  <a:pt x="914400" y="1346791"/>
                </a:lnTo>
                <a:cubicBezTo>
                  <a:pt x="845908" y="1339181"/>
                  <a:pt x="872001" y="1339703"/>
                  <a:pt x="836428" y="1339703"/>
                </a:cubicBezTo>
                <a:lnTo>
                  <a:pt x="708837" y="1339703"/>
                </a:lnTo>
                <a:lnTo>
                  <a:pt x="482009" y="1304261"/>
                </a:lnTo>
                <a:lnTo>
                  <a:pt x="318977" y="1275907"/>
                </a:lnTo>
                <a:lnTo>
                  <a:pt x="163033" y="1226289"/>
                </a:lnTo>
                <a:lnTo>
                  <a:pt x="85060" y="1183759"/>
                </a:lnTo>
                <a:lnTo>
                  <a:pt x="0" y="1148317"/>
                </a:lnTo>
                <a:lnTo>
                  <a:pt x="63795" y="1006549"/>
                </a:lnTo>
                <a:lnTo>
                  <a:pt x="113414" y="921489"/>
                </a:lnTo>
                <a:lnTo>
                  <a:pt x="184298" y="786810"/>
                </a:lnTo>
                <a:lnTo>
                  <a:pt x="219740" y="630866"/>
                </a:lnTo>
                <a:lnTo>
                  <a:pt x="347330" y="418214"/>
                </a:lnTo>
                <a:lnTo>
                  <a:pt x="474921" y="297712"/>
                </a:lnTo>
                <a:lnTo>
                  <a:pt x="800986" y="134679"/>
                </a:lnTo>
                <a:lnTo>
                  <a:pt x="978195" y="49619"/>
                </a:lnTo>
                <a:lnTo>
                  <a:pt x="1119963" y="14177"/>
                </a:lnTo>
                <a:lnTo>
                  <a:pt x="1205023" y="0"/>
                </a:lnTo>
                <a:close/>
              </a:path>
            </a:pathLst>
          </a:custGeom>
          <a:noFill/>
          <a:ln>
            <a:solidFill>
              <a:schemeClr val="bg1"/>
            </a:solidFill>
            <a:prstDash val="lgDashDot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Forma libre: forma 12">
            <a:extLst>
              <a:ext uri="{FF2B5EF4-FFF2-40B4-BE49-F238E27FC236}">
                <a16:creationId xmlns:a16="http://schemas.microsoft.com/office/drawing/2014/main" id="{9D2180C9-251D-4BE2-953F-4AED6453A81E}"/>
              </a:ext>
            </a:extLst>
          </p:cNvPr>
          <p:cNvSpPr/>
          <p:nvPr/>
        </p:nvSpPr>
        <p:spPr>
          <a:xfrm>
            <a:off x="4026195" y="4593265"/>
            <a:ext cx="779721" cy="680484"/>
          </a:xfrm>
          <a:custGeom>
            <a:avLst/>
            <a:gdLst>
              <a:gd name="connsiteX0" fmla="*/ 524540 w 779721"/>
              <a:gd name="connsiteY0" fmla="*/ 7088 h 680484"/>
              <a:gd name="connsiteX1" fmla="*/ 354419 w 779721"/>
              <a:gd name="connsiteY1" fmla="*/ 0 h 680484"/>
              <a:gd name="connsiteX2" fmla="*/ 212652 w 779721"/>
              <a:gd name="connsiteY2" fmla="*/ 7088 h 680484"/>
              <a:gd name="connsiteX3" fmla="*/ 0 w 779721"/>
              <a:gd name="connsiteY3" fmla="*/ 56707 h 680484"/>
              <a:gd name="connsiteX4" fmla="*/ 0 w 779721"/>
              <a:gd name="connsiteY4" fmla="*/ 56707 h 680484"/>
              <a:gd name="connsiteX5" fmla="*/ 28354 w 779721"/>
              <a:gd name="connsiteY5" fmla="*/ 170121 h 680484"/>
              <a:gd name="connsiteX6" fmla="*/ 99238 w 779721"/>
              <a:gd name="connsiteY6" fmla="*/ 276447 h 680484"/>
              <a:gd name="connsiteX7" fmla="*/ 120503 w 779721"/>
              <a:gd name="connsiteY7" fmla="*/ 368595 h 680484"/>
              <a:gd name="connsiteX8" fmla="*/ 155945 w 779721"/>
              <a:gd name="connsiteY8" fmla="*/ 453656 h 680484"/>
              <a:gd name="connsiteX9" fmla="*/ 155945 w 779721"/>
              <a:gd name="connsiteY9" fmla="*/ 552893 h 680484"/>
              <a:gd name="connsiteX10" fmla="*/ 155945 w 779721"/>
              <a:gd name="connsiteY10" fmla="*/ 630865 h 680484"/>
              <a:gd name="connsiteX11" fmla="*/ 241005 w 779721"/>
              <a:gd name="connsiteY11" fmla="*/ 637954 h 680484"/>
              <a:gd name="connsiteX12" fmla="*/ 368596 w 779721"/>
              <a:gd name="connsiteY12" fmla="*/ 659219 h 680484"/>
              <a:gd name="connsiteX13" fmla="*/ 496186 w 779721"/>
              <a:gd name="connsiteY13" fmla="*/ 673395 h 680484"/>
              <a:gd name="connsiteX14" fmla="*/ 616689 w 779721"/>
              <a:gd name="connsiteY14" fmla="*/ 680484 h 680484"/>
              <a:gd name="connsiteX15" fmla="*/ 701749 w 779721"/>
              <a:gd name="connsiteY15" fmla="*/ 680484 h 680484"/>
              <a:gd name="connsiteX16" fmla="*/ 779721 w 779721"/>
              <a:gd name="connsiteY16" fmla="*/ 637954 h 680484"/>
              <a:gd name="connsiteX17" fmla="*/ 751368 w 779721"/>
              <a:gd name="connsiteY17" fmla="*/ 524540 h 680484"/>
              <a:gd name="connsiteX18" fmla="*/ 666307 w 779721"/>
              <a:gd name="connsiteY18" fmla="*/ 467833 h 680484"/>
              <a:gd name="connsiteX19" fmla="*/ 602512 w 779721"/>
              <a:gd name="connsiteY19" fmla="*/ 411126 h 680484"/>
              <a:gd name="connsiteX20" fmla="*/ 574158 w 779721"/>
              <a:gd name="connsiteY20" fmla="*/ 269358 h 680484"/>
              <a:gd name="connsiteX21" fmla="*/ 574158 w 779721"/>
              <a:gd name="connsiteY21" fmla="*/ 155944 h 680484"/>
              <a:gd name="connsiteX22" fmla="*/ 574158 w 779721"/>
              <a:gd name="connsiteY22" fmla="*/ 77972 h 680484"/>
              <a:gd name="connsiteX23" fmla="*/ 524540 w 779721"/>
              <a:gd name="connsiteY23" fmla="*/ 7088 h 68048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Lst>
            <a:rect l="l" t="t" r="r" b="b"/>
            <a:pathLst>
              <a:path w="779721" h="680484">
                <a:moveTo>
                  <a:pt x="524540" y="7088"/>
                </a:moveTo>
                <a:lnTo>
                  <a:pt x="354419" y="0"/>
                </a:lnTo>
                <a:lnTo>
                  <a:pt x="212652" y="7088"/>
                </a:lnTo>
                <a:lnTo>
                  <a:pt x="0" y="56707"/>
                </a:lnTo>
                <a:lnTo>
                  <a:pt x="0" y="56707"/>
                </a:lnTo>
                <a:lnTo>
                  <a:pt x="28354" y="170121"/>
                </a:lnTo>
                <a:lnTo>
                  <a:pt x="99238" y="276447"/>
                </a:lnTo>
                <a:lnTo>
                  <a:pt x="120503" y="368595"/>
                </a:lnTo>
                <a:lnTo>
                  <a:pt x="155945" y="453656"/>
                </a:lnTo>
                <a:lnTo>
                  <a:pt x="155945" y="552893"/>
                </a:lnTo>
                <a:lnTo>
                  <a:pt x="155945" y="630865"/>
                </a:lnTo>
                <a:lnTo>
                  <a:pt x="241005" y="637954"/>
                </a:lnTo>
                <a:lnTo>
                  <a:pt x="368596" y="659219"/>
                </a:lnTo>
                <a:lnTo>
                  <a:pt x="496186" y="673395"/>
                </a:lnTo>
                <a:lnTo>
                  <a:pt x="616689" y="680484"/>
                </a:lnTo>
                <a:lnTo>
                  <a:pt x="701749" y="680484"/>
                </a:lnTo>
                <a:lnTo>
                  <a:pt x="779721" y="637954"/>
                </a:lnTo>
                <a:lnTo>
                  <a:pt x="751368" y="524540"/>
                </a:lnTo>
                <a:lnTo>
                  <a:pt x="666307" y="467833"/>
                </a:lnTo>
                <a:lnTo>
                  <a:pt x="602512" y="411126"/>
                </a:lnTo>
                <a:lnTo>
                  <a:pt x="574158" y="269358"/>
                </a:lnTo>
                <a:lnTo>
                  <a:pt x="574158" y="155944"/>
                </a:lnTo>
                <a:lnTo>
                  <a:pt x="574158" y="77972"/>
                </a:lnTo>
                <a:lnTo>
                  <a:pt x="524540" y="7088"/>
                </a:lnTo>
                <a:close/>
              </a:path>
            </a:pathLst>
          </a:custGeom>
          <a:noFill/>
          <a:ln>
            <a:solidFill>
              <a:schemeClr val="bg1"/>
            </a:solidFill>
            <a:prstDash val="lgDashDot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4" name="Conector recto de flecha 13">
            <a:extLst>
              <a:ext uri="{FF2B5EF4-FFF2-40B4-BE49-F238E27FC236}">
                <a16:creationId xmlns:a16="http://schemas.microsoft.com/office/drawing/2014/main" id="{5D19ECAD-B433-43A4-9427-8B3CF5D36D2E}"/>
              </a:ext>
            </a:extLst>
          </p:cNvPr>
          <p:cNvCxnSpPr>
            <a:cxnSpLocks/>
          </p:cNvCxnSpPr>
          <p:nvPr/>
        </p:nvCxnSpPr>
        <p:spPr>
          <a:xfrm flipV="1">
            <a:off x="7336465" y="2198549"/>
            <a:ext cx="130012" cy="515026"/>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sp>
        <p:nvSpPr>
          <p:cNvPr id="15" name="CuadroTexto 14">
            <a:extLst>
              <a:ext uri="{FF2B5EF4-FFF2-40B4-BE49-F238E27FC236}">
                <a16:creationId xmlns:a16="http://schemas.microsoft.com/office/drawing/2014/main" id="{F77ADE21-6EAD-434F-96B9-2BD0F062D055}"/>
              </a:ext>
            </a:extLst>
          </p:cNvPr>
          <p:cNvSpPr txBox="1"/>
          <p:nvPr/>
        </p:nvSpPr>
        <p:spPr>
          <a:xfrm>
            <a:off x="7401471" y="2295756"/>
            <a:ext cx="683230" cy="461665"/>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SW</a:t>
            </a:r>
          </a:p>
          <a:p>
            <a:r>
              <a:rPr lang="en-GB" sz="1200" dirty="0">
                <a:solidFill>
                  <a:schemeClr val="bg1">
                    <a:lumMod val="95000"/>
                  </a:schemeClr>
                </a:solidFill>
                <a:effectLst>
                  <a:outerShdw blurRad="38100" dist="38100" dir="2700000" algn="tl">
                    <a:srgbClr val="000000">
                      <a:alpha val="43137"/>
                    </a:srgbClr>
                  </a:outerShdw>
                </a:effectLst>
                <a:latin typeface="+mj-lt"/>
              </a:rPr>
              <a:t>gallery</a:t>
            </a:r>
          </a:p>
        </p:txBody>
      </p:sp>
      <p:sp>
        <p:nvSpPr>
          <p:cNvPr id="20" name="CuadroTexto 19">
            <a:extLst>
              <a:ext uri="{FF2B5EF4-FFF2-40B4-BE49-F238E27FC236}">
                <a16:creationId xmlns:a16="http://schemas.microsoft.com/office/drawing/2014/main" id="{F40A50FE-09C9-4FF4-AEE7-521E51A3D3B9}"/>
              </a:ext>
            </a:extLst>
          </p:cNvPr>
          <p:cNvSpPr txBox="1"/>
          <p:nvPr/>
        </p:nvSpPr>
        <p:spPr>
          <a:xfrm>
            <a:off x="402137" y="4468941"/>
            <a:ext cx="733644"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Layer IIIc</a:t>
            </a:r>
          </a:p>
        </p:txBody>
      </p:sp>
    </p:spTree>
    <p:extLst>
      <p:ext uri="{BB962C8B-B14F-4D97-AF65-F5344CB8AC3E}">
        <p14:creationId xmlns:p14="http://schemas.microsoft.com/office/powerpoint/2010/main" val="260473706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87132" y="563880"/>
            <a:ext cx="646331" cy="369332"/>
          </a:xfrm>
          <a:prstGeom prst="rect">
            <a:avLst/>
          </a:prstGeom>
          <a:noFill/>
        </p:spPr>
        <p:txBody>
          <a:bodyPr wrap="none" rtlCol="0">
            <a:spAutoFit/>
          </a:bodyPr>
          <a:lstStyle/>
          <a:p>
            <a:r>
              <a:rPr lang="en-GB" b="1" dirty="0">
                <a:latin typeface="+mj-lt"/>
              </a:rPr>
              <a:t>Fig. L</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540923" cy="338554"/>
          </a:xfrm>
          <a:prstGeom prst="rect">
            <a:avLst/>
          </a:prstGeom>
          <a:noFill/>
        </p:spPr>
        <p:txBody>
          <a:bodyPr wrap="none" rtlCol="0">
            <a:spAutoFit/>
          </a:bodyPr>
          <a:lstStyle/>
          <a:p>
            <a:r>
              <a:rPr lang="en-GB" sz="1600" b="1" dirty="0">
                <a:latin typeface="+mj-lt"/>
              </a:rPr>
              <a:t>Supporting Information 1 – Excavation of the Layer IIIc</a:t>
            </a:r>
          </a:p>
        </p:txBody>
      </p:sp>
      <p:pic>
        <p:nvPicPr>
          <p:cNvPr id="4" name="Imagen 3" descr="Imagen que contiene rock, suelo, naturaleza, exterior&#10;&#10;Descripción generada automáticamente">
            <a:extLst>
              <a:ext uri="{FF2B5EF4-FFF2-40B4-BE49-F238E27FC236}">
                <a16:creationId xmlns:a16="http://schemas.microsoft.com/office/drawing/2014/main" id="{21C93785-D524-4BBA-9743-500B8F367BEC}"/>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63880"/>
            <a:ext cx="8866099" cy="5888678"/>
          </a:xfrm>
          <a:prstGeom prst="rect">
            <a:avLst/>
          </a:prstGeom>
        </p:spPr>
      </p:pic>
      <p:sp>
        <p:nvSpPr>
          <p:cNvPr id="8" name="CuadroTexto 7">
            <a:extLst>
              <a:ext uri="{FF2B5EF4-FFF2-40B4-BE49-F238E27FC236}">
                <a16:creationId xmlns:a16="http://schemas.microsoft.com/office/drawing/2014/main" id="{CD134B48-A029-46CE-96AC-68391D39A390}"/>
              </a:ext>
            </a:extLst>
          </p:cNvPr>
          <p:cNvSpPr txBox="1"/>
          <p:nvPr/>
        </p:nvSpPr>
        <p:spPr>
          <a:xfrm>
            <a:off x="9187132" y="1171253"/>
            <a:ext cx="2743200" cy="2677656"/>
          </a:xfrm>
          <a:prstGeom prst="rect">
            <a:avLst/>
          </a:prstGeom>
          <a:noFill/>
        </p:spPr>
        <p:txBody>
          <a:bodyPr wrap="square" rtlCol="0">
            <a:spAutoFit/>
          </a:bodyPr>
          <a:lstStyle/>
          <a:p>
            <a:pPr algn="just"/>
            <a:r>
              <a:rPr lang="en-GB" sz="1400" dirty="0"/>
              <a:t>Same surface of Fig. 11 viewed from the lower entrance of the cave. Note the lateral contact between the Travertine Platform 2 and the top of Unit IIIc at the squares E6-7.</a:t>
            </a:r>
          </a:p>
          <a:p>
            <a:pPr algn="just"/>
            <a:endParaRPr lang="en-GB" sz="1400" dirty="0"/>
          </a:p>
          <a:p>
            <a:pPr algn="just"/>
            <a:r>
              <a:rPr lang="en-GB" sz="1400" dirty="0"/>
              <a:t>In square D7 a large calcarenite boulder appears embedded in the Travertine Platform 2.</a:t>
            </a:r>
          </a:p>
          <a:p>
            <a:pPr algn="just"/>
            <a:endParaRPr lang="en-GB" sz="1400" dirty="0"/>
          </a:p>
          <a:p>
            <a:pPr algn="just"/>
            <a:r>
              <a:rPr lang="en-GB" sz="1400" dirty="0"/>
              <a:t>Photo 2013</a:t>
            </a:r>
          </a:p>
        </p:txBody>
      </p:sp>
      <p:sp>
        <p:nvSpPr>
          <p:cNvPr id="9" name="Marcador de número de diapositiva 1">
            <a:extLst>
              <a:ext uri="{FF2B5EF4-FFF2-40B4-BE49-F238E27FC236}">
                <a16:creationId xmlns:a16="http://schemas.microsoft.com/office/drawing/2014/main" id="{B82CA020-A18E-4426-891A-8AF37C84B686}"/>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2</a:t>
            </a:fld>
            <a:endParaRPr lang="en-GB" sz="1800" dirty="0">
              <a:latin typeface="+mj-lt"/>
            </a:endParaRPr>
          </a:p>
        </p:txBody>
      </p:sp>
      <p:cxnSp>
        <p:nvCxnSpPr>
          <p:cNvPr id="10" name="Conector recto 9">
            <a:extLst>
              <a:ext uri="{FF2B5EF4-FFF2-40B4-BE49-F238E27FC236}">
                <a16:creationId xmlns:a16="http://schemas.microsoft.com/office/drawing/2014/main" id="{F6CE471A-DA94-4906-9FB1-74C5701A9BA9}"/>
              </a:ext>
            </a:extLst>
          </p:cNvPr>
          <p:cNvCxnSpPr>
            <a:cxnSpLocks/>
          </p:cNvCxnSpPr>
          <p:nvPr/>
        </p:nvCxnSpPr>
        <p:spPr>
          <a:xfrm>
            <a:off x="9282023" y="1064766"/>
            <a:ext cx="2527539"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2" name="CuadroTexto 11">
            <a:extLst>
              <a:ext uri="{FF2B5EF4-FFF2-40B4-BE49-F238E27FC236}">
                <a16:creationId xmlns:a16="http://schemas.microsoft.com/office/drawing/2014/main" id="{30226658-947C-4C76-BE65-7AB8465DF8E1}"/>
              </a:ext>
            </a:extLst>
          </p:cNvPr>
          <p:cNvSpPr txBox="1"/>
          <p:nvPr/>
        </p:nvSpPr>
        <p:spPr>
          <a:xfrm>
            <a:off x="1491466" y="4914213"/>
            <a:ext cx="991852" cy="276999"/>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Layer IIIc</a:t>
            </a:r>
          </a:p>
        </p:txBody>
      </p:sp>
      <p:sp>
        <p:nvSpPr>
          <p:cNvPr id="13" name="CuadroTexto 12">
            <a:extLst>
              <a:ext uri="{FF2B5EF4-FFF2-40B4-BE49-F238E27FC236}">
                <a16:creationId xmlns:a16="http://schemas.microsoft.com/office/drawing/2014/main" id="{EA4C7625-5597-4617-B67A-2AC6B83A8056}"/>
              </a:ext>
            </a:extLst>
          </p:cNvPr>
          <p:cNvSpPr txBox="1"/>
          <p:nvPr/>
        </p:nvSpPr>
        <p:spPr>
          <a:xfrm>
            <a:off x="6096000" y="2279248"/>
            <a:ext cx="1150143" cy="461665"/>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Travertine</a:t>
            </a:r>
          </a:p>
          <a:p>
            <a:pPr algn="ctr"/>
            <a:r>
              <a:rPr lang="en-GB" sz="1200" dirty="0">
                <a:solidFill>
                  <a:schemeClr val="bg1">
                    <a:lumMod val="95000"/>
                  </a:schemeClr>
                </a:solidFill>
                <a:effectLst>
                  <a:outerShdw blurRad="38100" dist="38100" dir="2700000" algn="tl">
                    <a:srgbClr val="000000">
                      <a:alpha val="43137"/>
                    </a:srgbClr>
                  </a:outerShdw>
                </a:effectLst>
                <a:latin typeface="+mj-lt"/>
              </a:rPr>
              <a:t>platform 2</a:t>
            </a:r>
          </a:p>
        </p:txBody>
      </p:sp>
    </p:spTree>
    <p:extLst>
      <p:ext uri="{BB962C8B-B14F-4D97-AF65-F5344CB8AC3E}">
        <p14:creationId xmlns:p14="http://schemas.microsoft.com/office/powerpoint/2010/main" val="45650591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80356" y="563880"/>
            <a:ext cx="760144" cy="369332"/>
          </a:xfrm>
          <a:prstGeom prst="rect">
            <a:avLst/>
          </a:prstGeom>
          <a:noFill/>
        </p:spPr>
        <p:txBody>
          <a:bodyPr wrap="none" rtlCol="0">
            <a:spAutoFit/>
          </a:bodyPr>
          <a:lstStyle/>
          <a:p>
            <a:r>
              <a:rPr lang="en-GB" dirty="0"/>
              <a:t>Fig. M</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540923" cy="338554"/>
          </a:xfrm>
          <a:prstGeom prst="rect">
            <a:avLst/>
          </a:prstGeom>
          <a:noFill/>
        </p:spPr>
        <p:txBody>
          <a:bodyPr wrap="none" rtlCol="0">
            <a:spAutoFit/>
          </a:bodyPr>
          <a:lstStyle/>
          <a:p>
            <a:r>
              <a:rPr lang="en-GB" sz="1600" b="1" dirty="0">
                <a:latin typeface="+mj-lt"/>
              </a:rPr>
              <a:t>Supporting Information 1 – Excavation of the Layer IIIc</a:t>
            </a:r>
          </a:p>
        </p:txBody>
      </p:sp>
      <p:pic>
        <p:nvPicPr>
          <p:cNvPr id="3" name="Imagen 2" descr="Imagen que contiene edificio, suelo, exterior&#10;&#10;Descripción generada automáticamente">
            <a:extLst>
              <a:ext uri="{FF2B5EF4-FFF2-40B4-BE49-F238E27FC236}">
                <a16:creationId xmlns:a16="http://schemas.microsoft.com/office/drawing/2014/main" id="{435C41E6-7C95-4312-88C9-2963A1ED0FAD}"/>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63880"/>
            <a:ext cx="8721249" cy="5792470"/>
          </a:xfrm>
          <a:prstGeom prst="rect">
            <a:avLst/>
          </a:prstGeom>
        </p:spPr>
      </p:pic>
      <p:sp>
        <p:nvSpPr>
          <p:cNvPr id="8" name="CuadroTexto 7">
            <a:extLst>
              <a:ext uri="{FF2B5EF4-FFF2-40B4-BE49-F238E27FC236}">
                <a16:creationId xmlns:a16="http://schemas.microsoft.com/office/drawing/2014/main" id="{83C354B2-20B5-48C2-A41C-82BBCCD066CE}"/>
              </a:ext>
            </a:extLst>
          </p:cNvPr>
          <p:cNvSpPr txBox="1"/>
          <p:nvPr/>
        </p:nvSpPr>
        <p:spPr>
          <a:xfrm>
            <a:off x="9080356" y="1110868"/>
            <a:ext cx="2849975" cy="3754874"/>
          </a:xfrm>
          <a:prstGeom prst="rect">
            <a:avLst/>
          </a:prstGeom>
          <a:noFill/>
        </p:spPr>
        <p:txBody>
          <a:bodyPr wrap="square" rtlCol="0">
            <a:spAutoFit/>
          </a:bodyPr>
          <a:lstStyle/>
          <a:p>
            <a:pPr algn="just"/>
            <a:r>
              <a:rPr lang="en-GB" sz="1400" dirty="0"/>
              <a:t>The top of Layer IIIc appeared still affected by some burrows coming from the upper layers (E7). The identification and isolation was easy due to the clear colour and textural differences between the burrow-filling sediment and the </a:t>
            </a:r>
            <a:r>
              <a:rPr lang="en-GB" sz="1400" i="1" dirty="0"/>
              <a:t>in situ </a:t>
            </a:r>
            <a:r>
              <a:rPr lang="en-GB" sz="1400" dirty="0"/>
              <a:t>Layer IIIc. </a:t>
            </a:r>
          </a:p>
          <a:p>
            <a:pPr algn="just"/>
            <a:endParaRPr lang="en-GB" sz="1400" i="1" dirty="0"/>
          </a:p>
          <a:p>
            <a:pPr algn="just"/>
            <a:r>
              <a:rPr lang="en-GB" sz="1400" dirty="0"/>
              <a:t>Note the abundance of charcoals, some of them larger than 2cm, characteristic at Layer IIIc, and probably derived from the fire features documented at the reference section (E9 – D9).</a:t>
            </a:r>
          </a:p>
          <a:p>
            <a:pPr algn="just"/>
            <a:endParaRPr lang="en-GB" sz="1400" dirty="0"/>
          </a:p>
          <a:p>
            <a:pPr algn="just"/>
            <a:r>
              <a:rPr lang="en-GB" sz="1400" dirty="0"/>
              <a:t>Photo 2013</a:t>
            </a:r>
          </a:p>
        </p:txBody>
      </p:sp>
      <p:cxnSp>
        <p:nvCxnSpPr>
          <p:cNvPr id="9" name="Conector recto 8">
            <a:extLst>
              <a:ext uri="{FF2B5EF4-FFF2-40B4-BE49-F238E27FC236}">
                <a16:creationId xmlns:a16="http://schemas.microsoft.com/office/drawing/2014/main" id="{6172E6A4-3D18-4E40-AD02-9B0C2185ED4D}"/>
              </a:ext>
            </a:extLst>
          </p:cNvPr>
          <p:cNvCxnSpPr>
            <a:cxnSpLocks/>
          </p:cNvCxnSpPr>
          <p:nvPr/>
        </p:nvCxnSpPr>
        <p:spPr>
          <a:xfrm>
            <a:off x="9152626" y="1021634"/>
            <a:ext cx="268281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C836E0E3-1B2A-4E54-A5E7-B7990BB82AB7}"/>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3</a:t>
            </a:fld>
            <a:endParaRPr lang="en-GB" sz="1800" dirty="0">
              <a:latin typeface="+mj-lt"/>
            </a:endParaRPr>
          </a:p>
        </p:txBody>
      </p:sp>
      <p:sp>
        <p:nvSpPr>
          <p:cNvPr id="5" name="Forma libre: forma 4">
            <a:extLst>
              <a:ext uri="{FF2B5EF4-FFF2-40B4-BE49-F238E27FC236}">
                <a16:creationId xmlns:a16="http://schemas.microsoft.com/office/drawing/2014/main" id="{158554EB-DCCF-4C47-BFE0-5838837ECE97}"/>
              </a:ext>
            </a:extLst>
          </p:cNvPr>
          <p:cNvSpPr/>
          <p:nvPr/>
        </p:nvSpPr>
        <p:spPr>
          <a:xfrm>
            <a:off x="146304" y="539496"/>
            <a:ext cx="3566915" cy="2900407"/>
          </a:xfrm>
          <a:custGeom>
            <a:avLst/>
            <a:gdLst>
              <a:gd name="connsiteX0" fmla="*/ 3392424 w 3566915"/>
              <a:gd name="connsiteY0" fmla="*/ 0 h 2900407"/>
              <a:gd name="connsiteX1" fmla="*/ 3493008 w 3566915"/>
              <a:gd name="connsiteY1" fmla="*/ 237744 h 2900407"/>
              <a:gd name="connsiteX2" fmla="*/ 3566160 w 3566915"/>
              <a:gd name="connsiteY2" fmla="*/ 438912 h 2900407"/>
              <a:gd name="connsiteX3" fmla="*/ 3447288 w 3566915"/>
              <a:gd name="connsiteY3" fmla="*/ 649224 h 2900407"/>
              <a:gd name="connsiteX4" fmla="*/ 3218688 w 3566915"/>
              <a:gd name="connsiteY4" fmla="*/ 822960 h 2900407"/>
              <a:gd name="connsiteX5" fmla="*/ 2962656 w 3566915"/>
              <a:gd name="connsiteY5" fmla="*/ 841248 h 2900407"/>
              <a:gd name="connsiteX6" fmla="*/ 2770632 w 3566915"/>
              <a:gd name="connsiteY6" fmla="*/ 832104 h 2900407"/>
              <a:gd name="connsiteX7" fmla="*/ 2615184 w 3566915"/>
              <a:gd name="connsiteY7" fmla="*/ 914400 h 2900407"/>
              <a:gd name="connsiteX8" fmla="*/ 2404872 w 3566915"/>
              <a:gd name="connsiteY8" fmla="*/ 1069848 h 2900407"/>
              <a:gd name="connsiteX9" fmla="*/ 2212848 w 3566915"/>
              <a:gd name="connsiteY9" fmla="*/ 1216152 h 2900407"/>
              <a:gd name="connsiteX10" fmla="*/ 2157984 w 3566915"/>
              <a:gd name="connsiteY10" fmla="*/ 1353312 h 2900407"/>
              <a:gd name="connsiteX11" fmla="*/ 1929384 w 3566915"/>
              <a:gd name="connsiteY11" fmla="*/ 1600200 h 2900407"/>
              <a:gd name="connsiteX12" fmla="*/ 1627632 w 3566915"/>
              <a:gd name="connsiteY12" fmla="*/ 1737360 h 2900407"/>
              <a:gd name="connsiteX13" fmla="*/ 1298448 w 3566915"/>
              <a:gd name="connsiteY13" fmla="*/ 1911096 h 2900407"/>
              <a:gd name="connsiteX14" fmla="*/ 1033272 w 3566915"/>
              <a:gd name="connsiteY14" fmla="*/ 2112264 h 2900407"/>
              <a:gd name="connsiteX15" fmla="*/ 786384 w 3566915"/>
              <a:gd name="connsiteY15" fmla="*/ 2249424 h 2900407"/>
              <a:gd name="connsiteX16" fmla="*/ 512064 w 3566915"/>
              <a:gd name="connsiteY16" fmla="*/ 2414016 h 2900407"/>
              <a:gd name="connsiteX17" fmla="*/ 265176 w 3566915"/>
              <a:gd name="connsiteY17" fmla="*/ 2688336 h 2900407"/>
              <a:gd name="connsiteX18" fmla="*/ 201168 w 3566915"/>
              <a:gd name="connsiteY18" fmla="*/ 2834640 h 2900407"/>
              <a:gd name="connsiteX19" fmla="*/ 54864 w 3566915"/>
              <a:gd name="connsiteY19" fmla="*/ 2880360 h 2900407"/>
              <a:gd name="connsiteX20" fmla="*/ 18288 w 3566915"/>
              <a:gd name="connsiteY20" fmla="*/ 2898648 h 2900407"/>
              <a:gd name="connsiteX21" fmla="*/ 0 w 3566915"/>
              <a:gd name="connsiteY21" fmla="*/ 2898648 h 290040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3566915" h="2900407">
                <a:moveTo>
                  <a:pt x="3392424" y="0"/>
                </a:moveTo>
                <a:cubicBezTo>
                  <a:pt x="3428238" y="82296"/>
                  <a:pt x="3464052" y="164592"/>
                  <a:pt x="3493008" y="237744"/>
                </a:cubicBezTo>
                <a:cubicBezTo>
                  <a:pt x="3521964" y="310896"/>
                  <a:pt x="3573780" y="370332"/>
                  <a:pt x="3566160" y="438912"/>
                </a:cubicBezTo>
                <a:cubicBezTo>
                  <a:pt x="3558540" y="507492"/>
                  <a:pt x="3505200" y="585216"/>
                  <a:pt x="3447288" y="649224"/>
                </a:cubicBezTo>
                <a:cubicBezTo>
                  <a:pt x="3389376" y="713232"/>
                  <a:pt x="3299460" y="790956"/>
                  <a:pt x="3218688" y="822960"/>
                </a:cubicBezTo>
                <a:cubicBezTo>
                  <a:pt x="3137916" y="854964"/>
                  <a:pt x="3037332" y="839724"/>
                  <a:pt x="2962656" y="841248"/>
                </a:cubicBezTo>
                <a:cubicBezTo>
                  <a:pt x="2887980" y="842772"/>
                  <a:pt x="2828544" y="819912"/>
                  <a:pt x="2770632" y="832104"/>
                </a:cubicBezTo>
                <a:cubicBezTo>
                  <a:pt x="2712720" y="844296"/>
                  <a:pt x="2676144" y="874776"/>
                  <a:pt x="2615184" y="914400"/>
                </a:cubicBezTo>
                <a:cubicBezTo>
                  <a:pt x="2554224" y="954024"/>
                  <a:pt x="2471928" y="1019556"/>
                  <a:pt x="2404872" y="1069848"/>
                </a:cubicBezTo>
                <a:cubicBezTo>
                  <a:pt x="2337816" y="1120140"/>
                  <a:pt x="2253996" y="1168908"/>
                  <a:pt x="2212848" y="1216152"/>
                </a:cubicBezTo>
                <a:cubicBezTo>
                  <a:pt x="2171700" y="1263396"/>
                  <a:pt x="2205228" y="1289304"/>
                  <a:pt x="2157984" y="1353312"/>
                </a:cubicBezTo>
                <a:cubicBezTo>
                  <a:pt x="2110740" y="1417320"/>
                  <a:pt x="2017776" y="1536192"/>
                  <a:pt x="1929384" y="1600200"/>
                </a:cubicBezTo>
                <a:cubicBezTo>
                  <a:pt x="1840992" y="1664208"/>
                  <a:pt x="1732788" y="1685544"/>
                  <a:pt x="1627632" y="1737360"/>
                </a:cubicBezTo>
                <a:cubicBezTo>
                  <a:pt x="1522476" y="1789176"/>
                  <a:pt x="1397508" y="1848612"/>
                  <a:pt x="1298448" y="1911096"/>
                </a:cubicBezTo>
                <a:cubicBezTo>
                  <a:pt x="1199388" y="1973580"/>
                  <a:pt x="1118616" y="2055876"/>
                  <a:pt x="1033272" y="2112264"/>
                </a:cubicBezTo>
                <a:cubicBezTo>
                  <a:pt x="947928" y="2168652"/>
                  <a:pt x="873252" y="2199132"/>
                  <a:pt x="786384" y="2249424"/>
                </a:cubicBezTo>
                <a:cubicBezTo>
                  <a:pt x="699516" y="2299716"/>
                  <a:pt x="598932" y="2340864"/>
                  <a:pt x="512064" y="2414016"/>
                </a:cubicBezTo>
                <a:cubicBezTo>
                  <a:pt x="425196" y="2487168"/>
                  <a:pt x="316992" y="2618232"/>
                  <a:pt x="265176" y="2688336"/>
                </a:cubicBezTo>
                <a:cubicBezTo>
                  <a:pt x="213360" y="2758440"/>
                  <a:pt x="236220" y="2802636"/>
                  <a:pt x="201168" y="2834640"/>
                </a:cubicBezTo>
                <a:cubicBezTo>
                  <a:pt x="166116" y="2866644"/>
                  <a:pt x="85344" y="2869692"/>
                  <a:pt x="54864" y="2880360"/>
                </a:cubicBezTo>
                <a:cubicBezTo>
                  <a:pt x="24384" y="2891028"/>
                  <a:pt x="18288" y="2898648"/>
                  <a:pt x="18288" y="2898648"/>
                </a:cubicBezTo>
                <a:cubicBezTo>
                  <a:pt x="9144" y="2901696"/>
                  <a:pt x="4572" y="2900172"/>
                  <a:pt x="0" y="2898648"/>
                </a:cubicBez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Forma libre: forma 10">
            <a:extLst>
              <a:ext uri="{FF2B5EF4-FFF2-40B4-BE49-F238E27FC236}">
                <a16:creationId xmlns:a16="http://schemas.microsoft.com/office/drawing/2014/main" id="{F55E8201-F553-4DF7-8D1C-FB32714008EE}"/>
              </a:ext>
            </a:extLst>
          </p:cNvPr>
          <p:cNvSpPr/>
          <p:nvPr/>
        </p:nvSpPr>
        <p:spPr>
          <a:xfrm>
            <a:off x="1207008" y="3803904"/>
            <a:ext cx="2852928" cy="2414016"/>
          </a:xfrm>
          <a:custGeom>
            <a:avLst/>
            <a:gdLst>
              <a:gd name="connsiteX0" fmla="*/ 0 w 2852928"/>
              <a:gd name="connsiteY0" fmla="*/ 1289304 h 2414016"/>
              <a:gd name="connsiteX1" fmla="*/ 356616 w 2852928"/>
              <a:gd name="connsiteY1" fmla="*/ 1499616 h 2414016"/>
              <a:gd name="connsiteX2" fmla="*/ 667512 w 2852928"/>
              <a:gd name="connsiteY2" fmla="*/ 1591056 h 2414016"/>
              <a:gd name="connsiteX3" fmla="*/ 923544 w 2852928"/>
              <a:gd name="connsiteY3" fmla="*/ 1682496 h 2414016"/>
              <a:gd name="connsiteX4" fmla="*/ 1143000 w 2852928"/>
              <a:gd name="connsiteY4" fmla="*/ 1737360 h 2414016"/>
              <a:gd name="connsiteX5" fmla="*/ 1399032 w 2852928"/>
              <a:gd name="connsiteY5" fmla="*/ 1709928 h 2414016"/>
              <a:gd name="connsiteX6" fmla="*/ 1600200 w 2852928"/>
              <a:gd name="connsiteY6" fmla="*/ 1581912 h 2414016"/>
              <a:gd name="connsiteX7" fmla="*/ 1737360 w 2852928"/>
              <a:gd name="connsiteY7" fmla="*/ 1435608 h 2414016"/>
              <a:gd name="connsiteX8" fmla="*/ 1737360 w 2852928"/>
              <a:gd name="connsiteY8" fmla="*/ 1225296 h 2414016"/>
              <a:gd name="connsiteX9" fmla="*/ 1709928 w 2852928"/>
              <a:gd name="connsiteY9" fmla="*/ 923544 h 2414016"/>
              <a:gd name="connsiteX10" fmla="*/ 1737360 w 2852928"/>
              <a:gd name="connsiteY10" fmla="*/ 740664 h 2414016"/>
              <a:gd name="connsiteX11" fmla="*/ 1746504 w 2852928"/>
              <a:gd name="connsiteY11" fmla="*/ 502920 h 2414016"/>
              <a:gd name="connsiteX12" fmla="*/ 1783080 w 2852928"/>
              <a:gd name="connsiteY12" fmla="*/ 411480 h 2414016"/>
              <a:gd name="connsiteX13" fmla="*/ 1883664 w 2852928"/>
              <a:gd name="connsiteY13" fmla="*/ 237744 h 2414016"/>
              <a:gd name="connsiteX14" fmla="*/ 2121408 w 2852928"/>
              <a:gd name="connsiteY14" fmla="*/ 82296 h 2414016"/>
              <a:gd name="connsiteX15" fmla="*/ 2414016 w 2852928"/>
              <a:gd name="connsiteY15" fmla="*/ 0 h 2414016"/>
              <a:gd name="connsiteX16" fmla="*/ 2569464 w 2852928"/>
              <a:gd name="connsiteY16" fmla="*/ 9144 h 2414016"/>
              <a:gd name="connsiteX17" fmla="*/ 2761488 w 2852928"/>
              <a:gd name="connsiteY17" fmla="*/ 91440 h 2414016"/>
              <a:gd name="connsiteX18" fmla="*/ 2852928 w 2852928"/>
              <a:gd name="connsiteY18" fmla="*/ 201168 h 2414016"/>
              <a:gd name="connsiteX19" fmla="*/ 2852928 w 2852928"/>
              <a:gd name="connsiteY19" fmla="*/ 329184 h 2414016"/>
              <a:gd name="connsiteX20" fmla="*/ 2761488 w 2852928"/>
              <a:gd name="connsiteY20" fmla="*/ 594360 h 2414016"/>
              <a:gd name="connsiteX21" fmla="*/ 2670048 w 2852928"/>
              <a:gd name="connsiteY21" fmla="*/ 822960 h 2414016"/>
              <a:gd name="connsiteX22" fmla="*/ 2587752 w 2852928"/>
              <a:gd name="connsiteY22" fmla="*/ 1088136 h 2414016"/>
              <a:gd name="connsiteX23" fmla="*/ 2551176 w 2852928"/>
              <a:gd name="connsiteY23" fmla="*/ 1188720 h 2414016"/>
              <a:gd name="connsiteX24" fmla="*/ 2478024 w 2852928"/>
              <a:gd name="connsiteY24" fmla="*/ 1408176 h 2414016"/>
              <a:gd name="connsiteX25" fmla="*/ 2432304 w 2852928"/>
              <a:gd name="connsiteY25" fmla="*/ 1545336 h 2414016"/>
              <a:gd name="connsiteX26" fmla="*/ 2350008 w 2852928"/>
              <a:gd name="connsiteY26" fmla="*/ 1819656 h 2414016"/>
              <a:gd name="connsiteX27" fmla="*/ 2295144 w 2852928"/>
              <a:gd name="connsiteY27" fmla="*/ 1901952 h 2414016"/>
              <a:gd name="connsiteX28" fmla="*/ 2276856 w 2852928"/>
              <a:gd name="connsiteY28" fmla="*/ 2176272 h 2414016"/>
              <a:gd name="connsiteX29" fmla="*/ 2313432 w 2852928"/>
              <a:gd name="connsiteY29" fmla="*/ 2414016 h 241401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Lst>
            <a:rect l="l" t="t" r="r" b="b"/>
            <a:pathLst>
              <a:path w="2852928" h="2414016">
                <a:moveTo>
                  <a:pt x="0" y="1289304"/>
                </a:moveTo>
                <a:lnTo>
                  <a:pt x="356616" y="1499616"/>
                </a:lnTo>
                <a:lnTo>
                  <a:pt x="667512" y="1591056"/>
                </a:lnTo>
                <a:lnTo>
                  <a:pt x="923544" y="1682496"/>
                </a:lnTo>
                <a:lnTo>
                  <a:pt x="1143000" y="1737360"/>
                </a:lnTo>
                <a:lnTo>
                  <a:pt x="1399032" y="1709928"/>
                </a:lnTo>
                <a:lnTo>
                  <a:pt x="1600200" y="1581912"/>
                </a:lnTo>
                <a:lnTo>
                  <a:pt x="1737360" y="1435608"/>
                </a:lnTo>
                <a:lnTo>
                  <a:pt x="1737360" y="1225296"/>
                </a:lnTo>
                <a:lnTo>
                  <a:pt x="1709928" y="923544"/>
                </a:lnTo>
                <a:lnTo>
                  <a:pt x="1737360" y="740664"/>
                </a:lnTo>
                <a:lnTo>
                  <a:pt x="1746504" y="502920"/>
                </a:lnTo>
                <a:cubicBezTo>
                  <a:pt x="1776329" y="423386"/>
                  <a:pt x="1762290" y="453061"/>
                  <a:pt x="1783080" y="411480"/>
                </a:cubicBezTo>
                <a:lnTo>
                  <a:pt x="1883664" y="237744"/>
                </a:lnTo>
                <a:lnTo>
                  <a:pt x="2121408" y="82296"/>
                </a:lnTo>
                <a:lnTo>
                  <a:pt x="2414016" y="0"/>
                </a:lnTo>
                <a:lnTo>
                  <a:pt x="2569464" y="9144"/>
                </a:lnTo>
                <a:lnTo>
                  <a:pt x="2761488" y="91440"/>
                </a:lnTo>
                <a:lnTo>
                  <a:pt x="2852928" y="201168"/>
                </a:lnTo>
                <a:lnTo>
                  <a:pt x="2852928" y="329184"/>
                </a:lnTo>
                <a:lnTo>
                  <a:pt x="2761488" y="594360"/>
                </a:lnTo>
                <a:lnTo>
                  <a:pt x="2670048" y="822960"/>
                </a:lnTo>
                <a:lnTo>
                  <a:pt x="2587752" y="1088136"/>
                </a:lnTo>
                <a:cubicBezTo>
                  <a:pt x="2558165" y="1176898"/>
                  <a:pt x="2573252" y="1144569"/>
                  <a:pt x="2551176" y="1188720"/>
                </a:cubicBezTo>
                <a:lnTo>
                  <a:pt x="2478024" y="1408176"/>
                </a:lnTo>
                <a:lnTo>
                  <a:pt x="2432304" y="1545336"/>
                </a:lnTo>
                <a:lnTo>
                  <a:pt x="2350008" y="1819656"/>
                </a:lnTo>
                <a:lnTo>
                  <a:pt x="2295144" y="1901952"/>
                </a:lnTo>
                <a:lnTo>
                  <a:pt x="2276856" y="2176272"/>
                </a:lnTo>
                <a:lnTo>
                  <a:pt x="2313432" y="2414016"/>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Forma libre: forma 11">
            <a:extLst>
              <a:ext uri="{FF2B5EF4-FFF2-40B4-BE49-F238E27FC236}">
                <a16:creationId xmlns:a16="http://schemas.microsoft.com/office/drawing/2014/main" id="{3CCAF1E7-B7E0-4420-AF2A-112C808A4941}"/>
              </a:ext>
            </a:extLst>
          </p:cNvPr>
          <p:cNvSpPr/>
          <p:nvPr/>
        </p:nvSpPr>
        <p:spPr>
          <a:xfrm>
            <a:off x="6583680" y="722376"/>
            <a:ext cx="2212848" cy="3401568"/>
          </a:xfrm>
          <a:custGeom>
            <a:avLst/>
            <a:gdLst>
              <a:gd name="connsiteX0" fmla="*/ 283464 w 2212848"/>
              <a:gd name="connsiteY0" fmla="*/ 0 h 3401568"/>
              <a:gd name="connsiteX1" fmla="*/ 164592 w 2212848"/>
              <a:gd name="connsiteY1" fmla="*/ 338328 h 3401568"/>
              <a:gd name="connsiteX2" fmla="*/ 45720 w 2212848"/>
              <a:gd name="connsiteY2" fmla="*/ 877824 h 3401568"/>
              <a:gd name="connsiteX3" fmla="*/ 0 w 2212848"/>
              <a:gd name="connsiteY3" fmla="*/ 1243584 h 3401568"/>
              <a:gd name="connsiteX4" fmla="*/ 45720 w 2212848"/>
              <a:gd name="connsiteY4" fmla="*/ 1316736 h 3401568"/>
              <a:gd name="connsiteX5" fmla="*/ 128016 w 2212848"/>
              <a:gd name="connsiteY5" fmla="*/ 1636776 h 3401568"/>
              <a:gd name="connsiteX6" fmla="*/ 164592 w 2212848"/>
              <a:gd name="connsiteY6" fmla="*/ 1709928 h 3401568"/>
              <a:gd name="connsiteX7" fmla="*/ 265176 w 2212848"/>
              <a:gd name="connsiteY7" fmla="*/ 1929384 h 3401568"/>
              <a:gd name="connsiteX8" fmla="*/ 402336 w 2212848"/>
              <a:gd name="connsiteY8" fmla="*/ 2322576 h 3401568"/>
              <a:gd name="connsiteX9" fmla="*/ 429768 w 2212848"/>
              <a:gd name="connsiteY9" fmla="*/ 2606040 h 3401568"/>
              <a:gd name="connsiteX10" fmla="*/ 393192 w 2212848"/>
              <a:gd name="connsiteY10" fmla="*/ 2862072 h 3401568"/>
              <a:gd name="connsiteX11" fmla="*/ 402336 w 2212848"/>
              <a:gd name="connsiteY11" fmla="*/ 3182112 h 3401568"/>
              <a:gd name="connsiteX12" fmla="*/ 493776 w 2212848"/>
              <a:gd name="connsiteY12" fmla="*/ 3374136 h 3401568"/>
              <a:gd name="connsiteX13" fmla="*/ 722376 w 2212848"/>
              <a:gd name="connsiteY13" fmla="*/ 3401568 h 3401568"/>
              <a:gd name="connsiteX14" fmla="*/ 905256 w 2212848"/>
              <a:gd name="connsiteY14" fmla="*/ 3383280 h 3401568"/>
              <a:gd name="connsiteX15" fmla="*/ 1060704 w 2212848"/>
              <a:gd name="connsiteY15" fmla="*/ 3172968 h 3401568"/>
              <a:gd name="connsiteX16" fmla="*/ 1234440 w 2212848"/>
              <a:gd name="connsiteY16" fmla="*/ 2926080 h 3401568"/>
              <a:gd name="connsiteX17" fmla="*/ 1371600 w 2212848"/>
              <a:gd name="connsiteY17" fmla="*/ 2834640 h 3401568"/>
              <a:gd name="connsiteX18" fmla="*/ 1618488 w 2212848"/>
              <a:gd name="connsiteY18" fmla="*/ 2816352 h 3401568"/>
              <a:gd name="connsiteX19" fmla="*/ 1837944 w 2212848"/>
              <a:gd name="connsiteY19" fmla="*/ 2852928 h 3401568"/>
              <a:gd name="connsiteX20" fmla="*/ 2020824 w 2212848"/>
              <a:gd name="connsiteY20" fmla="*/ 2889504 h 3401568"/>
              <a:gd name="connsiteX21" fmla="*/ 2185416 w 2212848"/>
              <a:gd name="connsiteY21" fmla="*/ 2916936 h 3401568"/>
              <a:gd name="connsiteX22" fmla="*/ 2212848 w 2212848"/>
              <a:gd name="connsiteY22" fmla="*/ 2953512 h 34015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Lst>
            <a:rect l="l" t="t" r="r" b="b"/>
            <a:pathLst>
              <a:path w="2212848" h="3401568">
                <a:moveTo>
                  <a:pt x="283464" y="0"/>
                </a:moveTo>
                <a:lnTo>
                  <a:pt x="164592" y="338328"/>
                </a:lnTo>
                <a:lnTo>
                  <a:pt x="45720" y="877824"/>
                </a:lnTo>
                <a:lnTo>
                  <a:pt x="0" y="1243584"/>
                </a:lnTo>
                <a:lnTo>
                  <a:pt x="45720" y="1316736"/>
                </a:lnTo>
                <a:lnTo>
                  <a:pt x="128016" y="1636776"/>
                </a:lnTo>
                <a:lnTo>
                  <a:pt x="164592" y="1709928"/>
                </a:lnTo>
                <a:lnTo>
                  <a:pt x="265176" y="1929384"/>
                </a:lnTo>
                <a:lnTo>
                  <a:pt x="402336" y="2322576"/>
                </a:lnTo>
                <a:lnTo>
                  <a:pt x="429768" y="2606040"/>
                </a:lnTo>
                <a:lnTo>
                  <a:pt x="393192" y="2862072"/>
                </a:lnTo>
                <a:lnTo>
                  <a:pt x="402336" y="3182112"/>
                </a:lnTo>
                <a:lnTo>
                  <a:pt x="493776" y="3374136"/>
                </a:lnTo>
                <a:lnTo>
                  <a:pt x="722376" y="3401568"/>
                </a:lnTo>
                <a:lnTo>
                  <a:pt x="905256" y="3383280"/>
                </a:lnTo>
                <a:lnTo>
                  <a:pt x="1060704" y="3172968"/>
                </a:lnTo>
                <a:lnTo>
                  <a:pt x="1234440" y="2926080"/>
                </a:lnTo>
                <a:lnTo>
                  <a:pt x="1371600" y="2834640"/>
                </a:lnTo>
                <a:lnTo>
                  <a:pt x="1618488" y="2816352"/>
                </a:lnTo>
                <a:lnTo>
                  <a:pt x="1837944" y="2852928"/>
                </a:lnTo>
                <a:lnTo>
                  <a:pt x="2020824" y="2889504"/>
                </a:lnTo>
                <a:lnTo>
                  <a:pt x="2185416" y="2916936"/>
                </a:lnTo>
                <a:lnTo>
                  <a:pt x="2212848" y="2953512"/>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Forma libre: forma 13">
            <a:extLst>
              <a:ext uri="{FF2B5EF4-FFF2-40B4-BE49-F238E27FC236}">
                <a16:creationId xmlns:a16="http://schemas.microsoft.com/office/drawing/2014/main" id="{6E193D2B-4790-4D93-836D-202E383ED6A4}"/>
              </a:ext>
            </a:extLst>
          </p:cNvPr>
          <p:cNvSpPr/>
          <p:nvPr/>
        </p:nvSpPr>
        <p:spPr>
          <a:xfrm>
            <a:off x="7790688" y="4636008"/>
            <a:ext cx="1014984" cy="1316736"/>
          </a:xfrm>
          <a:custGeom>
            <a:avLst/>
            <a:gdLst>
              <a:gd name="connsiteX0" fmla="*/ 0 w 1014984"/>
              <a:gd name="connsiteY0" fmla="*/ 1316736 h 1316736"/>
              <a:gd name="connsiteX1" fmla="*/ 146304 w 1014984"/>
              <a:gd name="connsiteY1" fmla="*/ 1115568 h 1316736"/>
              <a:gd name="connsiteX2" fmla="*/ 173736 w 1014984"/>
              <a:gd name="connsiteY2" fmla="*/ 1060704 h 1316736"/>
              <a:gd name="connsiteX3" fmla="*/ 155448 w 1014984"/>
              <a:gd name="connsiteY3" fmla="*/ 813816 h 1316736"/>
              <a:gd name="connsiteX4" fmla="*/ 146304 w 1014984"/>
              <a:gd name="connsiteY4" fmla="*/ 585216 h 1316736"/>
              <a:gd name="connsiteX5" fmla="*/ 146304 w 1014984"/>
              <a:gd name="connsiteY5" fmla="*/ 155448 h 1316736"/>
              <a:gd name="connsiteX6" fmla="*/ 292608 w 1014984"/>
              <a:gd name="connsiteY6" fmla="*/ 9144 h 1316736"/>
              <a:gd name="connsiteX7" fmla="*/ 475488 w 1014984"/>
              <a:gd name="connsiteY7" fmla="*/ 0 h 1316736"/>
              <a:gd name="connsiteX8" fmla="*/ 566928 w 1014984"/>
              <a:gd name="connsiteY8" fmla="*/ 146304 h 1316736"/>
              <a:gd name="connsiteX9" fmla="*/ 612648 w 1014984"/>
              <a:gd name="connsiteY9" fmla="*/ 246888 h 1316736"/>
              <a:gd name="connsiteX10" fmla="*/ 676656 w 1014984"/>
              <a:gd name="connsiteY10" fmla="*/ 438912 h 1316736"/>
              <a:gd name="connsiteX11" fmla="*/ 795528 w 1014984"/>
              <a:gd name="connsiteY11" fmla="*/ 612648 h 1316736"/>
              <a:gd name="connsiteX12" fmla="*/ 877824 w 1014984"/>
              <a:gd name="connsiteY12" fmla="*/ 667512 h 1316736"/>
              <a:gd name="connsiteX13" fmla="*/ 978408 w 1014984"/>
              <a:gd name="connsiteY13" fmla="*/ 685800 h 1316736"/>
              <a:gd name="connsiteX14" fmla="*/ 1014984 w 1014984"/>
              <a:gd name="connsiteY14" fmla="*/ 685800 h 131673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Lst>
            <a:rect l="l" t="t" r="r" b="b"/>
            <a:pathLst>
              <a:path w="1014984" h="1316736">
                <a:moveTo>
                  <a:pt x="0" y="1316736"/>
                </a:moveTo>
                <a:lnTo>
                  <a:pt x="146304" y="1115568"/>
                </a:lnTo>
                <a:lnTo>
                  <a:pt x="173736" y="1060704"/>
                </a:lnTo>
                <a:lnTo>
                  <a:pt x="155448" y="813816"/>
                </a:lnTo>
                <a:lnTo>
                  <a:pt x="146304" y="585216"/>
                </a:lnTo>
                <a:lnTo>
                  <a:pt x="146304" y="155448"/>
                </a:lnTo>
                <a:lnTo>
                  <a:pt x="292608" y="9144"/>
                </a:lnTo>
                <a:lnTo>
                  <a:pt x="475488" y="0"/>
                </a:lnTo>
                <a:lnTo>
                  <a:pt x="566928" y="146304"/>
                </a:lnTo>
                <a:lnTo>
                  <a:pt x="612648" y="246888"/>
                </a:lnTo>
                <a:lnTo>
                  <a:pt x="676656" y="438912"/>
                </a:lnTo>
                <a:lnTo>
                  <a:pt x="795528" y="612648"/>
                </a:lnTo>
                <a:lnTo>
                  <a:pt x="877824" y="667512"/>
                </a:lnTo>
                <a:cubicBezTo>
                  <a:pt x="966071" y="687122"/>
                  <a:pt x="932019" y="685800"/>
                  <a:pt x="978408" y="685800"/>
                </a:cubicBezTo>
                <a:lnTo>
                  <a:pt x="1014984" y="685800"/>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CuadroTexto 14">
            <a:extLst>
              <a:ext uri="{FF2B5EF4-FFF2-40B4-BE49-F238E27FC236}">
                <a16:creationId xmlns:a16="http://schemas.microsoft.com/office/drawing/2014/main" id="{C48ED8FD-F9F3-49E9-AE8A-3394A204958D}"/>
              </a:ext>
            </a:extLst>
          </p:cNvPr>
          <p:cNvSpPr txBox="1"/>
          <p:nvPr/>
        </p:nvSpPr>
        <p:spPr>
          <a:xfrm>
            <a:off x="4573378" y="1110868"/>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Layer IIIc</a:t>
            </a:r>
          </a:p>
        </p:txBody>
      </p:sp>
      <p:sp>
        <p:nvSpPr>
          <p:cNvPr id="16" name="CuadroTexto 15">
            <a:extLst>
              <a:ext uri="{FF2B5EF4-FFF2-40B4-BE49-F238E27FC236}">
                <a16:creationId xmlns:a16="http://schemas.microsoft.com/office/drawing/2014/main" id="{FE7424B0-2E7F-4471-8040-001C76167913}"/>
              </a:ext>
            </a:extLst>
          </p:cNvPr>
          <p:cNvSpPr txBox="1"/>
          <p:nvPr/>
        </p:nvSpPr>
        <p:spPr>
          <a:xfrm>
            <a:off x="7094634" y="2322945"/>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Burrow</a:t>
            </a:r>
          </a:p>
        </p:txBody>
      </p:sp>
      <p:sp>
        <p:nvSpPr>
          <p:cNvPr id="17" name="CuadroTexto 16">
            <a:extLst>
              <a:ext uri="{FF2B5EF4-FFF2-40B4-BE49-F238E27FC236}">
                <a16:creationId xmlns:a16="http://schemas.microsoft.com/office/drawing/2014/main" id="{210B8632-8397-42A8-BF0F-B7F7F1198A35}"/>
              </a:ext>
            </a:extLst>
          </p:cNvPr>
          <p:cNvSpPr txBox="1"/>
          <p:nvPr/>
        </p:nvSpPr>
        <p:spPr>
          <a:xfrm>
            <a:off x="1288249" y="1021634"/>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Burrow</a:t>
            </a:r>
          </a:p>
        </p:txBody>
      </p:sp>
      <p:sp>
        <p:nvSpPr>
          <p:cNvPr id="18" name="CuadroTexto 17">
            <a:extLst>
              <a:ext uri="{FF2B5EF4-FFF2-40B4-BE49-F238E27FC236}">
                <a16:creationId xmlns:a16="http://schemas.microsoft.com/office/drawing/2014/main" id="{192888DB-F29F-4BBE-B635-3450D8E558D8}"/>
              </a:ext>
            </a:extLst>
          </p:cNvPr>
          <p:cNvSpPr txBox="1"/>
          <p:nvPr/>
        </p:nvSpPr>
        <p:spPr>
          <a:xfrm>
            <a:off x="2853185" y="4359009"/>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Burrow</a:t>
            </a:r>
          </a:p>
        </p:txBody>
      </p:sp>
      <p:sp>
        <p:nvSpPr>
          <p:cNvPr id="19" name="CuadroTexto 18">
            <a:extLst>
              <a:ext uri="{FF2B5EF4-FFF2-40B4-BE49-F238E27FC236}">
                <a16:creationId xmlns:a16="http://schemas.microsoft.com/office/drawing/2014/main" id="{3B578ECC-C303-41B0-B78D-96E6D44DC95B}"/>
              </a:ext>
            </a:extLst>
          </p:cNvPr>
          <p:cNvSpPr txBox="1"/>
          <p:nvPr/>
        </p:nvSpPr>
        <p:spPr>
          <a:xfrm>
            <a:off x="7723108" y="5294376"/>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Burrow</a:t>
            </a:r>
          </a:p>
        </p:txBody>
      </p:sp>
    </p:spTree>
    <p:extLst>
      <p:ext uri="{BB962C8B-B14F-4D97-AF65-F5344CB8AC3E}">
        <p14:creationId xmlns:p14="http://schemas.microsoft.com/office/powerpoint/2010/main" val="17689242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11345" y="577094"/>
            <a:ext cx="696024" cy="369332"/>
          </a:xfrm>
          <a:prstGeom prst="rect">
            <a:avLst/>
          </a:prstGeom>
          <a:noFill/>
        </p:spPr>
        <p:txBody>
          <a:bodyPr wrap="none" rtlCol="0">
            <a:spAutoFit/>
          </a:bodyPr>
          <a:lstStyle/>
          <a:p>
            <a:r>
              <a:rPr lang="en-GB" b="1" dirty="0">
                <a:latin typeface="+mj-lt"/>
              </a:rPr>
              <a:t>Fig. N</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540923" cy="338554"/>
          </a:xfrm>
          <a:prstGeom prst="rect">
            <a:avLst/>
          </a:prstGeom>
          <a:noFill/>
        </p:spPr>
        <p:txBody>
          <a:bodyPr wrap="none" rtlCol="0">
            <a:spAutoFit/>
          </a:bodyPr>
          <a:lstStyle/>
          <a:p>
            <a:r>
              <a:rPr lang="en-GB" sz="1600" b="1" dirty="0">
                <a:latin typeface="+mj-lt"/>
              </a:rPr>
              <a:t>Supporting Information 1 – Excavation of the Layer IIIc</a:t>
            </a:r>
          </a:p>
        </p:txBody>
      </p:sp>
      <p:pic>
        <p:nvPicPr>
          <p:cNvPr id="5" name="Imagen 4" descr="Imagen que contiene edificio, suelo, pared&#10;&#10;Descripción generada automáticamente">
            <a:extLst>
              <a:ext uri="{FF2B5EF4-FFF2-40B4-BE49-F238E27FC236}">
                <a16:creationId xmlns:a16="http://schemas.microsoft.com/office/drawing/2014/main" id="{079CB1F1-49A6-49AC-8CDD-4241E2758D8F}"/>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77094"/>
            <a:ext cx="8701352" cy="5779256"/>
          </a:xfrm>
          <a:prstGeom prst="rect">
            <a:avLst/>
          </a:prstGeom>
        </p:spPr>
      </p:pic>
      <p:sp>
        <p:nvSpPr>
          <p:cNvPr id="8" name="CuadroTexto 7">
            <a:extLst>
              <a:ext uri="{FF2B5EF4-FFF2-40B4-BE49-F238E27FC236}">
                <a16:creationId xmlns:a16="http://schemas.microsoft.com/office/drawing/2014/main" id="{BD2D1204-89BB-4B17-AB44-ED101706ED53}"/>
              </a:ext>
            </a:extLst>
          </p:cNvPr>
          <p:cNvSpPr txBox="1"/>
          <p:nvPr/>
        </p:nvSpPr>
        <p:spPr>
          <a:xfrm>
            <a:off x="9011345" y="1179880"/>
            <a:ext cx="2901734" cy="2031325"/>
          </a:xfrm>
          <a:prstGeom prst="rect">
            <a:avLst/>
          </a:prstGeom>
          <a:noFill/>
        </p:spPr>
        <p:txBody>
          <a:bodyPr wrap="square" rtlCol="0">
            <a:spAutoFit/>
          </a:bodyPr>
          <a:lstStyle/>
          <a:p>
            <a:pPr algn="just"/>
            <a:r>
              <a:rPr lang="en-GB" sz="1400" dirty="0"/>
              <a:t>Detail of the previous surface showing a faunal remain and charcoals. This bone was one of the selected for 14C AMS pre-treatment and dating program at MPI-EVA. Unfortunately, no collagen was recovered.</a:t>
            </a:r>
          </a:p>
          <a:p>
            <a:pPr algn="just"/>
            <a:endParaRPr lang="en-GB" sz="1400" dirty="0"/>
          </a:p>
          <a:p>
            <a:pPr algn="just"/>
            <a:r>
              <a:rPr lang="en-GB" sz="1400" dirty="0"/>
              <a:t>Photo 2013</a:t>
            </a:r>
          </a:p>
        </p:txBody>
      </p:sp>
      <p:sp>
        <p:nvSpPr>
          <p:cNvPr id="9" name="Marcador de número de diapositiva 1">
            <a:extLst>
              <a:ext uri="{FF2B5EF4-FFF2-40B4-BE49-F238E27FC236}">
                <a16:creationId xmlns:a16="http://schemas.microsoft.com/office/drawing/2014/main" id="{3DCDF01B-158D-40CE-9363-C351C4240ED4}"/>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4</a:t>
            </a:fld>
            <a:endParaRPr lang="en-GB" sz="1800" dirty="0">
              <a:latin typeface="+mj-lt"/>
            </a:endParaRPr>
          </a:p>
        </p:txBody>
      </p:sp>
      <p:cxnSp>
        <p:nvCxnSpPr>
          <p:cNvPr id="10" name="Conector recto 9">
            <a:extLst>
              <a:ext uri="{FF2B5EF4-FFF2-40B4-BE49-F238E27FC236}">
                <a16:creationId xmlns:a16="http://schemas.microsoft.com/office/drawing/2014/main" id="{70D3D9B8-4E7A-4F67-9079-E7C2A06A5B86}"/>
              </a:ext>
            </a:extLst>
          </p:cNvPr>
          <p:cNvCxnSpPr>
            <a:cxnSpLocks/>
          </p:cNvCxnSpPr>
          <p:nvPr/>
        </p:nvCxnSpPr>
        <p:spPr>
          <a:xfrm>
            <a:off x="9109494" y="1064765"/>
            <a:ext cx="2691442"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cxnSp>
        <p:nvCxnSpPr>
          <p:cNvPr id="11" name="Conector recto de flecha 10">
            <a:extLst>
              <a:ext uri="{FF2B5EF4-FFF2-40B4-BE49-F238E27FC236}">
                <a16:creationId xmlns:a16="http://schemas.microsoft.com/office/drawing/2014/main" id="{446353D3-09AA-4A44-84AC-71D6E708EE3C}"/>
              </a:ext>
            </a:extLst>
          </p:cNvPr>
          <p:cNvCxnSpPr>
            <a:cxnSpLocks/>
          </p:cNvCxnSpPr>
          <p:nvPr/>
        </p:nvCxnSpPr>
        <p:spPr>
          <a:xfrm flipH="1">
            <a:off x="5966861" y="1563624"/>
            <a:ext cx="433939" cy="543485"/>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2976107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49368" y="563880"/>
            <a:ext cx="699230" cy="369332"/>
          </a:xfrm>
          <a:prstGeom prst="rect">
            <a:avLst/>
          </a:prstGeom>
          <a:noFill/>
        </p:spPr>
        <p:txBody>
          <a:bodyPr wrap="none" rtlCol="0">
            <a:spAutoFit/>
          </a:bodyPr>
          <a:lstStyle/>
          <a:p>
            <a:r>
              <a:rPr lang="en-GB" b="1" dirty="0">
                <a:latin typeface="+mj-lt"/>
              </a:rPr>
              <a:t>Fig. O</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540923" cy="338554"/>
          </a:xfrm>
          <a:prstGeom prst="rect">
            <a:avLst/>
          </a:prstGeom>
          <a:noFill/>
        </p:spPr>
        <p:txBody>
          <a:bodyPr wrap="none" rtlCol="0">
            <a:spAutoFit/>
          </a:bodyPr>
          <a:lstStyle/>
          <a:p>
            <a:r>
              <a:rPr lang="en-GB" sz="1600" b="1" dirty="0">
                <a:latin typeface="+mj-lt"/>
              </a:rPr>
              <a:t>Supporting Information 1 – Excavation of the Layer IIIc</a:t>
            </a:r>
          </a:p>
        </p:txBody>
      </p:sp>
      <p:pic>
        <p:nvPicPr>
          <p:cNvPr id="4" name="Imagen 3" descr="Imagen que contiene suelo, rock, edificio, pared&#10;&#10;Descripción generada automáticamente">
            <a:extLst>
              <a:ext uri="{FF2B5EF4-FFF2-40B4-BE49-F238E27FC236}">
                <a16:creationId xmlns:a16="http://schemas.microsoft.com/office/drawing/2014/main" id="{32AFD5C3-8604-4C7B-9DF1-532065890699}"/>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63880"/>
            <a:ext cx="8840124" cy="5871426"/>
          </a:xfrm>
          <a:prstGeom prst="rect">
            <a:avLst/>
          </a:prstGeom>
        </p:spPr>
      </p:pic>
      <p:sp>
        <p:nvSpPr>
          <p:cNvPr id="14" name="CuadroTexto 13">
            <a:extLst>
              <a:ext uri="{FF2B5EF4-FFF2-40B4-BE49-F238E27FC236}">
                <a16:creationId xmlns:a16="http://schemas.microsoft.com/office/drawing/2014/main" id="{9E29F6AB-7549-4155-A208-04B3B48646FE}"/>
              </a:ext>
            </a:extLst>
          </p:cNvPr>
          <p:cNvSpPr txBox="1"/>
          <p:nvPr/>
        </p:nvSpPr>
        <p:spPr>
          <a:xfrm>
            <a:off x="9149368" y="1153999"/>
            <a:ext cx="2841349" cy="1169551"/>
          </a:xfrm>
          <a:prstGeom prst="rect">
            <a:avLst/>
          </a:prstGeom>
          <a:noFill/>
        </p:spPr>
        <p:txBody>
          <a:bodyPr wrap="square" rtlCol="0">
            <a:spAutoFit/>
          </a:bodyPr>
          <a:lstStyle/>
          <a:p>
            <a:pPr algn="just"/>
            <a:r>
              <a:rPr lang="en-GB" sz="1400" dirty="0"/>
              <a:t>Fibula of </a:t>
            </a:r>
            <a:r>
              <a:rPr lang="en-GB" sz="1400" i="1" dirty="0"/>
              <a:t>Panthera </a:t>
            </a:r>
            <a:r>
              <a:rPr lang="en-GB" sz="1400" i="1" dirty="0" err="1"/>
              <a:t>pardus</a:t>
            </a:r>
            <a:r>
              <a:rPr lang="en-GB" sz="1400" dirty="0"/>
              <a:t> recovered at Layer IIIc, square E8, affected by post-depositional breakage. </a:t>
            </a:r>
          </a:p>
          <a:p>
            <a:pPr algn="just"/>
            <a:endParaRPr lang="en-GB" sz="1400" dirty="0"/>
          </a:p>
          <a:p>
            <a:pPr algn="just"/>
            <a:r>
              <a:rPr lang="en-GB" sz="1400" dirty="0"/>
              <a:t>Photo 2013</a:t>
            </a:r>
          </a:p>
        </p:txBody>
      </p:sp>
      <p:cxnSp>
        <p:nvCxnSpPr>
          <p:cNvPr id="8" name="Conector recto 7">
            <a:extLst>
              <a:ext uri="{FF2B5EF4-FFF2-40B4-BE49-F238E27FC236}">
                <a16:creationId xmlns:a16="http://schemas.microsoft.com/office/drawing/2014/main" id="{EBF115A3-E4A9-4461-AEF4-1D78E40555C5}"/>
              </a:ext>
            </a:extLst>
          </p:cNvPr>
          <p:cNvCxnSpPr>
            <a:cxnSpLocks/>
          </p:cNvCxnSpPr>
          <p:nvPr/>
        </p:nvCxnSpPr>
        <p:spPr>
          <a:xfrm>
            <a:off x="9238891" y="1021634"/>
            <a:ext cx="2613803"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8406BB4F-E112-4DA3-9A66-ED6E1454E2D4}"/>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5</a:t>
            </a:fld>
            <a:endParaRPr lang="en-GB" sz="1800" dirty="0">
              <a:latin typeface="+mj-lt"/>
            </a:endParaRPr>
          </a:p>
        </p:txBody>
      </p:sp>
      <p:cxnSp>
        <p:nvCxnSpPr>
          <p:cNvPr id="11" name="Conector recto de flecha 10">
            <a:extLst>
              <a:ext uri="{FF2B5EF4-FFF2-40B4-BE49-F238E27FC236}">
                <a16:creationId xmlns:a16="http://schemas.microsoft.com/office/drawing/2014/main" id="{5B989E1D-C092-4978-BC43-7E4358A802D1}"/>
              </a:ext>
            </a:extLst>
          </p:cNvPr>
          <p:cNvCxnSpPr>
            <a:cxnSpLocks/>
          </p:cNvCxnSpPr>
          <p:nvPr/>
        </p:nvCxnSpPr>
        <p:spPr>
          <a:xfrm flipV="1">
            <a:off x="3282696" y="2628317"/>
            <a:ext cx="315870" cy="480643"/>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cxnSp>
        <p:nvCxnSpPr>
          <p:cNvPr id="13" name="Conector recto de flecha 12">
            <a:extLst>
              <a:ext uri="{FF2B5EF4-FFF2-40B4-BE49-F238E27FC236}">
                <a16:creationId xmlns:a16="http://schemas.microsoft.com/office/drawing/2014/main" id="{C27092B6-0211-4E8B-BFE9-2178F5986591}"/>
              </a:ext>
            </a:extLst>
          </p:cNvPr>
          <p:cNvCxnSpPr>
            <a:cxnSpLocks/>
          </p:cNvCxnSpPr>
          <p:nvPr/>
        </p:nvCxnSpPr>
        <p:spPr>
          <a:xfrm flipV="1">
            <a:off x="4989576" y="2753285"/>
            <a:ext cx="315870" cy="480643"/>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cxnSp>
        <p:nvCxnSpPr>
          <p:cNvPr id="15" name="Conector recto de flecha 14">
            <a:extLst>
              <a:ext uri="{FF2B5EF4-FFF2-40B4-BE49-F238E27FC236}">
                <a16:creationId xmlns:a16="http://schemas.microsoft.com/office/drawing/2014/main" id="{0A7F13BB-7AD5-46F9-B36C-9D298DD90EA7}"/>
              </a:ext>
            </a:extLst>
          </p:cNvPr>
          <p:cNvCxnSpPr>
            <a:cxnSpLocks/>
          </p:cNvCxnSpPr>
          <p:nvPr/>
        </p:nvCxnSpPr>
        <p:spPr>
          <a:xfrm flipV="1">
            <a:off x="6601407" y="2868638"/>
            <a:ext cx="315870" cy="480643"/>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060084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598747" y="4875635"/>
            <a:ext cx="667170" cy="369332"/>
          </a:xfrm>
          <a:prstGeom prst="rect">
            <a:avLst/>
          </a:prstGeom>
          <a:noFill/>
        </p:spPr>
        <p:txBody>
          <a:bodyPr wrap="none" rtlCol="0">
            <a:spAutoFit/>
          </a:bodyPr>
          <a:lstStyle/>
          <a:p>
            <a:r>
              <a:rPr lang="en-GB" b="1" dirty="0">
                <a:latin typeface="+mj-lt"/>
              </a:rPr>
              <a:t>Fig. P</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540923" cy="338554"/>
          </a:xfrm>
          <a:prstGeom prst="rect">
            <a:avLst/>
          </a:prstGeom>
          <a:noFill/>
        </p:spPr>
        <p:txBody>
          <a:bodyPr wrap="none" rtlCol="0">
            <a:spAutoFit/>
          </a:bodyPr>
          <a:lstStyle/>
          <a:p>
            <a:r>
              <a:rPr lang="en-GB" sz="1600" b="1" dirty="0">
                <a:latin typeface="+mj-lt"/>
              </a:rPr>
              <a:t>Supporting Information 1 – Excavation of the Layer IIIc</a:t>
            </a:r>
          </a:p>
        </p:txBody>
      </p:sp>
      <p:pic>
        <p:nvPicPr>
          <p:cNvPr id="8" name="Imagen 7" descr="Imagen que contiene suelo, exterior&#10;&#10;Descripción generada automáticamente">
            <a:extLst>
              <a:ext uri="{FF2B5EF4-FFF2-40B4-BE49-F238E27FC236}">
                <a16:creationId xmlns:a16="http://schemas.microsoft.com/office/drawing/2014/main" id="{B797EEDC-47DF-4BA6-A208-DE0C2330FEA7}"/>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06311" y="870042"/>
            <a:ext cx="6150493" cy="3848775"/>
          </a:xfrm>
          <a:prstGeom prst="rect">
            <a:avLst/>
          </a:prstGeom>
        </p:spPr>
      </p:pic>
      <p:pic>
        <p:nvPicPr>
          <p:cNvPr id="9" name="Imagen 8" descr="Imagen que contiene vara de medición, suelo, edificio, exterior&#10;&#10;Descripción generada automáticamente">
            <a:extLst>
              <a:ext uri="{FF2B5EF4-FFF2-40B4-BE49-F238E27FC236}">
                <a16:creationId xmlns:a16="http://schemas.microsoft.com/office/drawing/2014/main" id="{4C1DF777-DDD7-45A2-814D-5741C403DDB7}"/>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6307165" y="870041"/>
            <a:ext cx="5795667" cy="3849361"/>
          </a:xfrm>
          <a:prstGeom prst="rect">
            <a:avLst/>
          </a:prstGeom>
        </p:spPr>
      </p:pic>
      <p:sp>
        <p:nvSpPr>
          <p:cNvPr id="12" name="CuadroTexto 11">
            <a:extLst>
              <a:ext uri="{FF2B5EF4-FFF2-40B4-BE49-F238E27FC236}">
                <a16:creationId xmlns:a16="http://schemas.microsoft.com/office/drawing/2014/main" id="{2AD0E4E0-123E-4B52-B584-9FFD2405F800}"/>
              </a:ext>
            </a:extLst>
          </p:cNvPr>
          <p:cNvSpPr txBox="1"/>
          <p:nvPr/>
        </p:nvSpPr>
        <p:spPr>
          <a:xfrm>
            <a:off x="106311" y="450512"/>
            <a:ext cx="365806" cy="369332"/>
          </a:xfrm>
          <a:prstGeom prst="rect">
            <a:avLst/>
          </a:prstGeom>
          <a:noFill/>
        </p:spPr>
        <p:txBody>
          <a:bodyPr wrap="none" rtlCol="0">
            <a:spAutoFit/>
          </a:bodyPr>
          <a:lstStyle/>
          <a:p>
            <a:r>
              <a:rPr lang="en-GB" b="1" dirty="0">
                <a:latin typeface="+mj-lt"/>
              </a:rPr>
              <a:t>a)</a:t>
            </a:r>
          </a:p>
        </p:txBody>
      </p:sp>
      <p:sp>
        <p:nvSpPr>
          <p:cNvPr id="13" name="CuadroTexto 12">
            <a:extLst>
              <a:ext uri="{FF2B5EF4-FFF2-40B4-BE49-F238E27FC236}">
                <a16:creationId xmlns:a16="http://schemas.microsoft.com/office/drawing/2014/main" id="{51A3E5B5-BD61-4DB0-B7AD-20EB3E59A383}"/>
              </a:ext>
            </a:extLst>
          </p:cNvPr>
          <p:cNvSpPr txBox="1"/>
          <p:nvPr/>
        </p:nvSpPr>
        <p:spPr>
          <a:xfrm>
            <a:off x="6307165" y="450970"/>
            <a:ext cx="480108" cy="369332"/>
          </a:xfrm>
          <a:prstGeom prst="rect">
            <a:avLst/>
          </a:prstGeom>
          <a:noFill/>
        </p:spPr>
        <p:txBody>
          <a:bodyPr wrap="square" rtlCol="0">
            <a:spAutoFit/>
          </a:bodyPr>
          <a:lstStyle/>
          <a:p>
            <a:r>
              <a:rPr lang="en-GB" b="1" dirty="0">
                <a:latin typeface="+mj-lt"/>
              </a:rPr>
              <a:t>b)</a:t>
            </a:r>
          </a:p>
        </p:txBody>
      </p:sp>
      <p:sp>
        <p:nvSpPr>
          <p:cNvPr id="14" name="CuadroTexto 13">
            <a:extLst>
              <a:ext uri="{FF2B5EF4-FFF2-40B4-BE49-F238E27FC236}">
                <a16:creationId xmlns:a16="http://schemas.microsoft.com/office/drawing/2014/main" id="{CC385902-4686-4F28-A2F6-79C9D347F578}"/>
              </a:ext>
            </a:extLst>
          </p:cNvPr>
          <p:cNvSpPr txBox="1"/>
          <p:nvPr/>
        </p:nvSpPr>
        <p:spPr>
          <a:xfrm>
            <a:off x="598746" y="5453267"/>
            <a:ext cx="10641467" cy="954107"/>
          </a:xfrm>
          <a:prstGeom prst="rect">
            <a:avLst/>
          </a:prstGeom>
          <a:noFill/>
        </p:spPr>
        <p:txBody>
          <a:bodyPr wrap="square" rtlCol="0">
            <a:spAutoFit/>
          </a:bodyPr>
          <a:lstStyle/>
          <a:p>
            <a:pPr algn="just"/>
            <a:r>
              <a:rPr lang="en-GB" sz="1400" dirty="0"/>
              <a:t>Layer IIIc surface excavation. 16a, general view of square E7 during the excavation works. Fig. 16b, detail of Dufour bladelet, corresponding with Fig. 13.3 of the manuscript.</a:t>
            </a:r>
          </a:p>
          <a:p>
            <a:pPr algn="just"/>
            <a:endParaRPr lang="en-GB" sz="1400" dirty="0"/>
          </a:p>
          <a:p>
            <a:pPr algn="just"/>
            <a:r>
              <a:rPr lang="en-GB" sz="1400" dirty="0"/>
              <a:t>Photo 2013</a:t>
            </a:r>
          </a:p>
        </p:txBody>
      </p:sp>
      <p:sp>
        <p:nvSpPr>
          <p:cNvPr id="15" name="Marcador de número de diapositiva 1">
            <a:extLst>
              <a:ext uri="{FF2B5EF4-FFF2-40B4-BE49-F238E27FC236}">
                <a16:creationId xmlns:a16="http://schemas.microsoft.com/office/drawing/2014/main" id="{BA877862-10E8-462D-94F7-104E4C6CB492}"/>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6</a:t>
            </a:fld>
            <a:endParaRPr lang="en-GB" sz="1800" dirty="0">
              <a:latin typeface="+mj-lt"/>
            </a:endParaRPr>
          </a:p>
        </p:txBody>
      </p:sp>
      <p:cxnSp>
        <p:nvCxnSpPr>
          <p:cNvPr id="16" name="Conector recto 15">
            <a:extLst>
              <a:ext uri="{FF2B5EF4-FFF2-40B4-BE49-F238E27FC236}">
                <a16:creationId xmlns:a16="http://schemas.microsoft.com/office/drawing/2014/main" id="{34FB3E17-0E97-4B2A-BBB4-507AAB71FDA5}"/>
              </a:ext>
            </a:extLst>
          </p:cNvPr>
          <p:cNvCxnSpPr>
            <a:cxnSpLocks/>
          </p:cNvCxnSpPr>
          <p:nvPr/>
        </p:nvCxnSpPr>
        <p:spPr>
          <a:xfrm>
            <a:off x="690113" y="5334945"/>
            <a:ext cx="1042933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9" name="Cerrar corchete 18">
            <a:extLst>
              <a:ext uri="{FF2B5EF4-FFF2-40B4-BE49-F238E27FC236}">
                <a16:creationId xmlns:a16="http://schemas.microsoft.com/office/drawing/2014/main" id="{9BAF6CCE-644B-4B7D-B4E8-18A7A7A37B9D}"/>
              </a:ext>
            </a:extLst>
          </p:cNvPr>
          <p:cNvSpPr/>
          <p:nvPr/>
        </p:nvSpPr>
        <p:spPr>
          <a:xfrm>
            <a:off x="5586984" y="3340455"/>
            <a:ext cx="82296" cy="374904"/>
          </a:xfrm>
          <a:prstGeom prst="rightBracket">
            <a:avLst/>
          </a:prstGeom>
          <a:ln w="1270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20" name="Cerrar corchete 19">
            <a:extLst>
              <a:ext uri="{FF2B5EF4-FFF2-40B4-BE49-F238E27FC236}">
                <a16:creationId xmlns:a16="http://schemas.microsoft.com/office/drawing/2014/main" id="{8A3D4F33-2BEC-4B19-97D8-BEEBE2B98DBE}"/>
              </a:ext>
            </a:extLst>
          </p:cNvPr>
          <p:cNvSpPr/>
          <p:nvPr/>
        </p:nvSpPr>
        <p:spPr>
          <a:xfrm>
            <a:off x="9296400" y="1947518"/>
            <a:ext cx="112776" cy="713385"/>
          </a:xfrm>
          <a:prstGeom prst="rightBracket">
            <a:avLst/>
          </a:prstGeom>
          <a:ln w="1270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Tree>
    <p:extLst>
      <p:ext uri="{BB962C8B-B14F-4D97-AF65-F5344CB8AC3E}">
        <p14:creationId xmlns:p14="http://schemas.microsoft.com/office/powerpoint/2010/main" val="16451819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481469" y="5067976"/>
            <a:ext cx="718466" cy="369332"/>
          </a:xfrm>
          <a:prstGeom prst="rect">
            <a:avLst/>
          </a:prstGeom>
          <a:noFill/>
        </p:spPr>
        <p:txBody>
          <a:bodyPr wrap="none" rtlCol="0">
            <a:spAutoFit/>
          </a:bodyPr>
          <a:lstStyle/>
          <a:p>
            <a:r>
              <a:rPr lang="en-GB" dirty="0"/>
              <a:t>Fig. Q</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20829" y="0"/>
            <a:ext cx="4540923" cy="338554"/>
          </a:xfrm>
          <a:prstGeom prst="rect">
            <a:avLst/>
          </a:prstGeom>
          <a:noFill/>
        </p:spPr>
        <p:txBody>
          <a:bodyPr wrap="none" rtlCol="0">
            <a:spAutoFit/>
          </a:bodyPr>
          <a:lstStyle/>
          <a:p>
            <a:r>
              <a:rPr lang="en-GB" sz="1600" b="1" dirty="0">
                <a:latin typeface="+mj-lt"/>
              </a:rPr>
              <a:t>Supporting Information 1 – Excavation of the Layer IIIc</a:t>
            </a:r>
          </a:p>
        </p:txBody>
      </p:sp>
      <p:pic>
        <p:nvPicPr>
          <p:cNvPr id="8" name="Imagen 7" descr="Imagen que contiene suelo, tarta, rock, chocolate&#10;&#10;Descripción generada automáticamente">
            <a:extLst>
              <a:ext uri="{FF2B5EF4-FFF2-40B4-BE49-F238E27FC236}">
                <a16:creationId xmlns:a16="http://schemas.microsoft.com/office/drawing/2014/main" id="{91D4070E-60A9-4A78-AC2A-AD50D66B13CC}"/>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6151320" y="953692"/>
            <a:ext cx="5943812" cy="3971991"/>
          </a:xfrm>
          <a:prstGeom prst="rect">
            <a:avLst/>
          </a:prstGeom>
        </p:spPr>
      </p:pic>
      <p:pic>
        <p:nvPicPr>
          <p:cNvPr id="3" name="Imagen 2" descr="Imagen que contiene suelo, edificio, interior&#10;&#10;Descripción generada automáticamente">
            <a:extLst>
              <a:ext uri="{FF2B5EF4-FFF2-40B4-BE49-F238E27FC236}">
                <a16:creationId xmlns:a16="http://schemas.microsoft.com/office/drawing/2014/main" id="{BDE600C5-F38D-4C0C-95EC-2D8FBD2C8B17}"/>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99568" y="953693"/>
            <a:ext cx="5980301" cy="3971991"/>
          </a:xfrm>
          <a:prstGeom prst="rect">
            <a:avLst/>
          </a:prstGeom>
        </p:spPr>
      </p:pic>
      <p:sp>
        <p:nvSpPr>
          <p:cNvPr id="12" name="CuadroTexto 11">
            <a:extLst>
              <a:ext uri="{FF2B5EF4-FFF2-40B4-BE49-F238E27FC236}">
                <a16:creationId xmlns:a16="http://schemas.microsoft.com/office/drawing/2014/main" id="{FCB6F16C-7070-4350-AAF1-64817DF207F5}"/>
              </a:ext>
            </a:extLst>
          </p:cNvPr>
          <p:cNvSpPr txBox="1"/>
          <p:nvPr/>
        </p:nvSpPr>
        <p:spPr>
          <a:xfrm>
            <a:off x="99568" y="551154"/>
            <a:ext cx="365806" cy="369332"/>
          </a:xfrm>
          <a:prstGeom prst="rect">
            <a:avLst/>
          </a:prstGeom>
          <a:noFill/>
        </p:spPr>
        <p:txBody>
          <a:bodyPr wrap="square" rtlCol="0">
            <a:spAutoFit/>
          </a:bodyPr>
          <a:lstStyle/>
          <a:p>
            <a:r>
              <a:rPr lang="en-GB" b="1" dirty="0">
                <a:latin typeface="+mj-lt"/>
              </a:rPr>
              <a:t>a)</a:t>
            </a:r>
          </a:p>
        </p:txBody>
      </p:sp>
      <p:sp>
        <p:nvSpPr>
          <p:cNvPr id="13" name="CuadroTexto 12">
            <a:extLst>
              <a:ext uri="{FF2B5EF4-FFF2-40B4-BE49-F238E27FC236}">
                <a16:creationId xmlns:a16="http://schemas.microsoft.com/office/drawing/2014/main" id="{364BC552-FDD2-4062-96BE-737297C97518}"/>
              </a:ext>
            </a:extLst>
          </p:cNvPr>
          <p:cNvSpPr txBox="1"/>
          <p:nvPr/>
        </p:nvSpPr>
        <p:spPr>
          <a:xfrm>
            <a:off x="6151320" y="551154"/>
            <a:ext cx="480108" cy="369332"/>
          </a:xfrm>
          <a:prstGeom prst="rect">
            <a:avLst/>
          </a:prstGeom>
          <a:noFill/>
        </p:spPr>
        <p:txBody>
          <a:bodyPr wrap="square" rtlCol="0">
            <a:spAutoFit/>
          </a:bodyPr>
          <a:lstStyle/>
          <a:p>
            <a:r>
              <a:rPr lang="en-GB" b="1" dirty="0">
                <a:latin typeface="+mj-lt"/>
              </a:rPr>
              <a:t>b)</a:t>
            </a:r>
          </a:p>
        </p:txBody>
      </p:sp>
      <p:sp>
        <p:nvSpPr>
          <p:cNvPr id="14" name="CuadroTexto 13">
            <a:extLst>
              <a:ext uri="{FF2B5EF4-FFF2-40B4-BE49-F238E27FC236}">
                <a16:creationId xmlns:a16="http://schemas.microsoft.com/office/drawing/2014/main" id="{596936D9-0847-4676-AA5B-8A506729721A}"/>
              </a:ext>
            </a:extLst>
          </p:cNvPr>
          <p:cNvSpPr txBox="1"/>
          <p:nvPr/>
        </p:nvSpPr>
        <p:spPr>
          <a:xfrm>
            <a:off x="481469" y="5663853"/>
            <a:ext cx="10681112" cy="954107"/>
          </a:xfrm>
          <a:prstGeom prst="rect">
            <a:avLst/>
          </a:prstGeom>
          <a:noFill/>
        </p:spPr>
        <p:txBody>
          <a:bodyPr wrap="square" rtlCol="0">
            <a:spAutoFit/>
          </a:bodyPr>
          <a:lstStyle/>
          <a:p>
            <a:pPr algn="just"/>
            <a:r>
              <a:rPr lang="en-GB" sz="1400" dirty="0"/>
              <a:t>Fig. 17a, general view of the reference section (E9 – D9) at the end of the excavation of Layer IIIc. Fig. 17b, close view of the interstratification of fire-related (carbonaceous lines and reddened sediment and stones) sediments and unaltered ones.</a:t>
            </a:r>
            <a:endParaRPr lang="en-GB" sz="1400" dirty="0">
              <a:highlight>
                <a:srgbClr val="FFFF00"/>
              </a:highlight>
            </a:endParaRPr>
          </a:p>
          <a:p>
            <a:pPr algn="just"/>
            <a:endParaRPr lang="en-GB" sz="1400" dirty="0"/>
          </a:p>
          <a:p>
            <a:pPr algn="just"/>
            <a:r>
              <a:rPr lang="en-GB" sz="1400" dirty="0"/>
              <a:t>Photo 2014</a:t>
            </a:r>
          </a:p>
        </p:txBody>
      </p:sp>
      <p:cxnSp>
        <p:nvCxnSpPr>
          <p:cNvPr id="15" name="Conector recto 14">
            <a:extLst>
              <a:ext uri="{FF2B5EF4-FFF2-40B4-BE49-F238E27FC236}">
                <a16:creationId xmlns:a16="http://schemas.microsoft.com/office/drawing/2014/main" id="{F44BC930-EB5D-46EE-8386-30E244B1DEBC}"/>
              </a:ext>
            </a:extLst>
          </p:cNvPr>
          <p:cNvCxnSpPr>
            <a:cxnSpLocks/>
          </p:cNvCxnSpPr>
          <p:nvPr/>
        </p:nvCxnSpPr>
        <p:spPr>
          <a:xfrm>
            <a:off x="569343" y="5559128"/>
            <a:ext cx="10463842"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6" name="Marcador de número de diapositiva 1">
            <a:extLst>
              <a:ext uri="{FF2B5EF4-FFF2-40B4-BE49-F238E27FC236}">
                <a16:creationId xmlns:a16="http://schemas.microsoft.com/office/drawing/2014/main" id="{0C5A6C75-BDD8-4FB9-A3EF-7B57D7858B17}"/>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7</a:t>
            </a:fld>
            <a:endParaRPr lang="en-GB" sz="1800" dirty="0">
              <a:latin typeface="+mj-lt"/>
            </a:endParaRPr>
          </a:p>
        </p:txBody>
      </p:sp>
      <p:sp>
        <p:nvSpPr>
          <p:cNvPr id="11" name="Abrir corchete 10">
            <a:extLst>
              <a:ext uri="{FF2B5EF4-FFF2-40B4-BE49-F238E27FC236}">
                <a16:creationId xmlns:a16="http://schemas.microsoft.com/office/drawing/2014/main" id="{466D7E09-BF2B-4382-85E0-7E9A8FD20BC9}"/>
              </a:ext>
            </a:extLst>
          </p:cNvPr>
          <p:cNvSpPr/>
          <p:nvPr/>
        </p:nvSpPr>
        <p:spPr>
          <a:xfrm>
            <a:off x="2066544" y="3300984"/>
            <a:ext cx="237744" cy="539496"/>
          </a:xfrm>
          <a:prstGeom prst="leftBracket">
            <a:avLst/>
          </a:prstGeom>
          <a:ln w="1270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cxnSp>
        <p:nvCxnSpPr>
          <p:cNvPr id="18" name="Conector recto 17">
            <a:extLst>
              <a:ext uri="{FF2B5EF4-FFF2-40B4-BE49-F238E27FC236}">
                <a16:creationId xmlns:a16="http://schemas.microsoft.com/office/drawing/2014/main" id="{8569CB11-8435-435F-98EA-ED1664E7E7D3}"/>
              </a:ext>
            </a:extLst>
          </p:cNvPr>
          <p:cNvCxnSpPr/>
          <p:nvPr/>
        </p:nvCxnSpPr>
        <p:spPr>
          <a:xfrm flipV="1">
            <a:off x="7315200" y="1502729"/>
            <a:ext cx="1243584" cy="13716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 name="Conector recto 18">
            <a:extLst>
              <a:ext uri="{FF2B5EF4-FFF2-40B4-BE49-F238E27FC236}">
                <a16:creationId xmlns:a16="http://schemas.microsoft.com/office/drawing/2014/main" id="{9DAF7FEC-58DB-44F1-96B5-C057FBB3AB65}"/>
              </a:ext>
            </a:extLst>
          </p:cNvPr>
          <p:cNvCxnSpPr>
            <a:cxnSpLocks/>
          </p:cNvCxnSpPr>
          <p:nvPr/>
        </p:nvCxnSpPr>
        <p:spPr>
          <a:xfrm flipV="1">
            <a:off x="7315200" y="1866434"/>
            <a:ext cx="1325880" cy="9246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0" name="Conector recto 19">
            <a:extLst>
              <a:ext uri="{FF2B5EF4-FFF2-40B4-BE49-F238E27FC236}">
                <a16:creationId xmlns:a16="http://schemas.microsoft.com/office/drawing/2014/main" id="{14CE9A8D-322E-4189-9883-BCC693CCD06B}"/>
              </a:ext>
            </a:extLst>
          </p:cNvPr>
          <p:cNvCxnSpPr>
            <a:cxnSpLocks/>
          </p:cNvCxnSpPr>
          <p:nvPr/>
        </p:nvCxnSpPr>
        <p:spPr>
          <a:xfrm>
            <a:off x="8363712" y="2378059"/>
            <a:ext cx="1795272" cy="530935"/>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3" name="Conector recto 22">
            <a:extLst>
              <a:ext uri="{FF2B5EF4-FFF2-40B4-BE49-F238E27FC236}">
                <a16:creationId xmlns:a16="http://schemas.microsoft.com/office/drawing/2014/main" id="{39E98FB5-3D51-4C9A-9262-6F1456B9C6C8}"/>
              </a:ext>
            </a:extLst>
          </p:cNvPr>
          <p:cNvCxnSpPr>
            <a:cxnSpLocks/>
          </p:cNvCxnSpPr>
          <p:nvPr/>
        </p:nvCxnSpPr>
        <p:spPr>
          <a:xfrm>
            <a:off x="8225590" y="2708872"/>
            <a:ext cx="1732226" cy="592112"/>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5" name="Conector recto 24">
            <a:extLst>
              <a:ext uri="{FF2B5EF4-FFF2-40B4-BE49-F238E27FC236}">
                <a16:creationId xmlns:a16="http://schemas.microsoft.com/office/drawing/2014/main" id="{CDAA5348-E946-4920-93CF-6EB55FF6D301}"/>
              </a:ext>
            </a:extLst>
          </p:cNvPr>
          <p:cNvCxnSpPr/>
          <p:nvPr/>
        </p:nvCxnSpPr>
        <p:spPr>
          <a:xfrm flipV="1">
            <a:off x="6912945" y="2771834"/>
            <a:ext cx="1243584" cy="13716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6" name="Conector recto 25">
            <a:extLst>
              <a:ext uri="{FF2B5EF4-FFF2-40B4-BE49-F238E27FC236}">
                <a16:creationId xmlns:a16="http://schemas.microsoft.com/office/drawing/2014/main" id="{375F41DC-7932-4A34-AAEA-33E9B99DE354}"/>
              </a:ext>
            </a:extLst>
          </p:cNvPr>
          <p:cNvCxnSpPr/>
          <p:nvPr/>
        </p:nvCxnSpPr>
        <p:spPr>
          <a:xfrm flipV="1">
            <a:off x="6982006" y="3305132"/>
            <a:ext cx="1243584" cy="13716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86152970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18120" y="563880"/>
            <a:ext cx="671979" cy="369332"/>
          </a:xfrm>
          <a:prstGeom prst="rect">
            <a:avLst/>
          </a:prstGeom>
          <a:noFill/>
        </p:spPr>
        <p:txBody>
          <a:bodyPr wrap="none" rtlCol="0">
            <a:spAutoFit/>
          </a:bodyPr>
          <a:lstStyle/>
          <a:p>
            <a:r>
              <a:rPr lang="en-GB" b="1" dirty="0">
                <a:latin typeface="+mj-lt"/>
              </a:rPr>
              <a:t>Fig. R</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13" name="Imagen 12" descr="Imagen que contiene rock, suelo&#10;&#10;Descripción generada automáticamente">
            <a:extLst>
              <a:ext uri="{FF2B5EF4-FFF2-40B4-BE49-F238E27FC236}">
                <a16:creationId xmlns:a16="http://schemas.microsoft.com/office/drawing/2014/main" id="{E891096E-55C0-4195-B235-3AC161E48C9E}"/>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563880"/>
            <a:ext cx="8840125" cy="5871426"/>
          </a:xfrm>
          <a:prstGeom prst="rect">
            <a:avLst/>
          </a:prstGeom>
        </p:spPr>
      </p:pic>
      <p:sp>
        <p:nvSpPr>
          <p:cNvPr id="8" name="CuadroTexto 7">
            <a:extLst>
              <a:ext uri="{FF2B5EF4-FFF2-40B4-BE49-F238E27FC236}">
                <a16:creationId xmlns:a16="http://schemas.microsoft.com/office/drawing/2014/main" id="{2AED46D4-47D7-4EA4-92A7-CFF631067864}"/>
              </a:ext>
            </a:extLst>
          </p:cNvPr>
          <p:cNvSpPr txBox="1"/>
          <p:nvPr/>
        </p:nvSpPr>
        <p:spPr>
          <a:xfrm>
            <a:off x="9118120" y="1223010"/>
            <a:ext cx="2863971" cy="1169551"/>
          </a:xfrm>
          <a:prstGeom prst="rect">
            <a:avLst/>
          </a:prstGeom>
          <a:noFill/>
        </p:spPr>
        <p:txBody>
          <a:bodyPr wrap="square" rtlCol="0">
            <a:spAutoFit/>
          </a:bodyPr>
          <a:lstStyle/>
          <a:p>
            <a:pPr algn="just"/>
            <a:r>
              <a:rPr lang="en-GB" sz="1400" dirty="0"/>
              <a:t>General view of the cave, showing the top of  Layer IV at the end of 2013 fieldwork season.</a:t>
            </a:r>
          </a:p>
          <a:p>
            <a:pPr algn="just"/>
            <a:endParaRPr lang="en-GB" sz="1400" dirty="0"/>
          </a:p>
          <a:p>
            <a:pPr algn="just"/>
            <a:r>
              <a:rPr lang="en-GB" sz="1400" dirty="0"/>
              <a:t>Photo 2013</a:t>
            </a:r>
          </a:p>
        </p:txBody>
      </p:sp>
      <p:sp>
        <p:nvSpPr>
          <p:cNvPr id="9" name="Marcador de número de diapositiva 1">
            <a:extLst>
              <a:ext uri="{FF2B5EF4-FFF2-40B4-BE49-F238E27FC236}">
                <a16:creationId xmlns:a16="http://schemas.microsoft.com/office/drawing/2014/main" id="{5EDABF66-FA9E-40A0-8DE9-C8CC2EBC54A6}"/>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8</a:t>
            </a:fld>
            <a:endParaRPr lang="en-GB" sz="1800" dirty="0">
              <a:latin typeface="+mj-lt"/>
            </a:endParaRPr>
          </a:p>
        </p:txBody>
      </p:sp>
      <p:cxnSp>
        <p:nvCxnSpPr>
          <p:cNvPr id="10" name="Conector recto 9">
            <a:extLst>
              <a:ext uri="{FF2B5EF4-FFF2-40B4-BE49-F238E27FC236}">
                <a16:creationId xmlns:a16="http://schemas.microsoft.com/office/drawing/2014/main" id="{3A1786CC-65BB-43CF-9669-78D2A12E4D83}"/>
              </a:ext>
            </a:extLst>
          </p:cNvPr>
          <p:cNvCxnSpPr>
            <a:cxnSpLocks/>
          </p:cNvCxnSpPr>
          <p:nvPr/>
        </p:nvCxnSpPr>
        <p:spPr>
          <a:xfrm>
            <a:off x="9221638" y="1082016"/>
            <a:ext cx="265693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8214172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44000" y="563880"/>
            <a:ext cx="654346" cy="369332"/>
          </a:xfrm>
          <a:prstGeom prst="rect">
            <a:avLst/>
          </a:prstGeom>
          <a:noFill/>
        </p:spPr>
        <p:txBody>
          <a:bodyPr wrap="none" rtlCol="0">
            <a:spAutoFit/>
          </a:bodyPr>
          <a:lstStyle/>
          <a:p>
            <a:r>
              <a:rPr lang="en-GB" b="1" dirty="0">
                <a:latin typeface="+mj-lt"/>
              </a:rPr>
              <a:t>Fig. S</a:t>
            </a:r>
          </a:p>
        </p:txBody>
      </p:sp>
      <p:pic>
        <p:nvPicPr>
          <p:cNvPr id="12" name="Imagen 11" descr="Imagen que contiene suelo, rock, exterior&#10;&#10;Descripción generada automáticamente">
            <a:extLst>
              <a:ext uri="{FF2B5EF4-FFF2-40B4-BE49-F238E27FC236}">
                <a16:creationId xmlns:a16="http://schemas.microsoft.com/office/drawing/2014/main" id="{FC8594A8-571F-4733-8EF8-98AC71924E0A}"/>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563880"/>
            <a:ext cx="8866099" cy="5888678"/>
          </a:xfrm>
          <a:prstGeom prst="rect">
            <a:avLst/>
          </a:prstGeom>
        </p:spPr>
      </p:pic>
      <p:sp>
        <p:nvSpPr>
          <p:cNvPr id="13" name="CuadroTexto 12">
            <a:extLst>
              <a:ext uri="{FF2B5EF4-FFF2-40B4-BE49-F238E27FC236}">
                <a16:creationId xmlns:a16="http://schemas.microsoft.com/office/drawing/2014/main" id="{64CFBCF7-9E9B-48CA-8217-BEB667EA3764}"/>
              </a:ext>
            </a:extLst>
          </p:cNvPr>
          <p:cNvSpPr txBox="1"/>
          <p:nvPr/>
        </p:nvSpPr>
        <p:spPr>
          <a:xfrm>
            <a:off x="0" y="0"/>
            <a:ext cx="4713726" cy="338554"/>
          </a:xfrm>
          <a:prstGeom prst="rect">
            <a:avLst/>
          </a:prstGeom>
          <a:noFill/>
        </p:spPr>
        <p:txBody>
          <a:bodyPr wrap="none" rtlCol="0">
            <a:spAutoFit/>
          </a:bodyPr>
          <a:lstStyle/>
          <a:p>
            <a:r>
              <a:rPr lang="en-GB" sz="1600" b="1" dirty="0">
                <a:latin typeface="+mj-lt"/>
              </a:rPr>
              <a:t>Supporting Information 1 – Excavation of the SW Gallery</a:t>
            </a:r>
          </a:p>
        </p:txBody>
      </p:sp>
      <p:sp>
        <p:nvSpPr>
          <p:cNvPr id="14" name="CuadroTexto 13">
            <a:extLst>
              <a:ext uri="{FF2B5EF4-FFF2-40B4-BE49-F238E27FC236}">
                <a16:creationId xmlns:a16="http://schemas.microsoft.com/office/drawing/2014/main" id="{668BD7DE-A460-460F-B81E-2DD73ABAF793}"/>
              </a:ext>
            </a:extLst>
          </p:cNvPr>
          <p:cNvSpPr txBox="1"/>
          <p:nvPr/>
        </p:nvSpPr>
        <p:spPr>
          <a:xfrm>
            <a:off x="9144000" y="1223010"/>
            <a:ext cx="2743200" cy="2031325"/>
          </a:xfrm>
          <a:prstGeom prst="rect">
            <a:avLst/>
          </a:prstGeom>
          <a:noFill/>
        </p:spPr>
        <p:txBody>
          <a:bodyPr wrap="square" rtlCol="0">
            <a:spAutoFit/>
          </a:bodyPr>
          <a:lstStyle/>
          <a:p>
            <a:pPr algn="just"/>
            <a:r>
              <a:rPr lang="en-GB" sz="1400" dirty="0"/>
              <a:t>View of the SW Gallery once all the sediments from the Upper Layers were excavated. </a:t>
            </a:r>
          </a:p>
          <a:p>
            <a:pPr algn="just"/>
            <a:endParaRPr lang="en-GB" sz="1400" dirty="0"/>
          </a:p>
          <a:p>
            <a:pPr algn="just"/>
            <a:r>
              <a:rPr lang="en-GB" sz="1400" dirty="0"/>
              <a:t>The depth of the surface correlates with the top of Layer IIIc in lines E and F.</a:t>
            </a:r>
          </a:p>
          <a:p>
            <a:pPr algn="just"/>
            <a:endParaRPr lang="en-GB" sz="1400" dirty="0"/>
          </a:p>
          <a:p>
            <a:pPr algn="just"/>
            <a:r>
              <a:rPr lang="en-GB" sz="1400" dirty="0"/>
              <a:t>Photo 2014</a:t>
            </a:r>
          </a:p>
        </p:txBody>
      </p:sp>
      <p:cxnSp>
        <p:nvCxnSpPr>
          <p:cNvPr id="7" name="Conector recto 6">
            <a:extLst>
              <a:ext uri="{FF2B5EF4-FFF2-40B4-BE49-F238E27FC236}">
                <a16:creationId xmlns:a16="http://schemas.microsoft.com/office/drawing/2014/main" id="{8CA938EB-A99F-4431-A73D-E1B0BEB41A94}"/>
              </a:ext>
            </a:extLst>
          </p:cNvPr>
          <p:cNvCxnSpPr>
            <a:cxnSpLocks/>
          </p:cNvCxnSpPr>
          <p:nvPr/>
        </p:nvCxnSpPr>
        <p:spPr>
          <a:xfrm>
            <a:off x="9204385" y="1056138"/>
            <a:ext cx="2562045"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3B39DA34-DCDE-40E1-A920-587D133E40C2}"/>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19</a:t>
            </a:fld>
            <a:endParaRPr lang="en-GB" sz="1800" dirty="0">
              <a:latin typeface="+mj-lt"/>
            </a:endParaRPr>
          </a:p>
        </p:txBody>
      </p:sp>
    </p:spTree>
    <p:extLst>
      <p:ext uri="{BB962C8B-B14F-4D97-AF65-F5344CB8AC3E}">
        <p14:creationId xmlns:p14="http://schemas.microsoft.com/office/powerpoint/2010/main" val="23518772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8950960" y="650059"/>
            <a:ext cx="673582" cy="369332"/>
          </a:xfrm>
          <a:prstGeom prst="rect">
            <a:avLst/>
          </a:prstGeom>
          <a:noFill/>
        </p:spPr>
        <p:txBody>
          <a:bodyPr wrap="none" rtlCol="0">
            <a:spAutoFit/>
          </a:bodyPr>
          <a:lstStyle/>
          <a:p>
            <a:r>
              <a:rPr lang="en-GB" b="1" dirty="0">
                <a:latin typeface="+mj-lt"/>
              </a:rPr>
              <a:t>Fig. B</a:t>
            </a:r>
          </a:p>
        </p:txBody>
      </p:sp>
      <p:sp>
        <p:nvSpPr>
          <p:cNvPr id="8" name="CuadroTexto 7">
            <a:extLst>
              <a:ext uri="{FF2B5EF4-FFF2-40B4-BE49-F238E27FC236}">
                <a16:creationId xmlns:a16="http://schemas.microsoft.com/office/drawing/2014/main" id="{A1976D3B-15C6-4686-AAA1-291BAB67641B}"/>
              </a:ext>
            </a:extLst>
          </p:cNvPr>
          <p:cNvSpPr txBox="1"/>
          <p:nvPr/>
        </p:nvSpPr>
        <p:spPr>
          <a:xfrm>
            <a:off x="0" y="0"/>
            <a:ext cx="5150834" cy="338554"/>
          </a:xfrm>
          <a:prstGeom prst="rect">
            <a:avLst/>
          </a:prstGeom>
          <a:noFill/>
        </p:spPr>
        <p:txBody>
          <a:bodyPr wrap="none" rtlCol="0">
            <a:spAutoFit/>
          </a:bodyPr>
          <a:lstStyle/>
          <a:p>
            <a:r>
              <a:rPr lang="en-GB" sz="1600" b="1" dirty="0">
                <a:latin typeface="+mj-lt"/>
              </a:rPr>
              <a:t>Supporting Information 1 – Excavation of the Holocene Layers</a:t>
            </a:r>
          </a:p>
        </p:txBody>
      </p:sp>
      <p:sp>
        <p:nvSpPr>
          <p:cNvPr id="7" name="CuadroTexto 6">
            <a:extLst>
              <a:ext uri="{FF2B5EF4-FFF2-40B4-BE49-F238E27FC236}">
                <a16:creationId xmlns:a16="http://schemas.microsoft.com/office/drawing/2014/main" id="{402C3B87-97E2-4442-AD36-8C72C096CFB4}"/>
              </a:ext>
            </a:extLst>
          </p:cNvPr>
          <p:cNvSpPr txBox="1"/>
          <p:nvPr/>
        </p:nvSpPr>
        <p:spPr>
          <a:xfrm>
            <a:off x="8950960" y="1231721"/>
            <a:ext cx="2857863" cy="954107"/>
          </a:xfrm>
          <a:prstGeom prst="rect">
            <a:avLst/>
          </a:prstGeom>
          <a:noFill/>
        </p:spPr>
        <p:txBody>
          <a:bodyPr wrap="square" rtlCol="0">
            <a:spAutoFit/>
          </a:bodyPr>
          <a:lstStyle/>
          <a:p>
            <a:pPr algn="just"/>
            <a:r>
              <a:rPr lang="en-GB" sz="1400" dirty="0"/>
              <a:t>View of Cova </a:t>
            </a:r>
            <a:r>
              <a:rPr lang="en-GB" sz="1400" dirty="0" err="1"/>
              <a:t>Foradada´s</a:t>
            </a:r>
            <a:r>
              <a:rPr lang="en-GB" sz="1400" dirty="0"/>
              <a:t> the first day of the rescue excavation in 1997</a:t>
            </a:r>
          </a:p>
          <a:p>
            <a:pPr algn="just"/>
            <a:endParaRPr lang="en-GB" sz="1400" dirty="0"/>
          </a:p>
          <a:p>
            <a:pPr algn="just"/>
            <a:r>
              <a:rPr lang="en-GB" sz="1400" dirty="0"/>
              <a:t>Photo 1997</a:t>
            </a:r>
          </a:p>
        </p:txBody>
      </p:sp>
      <p:pic>
        <p:nvPicPr>
          <p:cNvPr id="3" name="Imagen 2" descr="Imagen que contiene interior&#10;&#10;Descripción generada automáticamente">
            <a:extLst>
              <a:ext uri="{FF2B5EF4-FFF2-40B4-BE49-F238E27FC236}">
                <a16:creationId xmlns:a16="http://schemas.microsoft.com/office/drawing/2014/main" id="{C7AC11B4-53EC-4964-83FE-9A7DB4D636B7}"/>
              </a:ext>
            </a:extLst>
          </p:cNvPr>
          <p:cNvPicPr>
            <a:picLocks noChangeAspect="1"/>
          </p:cNvPicPr>
          <p:nvPr/>
        </p:nvPicPr>
        <p:blipFill rotWithShape="1">
          <a:blip r:embed="rId2">
            <a:extLst>
              <a:ext uri="{28A0092B-C50C-407E-A947-70E740481C1C}">
                <a14:useLocalDpi xmlns:a14="http://schemas.microsoft.com/office/drawing/2010/main"/>
              </a:ext>
            </a:extLst>
          </a:blip>
          <a:srcRect/>
          <a:stretch/>
        </p:blipFill>
        <p:spPr>
          <a:xfrm>
            <a:off x="121920" y="650059"/>
            <a:ext cx="8666736" cy="5706291"/>
          </a:xfrm>
          <a:prstGeom prst="rect">
            <a:avLst/>
          </a:prstGeom>
        </p:spPr>
      </p:pic>
      <p:sp>
        <p:nvSpPr>
          <p:cNvPr id="9" name="Marcador de número de diapositiva 1">
            <a:extLst>
              <a:ext uri="{FF2B5EF4-FFF2-40B4-BE49-F238E27FC236}">
                <a16:creationId xmlns:a16="http://schemas.microsoft.com/office/drawing/2014/main" id="{C9DDE7B1-4888-46B5-AB9F-EFD67021C425}"/>
              </a:ext>
            </a:extLst>
          </p:cNvPr>
          <p:cNvSpPr>
            <a:spLocks noGrp="1"/>
          </p:cNvSpPr>
          <p:nvPr>
            <p:ph type="sldNum" sz="quarter" idx="12"/>
          </p:nvPr>
        </p:nvSpPr>
        <p:spPr>
          <a:xfrm>
            <a:off x="11696697" y="6371729"/>
            <a:ext cx="315806" cy="365125"/>
          </a:xfrm>
        </p:spPr>
        <p:txBody>
          <a:bodyPr/>
          <a:lstStyle/>
          <a:p>
            <a:fld id="{192579BF-C6FD-43AD-A8B9-573B46B983AA}" type="slidenum">
              <a:rPr lang="en-GB" sz="1800" smtClean="0">
                <a:latin typeface="+mj-lt"/>
              </a:rPr>
              <a:t>2</a:t>
            </a:fld>
            <a:endParaRPr lang="en-GB" sz="1800" dirty="0">
              <a:latin typeface="+mj-lt"/>
            </a:endParaRPr>
          </a:p>
        </p:txBody>
      </p:sp>
      <p:cxnSp>
        <p:nvCxnSpPr>
          <p:cNvPr id="10" name="Conector recto 9">
            <a:extLst>
              <a:ext uri="{FF2B5EF4-FFF2-40B4-BE49-F238E27FC236}">
                <a16:creationId xmlns:a16="http://schemas.microsoft.com/office/drawing/2014/main" id="{C3F1318A-6819-4DD4-B28B-AD36753199F8}"/>
              </a:ext>
            </a:extLst>
          </p:cNvPr>
          <p:cNvCxnSpPr>
            <a:cxnSpLocks/>
          </p:cNvCxnSpPr>
          <p:nvPr/>
        </p:nvCxnSpPr>
        <p:spPr>
          <a:xfrm>
            <a:off x="9030789" y="1090315"/>
            <a:ext cx="2665908"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5817735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69878" y="549671"/>
            <a:ext cx="675185" cy="369332"/>
          </a:xfrm>
          <a:prstGeom prst="rect">
            <a:avLst/>
          </a:prstGeom>
          <a:noFill/>
        </p:spPr>
        <p:txBody>
          <a:bodyPr wrap="none" rtlCol="0">
            <a:spAutoFit/>
          </a:bodyPr>
          <a:lstStyle/>
          <a:p>
            <a:r>
              <a:rPr lang="en-GB" dirty="0"/>
              <a:t>Fig. T</a:t>
            </a:r>
          </a:p>
        </p:txBody>
      </p:sp>
      <p:pic>
        <p:nvPicPr>
          <p:cNvPr id="10" name="Imagen 9" descr="Imagen que contiene rock, exterior, suelo, montaña&#10;&#10;Descripción generada automáticamente">
            <a:extLst>
              <a:ext uri="{FF2B5EF4-FFF2-40B4-BE49-F238E27FC236}">
                <a16:creationId xmlns:a16="http://schemas.microsoft.com/office/drawing/2014/main" id="{DD932E92-6CD1-4A06-8EA6-39E31ABB130E}"/>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49671"/>
            <a:ext cx="8900482" cy="5911514"/>
          </a:xfrm>
          <a:prstGeom prst="rect">
            <a:avLst/>
          </a:prstGeom>
        </p:spPr>
      </p:pic>
      <p:sp>
        <p:nvSpPr>
          <p:cNvPr id="8" name="CuadroTexto 7">
            <a:extLst>
              <a:ext uri="{FF2B5EF4-FFF2-40B4-BE49-F238E27FC236}">
                <a16:creationId xmlns:a16="http://schemas.microsoft.com/office/drawing/2014/main" id="{76F1A5FB-C744-4D7C-A191-272D89AD1CD4}"/>
              </a:ext>
            </a:extLst>
          </p:cNvPr>
          <p:cNvSpPr txBox="1"/>
          <p:nvPr/>
        </p:nvSpPr>
        <p:spPr>
          <a:xfrm>
            <a:off x="9169878" y="1223010"/>
            <a:ext cx="2743201" cy="1384995"/>
          </a:xfrm>
          <a:prstGeom prst="rect">
            <a:avLst/>
          </a:prstGeom>
          <a:noFill/>
        </p:spPr>
        <p:txBody>
          <a:bodyPr wrap="square" rtlCol="0">
            <a:spAutoFit/>
          </a:bodyPr>
          <a:lstStyle/>
          <a:p>
            <a:pPr algn="just"/>
            <a:r>
              <a:rPr lang="en-GB" sz="1400" dirty="0"/>
              <a:t>Detailed view of the large calcareous boulders accumulated in the SW Gallery and the scarcity of sedimentary matrix.</a:t>
            </a:r>
          </a:p>
          <a:p>
            <a:pPr algn="just"/>
            <a:endParaRPr lang="en-GB" sz="1400" dirty="0"/>
          </a:p>
          <a:p>
            <a:pPr algn="just"/>
            <a:r>
              <a:rPr lang="en-GB" sz="1400" dirty="0"/>
              <a:t>Photo 2014</a:t>
            </a:r>
          </a:p>
        </p:txBody>
      </p:sp>
      <p:sp>
        <p:nvSpPr>
          <p:cNvPr id="9" name="CuadroTexto 8">
            <a:extLst>
              <a:ext uri="{FF2B5EF4-FFF2-40B4-BE49-F238E27FC236}">
                <a16:creationId xmlns:a16="http://schemas.microsoft.com/office/drawing/2014/main" id="{8C3FB265-9677-4059-BE62-6DE0E674029B}"/>
              </a:ext>
            </a:extLst>
          </p:cNvPr>
          <p:cNvSpPr txBox="1"/>
          <p:nvPr/>
        </p:nvSpPr>
        <p:spPr>
          <a:xfrm>
            <a:off x="0" y="0"/>
            <a:ext cx="4713726" cy="338554"/>
          </a:xfrm>
          <a:prstGeom prst="rect">
            <a:avLst/>
          </a:prstGeom>
          <a:noFill/>
        </p:spPr>
        <p:txBody>
          <a:bodyPr wrap="none" rtlCol="0">
            <a:spAutoFit/>
          </a:bodyPr>
          <a:lstStyle/>
          <a:p>
            <a:r>
              <a:rPr lang="en-GB" sz="1600" b="1" dirty="0">
                <a:latin typeface="+mj-lt"/>
              </a:rPr>
              <a:t>Supporting Information 1 – Excavation of the SW Gallery</a:t>
            </a:r>
          </a:p>
        </p:txBody>
      </p:sp>
      <p:sp>
        <p:nvSpPr>
          <p:cNvPr id="7" name="Marcador de número de diapositiva 1">
            <a:extLst>
              <a:ext uri="{FF2B5EF4-FFF2-40B4-BE49-F238E27FC236}">
                <a16:creationId xmlns:a16="http://schemas.microsoft.com/office/drawing/2014/main" id="{F36CCA99-80CF-46DB-B4E0-C61CC8ED2C8B}"/>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0</a:t>
            </a:fld>
            <a:endParaRPr lang="en-GB" sz="1800" dirty="0">
              <a:latin typeface="+mj-lt"/>
            </a:endParaRPr>
          </a:p>
        </p:txBody>
      </p:sp>
      <p:cxnSp>
        <p:nvCxnSpPr>
          <p:cNvPr id="11" name="Conector recto 10">
            <a:extLst>
              <a:ext uri="{FF2B5EF4-FFF2-40B4-BE49-F238E27FC236}">
                <a16:creationId xmlns:a16="http://schemas.microsoft.com/office/drawing/2014/main" id="{AD09D569-A4D3-4071-97D2-46C99D6BA9EC}"/>
              </a:ext>
            </a:extLst>
          </p:cNvPr>
          <p:cNvCxnSpPr>
            <a:cxnSpLocks/>
          </p:cNvCxnSpPr>
          <p:nvPr/>
        </p:nvCxnSpPr>
        <p:spPr>
          <a:xfrm>
            <a:off x="9204385" y="1056138"/>
            <a:ext cx="2648309"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34596733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230264" y="488399"/>
            <a:ext cx="696024" cy="369332"/>
          </a:xfrm>
          <a:prstGeom prst="rect">
            <a:avLst/>
          </a:prstGeom>
          <a:noFill/>
        </p:spPr>
        <p:txBody>
          <a:bodyPr wrap="none" rtlCol="0">
            <a:spAutoFit/>
          </a:bodyPr>
          <a:lstStyle/>
          <a:p>
            <a:r>
              <a:rPr lang="en-GB" b="1" dirty="0">
                <a:latin typeface="+mj-lt"/>
              </a:rPr>
              <a:t>Fig. U</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5" name="Imagen 4" descr="Imagen que contiene edificio&#10;&#10;Descripción generada automáticamente">
            <a:extLst>
              <a:ext uri="{FF2B5EF4-FFF2-40B4-BE49-F238E27FC236}">
                <a16:creationId xmlns:a16="http://schemas.microsoft.com/office/drawing/2014/main" id="{33D73780-BFBE-4FEB-AC41-EFC1F0846E7B}"/>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a:off x="121920" y="488399"/>
            <a:ext cx="8932217" cy="5938280"/>
          </a:xfrm>
          <a:prstGeom prst="rect">
            <a:avLst/>
          </a:prstGeom>
        </p:spPr>
      </p:pic>
      <p:sp>
        <p:nvSpPr>
          <p:cNvPr id="14" name="CuadroTexto 13">
            <a:extLst>
              <a:ext uri="{FF2B5EF4-FFF2-40B4-BE49-F238E27FC236}">
                <a16:creationId xmlns:a16="http://schemas.microsoft.com/office/drawing/2014/main" id="{9BA0ED99-049E-4152-8D5B-E1AEC067817E}"/>
              </a:ext>
            </a:extLst>
          </p:cNvPr>
          <p:cNvSpPr txBox="1"/>
          <p:nvPr/>
        </p:nvSpPr>
        <p:spPr>
          <a:xfrm>
            <a:off x="9230264" y="1223010"/>
            <a:ext cx="2743200" cy="2462213"/>
          </a:xfrm>
          <a:prstGeom prst="rect">
            <a:avLst/>
          </a:prstGeom>
          <a:noFill/>
        </p:spPr>
        <p:txBody>
          <a:bodyPr wrap="square" rtlCol="0">
            <a:spAutoFit/>
          </a:bodyPr>
          <a:lstStyle/>
          <a:p>
            <a:pPr algn="just"/>
            <a:r>
              <a:rPr lang="en-GB" sz="1400" dirty="0"/>
              <a:t>Top of the Layer IV exposed  at the excavation hall. A complex system of rabbit burrows was documented and emptied before starting with the excavation Layer IV. </a:t>
            </a:r>
          </a:p>
          <a:p>
            <a:pPr algn="just"/>
            <a:endParaRPr lang="en-GB" sz="1400" dirty="0"/>
          </a:p>
          <a:p>
            <a:pPr algn="just"/>
            <a:r>
              <a:rPr lang="en-GB" sz="1400" dirty="0"/>
              <a:t>Note how the top of Layer IV continues below the Travertine Platform 2.</a:t>
            </a:r>
          </a:p>
          <a:p>
            <a:pPr algn="just"/>
            <a:endParaRPr lang="en-GB" sz="1400" dirty="0"/>
          </a:p>
          <a:p>
            <a:pPr algn="just"/>
            <a:r>
              <a:rPr lang="en-GB" sz="1400" dirty="0"/>
              <a:t>Photo 2014</a:t>
            </a:r>
          </a:p>
        </p:txBody>
      </p:sp>
      <p:cxnSp>
        <p:nvCxnSpPr>
          <p:cNvPr id="8" name="Conector recto 7">
            <a:extLst>
              <a:ext uri="{FF2B5EF4-FFF2-40B4-BE49-F238E27FC236}">
                <a16:creationId xmlns:a16="http://schemas.microsoft.com/office/drawing/2014/main" id="{652BABE4-C0BB-4126-A4F4-7D2D5E77DA2A}"/>
              </a:ext>
            </a:extLst>
          </p:cNvPr>
          <p:cNvCxnSpPr>
            <a:cxnSpLocks/>
          </p:cNvCxnSpPr>
          <p:nvPr/>
        </p:nvCxnSpPr>
        <p:spPr>
          <a:xfrm>
            <a:off x="9342408" y="1056138"/>
            <a:ext cx="253616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330A5CF7-4630-4B5C-A0B9-7B164A69686A}"/>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1</a:t>
            </a:fld>
            <a:endParaRPr lang="en-GB" sz="1800" dirty="0">
              <a:latin typeface="+mj-lt"/>
            </a:endParaRPr>
          </a:p>
        </p:txBody>
      </p:sp>
      <p:sp>
        <p:nvSpPr>
          <p:cNvPr id="9" name="Forma libre: forma 8">
            <a:extLst>
              <a:ext uri="{FF2B5EF4-FFF2-40B4-BE49-F238E27FC236}">
                <a16:creationId xmlns:a16="http://schemas.microsoft.com/office/drawing/2014/main" id="{5A8F705B-48E9-43AD-9F37-9297BCEE4C5D}"/>
              </a:ext>
            </a:extLst>
          </p:cNvPr>
          <p:cNvSpPr/>
          <p:nvPr/>
        </p:nvSpPr>
        <p:spPr>
          <a:xfrm>
            <a:off x="3251200" y="3314700"/>
            <a:ext cx="895350" cy="1282700"/>
          </a:xfrm>
          <a:custGeom>
            <a:avLst/>
            <a:gdLst>
              <a:gd name="connsiteX0" fmla="*/ 552450 w 895350"/>
              <a:gd name="connsiteY0" fmla="*/ 38100 h 1282700"/>
              <a:gd name="connsiteX1" fmla="*/ 635000 w 895350"/>
              <a:gd name="connsiteY1" fmla="*/ 0 h 1282700"/>
              <a:gd name="connsiteX2" fmla="*/ 723900 w 895350"/>
              <a:gd name="connsiteY2" fmla="*/ 0 h 1282700"/>
              <a:gd name="connsiteX3" fmla="*/ 812800 w 895350"/>
              <a:gd name="connsiteY3" fmla="*/ 69850 h 1282700"/>
              <a:gd name="connsiteX4" fmla="*/ 831850 w 895350"/>
              <a:gd name="connsiteY4" fmla="*/ 234950 h 1282700"/>
              <a:gd name="connsiteX5" fmla="*/ 882650 w 895350"/>
              <a:gd name="connsiteY5" fmla="*/ 393700 h 1282700"/>
              <a:gd name="connsiteX6" fmla="*/ 895350 w 895350"/>
              <a:gd name="connsiteY6" fmla="*/ 571500 h 1282700"/>
              <a:gd name="connsiteX7" fmla="*/ 876300 w 895350"/>
              <a:gd name="connsiteY7" fmla="*/ 628650 h 1282700"/>
              <a:gd name="connsiteX8" fmla="*/ 844550 w 895350"/>
              <a:gd name="connsiteY8" fmla="*/ 742950 h 1282700"/>
              <a:gd name="connsiteX9" fmla="*/ 806450 w 895350"/>
              <a:gd name="connsiteY9" fmla="*/ 901700 h 1282700"/>
              <a:gd name="connsiteX10" fmla="*/ 590550 w 895350"/>
              <a:gd name="connsiteY10" fmla="*/ 1066800 h 1282700"/>
              <a:gd name="connsiteX11" fmla="*/ 457200 w 895350"/>
              <a:gd name="connsiteY11" fmla="*/ 1130300 h 1282700"/>
              <a:gd name="connsiteX12" fmla="*/ 285750 w 895350"/>
              <a:gd name="connsiteY12" fmla="*/ 1181100 h 1282700"/>
              <a:gd name="connsiteX13" fmla="*/ 107950 w 895350"/>
              <a:gd name="connsiteY13" fmla="*/ 1257300 h 1282700"/>
              <a:gd name="connsiteX14" fmla="*/ 0 w 895350"/>
              <a:gd name="connsiteY14" fmla="*/ 1282700 h 1282700"/>
              <a:gd name="connsiteX15" fmla="*/ 0 w 895350"/>
              <a:gd name="connsiteY15" fmla="*/ 1282700 h 12827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Lst>
            <a:rect l="l" t="t" r="r" b="b"/>
            <a:pathLst>
              <a:path w="895350" h="1282700">
                <a:moveTo>
                  <a:pt x="552450" y="38100"/>
                </a:moveTo>
                <a:lnTo>
                  <a:pt x="635000" y="0"/>
                </a:lnTo>
                <a:lnTo>
                  <a:pt x="723900" y="0"/>
                </a:lnTo>
                <a:lnTo>
                  <a:pt x="812800" y="69850"/>
                </a:lnTo>
                <a:lnTo>
                  <a:pt x="831850" y="234950"/>
                </a:lnTo>
                <a:lnTo>
                  <a:pt x="882650" y="393700"/>
                </a:lnTo>
                <a:lnTo>
                  <a:pt x="895350" y="571500"/>
                </a:lnTo>
                <a:lnTo>
                  <a:pt x="876300" y="628650"/>
                </a:lnTo>
                <a:lnTo>
                  <a:pt x="844550" y="742950"/>
                </a:lnTo>
                <a:lnTo>
                  <a:pt x="806450" y="901700"/>
                </a:lnTo>
                <a:lnTo>
                  <a:pt x="590550" y="1066800"/>
                </a:lnTo>
                <a:lnTo>
                  <a:pt x="457200" y="1130300"/>
                </a:lnTo>
                <a:lnTo>
                  <a:pt x="285750" y="1181100"/>
                </a:lnTo>
                <a:lnTo>
                  <a:pt x="107950" y="1257300"/>
                </a:lnTo>
                <a:lnTo>
                  <a:pt x="0" y="1282700"/>
                </a:lnTo>
                <a:lnTo>
                  <a:pt x="0" y="1282700"/>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Forma libre: forma 10">
            <a:extLst>
              <a:ext uri="{FF2B5EF4-FFF2-40B4-BE49-F238E27FC236}">
                <a16:creationId xmlns:a16="http://schemas.microsoft.com/office/drawing/2014/main" id="{2B995A44-F894-401F-806F-305A444ECE93}"/>
              </a:ext>
            </a:extLst>
          </p:cNvPr>
          <p:cNvSpPr/>
          <p:nvPr/>
        </p:nvSpPr>
        <p:spPr>
          <a:xfrm>
            <a:off x="4222750" y="3308350"/>
            <a:ext cx="2006600" cy="1327150"/>
          </a:xfrm>
          <a:custGeom>
            <a:avLst/>
            <a:gdLst>
              <a:gd name="connsiteX0" fmla="*/ 0 w 2006600"/>
              <a:gd name="connsiteY0" fmla="*/ 0 h 1327150"/>
              <a:gd name="connsiteX1" fmla="*/ 146050 w 2006600"/>
              <a:gd name="connsiteY1" fmla="*/ 50800 h 1327150"/>
              <a:gd name="connsiteX2" fmla="*/ 241300 w 2006600"/>
              <a:gd name="connsiteY2" fmla="*/ 88900 h 1327150"/>
              <a:gd name="connsiteX3" fmla="*/ 273050 w 2006600"/>
              <a:gd name="connsiteY3" fmla="*/ 196850 h 1327150"/>
              <a:gd name="connsiteX4" fmla="*/ 279400 w 2006600"/>
              <a:gd name="connsiteY4" fmla="*/ 292100 h 1327150"/>
              <a:gd name="connsiteX5" fmla="*/ 279400 w 2006600"/>
              <a:gd name="connsiteY5" fmla="*/ 361950 h 1327150"/>
              <a:gd name="connsiteX6" fmla="*/ 254000 w 2006600"/>
              <a:gd name="connsiteY6" fmla="*/ 431800 h 1327150"/>
              <a:gd name="connsiteX7" fmla="*/ 247650 w 2006600"/>
              <a:gd name="connsiteY7" fmla="*/ 488950 h 1327150"/>
              <a:gd name="connsiteX8" fmla="*/ 247650 w 2006600"/>
              <a:gd name="connsiteY8" fmla="*/ 565150 h 1327150"/>
              <a:gd name="connsiteX9" fmla="*/ 266700 w 2006600"/>
              <a:gd name="connsiteY9" fmla="*/ 666750 h 1327150"/>
              <a:gd name="connsiteX10" fmla="*/ 266700 w 2006600"/>
              <a:gd name="connsiteY10" fmla="*/ 717550 h 1327150"/>
              <a:gd name="connsiteX11" fmla="*/ 209550 w 2006600"/>
              <a:gd name="connsiteY11" fmla="*/ 800100 h 1327150"/>
              <a:gd name="connsiteX12" fmla="*/ 177800 w 2006600"/>
              <a:gd name="connsiteY12" fmla="*/ 895350 h 1327150"/>
              <a:gd name="connsiteX13" fmla="*/ 152400 w 2006600"/>
              <a:gd name="connsiteY13" fmla="*/ 990600 h 1327150"/>
              <a:gd name="connsiteX14" fmla="*/ 222250 w 2006600"/>
              <a:gd name="connsiteY14" fmla="*/ 1136650 h 1327150"/>
              <a:gd name="connsiteX15" fmla="*/ 292100 w 2006600"/>
              <a:gd name="connsiteY15" fmla="*/ 1212850 h 1327150"/>
              <a:gd name="connsiteX16" fmla="*/ 425450 w 2006600"/>
              <a:gd name="connsiteY16" fmla="*/ 1263650 h 1327150"/>
              <a:gd name="connsiteX17" fmla="*/ 666750 w 2006600"/>
              <a:gd name="connsiteY17" fmla="*/ 1289050 h 1327150"/>
              <a:gd name="connsiteX18" fmla="*/ 1054100 w 2006600"/>
              <a:gd name="connsiteY18" fmla="*/ 1327150 h 1327150"/>
              <a:gd name="connsiteX19" fmla="*/ 1244600 w 2006600"/>
              <a:gd name="connsiteY19" fmla="*/ 1314450 h 1327150"/>
              <a:gd name="connsiteX20" fmla="*/ 1428750 w 2006600"/>
              <a:gd name="connsiteY20" fmla="*/ 1263650 h 1327150"/>
              <a:gd name="connsiteX21" fmla="*/ 1530350 w 2006600"/>
              <a:gd name="connsiteY21" fmla="*/ 1193800 h 1327150"/>
              <a:gd name="connsiteX22" fmla="*/ 1657350 w 2006600"/>
              <a:gd name="connsiteY22" fmla="*/ 1104900 h 1327150"/>
              <a:gd name="connsiteX23" fmla="*/ 1727200 w 2006600"/>
              <a:gd name="connsiteY23" fmla="*/ 977900 h 1327150"/>
              <a:gd name="connsiteX24" fmla="*/ 1790700 w 2006600"/>
              <a:gd name="connsiteY24" fmla="*/ 895350 h 1327150"/>
              <a:gd name="connsiteX25" fmla="*/ 1866900 w 2006600"/>
              <a:gd name="connsiteY25" fmla="*/ 869950 h 1327150"/>
              <a:gd name="connsiteX26" fmla="*/ 1924050 w 2006600"/>
              <a:gd name="connsiteY26" fmla="*/ 844550 h 1327150"/>
              <a:gd name="connsiteX27" fmla="*/ 1981200 w 2006600"/>
              <a:gd name="connsiteY27" fmla="*/ 838200 h 1327150"/>
              <a:gd name="connsiteX28" fmla="*/ 2006600 w 2006600"/>
              <a:gd name="connsiteY28" fmla="*/ 838200 h 13271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2006600" h="1327150">
                <a:moveTo>
                  <a:pt x="0" y="0"/>
                </a:moveTo>
                <a:lnTo>
                  <a:pt x="146050" y="50800"/>
                </a:lnTo>
                <a:lnTo>
                  <a:pt x="241300" y="88900"/>
                </a:lnTo>
                <a:lnTo>
                  <a:pt x="273050" y="196850"/>
                </a:lnTo>
                <a:lnTo>
                  <a:pt x="279400" y="292100"/>
                </a:lnTo>
                <a:lnTo>
                  <a:pt x="279400" y="361950"/>
                </a:lnTo>
                <a:lnTo>
                  <a:pt x="254000" y="431800"/>
                </a:lnTo>
                <a:lnTo>
                  <a:pt x="247650" y="488950"/>
                </a:lnTo>
                <a:lnTo>
                  <a:pt x="247650" y="565150"/>
                </a:lnTo>
                <a:lnTo>
                  <a:pt x="266700" y="666750"/>
                </a:lnTo>
                <a:lnTo>
                  <a:pt x="266700" y="717550"/>
                </a:lnTo>
                <a:lnTo>
                  <a:pt x="209550" y="800100"/>
                </a:lnTo>
                <a:lnTo>
                  <a:pt x="177800" y="895350"/>
                </a:lnTo>
                <a:lnTo>
                  <a:pt x="152400" y="990600"/>
                </a:lnTo>
                <a:lnTo>
                  <a:pt x="222250" y="1136650"/>
                </a:lnTo>
                <a:lnTo>
                  <a:pt x="292100" y="1212850"/>
                </a:lnTo>
                <a:lnTo>
                  <a:pt x="425450" y="1263650"/>
                </a:lnTo>
                <a:lnTo>
                  <a:pt x="666750" y="1289050"/>
                </a:lnTo>
                <a:lnTo>
                  <a:pt x="1054100" y="1327150"/>
                </a:lnTo>
                <a:lnTo>
                  <a:pt x="1244600" y="1314450"/>
                </a:lnTo>
                <a:lnTo>
                  <a:pt x="1428750" y="1263650"/>
                </a:lnTo>
                <a:lnTo>
                  <a:pt x="1530350" y="1193800"/>
                </a:lnTo>
                <a:lnTo>
                  <a:pt x="1657350" y="1104900"/>
                </a:lnTo>
                <a:lnTo>
                  <a:pt x="1727200" y="977900"/>
                </a:lnTo>
                <a:lnTo>
                  <a:pt x="1790700" y="895350"/>
                </a:lnTo>
                <a:lnTo>
                  <a:pt x="1866900" y="869950"/>
                </a:lnTo>
                <a:lnTo>
                  <a:pt x="1924050" y="844550"/>
                </a:lnTo>
                <a:lnTo>
                  <a:pt x="1981200" y="838200"/>
                </a:lnTo>
                <a:lnTo>
                  <a:pt x="2006600" y="838200"/>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Forma libre: forma 11">
            <a:extLst>
              <a:ext uri="{FF2B5EF4-FFF2-40B4-BE49-F238E27FC236}">
                <a16:creationId xmlns:a16="http://schemas.microsoft.com/office/drawing/2014/main" id="{E63B60B5-5004-41ED-B4E5-1FDD5E9DE994}"/>
              </a:ext>
            </a:extLst>
          </p:cNvPr>
          <p:cNvSpPr/>
          <p:nvPr/>
        </p:nvSpPr>
        <p:spPr>
          <a:xfrm>
            <a:off x="3340100" y="4610100"/>
            <a:ext cx="2952750" cy="831850"/>
          </a:xfrm>
          <a:custGeom>
            <a:avLst/>
            <a:gdLst>
              <a:gd name="connsiteX0" fmla="*/ 0 w 2952750"/>
              <a:gd name="connsiteY0" fmla="*/ 323850 h 831850"/>
              <a:gd name="connsiteX1" fmla="*/ 139700 w 2952750"/>
              <a:gd name="connsiteY1" fmla="*/ 292100 h 831850"/>
              <a:gd name="connsiteX2" fmla="*/ 304800 w 2952750"/>
              <a:gd name="connsiteY2" fmla="*/ 222250 h 831850"/>
              <a:gd name="connsiteX3" fmla="*/ 368300 w 2952750"/>
              <a:gd name="connsiteY3" fmla="*/ 171450 h 831850"/>
              <a:gd name="connsiteX4" fmla="*/ 488950 w 2952750"/>
              <a:gd name="connsiteY4" fmla="*/ 82550 h 831850"/>
              <a:gd name="connsiteX5" fmla="*/ 673100 w 2952750"/>
              <a:gd name="connsiteY5" fmla="*/ 31750 h 831850"/>
              <a:gd name="connsiteX6" fmla="*/ 749300 w 2952750"/>
              <a:gd name="connsiteY6" fmla="*/ 0 h 831850"/>
              <a:gd name="connsiteX7" fmla="*/ 806450 w 2952750"/>
              <a:gd name="connsiteY7" fmla="*/ 31750 h 831850"/>
              <a:gd name="connsiteX8" fmla="*/ 901700 w 2952750"/>
              <a:gd name="connsiteY8" fmla="*/ 76200 h 831850"/>
              <a:gd name="connsiteX9" fmla="*/ 1009650 w 2952750"/>
              <a:gd name="connsiteY9" fmla="*/ 101600 h 831850"/>
              <a:gd name="connsiteX10" fmla="*/ 1066800 w 2952750"/>
              <a:gd name="connsiteY10" fmla="*/ 165100 h 831850"/>
              <a:gd name="connsiteX11" fmla="*/ 1149350 w 2952750"/>
              <a:gd name="connsiteY11" fmla="*/ 228600 h 831850"/>
              <a:gd name="connsiteX12" fmla="*/ 1225550 w 2952750"/>
              <a:gd name="connsiteY12" fmla="*/ 285750 h 831850"/>
              <a:gd name="connsiteX13" fmla="*/ 1263650 w 2952750"/>
              <a:gd name="connsiteY13" fmla="*/ 355600 h 831850"/>
              <a:gd name="connsiteX14" fmla="*/ 1327150 w 2952750"/>
              <a:gd name="connsiteY14" fmla="*/ 400050 h 831850"/>
              <a:gd name="connsiteX15" fmla="*/ 1416050 w 2952750"/>
              <a:gd name="connsiteY15" fmla="*/ 412750 h 831850"/>
              <a:gd name="connsiteX16" fmla="*/ 1517650 w 2952750"/>
              <a:gd name="connsiteY16" fmla="*/ 419100 h 831850"/>
              <a:gd name="connsiteX17" fmla="*/ 1638300 w 2952750"/>
              <a:gd name="connsiteY17" fmla="*/ 406400 h 831850"/>
              <a:gd name="connsiteX18" fmla="*/ 1828800 w 2952750"/>
              <a:gd name="connsiteY18" fmla="*/ 412750 h 831850"/>
              <a:gd name="connsiteX19" fmla="*/ 1949450 w 2952750"/>
              <a:gd name="connsiteY19" fmla="*/ 406400 h 831850"/>
              <a:gd name="connsiteX20" fmla="*/ 2082800 w 2952750"/>
              <a:gd name="connsiteY20" fmla="*/ 406400 h 831850"/>
              <a:gd name="connsiteX21" fmla="*/ 2139950 w 2952750"/>
              <a:gd name="connsiteY21" fmla="*/ 444500 h 831850"/>
              <a:gd name="connsiteX22" fmla="*/ 2222500 w 2952750"/>
              <a:gd name="connsiteY22" fmla="*/ 527050 h 831850"/>
              <a:gd name="connsiteX23" fmla="*/ 2266950 w 2952750"/>
              <a:gd name="connsiteY23" fmla="*/ 603250 h 831850"/>
              <a:gd name="connsiteX24" fmla="*/ 2336800 w 2952750"/>
              <a:gd name="connsiteY24" fmla="*/ 654050 h 831850"/>
              <a:gd name="connsiteX25" fmla="*/ 2470150 w 2952750"/>
              <a:gd name="connsiteY25" fmla="*/ 698500 h 831850"/>
              <a:gd name="connsiteX26" fmla="*/ 2578100 w 2952750"/>
              <a:gd name="connsiteY26" fmla="*/ 736600 h 831850"/>
              <a:gd name="connsiteX27" fmla="*/ 2774950 w 2952750"/>
              <a:gd name="connsiteY27" fmla="*/ 755650 h 831850"/>
              <a:gd name="connsiteX28" fmla="*/ 2794000 w 2952750"/>
              <a:gd name="connsiteY28" fmla="*/ 774700 h 831850"/>
              <a:gd name="connsiteX29" fmla="*/ 2851150 w 2952750"/>
              <a:gd name="connsiteY29" fmla="*/ 825500 h 831850"/>
              <a:gd name="connsiteX30" fmla="*/ 2914650 w 2952750"/>
              <a:gd name="connsiteY30" fmla="*/ 831850 h 831850"/>
              <a:gd name="connsiteX31" fmla="*/ 2914650 w 2952750"/>
              <a:gd name="connsiteY31" fmla="*/ 831850 h 831850"/>
              <a:gd name="connsiteX32" fmla="*/ 2952750 w 2952750"/>
              <a:gd name="connsiteY32" fmla="*/ 831850 h 8318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Lst>
            <a:rect l="l" t="t" r="r" b="b"/>
            <a:pathLst>
              <a:path w="2952750" h="831850">
                <a:moveTo>
                  <a:pt x="0" y="323850"/>
                </a:moveTo>
                <a:lnTo>
                  <a:pt x="139700" y="292100"/>
                </a:lnTo>
                <a:lnTo>
                  <a:pt x="304800" y="222250"/>
                </a:lnTo>
                <a:lnTo>
                  <a:pt x="368300" y="171450"/>
                </a:lnTo>
                <a:lnTo>
                  <a:pt x="488950" y="82550"/>
                </a:lnTo>
                <a:lnTo>
                  <a:pt x="673100" y="31750"/>
                </a:lnTo>
                <a:lnTo>
                  <a:pt x="749300" y="0"/>
                </a:lnTo>
                <a:lnTo>
                  <a:pt x="806450" y="31750"/>
                </a:lnTo>
                <a:lnTo>
                  <a:pt x="901700" y="76200"/>
                </a:lnTo>
                <a:lnTo>
                  <a:pt x="1009650" y="101600"/>
                </a:lnTo>
                <a:lnTo>
                  <a:pt x="1066800" y="165100"/>
                </a:lnTo>
                <a:lnTo>
                  <a:pt x="1149350" y="228600"/>
                </a:lnTo>
                <a:lnTo>
                  <a:pt x="1225550" y="285750"/>
                </a:lnTo>
                <a:lnTo>
                  <a:pt x="1263650" y="355600"/>
                </a:lnTo>
                <a:lnTo>
                  <a:pt x="1327150" y="400050"/>
                </a:lnTo>
                <a:lnTo>
                  <a:pt x="1416050" y="412750"/>
                </a:lnTo>
                <a:lnTo>
                  <a:pt x="1517650" y="419100"/>
                </a:lnTo>
                <a:lnTo>
                  <a:pt x="1638300" y="406400"/>
                </a:lnTo>
                <a:lnTo>
                  <a:pt x="1828800" y="412750"/>
                </a:lnTo>
                <a:lnTo>
                  <a:pt x="1949450" y="406400"/>
                </a:lnTo>
                <a:lnTo>
                  <a:pt x="2082800" y="406400"/>
                </a:lnTo>
                <a:lnTo>
                  <a:pt x="2139950" y="444500"/>
                </a:lnTo>
                <a:lnTo>
                  <a:pt x="2222500" y="527050"/>
                </a:lnTo>
                <a:lnTo>
                  <a:pt x="2266950" y="603250"/>
                </a:lnTo>
                <a:lnTo>
                  <a:pt x="2336800" y="654050"/>
                </a:lnTo>
                <a:lnTo>
                  <a:pt x="2470150" y="698500"/>
                </a:lnTo>
                <a:lnTo>
                  <a:pt x="2578100" y="736600"/>
                </a:lnTo>
                <a:lnTo>
                  <a:pt x="2774950" y="755650"/>
                </a:lnTo>
                <a:lnTo>
                  <a:pt x="2794000" y="774700"/>
                </a:lnTo>
                <a:lnTo>
                  <a:pt x="2851150" y="825500"/>
                </a:lnTo>
                <a:lnTo>
                  <a:pt x="2914650" y="831850"/>
                </a:lnTo>
                <a:lnTo>
                  <a:pt x="2914650" y="831850"/>
                </a:lnTo>
                <a:lnTo>
                  <a:pt x="2952750" y="831850"/>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CuadroTexto 14">
            <a:extLst>
              <a:ext uri="{FF2B5EF4-FFF2-40B4-BE49-F238E27FC236}">
                <a16:creationId xmlns:a16="http://schemas.microsoft.com/office/drawing/2014/main" id="{1DD90307-DC9F-4C02-B200-F81A9DC5BFB0}"/>
              </a:ext>
            </a:extLst>
          </p:cNvPr>
          <p:cNvSpPr txBox="1"/>
          <p:nvPr/>
        </p:nvSpPr>
        <p:spPr>
          <a:xfrm>
            <a:off x="4816475" y="4020118"/>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Layer IV</a:t>
            </a:r>
          </a:p>
        </p:txBody>
      </p:sp>
      <p:sp>
        <p:nvSpPr>
          <p:cNvPr id="16" name="CuadroTexto 15">
            <a:extLst>
              <a:ext uri="{FF2B5EF4-FFF2-40B4-BE49-F238E27FC236}">
                <a16:creationId xmlns:a16="http://schemas.microsoft.com/office/drawing/2014/main" id="{B479602A-804D-44E0-8DAF-F79CBA4BC33F}"/>
              </a:ext>
            </a:extLst>
          </p:cNvPr>
          <p:cNvSpPr txBox="1"/>
          <p:nvPr/>
        </p:nvSpPr>
        <p:spPr>
          <a:xfrm>
            <a:off x="5231607" y="4852066"/>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Burrows</a:t>
            </a:r>
          </a:p>
        </p:txBody>
      </p:sp>
    </p:spTree>
    <p:extLst>
      <p:ext uri="{BB962C8B-B14F-4D97-AF65-F5344CB8AC3E}">
        <p14:creationId xmlns:p14="http://schemas.microsoft.com/office/powerpoint/2010/main" val="147865847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61252" y="569859"/>
            <a:ext cx="676788" cy="369332"/>
          </a:xfrm>
          <a:prstGeom prst="rect">
            <a:avLst/>
          </a:prstGeom>
          <a:noFill/>
        </p:spPr>
        <p:txBody>
          <a:bodyPr wrap="none" rtlCol="0">
            <a:spAutoFit/>
          </a:bodyPr>
          <a:lstStyle/>
          <a:p>
            <a:r>
              <a:rPr lang="en-GB" b="1" dirty="0">
                <a:latin typeface="+mj-lt"/>
              </a:rPr>
              <a:t>Fig. V</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11" name="Imagen 10" descr="Imagen que contiene rock, naturaleza, suelo&#10;&#10;Descripción generada automáticamente">
            <a:extLst>
              <a:ext uri="{FF2B5EF4-FFF2-40B4-BE49-F238E27FC236}">
                <a16:creationId xmlns:a16="http://schemas.microsoft.com/office/drawing/2014/main" id="{801058B2-AAD5-4E21-95E2-410C15341EB8}"/>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63880"/>
            <a:ext cx="8918052" cy="5923184"/>
          </a:xfrm>
          <a:prstGeom prst="rect">
            <a:avLst/>
          </a:prstGeom>
        </p:spPr>
      </p:pic>
      <p:sp>
        <p:nvSpPr>
          <p:cNvPr id="8" name="CuadroTexto 7">
            <a:extLst>
              <a:ext uri="{FF2B5EF4-FFF2-40B4-BE49-F238E27FC236}">
                <a16:creationId xmlns:a16="http://schemas.microsoft.com/office/drawing/2014/main" id="{2C577CAF-C106-49FF-A6A4-D2E76697C8EA}"/>
              </a:ext>
            </a:extLst>
          </p:cNvPr>
          <p:cNvSpPr txBox="1"/>
          <p:nvPr/>
        </p:nvSpPr>
        <p:spPr>
          <a:xfrm>
            <a:off x="9161252" y="1223010"/>
            <a:ext cx="2743201" cy="1815882"/>
          </a:xfrm>
          <a:prstGeom prst="rect">
            <a:avLst/>
          </a:prstGeom>
          <a:noFill/>
        </p:spPr>
        <p:txBody>
          <a:bodyPr wrap="square" rtlCol="0">
            <a:spAutoFit/>
          </a:bodyPr>
          <a:lstStyle/>
          <a:p>
            <a:pPr algn="just"/>
            <a:r>
              <a:rPr lang="en-GB" sz="1400" dirty="0"/>
              <a:t>Advancing the excavation of Layer IV. Some of the calcarenite and travertine fragments helping to differentiate Layer IV and sublayer IV1 starts to appear, specially at E7 and D8.</a:t>
            </a:r>
          </a:p>
          <a:p>
            <a:pPr algn="just"/>
            <a:endParaRPr lang="en-GB" sz="1400" dirty="0"/>
          </a:p>
          <a:p>
            <a:pPr algn="just"/>
            <a:r>
              <a:rPr lang="en-GB" sz="1400" dirty="0"/>
              <a:t>Photo 2014</a:t>
            </a:r>
          </a:p>
        </p:txBody>
      </p:sp>
      <p:sp>
        <p:nvSpPr>
          <p:cNvPr id="9" name="Marcador de número de diapositiva 1">
            <a:extLst>
              <a:ext uri="{FF2B5EF4-FFF2-40B4-BE49-F238E27FC236}">
                <a16:creationId xmlns:a16="http://schemas.microsoft.com/office/drawing/2014/main" id="{65A85276-6925-40BE-A102-4C33A9C0C224}"/>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2</a:t>
            </a:fld>
            <a:endParaRPr lang="en-GB" sz="1800" dirty="0">
              <a:latin typeface="+mj-lt"/>
            </a:endParaRPr>
          </a:p>
        </p:txBody>
      </p:sp>
      <p:cxnSp>
        <p:nvCxnSpPr>
          <p:cNvPr id="10" name="Conector recto 9">
            <a:extLst>
              <a:ext uri="{FF2B5EF4-FFF2-40B4-BE49-F238E27FC236}">
                <a16:creationId xmlns:a16="http://schemas.microsoft.com/office/drawing/2014/main" id="{3C6E2292-505C-4062-9412-25D6E9095DF7}"/>
              </a:ext>
            </a:extLst>
          </p:cNvPr>
          <p:cNvCxnSpPr>
            <a:cxnSpLocks/>
          </p:cNvCxnSpPr>
          <p:nvPr/>
        </p:nvCxnSpPr>
        <p:spPr>
          <a:xfrm>
            <a:off x="9247517" y="1056138"/>
            <a:ext cx="2553419"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cxnSp>
        <p:nvCxnSpPr>
          <p:cNvPr id="12" name="Conector recto de flecha 11">
            <a:extLst>
              <a:ext uri="{FF2B5EF4-FFF2-40B4-BE49-F238E27FC236}">
                <a16:creationId xmlns:a16="http://schemas.microsoft.com/office/drawing/2014/main" id="{4B12896A-1128-4EE2-B509-11D1EC195DE9}"/>
              </a:ext>
            </a:extLst>
          </p:cNvPr>
          <p:cNvCxnSpPr>
            <a:cxnSpLocks/>
          </p:cNvCxnSpPr>
          <p:nvPr/>
        </p:nvCxnSpPr>
        <p:spPr>
          <a:xfrm flipH="1">
            <a:off x="2417198" y="3271031"/>
            <a:ext cx="308908" cy="262392"/>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cxnSp>
        <p:nvCxnSpPr>
          <p:cNvPr id="13" name="Conector recto de flecha 12">
            <a:extLst>
              <a:ext uri="{FF2B5EF4-FFF2-40B4-BE49-F238E27FC236}">
                <a16:creationId xmlns:a16="http://schemas.microsoft.com/office/drawing/2014/main" id="{D741CA92-395F-4D33-9658-499B61C6D090}"/>
              </a:ext>
            </a:extLst>
          </p:cNvPr>
          <p:cNvCxnSpPr>
            <a:cxnSpLocks/>
          </p:cNvCxnSpPr>
          <p:nvPr/>
        </p:nvCxnSpPr>
        <p:spPr>
          <a:xfrm flipH="1">
            <a:off x="2831991" y="4210610"/>
            <a:ext cx="308908" cy="262392"/>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cxnSp>
        <p:nvCxnSpPr>
          <p:cNvPr id="14" name="Conector recto de flecha 13">
            <a:extLst>
              <a:ext uri="{FF2B5EF4-FFF2-40B4-BE49-F238E27FC236}">
                <a16:creationId xmlns:a16="http://schemas.microsoft.com/office/drawing/2014/main" id="{B9C97759-0592-46B4-A998-87839ECB11CA}"/>
              </a:ext>
            </a:extLst>
          </p:cNvPr>
          <p:cNvCxnSpPr>
            <a:cxnSpLocks/>
          </p:cNvCxnSpPr>
          <p:nvPr/>
        </p:nvCxnSpPr>
        <p:spPr>
          <a:xfrm flipH="1">
            <a:off x="3246784" y="2875892"/>
            <a:ext cx="308908" cy="262392"/>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8900247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06731" y="481965"/>
            <a:ext cx="750526" cy="369332"/>
          </a:xfrm>
          <a:prstGeom prst="rect">
            <a:avLst/>
          </a:prstGeom>
          <a:noFill/>
        </p:spPr>
        <p:txBody>
          <a:bodyPr wrap="none" rtlCol="0">
            <a:spAutoFit/>
          </a:bodyPr>
          <a:lstStyle/>
          <a:p>
            <a:r>
              <a:rPr lang="en-GB" b="1" dirty="0">
                <a:latin typeface="+mj-lt"/>
              </a:rPr>
              <a:t>Fig. W</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3" name="Imagen 2" descr="Imagen que contiene rock, suelo&#10;&#10;Descripción generada automáticamente">
            <a:extLst>
              <a:ext uri="{FF2B5EF4-FFF2-40B4-BE49-F238E27FC236}">
                <a16:creationId xmlns:a16="http://schemas.microsoft.com/office/drawing/2014/main" id="{00DD9B6A-E018-47B7-B9C6-841E2A843947}"/>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a:off x="121920" y="481965"/>
            <a:ext cx="8704723" cy="6151748"/>
          </a:xfrm>
          <a:prstGeom prst="rect">
            <a:avLst/>
          </a:prstGeom>
        </p:spPr>
      </p:pic>
      <p:sp>
        <p:nvSpPr>
          <p:cNvPr id="8" name="CuadroTexto 7">
            <a:extLst>
              <a:ext uri="{FF2B5EF4-FFF2-40B4-BE49-F238E27FC236}">
                <a16:creationId xmlns:a16="http://schemas.microsoft.com/office/drawing/2014/main" id="{18094604-0561-49C4-A6F2-7D00501F4AE9}"/>
              </a:ext>
            </a:extLst>
          </p:cNvPr>
          <p:cNvSpPr txBox="1"/>
          <p:nvPr/>
        </p:nvSpPr>
        <p:spPr>
          <a:xfrm>
            <a:off x="9002717" y="1223010"/>
            <a:ext cx="3009786" cy="1384995"/>
          </a:xfrm>
          <a:prstGeom prst="rect">
            <a:avLst/>
          </a:prstGeom>
          <a:noFill/>
        </p:spPr>
        <p:txBody>
          <a:bodyPr wrap="square" rtlCol="0">
            <a:spAutoFit/>
          </a:bodyPr>
          <a:lstStyle/>
          <a:p>
            <a:pPr algn="just"/>
            <a:r>
              <a:rPr lang="en-GB" sz="1400" dirty="0"/>
              <a:t>First Châtelperronian point uncovered during the excavation of Layer I.  Squares E8 – F8 (Fig. 15.1 of the manuscript).</a:t>
            </a:r>
          </a:p>
          <a:p>
            <a:pPr algn="just"/>
            <a:endParaRPr lang="en-GB" sz="1400" dirty="0"/>
          </a:p>
          <a:p>
            <a:pPr algn="just"/>
            <a:r>
              <a:rPr lang="en-GB" sz="1400" dirty="0"/>
              <a:t>Photo 2014</a:t>
            </a:r>
          </a:p>
        </p:txBody>
      </p:sp>
      <p:cxnSp>
        <p:nvCxnSpPr>
          <p:cNvPr id="9" name="Conector recto 8">
            <a:extLst>
              <a:ext uri="{FF2B5EF4-FFF2-40B4-BE49-F238E27FC236}">
                <a16:creationId xmlns:a16="http://schemas.microsoft.com/office/drawing/2014/main" id="{2A4A205B-1CA5-4FC5-8734-855F3BD8A0CC}"/>
              </a:ext>
            </a:extLst>
          </p:cNvPr>
          <p:cNvCxnSpPr>
            <a:cxnSpLocks/>
          </p:cNvCxnSpPr>
          <p:nvPr/>
        </p:nvCxnSpPr>
        <p:spPr>
          <a:xfrm>
            <a:off x="9092240" y="1056138"/>
            <a:ext cx="2622430"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8B285890-06EB-4CB9-B2E3-41C80268ABF0}"/>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3</a:t>
            </a:fld>
            <a:endParaRPr lang="en-GB" sz="1800" dirty="0">
              <a:latin typeface="+mj-lt"/>
            </a:endParaRPr>
          </a:p>
        </p:txBody>
      </p:sp>
    </p:spTree>
    <p:extLst>
      <p:ext uri="{BB962C8B-B14F-4D97-AF65-F5344CB8AC3E}">
        <p14:creationId xmlns:p14="http://schemas.microsoft.com/office/powerpoint/2010/main" val="157348510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8185150" y="473372"/>
            <a:ext cx="665567" cy="369332"/>
          </a:xfrm>
          <a:prstGeom prst="rect">
            <a:avLst/>
          </a:prstGeom>
          <a:noFill/>
        </p:spPr>
        <p:txBody>
          <a:bodyPr wrap="none" rtlCol="0">
            <a:spAutoFit/>
          </a:bodyPr>
          <a:lstStyle/>
          <a:p>
            <a:r>
              <a:rPr lang="en-GB" b="1" dirty="0">
                <a:latin typeface="+mj-lt"/>
              </a:rPr>
              <a:t>Fig. X</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10" name="Imagen 9" descr="Imagen que contiene dispositivo, edificio, suelo&#10;&#10;Descripción generada automáticamente">
            <a:extLst>
              <a:ext uri="{FF2B5EF4-FFF2-40B4-BE49-F238E27FC236}">
                <a16:creationId xmlns:a16="http://schemas.microsoft.com/office/drawing/2014/main" id="{65340530-EB6B-404B-9829-CBA3B65C0458}"/>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a:off x="99528" y="473372"/>
            <a:ext cx="7733257" cy="6261649"/>
          </a:xfrm>
          <a:prstGeom prst="rect">
            <a:avLst/>
          </a:prstGeom>
        </p:spPr>
      </p:pic>
      <p:sp>
        <p:nvSpPr>
          <p:cNvPr id="5" name="CuadroTexto 4">
            <a:extLst>
              <a:ext uri="{FF2B5EF4-FFF2-40B4-BE49-F238E27FC236}">
                <a16:creationId xmlns:a16="http://schemas.microsoft.com/office/drawing/2014/main" id="{35FD6215-8BB5-42AD-A9D7-E9E6DFDAEB63}"/>
              </a:ext>
            </a:extLst>
          </p:cNvPr>
          <p:cNvSpPr txBox="1"/>
          <p:nvPr/>
        </p:nvSpPr>
        <p:spPr>
          <a:xfrm>
            <a:off x="8185150" y="1145372"/>
            <a:ext cx="3507740" cy="1169551"/>
          </a:xfrm>
          <a:prstGeom prst="rect">
            <a:avLst/>
          </a:prstGeom>
          <a:noFill/>
        </p:spPr>
        <p:txBody>
          <a:bodyPr wrap="square" rtlCol="0">
            <a:spAutoFit/>
          </a:bodyPr>
          <a:lstStyle/>
          <a:p>
            <a:pPr algn="just"/>
            <a:r>
              <a:rPr lang="en-GB" sz="1400" dirty="0"/>
              <a:t>Distally fractured Châtelperronian point appeared during the excavation of sublayer IV1 at F8. Fig.15.2 of the manuscript.</a:t>
            </a:r>
          </a:p>
          <a:p>
            <a:pPr algn="just"/>
            <a:endParaRPr lang="en-GB" sz="1400" dirty="0"/>
          </a:p>
          <a:p>
            <a:pPr algn="just"/>
            <a:r>
              <a:rPr lang="en-GB" sz="1400" dirty="0"/>
              <a:t>Photo 2014</a:t>
            </a:r>
          </a:p>
        </p:txBody>
      </p:sp>
      <p:sp>
        <p:nvSpPr>
          <p:cNvPr id="8" name="Marcador de número de diapositiva 1">
            <a:extLst>
              <a:ext uri="{FF2B5EF4-FFF2-40B4-BE49-F238E27FC236}">
                <a16:creationId xmlns:a16="http://schemas.microsoft.com/office/drawing/2014/main" id="{F3349FA3-EA63-49A2-89D6-B995CCD72536}"/>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4</a:t>
            </a:fld>
            <a:endParaRPr lang="en-GB" sz="1800" dirty="0">
              <a:latin typeface="+mj-lt"/>
            </a:endParaRPr>
          </a:p>
        </p:txBody>
      </p:sp>
      <p:cxnSp>
        <p:nvCxnSpPr>
          <p:cNvPr id="9" name="Conector recto 8">
            <a:extLst>
              <a:ext uri="{FF2B5EF4-FFF2-40B4-BE49-F238E27FC236}">
                <a16:creationId xmlns:a16="http://schemas.microsoft.com/office/drawing/2014/main" id="{4B011D15-62A3-4ED2-B5C1-14933AEEC32A}"/>
              </a:ext>
            </a:extLst>
          </p:cNvPr>
          <p:cNvCxnSpPr>
            <a:cxnSpLocks/>
          </p:cNvCxnSpPr>
          <p:nvPr/>
        </p:nvCxnSpPr>
        <p:spPr>
          <a:xfrm>
            <a:off x="8272732" y="995756"/>
            <a:ext cx="3283542"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05739961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8950960" y="563880"/>
            <a:ext cx="657552" cy="369332"/>
          </a:xfrm>
          <a:prstGeom prst="rect">
            <a:avLst/>
          </a:prstGeom>
          <a:noFill/>
        </p:spPr>
        <p:txBody>
          <a:bodyPr wrap="none" rtlCol="0">
            <a:spAutoFit/>
          </a:bodyPr>
          <a:lstStyle/>
          <a:p>
            <a:r>
              <a:rPr lang="en-GB" b="1" dirty="0">
                <a:latin typeface="+mj-lt"/>
              </a:rPr>
              <a:t>Fig. Y</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5" name="Imagen 4">
            <a:extLst>
              <a:ext uri="{FF2B5EF4-FFF2-40B4-BE49-F238E27FC236}">
                <a16:creationId xmlns:a16="http://schemas.microsoft.com/office/drawing/2014/main" id="{B8477733-82BE-4441-982A-F829BF79EC3A}"/>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12066" y="563880"/>
            <a:ext cx="8701464" cy="5792470"/>
          </a:xfrm>
          <a:prstGeom prst="rect">
            <a:avLst/>
          </a:prstGeom>
        </p:spPr>
      </p:pic>
      <p:sp>
        <p:nvSpPr>
          <p:cNvPr id="8" name="CuadroTexto 7">
            <a:extLst>
              <a:ext uri="{FF2B5EF4-FFF2-40B4-BE49-F238E27FC236}">
                <a16:creationId xmlns:a16="http://schemas.microsoft.com/office/drawing/2014/main" id="{4C779A88-4259-467B-A015-AFB02964278A}"/>
              </a:ext>
            </a:extLst>
          </p:cNvPr>
          <p:cNvSpPr txBox="1"/>
          <p:nvPr/>
        </p:nvSpPr>
        <p:spPr>
          <a:xfrm>
            <a:off x="8950960" y="1214384"/>
            <a:ext cx="2901734" cy="1384995"/>
          </a:xfrm>
          <a:prstGeom prst="rect">
            <a:avLst/>
          </a:prstGeom>
          <a:noFill/>
        </p:spPr>
        <p:txBody>
          <a:bodyPr wrap="square" rtlCol="0">
            <a:spAutoFit/>
          </a:bodyPr>
          <a:lstStyle/>
          <a:p>
            <a:pPr algn="just"/>
            <a:r>
              <a:rPr lang="en-GB" sz="1400" dirty="0"/>
              <a:t>Faunal remains (</a:t>
            </a:r>
            <a:r>
              <a:rPr lang="en-GB" sz="1400" i="1" dirty="0"/>
              <a:t>Lynx</a:t>
            </a:r>
            <a:r>
              <a:rPr lang="en-GB" sz="1400" dirty="0"/>
              <a:t> cf. </a:t>
            </a:r>
            <a:r>
              <a:rPr lang="en-GB" sz="1400" i="1" dirty="0" err="1"/>
              <a:t>pardinus</a:t>
            </a:r>
            <a:r>
              <a:rPr lang="en-GB" sz="1400" i="1" dirty="0"/>
              <a:t> </a:t>
            </a:r>
            <a:r>
              <a:rPr lang="en-GB" sz="1400" dirty="0"/>
              <a:t>radius and rabbit remains) recovered in sublayer IV1 are completely covered by manganese oxide.</a:t>
            </a:r>
          </a:p>
          <a:p>
            <a:pPr algn="just"/>
            <a:endParaRPr lang="en-GB" sz="1400" dirty="0"/>
          </a:p>
          <a:p>
            <a:pPr algn="just"/>
            <a:r>
              <a:rPr lang="en-GB" sz="1400" dirty="0"/>
              <a:t>Photo 2014</a:t>
            </a:r>
          </a:p>
        </p:txBody>
      </p:sp>
      <p:cxnSp>
        <p:nvCxnSpPr>
          <p:cNvPr id="9" name="Conector recto 8">
            <a:extLst>
              <a:ext uri="{FF2B5EF4-FFF2-40B4-BE49-F238E27FC236}">
                <a16:creationId xmlns:a16="http://schemas.microsoft.com/office/drawing/2014/main" id="{3E62F9DB-7717-4E1E-93AB-CCF5F94A427D}"/>
              </a:ext>
            </a:extLst>
          </p:cNvPr>
          <p:cNvCxnSpPr>
            <a:cxnSpLocks/>
          </p:cNvCxnSpPr>
          <p:nvPr/>
        </p:nvCxnSpPr>
        <p:spPr>
          <a:xfrm>
            <a:off x="9023230" y="1056138"/>
            <a:ext cx="2717321"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3EE59B03-1DF0-4213-8F81-0FBCA281DEA5}"/>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5</a:t>
            </a:fld>
            <a:endParaRPr lang="en-GB" sz="1800" dirty="0">
              <a:latin typeface="+mj-lt"/>
            </a:endParaRPr>
          </a:p>
        </p:txBody>
      </p:sp>
    </p:spTree>
    <p:extLst>
      <p:ext uri="{BB962C8B-B14F-4D97-AF65-F5344CB8AC3E}">
        <p14:creationId xmlns:p14="http://schemas.microsoft.com/office/powerpoint/2010/main" val="250107977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06235" y="563880"/>
            <a:ext cx="655949" cy="369332"/>
          </a:xfrm>
          <a:prstGeom prst="rect">
            <a:avLst/>
          </a:prstGeom>
          <a:noFill/>
        </p:spPr>
        <p:txBody>
          <a:bodyPr wrap="none" rtlCol="0">
            <a:spAutoFit/>
          </a:bodyPr>
          <a:lstStyle/>
          <a:p>
            <a:r>
              <a:rPr lang="en-GB" b="1" dirty="0">
                <a:latin typeface="+mj-lt"/>
              </a:rPr>
              <a:t>Fig. Z</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12" name="Imagen 11" descr="Imagen que contiene rock, naturaleza, cueva&#10;&#10;Descripción generada automáticamente">
            <a:extLst>
              <a:ext uri="{FF2B5EF4-FFF2-40B4-BE49-F238E27FC236}">
                <a16:creationId xmlns:a16="http://schemas.microsoft.com/office/drawing/2014/main" id="{2DB66661-5657-4D86-9EC6-BC8315F117C7}"/>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99568" y="563880"/>
            <a:ext cx="8851392" cy="5900928"/>
          </a:xfrm>
          <a:prstGeom prst="rect">
            <a:avLst/>
          </a:prstGeom>
        </p:spPr>
      </p:pic>
      <p:sp>
        <p:nvSpPr>
          <p:cNvPr id="13" name="CuadroTexto 12">
            <a:extLst>
              <a:ext uri="{FF2B5EF4-FFF2-40B4-BE49-F238E27FC236}">
                <a16:creationId xmlns:a16="http://schemas.microsoft.com/office/drawing/2014/main" id="{C80D99A0-FB5F-4754-962C-AB041770297A}"/>
              </a:ext>
            </a:extLst>
          </p:cNvPr>
          <p:cNvSpPr txBox="1"/>
          <p:nvPr/>
        </p:nvSpPr>
        <p:spPr>
          <a:xfrm>
            <a:off x="9106236" y="1179878"/>
            <a:ext cx="2743200" cy="1169551"/>
          </a:xfrm>
          <a:prstGeom prst="rect">
            <a:avLst/>
          </a:prstGeom>
          <a:noFill/>
        </p:spPr>
        <p:txBody>
          <a:bodyPr wrap="square" rtlCol="0">
            <a:spAutoFit/>
          </a:bodyPr>
          <a:lstStyle/>
          <a:p>
            <a:pPr algn="just"/>
            <a:r>
              <a:rPr lang="en-GB" sz="1400" dirty="0"/>
              <a:t>Accumulation of calcarenite and travertine fragments allowed separating sublayers IV1 and IV2.</a:t>
            </a:r>
          </a:p>
          <a:p>
            <a:pPr algn="just"/>
            <a:endParaRPr lang="en-GB" sz="1400" dirty="0"/>
          </a:p>
          <a:p>
            <a:pPr algn="just"/>
            <a:r>
              <a:rPr lang="en-GB" sz="1400" dirty="0"/>
              <a:t>Photo 2015</a:t>
            </a:r>
          </a:p>
        </p:txBody>
      </p:sp>
      <p:sp>
        <p:nvSpPr>
          <p:cNvPr id="8" name="Marcador de número de diapositiva 1">
            <a:extLst>
              <a:ext uri="{FF2B5EF4-FFF2-40B4-BE49-F238E27FC236}">
                <a16:creationId xmlns:a16="http://schemas.microsoft.com/office/drawing/2014/main" id="{599F3D2A-74AF-4085-81CE-19764D9C9858}"/>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6</a:t>
            </a:fld>
            <a:endParaRPr lang="en-GB" sz="1800" dirty="0">
              <a:latin typeface="+mj-lt"/>
            </a:endParaRPr>
          </a:p>
        </p:txBody>
      </p:sp>
      <p:cxnSp>
        <p:nvCxnSpPr>
          <p:cNvPr id="9" name="Conector recto 8">
            <a:extLst>
              <a:ext uri="{FF2B5EF4-FFF2-40B4-BE49-F238E27FC236}">
                <a16:creationId xmlns:a16="http://schemas.microsoft.com/office/drawing/2014/main" id="{96DC8FF8-CE39-4026-9599-6298CF75BA96}"/>
              </a:ext>
            </a:extLst>
          </p:cNvPr>
          <p:cNvCxnSpPr>
            <a:cxnSpLocks/>
          </p:cNvCxnSpPr>
          <p:nvPr/>
        </p:nvCxnSpPr>
        <p:spPr>
          <a:xfrm>
            <a:off x="9213011" y="1056138"/>
            <a:ext cx="2544793"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0875616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61253" y="498463"/>
            <a:ext cx="808235" cy="369332"/>
          </a:xfrm>
          <a:prstGeom prst="rect">
            <a:avLst/>
          </a:prstGeom>
          <a:noFill/>
        </p:spPr>
        <p:txBody>
          <a:bodyPr wrap="none" rtlCol="0">
            <a:spAutoFit/>
          </a:bodyPr>
          <a:lstStyle/>
          <a:p>
            <a:r>
              <a:rPr lang="en-GB" b="1" dirty="0">
                <a:latin typeface="+mj-lt"/>
              </a:rPr>
              <a:t>Fig. AA</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4" name="Imagen 3" descr="Imagen que contiene rock, naturaleza&#10;&#10;Descripción generada automáticamente">
            <a:extLst>
              <a:ext uri="{FF2B5EF4-FFF2-40B4-BE49-F238E27FC236}">
                <a16:creationId xmlns:a16="http://schemas.microsoft.com/office/drawing/2014/main" id="{D7B9B206-5900-4795-9FB5-EA11293CCE1F}"/>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498463"/>
            <a:ext cx="8912642" cy="5919590"/>
          </a:xfrm>
          <a:prstGeom prst="rect">
            <a:avLst/>
          </a:prstGeom>
        </p:spPr>
      </p:pic>
      <p:sp>
        <p:nvSpPr>
          <p:cNvPr id="8" name="CuadroTexto 7">
            <a:extLst>
              <a:ext uri="{FF2B5EF4-FFF2-40B4-BE49-F238E27FC236}">
                <a16:creationId xmlns:a16="http://schemas.microsoft.com/office/drawing/2014/main" id="{77DAE71A-D64B-4DB8-98B3-49E25CDB92E0}"/>
              </a:ext>
            </a:extLst>
          </p:cNvPr>
          <p:cNvSpPr txBox="1"/>
          <p:nvPr/>
        </p:nvSpPr>
        <p:spPr>
          <a:xfrm>
            <a:off x="9161253" y="1197132"/>
            <a:ext cx="2743200" cy="954107"/>
          </a:xfrm>
          <a:prstGeom prst="rect">
            <a:avLst/>
          </a:prstGeom>
          <a:noFill/>
        </p:spPr>
        <p:txBody>
          <a:bodyPr wrap="square" rtlCol="0">
            <a:spAutoFit/>
          </a:bodyPr>
          <a:lstStyle/>
          <a:p>
            <a:pPr algn="just"/>
            <a:r>
              <a:rPr lang="en-GB" sz="1400" dirty="0"/>
              <a:t>Top of sublayer IV2 and its relation to the Travertine Platform 2.</a:t>
            </a:r>
          </a:p>
          <a:p>
            <a:pPr algn="just"/>
            <a:endParaRPr lang="en-GB" sz="1400" dirty="0"/>
          </a:p>
          <a:p>
            <a:pPr algn="just"/>
            <a:r>
              <a:rPr lang="en-GB" sz="1400" dirty="0"/>
              <a:t>Photo 2015</a:t>
            </a:r>
          </a:p>
        </p:txBody>
      </p:sp>
      <p:cxnSp>
        <p:nvCxnSpPr>
          <p:cNvPr id="9" name="Conector recto 8">
            <a:extLst>
              <a:ext uri="{FF2B5EF4-FFF2-40B4-BE49-F238E27FC236}">
                <a16:creationId xmlns:a16="http://schemas.microsoft.com/office/drawing/2014/main" id="{A4991572-6A41-4075-BFC3-345A29F36F55}"/>
              </a:ext>
            </a:extLst>
          </p:cNvPr>
          <p:cNvCxnSpPr>
            <a:cxnSpLocks/>
          </p:cNvCxnSpPr>
          <p:nvPr/>
        </p:nvCxnSpPr>
        <p:spPr>
          <a:xfrm>
            <a:off x="9256143" y="1056138"/>
            <a:ext cx="2579299"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FD319BED-A12A-4CCF-9811-91E69981A57C}"/>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7</a:t>
            </a:fld>
            <a:endParaRPr lang="en-GB" sz="1800" dirty="0">
              <a:latin typeface="+mj-lt"/>
            </a:endParaRPr>
          </a:p>
        </p:txBody>
      </p:sp>
      <p:sp>
        <p:nvSpPr>
          <p:cNvPr id="12" name="Forma libre: forma 11">
            <a:extLst>
              <a:ext uri="{FF2B5EF4-FFF2-40B4-BE49-F238E27FC236}">
                <a16:creationId xmlns:a16="http://schemas.microsoft.com/office/drawing/2014/main" id="{188825E1-C623-4522-AEC2-191AE38EAC1F}"/>
              </a:ext>
            </a:extLst>
          </p:cNvPr>
          <p:cNvSpPr/>
          <p:nvPr/>
        </p:nvSpPr>
        <p:spPr>
          <a:xfrm>
            <a:off x="2216150" y="4578350"/>
            <a:ext cx="5683250" cy="990600"/>
          </a:xfrm>
          <a:custGeom>
            <a:avLst/>
            <a:gdLst>
              <a:gd name="connsiteX0" fmla="*/ 5683250 w 5683250"/>
              <a:gd name="connsiteY0" fmla="*/ 0 h 990600"/>
              <a:gd name="connsiteX1" fmla="*/ 5549900 w 5683250"/>
              <a:gd name="connsiteY1" fmla="*/ 50800 h 990600"/>
              <a:gd name="connsiteX2" fmla="*/ 5435600 w 5683250"/>
              <a:gd name="connsiteY2" fmla="*/ 120650 h 990600"/>
              <a:gd name="connsiteX3" fmla="*/ 5270500 w 5683250"/>
              <a:gd name="connsiteY3" fmla="*/ 215900 h 990600"/>
              <a:gd name="connsiteX4" fmla="*/ 5168900 w 5683250"/>
              <a:gd name="connsiteY4" fmla="*/ 304800 h 990600"/>
              <a:gd name="connsiteX5" fmla="*/ 4984750 w 5683250"/>
              <a:gd name="connsiteY5" fmla="*/ 361950 h 990600"/>
              <a:gd name="connsiteX6" fmla="*/ 4806950 w 5683250"/>
              <a:gd name="connsiteY6" fmla="*/ 342900 h 990600"/>
              <a:gd name="connsiteX7" fmla="*/ 4737100 w 5683250"/>
              <a:gd name="connsiteY7" fmla="*/ 279400 h 990600"/>
              <a:gd name="connsiteX8" fmla="*/ 4616450 w 5683250"/>
              <a:gd name="connsiteY8" fmla="*/ 234950 h 990600"/>
              <a:gd name="connsiteX9" fmla="*/ 4521200 w 5683250"/>
              <a:gd name="connsiteY9" fmla="*/ 247650 h 990600"/>
              <a:gd name="connsiteX10" fmla="*/ 4368800 w 5683250"/>
              <a:gd name="connsiteY10" fmla="*/ 260350 h 990600"/>
              <a:gd name="connsiteX11" fmla="*/ 4216400 w 5683250"/>
              <a:gd name="connsiteY11" fmla="*/ 285750 h 990600"/>
              <a:gd name="connsiteX12" fmla="*/ 4038600 w 5683250"/>
              <a:gd name="connsiteY12" fmla="*/ 361950 h 990600"/>
              <a:gd name="connsiteX13" fmla="*/ 3937000 w 5683250"/>
              <a:gd name="connsiteY13" fmla="*/ 381000 h 990600"/>
              <a:gd name="connsiteX14" fmla="*/ 3727450 w 5683250"/>
              <a:gd name="connsiteY14" fmla="*/ 387350 h 990600"/>
              <a:gd name="connsiteX15" fmla="*/ 3556000 w 5683250"/>
              <a:gd name="connsiteY15" fmla="*/ 330200 h 990600"/>
              <a:gd name="connsiteX16" fmla="*/ 3384550 w 5683250"/>
              <a:gd name="connsiteY16" fmla="*/ 330200 h 990600"/>
              <a:gd name="connsiteX17" fmla="*/ 3238500 w 5683250"/>
              <a:gd name="connsiteY17" fmla="*/ 260350 h 990600"/>
              <a:gd name="connsiteX18" fmla="*/ 2990850 w 5683250"/>
              <a:gd name="connsiteY18" fmla="*/ 190500 h 990600"/>
              <a:gd name="connsiteX19" fmla="*/ 2908300 w 5683250"/>
              <a:gd name="connsiteY19" fmla="*/ 158750 h 990600"/>
              <a:gd name="connsiteX20" fmla="*/ 2800350 w 5683250"/>
              <a:gd name="connsiteY20" fmla="*/ 120650 h 990600"/>
              <a:gd name="connsiteX21" fmla="*/ 2705100 w 5683250"/>
              <a:gd name="connsiteY21" fmla="*/ 127000 h 990600"/>
              <a:gd name="connsiteX22" fmla="*/ 2590800 w 5683250"/>
              <a:gd name="connsiteY22" fmla="*/ 209550 h 990600"/>
              <a:gd name="connsiteX23" fmla="*/ 2444750 w 5683250"/>
              <a:gd name="connsiteY23" fmla="*/ 241300 h 990600"/>
              <a:gd name="connsiteX24" fmla="*/ 2406650 w 5683250"/>
              <a:gd name="connsiteY24" fmla="*/ 247650 h 990600"/>
              <a:gd name="connsiteX25" fmla="*/ 2349500 w 5683250"/>
              <a:gd name="connsiteY25" fmla="*/ 342900 h 990600"/>
              <a:gd name="connsiteX26" fmla="*/ 2330450 w 5683250"/>
              <a:gd name="connsiteY26" fmla="*/ 450850 h 990600"/>
              <a:gd name="connsiteX27" fmla="*/ 2298700 w 5683250"/>
              <a:gd name="connsiteY27" fmla="*/ 565150 h 990600"/>
              <a:gd name="connsiteX28" fmla="*/ 2197100 w 5683250"/>
              <a:gd name="connsiteY28" fmla="*/ 647700 h 990600"/>
              <a:gd name="connsiteX29" fmla="*/ 2101850 w 5683250"/>
              <a:gd name="connsiteY29" fmla="*/ 647700 h 990600"/>
              <a:gd name="connsiteX30" fmla="*/ 2070100 w 5683250"/>
              <a:gd name="connsiteY30" fmla="*/ 571500 h 990600"/>
              <a:gd name="connsiteX31" fmla="*/ 2044700 w 5683250"/>
              <a:gd name="connsiteY31" fmla="*/ 482600 h 990600"/>
              <a:gd name="connsiteX32" fmla="*/ 2044700 w 5683250"/>
              <a:gd name="connsiteY32" fmla="*/ 406400 h 990600"/>
              <a:gd name="connsiteX33" fmla="*/ 1993900 w 5683250"/>
              <a:gd name="connsiteY33" fmla="*/ 336550 h 990600"/>
              <a:gd name="connsiteX34" fmla="*/ 1930400 w 5683250"/>
              <a:gd name="connsiteY34" fmla="*/ 285750 h 990600"/>
              <a:gd name="connsiteX35" fmla="*/ 1879600 w 5683250"/>
              <a:gd name="connsiteY35" fmla="*/ 254000 h 990600"/>
              <a:gd name="connsiteX36" fmla="*/ 1771650 w 5683250"/>
              <a:gd name="connsiteY36" fmla="*/ 184150 h 990600"/>
              <a:gd name="connsiteX37" fmla="*/ 1701800 w 5683250"/>
              <a:gd name="connsiteY37" fmla="*/ 177800 h 990600"/>
              <a:gd name="connsiteX38" fmla="*/ 1587500 w 5683250"/>
              <a:gd name="connsiteY38" fmla="*/ 127000 h 990600"/>
              <a:gd name="connsiteX39" fmla="*/ 1562100 w 5683250"/>
              <a:gd name="connsiteY39" fmla="*/ 82550 h 990600"/>
              <a:gd name="connsiteX40" fmla="*/ 1498600 w 5683250"/>
              <a:gd name="connsiteY40" fmla="*/ 69850 h 990600"/>
              <a:gd name="connsiteX41" fmla="*/ 1422400 w 5683250"/>
              <a:gd name="connsiteY41" fmla="*/ 82550 h 990600"/>
              <a:gd name="connsiteX42" fmla="*/ 1403350 w 5683250"/>
              <a:gd name="connsiteY42" fmla="*/ 139700 h 990600"/>
              <a:gd name="connsiteX43" fmla="*/ 1358900 w 5683250"/>
              <a:gd name="connsiteY43" fmla="*/ 285750 h 990600"/>
              <a:gd name="connsiteX44" fmla="*/ 1301750 w 5683250"/>
              <a:gd name="connsiteY44" fmla="*/ 412750 h 990600"/>
              <a:gd name="connsiteX45" fmla="*/ 1250950 w 5683250"/>
              <a:gd name="connsiteY45" fmla="*/ 508000 h 990600"/>
              <a:gd name="connsiteX46" fmla="*/ 1143000 w 5683250"/>
              <a:gd name="connsiteY46" fmla="*/ 565150 h 990600"/>
              <a:gd name="connsiteX47" fmla="*/ 1047750 w 5683250"/>
              <a:gd name="connsiteY47" fmla="*/ 603250 h 990600"/>
              <a:gd name="connsiteX48" fmla="*/ 965200 w 5683250"/>
              <a:gd name="connsiteY48" fmla="*/ 641350 h 990600"/>
              <a:gd name="connsiteX49" fmla="*/ 952500 w 5683250"/>
              <a:gd name="connsiteY49" fmla="*/ 692150 h 990600"/>
              <a:gd name="connsiteX50" fmla="*/ 908050 w 5683250"/>
              <a:gd name="connsiteY50" fmla="*/ 787400 h 990600"/>
              <a:gd name="connsiteX51" fmla="*/ 869950 w 5683250"/>
              <a:gd name="connsiteY51" fmla="*/ 800100 h 990600"/>
              <a:gd name="connsiteX52" fmla="*/ 736600 w 5683250"/>
              <a:gd name="connsiteY52" fmla="*/ 787400 h 990600"/>
              <a:gd name="connsiteX53" fmla="*/ 711200 w 5683250"/>
              <a:gd name="connsiteY53" fmla="*/ 806450 h 990600"/>
              <a:gd name="connsiteX54" fmla="*/ 647700 w 5683250"/>
              <a:gd name="connsiteY54" fmla="*/ 831850 h 990600"/>
              <a:gd name="connsiteX55" fmla="*/ 558800 w 5683250"/>
              <a:gd name="connsiteY55" fmla="*/ 850900 h 990600"/>
              <a:gd name="connsiteX56" fmla="*/ 476250 w 5683250"/>
              <a:gd name="connsiteY56" fmla="*/ 901700 h 990600"/>
              <a:gd name="connsiteX57" fmla="*/ 374650 w 5683250"/>
              <a:gd name="connsiteY57" fmla="*/ 933450 h 990600"/>
              <a:gd name="connsiteX58" fmla="*/ 196850 w 5683250"/>
              <a:gd name="connsiteY58" fmla="*/ 971550 h 990600"/>
              <a:gd name="connsiteX59" fmla="*/ 12700 w 5683250"/>
              <a:gd name="connsiteY59" fmla="*/ 977900 h 990600"/>
              <a:gd name="connsiteX60" fmla="*/ 0 w 5683250"/>
              <a:gd name="connsiteY60" fmla="*/ 990600 h 990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Lst>
            <a:rect l="l" t="t" r="r" b="b"/>
            <a:pathLst>
              <a:path w="5683250" h="990600">
                <a:moveTo>
                  <a:pt x="5683250" y="0"/>
                </a:moveTo>
                <a:lnTo>
                  <a:pt x="5549900" y="50800"/>
                </a:lnTo>
                <a:lnTo>
                  <a:pt x="5435600" y="120650"/>
                </a:lnTo>
                <a:lnTo>
                  <a:pt x="5270500" y="215900"/>
                </a:lnTo>
                <a:lnTo>
                  <a:pt x="5168900" y="304800"/>
                </a:lnTo>
                <a:lnTo>
                  <a:pt x="4984750" y="361950"/>
                </a:lnTo>
                <a:lnTo>
                  <a:pt x="4806950" y="342900"/>
                </a:lnTo>
                <a:lnTo>
                  <a:pt x="4737100" y="279400"/>
                </a:lnTo>
                <a:lnTo>
                  <a:pt x="4616450" y="234950"/>
                </a:lnTo>
                <a:lnTo>
                  <a:pt x="4521200" y="247650"/>
                </a:lnTo>
                <a:lnTo>
                  <a:pt x="4368800" y="260350"/>
                </a:lnTo>
                <a:lnTo>
                  <a:pt x="4216400" y="285750"/>
                </a:lnTo>
                <a:lnTo>
                  <a:pt x="4038600" y="361950"/>
                </a:lnTo>
                <a:lnTo>
                  <a:pt x="3937000" y="381000"/>
                </a:lnTo>
                <a:lnTo>
                  <a:pt x="3727450" y="387350"/>
                </a:lnTo>
                <a:lnTo>
                  <a:pt x="3556000" y="330200"/>
                </a:lnTo>
                <a:lnTo>
                  <a:pt x="3384550" y="330200"/>
                </a:lnTo>
                <a:lnTo>
                  <a:pt x="3238500" y="260350"/>
                </a:lnTo>
                <a:lnTo>
                  <a:pt x="2990850" y="190500"/>
                </a:lnTo>
                <a:lnTo>
                  <a:pt x="2908300" y="158750"/>
                </a:lnTo>
                <a:lnTo>
                  <a:pt x="2800350" y="120650"/>
                </a:lnTo>
                <a:lnTo>
                  <a:pt x="2705100" y="127000"/>
                </a:lnTo>
                <a:lnTo>
                  <a:pt x="2590800" y="209550"/>
                </a:lnTo>
                <a:lnTo>
                  <a:pt x="2444750" y="241300"/>
                </a:lnTo>
                <a:lnTo>
                  <a:pt x="2406650" y="247650"/>
                </a:lnTo>
                <a:lnTo>
                  <a:pt x="2349500" y="342900"/>
                </a:lnTo>
                <a:lnTo>
                  <a:pt x="2330450" y="450850"/>
                </a:lnTo>
                <a:lnTo>
                  <a:pt x="2298700" y="565150"/>
                </a:lnTo>
                <a:lnTo>
                  <a:pt x="2197100" y="647700"/>
                </a:lnTo>
                <a:lnTo>
                  <a:pt x="2101850" y="647700"/>
                </a:lnTo>
                <a:lnTo>
                  <a:pt x="2070100" y="571500"/>
                </a:lnTo>
                <a:lnTo>
                  <a:pt x="2044700" y="482600"/>
                </a:lnTo>
                <a:lnTo>
                  <a:pt x="2044700" y="406400"/>
                </a:lnTo>
                <a:lnTo>
                  <a:pt x="1993900" y="336550"/>
                </a:lnTo>
                <a:lnTo>
                  <a:pt x="1930400" y="285750"/>
                </a:lnTo>
                <a:lnTo>
                  <a:pt x="1879600" y="254000"/>
                </a:lnTo>
                <a:lnTo>
                  <a:pt x="1771650" y="184150"/>
                </a:lnTo>
                <a:lnTo>
                  <a:pt x="1701800" y="177800"/>
                </a:lnTo>
                <a:lnTo>
                  <a:pt x="1587500" y="127000"/>
                </a:lnTo>
                <a:lnTo>
                  <a:pt x="1562100" y="82550"/>
                </a:lnTo>
                <a:lnTo>
                  <a:pt x="1498600" y="69850"/>
                </a:lnTo>
                <a:lnTo>
                  <a:pt x="1422400" y="82550"/>
                </a:lnTo>
                <a:lnTo>
                  <a:pt x="1403350" y="139700"/>
                </a:lnTo>
                <a:lnTo>
                  <a:pt x="1358900" y="285750"/>
                </a:lnTo>
                <a:lnTo>
                  <a:pt x="1301750" y="412750"/>
                </a:lnTo>
                <a:lnTo>
                  <a:pt x="1250950" y="508000"/>
                </a:lnTo>
                <a:lnTo>
                  <a:pt x="1143000" y="565150"/>
                </a:lnTo>
                <a:lnTo>
                  <a:pt x="1047750" y="603250"/>
                </a:lnTo>
                <a:lnTo>
                  <a:pt x="965200" y="641350"/>
                </a:lnTo>
                <a:lnTo>
                  <a:pt x="952500" y="692150"/>
                </a:lnTo>
                <a:lnTo>
                  <a:pt x="908050" y="787400"/>
                </a:lnTo>
                <a:lnTo>
                  <a:pt x="869950" y="800100"/>
                </a:lnTo>
                <a:lnTo>
                  <a:pt x="736600" y="787400"/>
                </a:lnTo>
                <a:lnTo>
                  <a:pt x="711200" y="806450"/>
                </a:lnTo>
                <a:lnTo>
                  <a:pt x="647700" y="831850"/>
                </a:lnTo>
                <a:lnTo>
                  <a:pt x="558800" y="850900"/>
                </a:lnTo>
                <a:lnTo>
                  <a:pt x="476250" y="901700"/>
                </a:lnTo>
                <a:lnTo>
                  <a:pt x="374650" y="933450"/>
                </a:lnTo>
                <a:lnTo>
                  <a:pt x="196850" y="971550"/>
                </a:lnTo>
                <a:lnTo>
                  <a:pt x="12700" y="977900"/>
                </a:lnTo>
                <a:lnTo>
                  <a:pt x="0" y="990600"/>
                </a:lnTo>
              </a:path>
            </a:pathLst>
          </a:custGeom>
          <a:noFill/>
          <a:ln>
            <a:solidFill>
              <a:schemeClr val="bg1"/>
            </a:solidFill>
            <a:prstDash val="dash"/>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CuadroTexto 13">
            <a:extLst>
              <a:ext uri="{FF2B5EF4-FFF2-40B4-BE49-F238E27FC236}">
                <a16:creationId xmlns:a16="http://schemas.microsoft.com/office/drawing/2014/main" id="{F413790C-195D-4ABD-B2FB-ED810FCC08AB}"/>
              </a:ext>
            </a:extLst>
          </p:cNvPr>
          <p:cNvSpPr txBox="1"/>
          <p:nvPr/>
        </p:nvSpPr>
        <p:spPr>
          <a:xfrm>
            <a:off x="4945857" y="4206018"/>
            <a:ext cx="1150143" cy="461665"/>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Travertine</a:t>
            </a:r>
          </a:p>
          <a:p>
            <a:r>
              <a:rPr lang="en-GB" sz="1200" dirty="0">
                <a:solidFill>
                  <a:schemeClr val="bg1">
                    <a:lumMod val="95000"/>
                  </a:schemeClr>
                </a:solidFill>
                <a:effectLst>
                  <a:outerShdw blurRad="38100" dist="38100" dir="2700000" algn="tl">
                    <a:srgbClr val="000000">
                      <a:alpha val="43137"/>
                    </a:srgbClr>
                  </a:outerShdw>
                </a:effectLst>
                <a:latin typeface="+mj-lt"/>
              </a:rPr>
              <a:t>platform 2</a:t>
            </a:r>
          </a:p>
        </p:txBody>
      </p:sp>
      <p:sp>
        <p:nvSpPr>
          <p:cNvPr id="15" name="CuadroTexto 14">
            <a:extLst>
              <a:ext uri="{FF2B5EF4-FFF2-40B4-BE49-F238E27FC236}">
                <a16:creationId xmlns:a16="http://schemas.microsoft.com/office/drawing/2014/main" id="{2A1B09C5-DA9A-4084-B2C7-220C2A46790D}"/>
              </a:ext>
            </a:extLst>
          </p:cNvPr>
          <p:cNvSpPr txBox="1"/>
          <p:nvPr/>
        </p:nvSpPr>
        <p:spPr>
          <a:xfrm>
            <a:off x="5762863" y="5568950"/>
            <a:ext cx="1150143" cy="461665"/>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Sublayer</a:t>
            </a:r>
          </a:p>
          <a:p>
            <a:pPr algn="ctr"/>
            <a:r>
              <a:rPr lang="en-GB" sz="1200" dirty="0">
                <a:solidFill>
                  <a:schemeClr val="bg1">
                    <a:lumMod val="95000"/>
                  </a:schemeClr>
                </a:solidFill>
                <a:effectLst>
                  <a:outerShdw blurRad="38100" dist="38100" dir="2700000" algn="tl">
                    <a:srgbClr val="000000">
                      <a:alpha val="43137"/>
                    </a:srgbClr>
                  </a:outerShdw>
                </a:effectLst>
                <a:latin typeface="+mj-lt"/>
              </a:rPr>
              <a:t>IV2</a:t>
            </a:r>
          </a:p>
        </p:txBody>
      </p:sp>
    </p:spTree>
    <p:extLst>
      <p:ext uri="{BB962C8B-B14F-4D97-AF65-F5344CB8AC3E}">
        <p14:creationId xmlns:p14="http://schemas.microsoft.com/office/powerpoint/2010/main" val="153071485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66621" y="563880"/>
            <a:ext cx="801823" cy="369332"/>
          </a:xfrm>
          <a:prstGeom prst="rect">
            <a:avLst/>
          </a:prstGeom>
          <a:noFill/>
        </p:spPr>
        <p:txBody>
          <a:bodyPr wrap="none" rtlCol="0">
            <a:spAutoFit/>
          </a:bodyPr>
          <a:lstStyle/>
          <a:p>
            <a:r>
              <a:rPr lang="en-GB" b="1" dirty="0">
                <a:latin typeface="+mj-lt"/>
              </a:rPr>
              <a:t>Fig. AB</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3" name="Imagen 2" descr="Imagen que contiene naturaleza, suelo, exterior&#10;&#10;Descripción generada automáticamente">
            <a:extLst>
              <a:ext uri="{FF2B5EF4-FFF2-40B4-BE49-F238E27FC236}">
                <a16:creationId xmlns:a16="http://schemas.microsoft.com/office/drawing/2014/main" id="{7EABBB60-F756-4C0F-9ACD-7285304F9D29}"/>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63880"/>
            <a:ext cx="8873604" cy="5931811"/>
          </a:xfrm>
          <a:prstGeom prst="rect">
            <a:avLst/>
          </a:prstGeom>
        </p:spPr>
      </p:pic>
      <p:sp>
        <p:nvSpPr>
          <p:cNvPr id="8" name="CuadroTexto 7">
            <a:extLst>
              <a:ext uri="{FF2B5EF4-FFF2-40B4-BE49-F238E27FC236}">
                <a16:creationId xmlns:a16="http://schemas.microsoft.com/office/drawing/2014/main" id="{1A9845A0-7D32-4F89-90A9-19C4E802E6B7}"/>
              </a:ext>
            </a:extLst>
          </p:cNvPr>
          <p:cNvSpPr txBox="1"/>
          <p:nvPr/>
        </p:nvSpPr>
        <p:spPr>
          <a:xfrm>
            <a:off x="9166620" y="1179879"/>
            <a:ext cx="2743201" cy="954107"/>
          </a:xfrm>
          <a:prstGeom prst="rect">
            <a:avLst/>
          </a:prstGeom>
          <a:noFill/>
        </p:spPr>
        <p:txBody>
          <a:bodyPr wrap="square" rtlCol="0">
            <a:spAutoFit/>
          </a:bodyPr>
          <a:lstStyle/>
          <a:p>
            <a:pPr algn="just"/>
            <a:r>
              <a:rPr lang="en-GB" sz="1400" dirty="0"/>
              <a:t>SW Gallery during the excavation of the Unit IV.</a:t>
            </a:r>
          </a:p>
          <a:p>
            <a:pPr algn="just"/>
            <a:endParaRPr lang="en-GB" sz="1400" dirty="0"/>
          </a:p>
          <a:p>
            <a:pPr algn="just"/>
            <a:r>
              <a:rPr lang="en-GB" sz="1400" dirty="0"/>
              <a:t>Photo 2015</a:t>
            </a:r>
          </a:p>
        </p:txBody>
      </p:sp>
      <p:sp>
        <p:nvSpPr>
          <p:cNvPr id="9" name="Marcador de número de diapositiva 1">
            <a:extLst>
              <a:ext uri="{FF2B5EF4-FFF2-40B4-BE49-F238E27FC236}">
                <a16:creationId xmlns:a16="http://schemas.microsoft.com/office/drawing/2014/main" id="{3A94792D-EEC7-409B-B971-70B0D84C9384}"/>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8</a:t>
            </a:fld>
            <a:endParaRPr lang="en-GB" sz="1800" dirty="0">
              <a:latin typeface="+mj-lt"/>
            </a:endParaRPr>
          </a:p>
        </p:txBody>
      </p:sp>
      <p:cxnSp>
        <p:nvCxnSpPr>
          <p:cNvPr id="10" name="Conector recto 9">
            <a:extLst>
              <a:ext uri="{FF2B5EF4-FFF2-40B4-BE49-F238E27FC236}">
                <a16:creationId xmlns:a16="http://schemas.microsoft.com/office/drawing/2014/main" id="{B3261F26-13DC-44D0-B7CF-B7EC7E4C24E2}"/>
              </a:ext>
            </a:extLst>
          </p:cNvPr>
          <p:cNvCxnSpPr>
            <a:cxnSpLocks/>
          </p:cNvCxnSpPr>
          <p:nvPr/>
        </p:nvCxnSpPr>
        <p:spPr>
          <a:xfrm>
            <a:off x="9256143" y="1056138"/>
            <a:ext cx="253616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6693566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28598" y="563880"/>
            <a:ext cx="800668" cy="369332"/>
          </a:xfrm>
          <a:prstGeom prst="rect">
            <a:avLst/>
          </a:prstGeom>
          <a:noFill/>
        </p:spPr>
        <p:txBody>
          <a:bodyPr wrap="none" rtlCol="0">
            <a:spAutoFit/>
          </a:bodyPr>
          <a:lstStyle/>
          <a:p>
            <a:r>
              <a:rPr lang="en-GB" b="1" dirty="0">
                <a:latin typeface="+mj-lt"/>
              </a:rPr>
              <a:t>Fig. AC</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3" name="Imagen 2" descr="Imagen que contiene rock, suelo, naturaleza&#10;&#10;Descripción generada automáticamente">
            <a:extLst>
              <a:ext uri="{FF2B5EF4-FFF2-40B4-BE49-F238E27FC236}">
                <a16:creationId xmlns:a16="http://schemas.microsoft.com/office/drawing/2014/main" id="{ABA84097-A9F6-4EB2-9BF9-211AA43EB589}"/>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63880"/>
            <a:ext cx="8763288" cy="5842192"/>
          </a:xfrm>
          <a:prstGeom prst="rect">
            <a:avLst/>
          </a:prstGeom>
        </p:spPr>
      </p:pic>
      <p:sp>
        <p:nvSpPr>
          <p:cNvPr id="8" name="CuadroTexto 7">
            <a:extLst>
              <a:ext uri="{FF2B5EF4-FFF2-40B4-BE49-F238E27FC236}">
                <a16:creationId xmlns:a16="http://schemas.microsoft.com/office/drawing/2014/main" id="{B798DE57-4AB6-4FB0-9577-E1051EF53537}"/>
              </a:ext>
            </a:extLst>
          </p:cNvPr>
          <p:cNvSpPr txBox="1"/>
          <p:nvPr/>
        </p:nvSpPr>
        <p:spPr>
          <a:xfrm>
            <a:off x="9028597" y="1223010"/>
            <a:ext cx="2998352" cy="2246769"/>
          </a:xfrm>
          <a:prstGeom prst="rect">
            <a:avLst/>
          </a:prstGeom>
          <a:noFill/>
        </p:spPr>
        <p:txBody>
          <a:bodyPr wrap="square" rtlCol="0">
            <a:spAutoFit/>
          </a:bodyPr>
          <a:lstStyle/>
          <a:p>
            <a:pPr algn="just"/>
            <a:r>
              <a:rPr lang="en-GB" sz="1400" dirty="0"/>
              <a:t>Ending the excavation of sublayer IV2. Most of the excavation surface shows the presence of speleothems (E8 – D8) and travertine crusts (E7 – D7).</a:t>
            </a:r>
          </a:p>
          <a:p>
            <a:pPr algn="just"/>
            <a:endParaRPr lang="en-GB" sz="1400" dirty="0"/>
          </a:p>
          <a:p>
            <a:pPr algn="just"/>
            <a:r>
              <a:rPr lang="en-GB" sz="1400" dirty="0"/>
              <a:t>The sediments from sublayer IV2 percolate between the crevices of the speleothems and travertines.</a:t>
            </a:r>
          </a:p>
          <a:p>
            <a:pPr algn="just"/>
            <a:endParaRPr lang="en-GB" sz="1400" dirty="0"/>
          </a:p>
          <a:p>
            <a:pPr algn="just"/>
            <a:r>
              <a:rPr lang="en-GB" sz="1400" dirty="0"/>
              <a:t>Photo 2015</a:t>
            </a:r>
          </a:p>
        </p:txBody>
      </p:sp>
      <p:cxnSp>
        <p:nvCxnSpPr>
          <p:cNvPr id="9" name="Conector recto 8">
            <a:extLst>
              <a:ext uri="{FF2B5EF4-FFF2-40B4-BE49-F238E27FC236}">
                <a16:creationId xmlns:a16="http://schemas.microsoft.com/office/drawing/2014/main" id="{C0BE58D0-C56F-45F1-8D09-DCBCFDDBEDF3}"/>
              </a:ext>
            </a:extLst>
          </p:cNvPr>
          <p:cNvCxnSpPr>
            <a:cxnSpLocks/>
          </p:cNvCxnSpPr>
          <p:nvPr/>
        </p:nvCxnSpPr>
        <p:spPr>
          <a:xfrm>
            <a:off x="9100868" y="1056138"/>
            <a:ext cx="2803585"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AFFFD210-BA8D-4818-BD06-DFD8AC81D6A6}"/>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29</a:t>
            </a:fld>
            <a:endParaRPr lang="en-GB" sz="1800" dirty="0">
              <a:latin typeface="+mj-lt"/>
            </a:endParaRPr>
          </a:p>
        </p:txBody>
      </p:sp>
    </p:spTree>
    <p:extLst>
      <p:ext uri="{BB962C8B-B14F-4D97-AF65-F5344CB8AC3E}">
        <p14:creationId xmlns:p14="http://schemas.microsoft.com/office/powerpoint/2010/main" val="13090877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n 4" descr="Imagen que contiene suelo, rock, exterior, naturaleza&#10;&#10;Descripción generada automáticamente">
            <a:extLst>
              <a:ext uri="{FF2B5EF4-FFF2-40B4-BE49-F238E27FC236}">
                <a16:creationId xmlns:a16="http://schemas.microsoft.com/office/drawing/2014/main" id="{14527C70-6FAE-4E13-8A5D-288F4F8DEA81}"/>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63880"/>
            <a:ext cx="8711874" cy="5792470"/>
          </a:xfrm>
          <a:prstGeom prst="rect">
            <a:avLst/>
          </a:prstGeom>
        </p:spPr>
      </p:pic>
      <p:sp>
        <p:nvSpPr>
          <p:cNvPr id="6" name="CuadroTexto 5">
            <a:extLst>
              <a:ext uri="{FF2B5EF4-FFF2-40B4-BE49-F238E27FC236}">
                <a16:creationId xmlns:a16="http://schemas.microsoft.com/office/drawing/2014/main" id="{74AF234C-E168-4284-B2E9-FEA4C9837CB3}"/>
              </a:ext>
            </a:extLst>
          </p:cNvPr>
          <p:cNvSpPr txBox="1"/>
          <p:nvPr/>
        </p:nvSpPr>
        <p:spPr>
          <a:xfrm>
            <a:off x="8950960" y="563880"/>
            <a:ext cx="673582" cy="369332"/>
          </a:xfrm>
          <a:prstGeom prst="rect">
            <a:avLst/>
          </a:prstGeom>
          <a:noFill/>
        </p:spPr>
        <p:txBody>
          <a:bodyPr wrap="none" rtlCol="0">
            <a:spAutoFit/>
          </a:bodyPr>
          <a:lstStyle/>
          <a:p>
            <a:r>
              <a:rPr lang="en-GB" b="1" dirty="0">
                <a:latin typeface="+mj-lt"/>
              </a:rPr>
              <a:t>Fig. C</a:t>
            </a:r>
          </a:p>
        </p:txBody>
      </p:sp>
      <p:sp>
        <p:nvSpPr>
          <p:cNvPr id="8" name="CuadroTexto 7">
            <a:extLst>
              <a:ext uri="{FF2B5EF4-FFF2-40B4-BE49-F238E27FC236}">
                <a16:creationId xmlns:a16="http://schemas.microsoft.com/office/drawing/2014/main" id="{A1976D3B-15C6-4686-AAA1-291BAB67641B}"/>
              </a:ext>
            </a:extLst>
          </p:cNvPr>
          <p:cNvSpPr txBox="1"/>
          <p:nvPr/>
        </p:nvSpPr>
        <p:spPr>
          <a:xfrm>
            <a:off x="0" y="0"/>
            <a:ext cx="5150834" cy="338554"/>
          </a:xfrm>
          <a:prstGeom prst="rect">
            <a:avLst/>
          </a:prstGeom>
          <a:noFill/>
        </p:spPr>
        <p:txBody>
          <a:bodyPr wrap="none" rtlCol="0">
            <a:spAutoFit/>
          </a:bodyPr>
          <a:lstStyle/>
          <a:p>
            <a:r>
              <a:rPr lang="en-GB" sz="1600" b="1" dirty="0">
                <a:latin typeface="+mj-lt"/>
              </a:rPr>
              <a:t>Supporting Information 1 – Excavation of the Holocene Layers</a:t>
            </a:r>
          </a:p>
        </p:txBody>
      </p:sp>
      <p:sp>
        <p:nvSpPr>
          <p:cNvPr id="7" name="CuadroTexto 6">
            <a:extLst>
              <a:ext uri="{FF2B5EF4-FFF2-40B4-BE49-F238E27FC236}">
                <a16:creationId xmlns:a16="http://schemas.microsoft.com/office/drawing/2014/main" id="{402C3B87-97E2-4442-AD36-8C72C096CFB4}"/>
              </a:ext>
            </a:extLst>
          </p:cNvPr>
          <p:cNvSpPr txBox="1"/>
          <p:nvPr/>
        </p:nvSpPr>
        <p:spPr>
          <a:xfrm>
            <a:off x="8950960" y="1170758"/>
            <a:ext cx="2927531" cy="2893100"/>
          </a:xfrm>
          <a:prstGeom prst="rect">
            <a:avLst/>
          </a:prstGeom>
          <a:noFill/>
        </p:spPr>
        <p:txBody>
          <a:bodyPr wrap="square" rtlCol="0">
            <a:spAutoFit/>
          </a:bodyPr>
          <a:lstStyle/>
          <a:p>
            <a:pPr algn="just"/>
            <a:r>
              <a:rPr lang="en-GB" sz="1400" dirty="0"/>
              <a:t>View of Cova </a:t>
            </a:r>
            <a:r>
              <a:rPr lang="en-GB" sz="1400" dirty="0" err="1"/>
              <a:t>Foradada´s</a:t>
            </a:r>
            <a:r>
              <a:rPr lang="en-GB" sz="1400" dirty="0"/>
              <a:t> lower entrance  leading to the excavation hall.</a:t>
            </a:r>
          </a:p>
          <a:p>
            <a:pPr algn="just"/>
            <a:endParaRPr lang="en-GB" sz="1400" dirty="0"/>
          </a:p>
          <a:p>
            <a:pPr algn="just"/>
            <a:r>
              <a:rPr lang="en-GB" sz="1400" dirty="0"/>
              <a:t>The image shows the original shape of the external terrace before its excavation in 2014.</a:t>
            </a:r>
          </a:p>
          <a:p>
            <a:pPr algn="just"/>
            <a:endParaRPr lang="en-GB" sz="1400" dirty="0"/>
          </a:p>
          <a:p>
            <a:pPr algn="just"/>
            <a:r>
              <a:rPr lang="en-GB" sz="1400" dirty="0"/>
              <a:t>The sediment height at the entrance coincides with original level when the excavation started in 1997.</a:t>
            </a:r>
          </a:p>
          <a:p>
            <a:pPr algn="just"/>
            <a:endParaRPr lang="en-GB" sz="1400" dirty="0"/>
          </a:p>
          <a:p>
            <a:pPr algn="just"/>
            <a:r>
              <a:rPr lang="en-GB" sz="1400" dirty="0"/>
              <a:t>Photo 2006</a:t>
            </a:r>
          </a:p>
        </p:txBody>
      </p:sp>
      <p:cxnSp>
        <p:nvCxnSpPr>
          <p:cNvPr id="9" name="Conector recto 8">
            <a:extLst>
              <a:ext uri="{FF2B5EF4-FFF2-40B4-BE49-F238E27FC236}">
                <a16:creationId xmlns:a16="http://schemas.microsoft.com/office/drawing/2014/main" id="{BB0000F7-6101-4087-90D2-18AF69CB5361}"/>
              </a:ext>
            </a:extLst>
          </p:cNvPr>
          <p:cNvCxnSpPr>
            <a:cxnSpLocks/>
          </p:cNvCxnSpPr>
          <p:nvPr/>
        </p:nvCxnSpPr>
        <p:spPr>
          <a:xfrm>
            <a:off x="9030789" y="1064188"/>
            <a:ext cx="2665908"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AE35BDEF-497E-4BB1-8B58-7B3DDCB782F2}"/>
              </a:ext>
            </a:extLst>
          </p:cNvPr>
          <p:cNvSpPr>
            <a:spLocks noGrp="1"/>
          </p:cNvSpPr>
          <p:nvPr>
            <p:ph type="sldNum" sz="quarter" idx="12"/>
          </p:nvPr>
        </p:nvSpPr>
        <p:spPr>
          <a:xfrm>
            <a:off x="11696697" y="6371729"/>
            <a:ext cx="315806" cy="365125"/>
          </a:xfrm>
        </p:spPr>
        <p:txBody>
          <a:bodyPr/>
          <a:lstStyle/>
          <a:p>
            <a:fld id="{192579BF-C6FD-43AD-A8B9-573B46B983AA}" type="slidenum">
              <a:rPr lang="en-GB" sz="1800" smtClean="0">
                <a:latin typeface="+mj-lt"/>
              </a:rPr>
              <a:t>3</a:t>
            </a:fld>
            <a:endParaRPr lang="en-GB" sz="1800" dirty="0">
              <a:latin typeface="+mj-lt"/>
            </a:endParaRPr>
          </a:p>
        </p:txBody>
      </p:sp>
    </p:spTree>
    <p:extLst>
      <p:ext uri="{BB962C8B-B14F-4D97-AF65-F5344CB8AC3E}">
        <p14:creationId xmlns:p14="http://schemas.microsoft.com/office/powerpoint/2010/main" val="324899299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49109" y="503494"/>
            <a:ext cx="817853" cy="369332"/>
          </a:xfrm>
          <a:prstGeom prst="rect">
            <a:avLst/>
          </a:prstGeom>
          <a:noFill/>
        </p:spPr>
        <p:txBody>
          <a:bodyPr wrap="none" rtlCol="0">
            <a:spAutoFit/>
          </a:bodyPr>
          <a:lstStyle/>
          <a:p>
            <a:r>
              <a:rPr lang="en-GB" b="1" dirty="0">
                <a:latin typeface="+mj-lt"/>
              </a:rPr>
              <a:t>Fig. AD</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4" name="Imagen 3" descr="Imagen que contiene rock, suelo, exterior, naturaleza&#10;&#10;Descripción generada automáticamente">
            <a:extLst>
              <a:ext uri="{FF2B5EF4-FFF2-40B4-BE49-F238E27FC236}">
                <a16:creationId xmlns:a16="http://schemas.microsoft.com/office/drawing/2014/main" id="{1B35BAC9-39E9-4C0C-AFA1-8A2D05F89060}"/>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503494"/>
            <a:ext cx="8779283" cy="5852855"/>
          </a:xfrm>
          <a:prstGeom prst="rect">
            <a:avLst/>
          </a:prstGeom>
        </p:spPr>
      </p:pic>
      <p:sp>
        <p:nvSpPr>
          <p:cNvPr id="8" name="CuadroTexto 7">
            <a:extLst>
              <a:ext uri="{FF2B5EF4-FFF2-40B4-BE49-F238E27FC236}">
                <a16:creationId xmlns:a16="http://schemas.microsoft.com/office/drawing/2014/main" id="{6D117227-428F-4574-AD0A-9F228810A557}"/>
              </a:ext>
            </a:extLst>
          </p:cNvPr>
          <p:cNvSpPr txBox="1"/>
          <p:nvPr/>
        </p:nvSpPr>
        <p:spPr>
          <a:xfrm>
            <a:off x="9049109" y="1162626"/>
            <a:ext cx="2889850" cy="2031325"/>
          </a:xfrm>
          <a:prstGeom prst="rect">
            <a:avLst/>
          </a:prstGeom>
          <a:noFill/>
        </p:spPr>
        <p:txBody>
          <a:bodyPr wrap="square" rtlCol="0">
            <a:spAutoFit/>
          </a:bodyPr>
          <a:lstStyle/>
          <a:p>
            <a:pPr algn="just"/>
            <a:r>
              <a:rPr lang="en-GB" sz="1400" dirty="0"/>
              <a:t>All the excavation surface is at this point occupied by speleothems. The sediment excavated between the crevices and fissures of the speleothem is attributed to Layer V, but it is exclusively paleontological, providing lynx and rabbit remains.</a:t>
            </a:r>
          </a:p>
          <a:p>
            <a:pPr algn="just"/>
            <a:endParaRPr lang="en-GB" sz="1400" dirty="0"/>
          </a:p>
          <a:p>
            <a:pPr algn="just"/>
            <a:r>
              <a:rPr lang="en-GB" sz="1400" dirty="0"/>
              <a:t>Photo 2015</a:t>
            </a:r>
          </a:p>
        </p:txBody>
      </p:sp>
      <p:sp>
        <p:nvSpPr>
          <p:cNvPr id="9" name="Marcador de número de diapositiva 1">
            <a:extLst>
              <a:ext uri="{FF2B5EF4-FFF2-40B4-BE49-F238E27FC236}">
                <a16:creationId xmlns:a16="http://schemas.microsoft.com/office/drawing/2014/main" id="{32AEFB31-2965-4860-AB60-8D211630555C}"/>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0</a:t>
            </a:fld>
            <a:endParaRPr lang="en-GB" sz="1800" dirty="0">
              <a:latin typeface="+mj-lt"/>
            </a:endParaRPr>
          </a:p>
        </p:txBody>
      </p:sp>
      <p:cxnSp>
        <p:nvCxnSpPr>
          <p:cNvPr id="10" name="Conector recto 9">
            <a:extLst>
              <a:ext uri="{FF2B5EF4-FFF2-40B4-BE49-F238E27FC236}">
                <a16:creationId xmlns:a16="http://schemas.microsoft.com/office/drawing/2014/main" id="{EF540D2C-357A-4DF2-87EF-7DE66BC0AFDE}"/>
              </a:ext>
            </a:extLst>
          </p:cNvPr>
          <p:cNvCxnSpPr>
            <a:cxnSpLocks/>
          </p:cNvCxnSpPr>
          <p:nvPr/>
        </p:nvCxnSpPr>
        <p:spPr>
          <a:xfrm>
            <a:off x="9152626" y="1013007"/>
            <a:ext cx="2674189"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5435315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19971" y="563880"/>
            <a:ext cx="790601" cy="369332"/>
          </a:xfrm>
          <a:prstGeom prst="rect">
            <a:avLst/>
          </a:prstGeom>
          <a:noFill/>
        </p:spPr>
        <p:txBody>
          <a:bodyPr wrap="none" rtlCol="0">
            <a:spAutoFit/>
          </a:bodyPr>
          <a:lstStyle/>
          <a:p>
            <a:r>
              <a:rPr lang="en-GB" b="1" dirty="0">
                <a:latin typeface="+mj-lt"/>
              </a:rPr>
              <a:t>Fig. AE</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sp>
        <p:nvSpPr>
          <p:cNvPr id="8" name="CuadroTexto 7">
            <a:extLst>
              <a:ext uri="{FF2B5EF4-FFF2-40B4-BE49-F238E27FC236}">
                <a16:creationId xmlns:a16="http://schemas.microsoft.com/office/drawing/2014/main" id="{C2F4F912-4EBC-4591-9317-BE90EAA1699C}"/>
              </a:ext>
            </a:extLst>
          </p:cNvPr>
          <p:cNvSpPr txBox="1"/>
          <p:nvPr/>
        </p:nvSpPr>
        <p:spPr>
          <a:xfrm>
            <a:off x="9019971" y="1223010"/>
            <a:ext cx="2962119" cy="1815882"/>
          </a:xfrm>
          <a:prstGeom prst="rect">
            <a:avLst/>
          </a:prstGeom>
          <a:noFill/>
        </p:spPr>
        <p:txBody>
          <a:bodyPr wrap="square" rtlCol="0">
            <a:spAutoFit/>
          </a:bodyPr>
          <a:lstStyle/>
          <a:p>
            <a:pPr algn="just"/>
            <a:r>
              <a:rPr lang="en-GB" sz="1400" dirty="0"/>
              <a:t>General view of the cave after the excavation of the Unit IV at the excavation hall. </a:t>
            </a:r>
          </a:p>
          <a:p>
            <a:pPr algn="just"/>
            <a:endParaRPr lang="en-GB" sz="1400" dirty="0"/>
          </a:p>
          <a:p>
            <a:pPr algn="just"/>
            <a:r>
              <a:rPr lang="en-GB" sz="1400" dirty="0"/>
              <a:t>At this point, Unit IV is still preserved under the Travertine Platform 2.</a:t>
            </a:r>
          </a:p>
          <a:p>
            <a:pPr algn="just"/>
            <a:endParaRPr lang="en-GB" sz="1400" dirty="0"/>
          </a:p>
          <a:p>
            <a:pPr algn="just"/>
            <a:r>
              <a:rPr lang="en-GB" sz="1400" dirty="0"/>
              <a:t>Photo 2015</a:t>
            </a:r>
          </a:p>
        </p:txBody>
      </p:sp>
      <p:pic>
        <p:nvPicPr>
          <p:cNvPr id="9" name="Imagen 8" descr="Imagen que contiene rock, naturaleza, montaña, valle&#10;&#10;Descripción generada automáticamente">
            <a:extLst>
              <a:ext uri="{FF2B5EF4-FFF2-40B4-BE49-F238E27FC236}">
                <a16:creationId xmlns:a16="http://schemas.microsoft.com/office/drawing/2014/main" id="{9F303A04-6FFD-4ED1-80FC-AEDFCB021E14}"/>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563880"/>
            <a:ext cx="8688705" cy="5792470"/>
          </a:xfrm>
          <a:prstGeom prst="rect">
            <a:avLst/>
          </a:prstGeom>
        </p:spPr>
      </p:pic>
      <p:cxnSp>
        <p:nvCxnSpPr>
          <p:cNvPr id="10" name="Conector recto 9">
            <a:extLst>
              <a:ext uri="{FF2B5EF4-FFF2-40B4-BE49-F238E27FC236}">
                <a16:creationId xmlns:a16="http://schemas.microsoft.com/office/drawing/2014/main" id="{B884F843-311C-465F-BD65-71983D033171}"/>
              </a:ext>
            </a:extLst>
          </p:cNvPr>
          <p:cNvCxnSpPr>
            <a:cxnSpLocks/>
          </p:cNvCxnSpPr>
          <p:nvPr/>
        </p:nvCxnSpPr>
        <p:spPr>
          <a:xfrm>
            <a:off x="9144000" y="1056138"/>
            <a:ext cx="275182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1" name="Marcador de número de diapositiva 1">
            <a:extLst>
              <a:ext uri="{FF2B5EF4-FFF2-40B4-BE49-F238E27FC236}">
                <a16:creationId xmlns:a16="http://schemas.microsoft.com/office/drawing/2014/main" id="{2BC76768-EAC2-4A09-BF3B-0EE04C663F43}"/>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1</a:t>
            </a:fld>
            <a:endParaRPr lang="en-GB" sz="1800" dirty="0">
              <a:latin typeface="+mj-lt"/>
            </a:endParaRPr>
          </a:p>
        </p:txBody>
      </p:sp>
      <p:sp>
        <p:nvSpPr>
          <p:cNvPr id="5" name="Forma libre: forma 4">
            <a:extLst>
              <a:ext uri="{FF2B5EF4-FFF2-40B4-BE49-F238E27FC236}">
                <a16:creationId xmlns:a16="http://schemas.microsoft.com/office/drawing/2014/main" id="{6F745476-9248-4F61-AB56-36410E114F5E}"/>
              </a:ext>
            </a:extLst>
          </p:cNvPr>
          <p:cNvSpPr/>
          <p:nvPr/>
        </p:nvSpPr>
        <p:spPr>
          <a:xfrm>
            <a:off x="3673503" y="2170706"/>
            <a:ext cx="1470991" cy="2814762"/>
          </a:xfrm>
          <a:custGeom>
            <a:avLst/>
            <a:gdLst>
              <a:gd name="connsiteX0" fmla="*/ 0 w 1470991"/>
              <a:gd name="connsiteY0" fmla="*/ 0 h 2814762"/>
              <a:gd name="connsiteX1" fmla="*/ 71561 w 1470991"/>
              <a:gd name="connsiteY1" fmla="*/ 103367 h 2814762"/>
              <a:gd name="connsiteX2" fmla="*/ 174928 w 1470991"/>
              <a:gd name="connsiteY2" fmla="*/ 182880 h 2814762"/>
              <a:gd name="connsiteX3" fmla="*/ 286247 w 1470991"/>
              <a:gd name="connsiteY3" fmla="*/ 294198 h 2814762"/>
              <a:gd name="connsiteX4" fmla="*/ 365760 w 1470991"/>
              <a:gd name="connsiteY4" fmla="*/ 429371 h 2814762"/>
              <a:gd name="connsiteX5" fmla="*/ 405516 w 1470991"/>
              <a:gd name="connsiteY5" fmla="*/ 620202 h 2814762"/>
              <a:gd name="connsiteX6" fmla="*/ 326003 w 1470991"/>
              <a:gd name="connsiteY6" fmla="*/ 715617 h 2814762"/>
              <a:gd name="connsiteX7" fmla="*/ 230587 w 1470991"/>
              <a:gd name="connsiteY7" fmla="*/ 779228 h 2814762"/>
              <a:gd name="connsiteX8" fmla="*/ 119269 w 1470991"/>
              <a:gd name="connsiteY8" fmla="*/ 850790 h 2814762"/>
              <a:gd name="connsiteX9" fmla="*/ 87464 w 1470991"/>
              <a:gd name="connsiteY9" fmla="*/ 946205 h 2814762"/>
              <a:gd name="connsiteX10" fmla="*/ 63610 w 1470991"/>
              <a:gd name="connsiteY10" fmla="*/ 1041621 h 2814762"/>
              <a:gd name="connsiteX11" fmla="*/ 39756 w 1470991"/>
              <a:gd name="connsiteY11" fmla="*/ 1152939 h 2814762"/>
              <a:gd name="connsiteX12" fmla="*/ 39756 w 1470991"/>
              <a:gd name="connsiteY12" fmla="*/ 1264257 h 2814762"/>
              <a:gd name="connsiteX13" fmla="*/ 79513 w 1470991"/>
              <a:gd name="connsiteY13" fmla="*/ 1343771 h 2814762"/>
              <a:gd name="connsiteX14" fmla="*/ 79513 w 1470991"/>
              <a:gd name="connsiteY14" fmla="*/ 1343771 h 2814762"/>
              <a:gd name="connsiteX15" fmla="*/ 151074 w 1470991"/>
              <a:gd name="connsiteY15" fmla="*/ 1447137 h 2814762"/>
              <a:gd name="connsiteX16" fmla="*/ 238539 w 1470991"/>
              <a:gd name="connsiteY16" fmla="*/ 1447137 h 2814762"/>
              <a:gd name="connsiteX17" fmla="*/ 453224 w 1470991"/>
              <a:gd name="connsiteY17" fmla="*/ 1494845 h 2814762"/>
              <a:gd name="connsiteX18" fmla="*/ 620201 w 1470991"/>
              <a:gd name="connsiteY18" fmla="*/ 1534602 h 2814762"/>
              <a:gd name="connsiteX19" fmla="*/ 731520 w 1470991"/>
              <a:gd name="connsiteY19" fmla="*/ 1606164 h 2814762"/>
              <a:gd name="connsiteX20" fmla="*/ 882594 w 1470991"/>
              <a:gd name="connsiteY20" fmla="*/ 1717482 h 2814762"/>
              <a:gd name="connsiteX21" fmla="*/ 906448 w 1470991"/>
              <a:gd name="connsiteY21" fmla="*/ 1733384 h 2814762"/>
              <a:gd name="connsiteX22" fmla="*/ 962107 w 1470991"/>
              <a:gd name="connsiteY22" fmla="*/ 1828800 h 2814762"/>
              <a:gd name="connsiteX23" fmla="*/ 1057523 w 1470991"/>
              <a:gd name="connsiteY23" fmla="*/ 1956021 h 2814762"/>
              <a:gd name="connsiteX24" fmla="*/ 1105231 w 1470991"/>
              <a:gd name="connsiteY24" fmla="*/ 2122998 h 2814762"/>
              <a:gd name="connsiteX25" fmla="*/ 1097280 w 1470991"/>
              <a:gd name="connsiteY25" fmla="*/ 2266122 h 2814762"/>
              <a:gd name="connsiteX26" fmla="*/ 1160890 w 1470991"/>
              <a:gd name="connsiteY26" fmla="*/ 2385391 h 2814762"/>
              <a:gd name="connsiteX27" fmla="*/ 1192695 w 1470991"/>
              <a:gd name="connsiteY27" fmla="*/ 2504661 h 2814762"/>
              <a:gd name="connsiteX28" fmla="*/ 1240403 w 1470991"/>
              <a:gd name="connsiteY28" fmla="*/ 2584174 h 2814762"/>
              <a:gd name="connsiteX29" fmla="*/ 1264257 w 1470991"/>
              <a:gd name="connsiteY29" fmla="*/ 2639833 h 2814762"/>
              <a:gd name="connsiteX30" fmla="*/ 1343770 w 1470991"/>
              <a:gd name="connsiteY30" fmla="*/ 2711395 h 2814762"/>
              <a:gd name="connsiteX31" fmla="*/ 1439186 w 1470991"/>
              <a:gd name="connsiteY31" fmla="*/ 2743200 h 2814762"/>
              <a:gd name="connsiteX32" fmla="*/ 1470991 w 1470991"/>
              <a:gd name="connsiteY32" fmla="*/ 2782957 h 2814762"/>
              <a:gd name="connsiteX33" fmla="*/ 1470991 w 1470991"/>
              <a:gd name="connsiteY33" fmla="*/ 2814762 h 281476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Lst>
            <a:rect l="l" t="t" r="r" b="b"/>
            <a:pathLst>
              <a:path w="1470991" h="2814762">
                <a:moveTo>
                  <a:pt x="0" y="0"/>
                </a:moveTo>
                <a:lnTo>
                  <a:pt x="71561" y="103367"/>
                </a:lnTo>
                <a:lnTo>
                  <a:pt x="174928" y="182880"/>
                </a:lnTo>
                <a:lnTo>
                  <a:pt x="286247" y="294198"/>
                </a:lnTo>
                <a:lnTo>
                  <a:pt x="365760" y="429371"/>
                </a:lnTo>
                <a:lnTo>
                  <a:pt x="405516" y="620202"/>
                </a:lnTo>
                <a:lnTo>
                  <a:pt x="326003" y="715617"/>
                </a:lnTo>
                <a:lnTo>
                  <a:pt x="230587" y="779228"/>
                </a:lnTo>
                <a:lnTo>
                  <a:pt x="119269" y="850790"/>
                </a:lnTo>
                <a:lnTo>
                  <a:pt x="87464" y="946205"/>
                </a:lnTo>
                <a:lnTo>
                  <a:pt x="63610" y="1041621"/>
                </a:lnTo>
                <a:lnTo>
                  <a:pt x="39756" y="1152939"/>
                </a:lnTo>
                <a:lnTo>
                  <a:pt x="39756" y="1264257"/>
                </a:lnTo>
                <a:lnTo>
                  <a:pt x="79513" y="1343771"/>
                </a:lnTo>
                <a:lnTo>
                  <a:pt x="79513" y="1343771"/>
                </a:lnTo>
                <a:lnTo>
                  <a:pt x="151074" y="1447137"/>
                </a:lnTo>
                <a:lnTo>
                  <a:pt x="238539" y="1447137"/>
                </a:lnTo>
                <a:lnTo>
                  <a:pt x="453224" y="1494845"/>
                </a:lnTo>
                <a:lnTo>
                  <a:pt x="620201" y="1534602"/>
                </a:lnTo>
                <a:lnTo>
                  <a:pt x="731520" y="1606164"/>
                </a:lnTo>
                <a:lnTo>
                  <a:pt x="882594" y="1717482"/>
                </a:lnTo>
                <a:lnTo>
                  <a:pt x="906448" y="1733384"/>
                </a:lnTo>
                <a:lnTo>
                  <a:pt x="962107" y="1828800"/>
                </a:lnTo>
                <a:lnTo>
                  <a:pt x="1057523" y="1956021"/>
                </a:lnTo>
                <a:lnTo>
                  <a:pt x="1105231" y="2122998"/>
                </a:lnTo>
                <a:lnTo>
                  <a:pt x="1097280" y="2266122"/>
                </a:lnTo>
                <a:lnTo>
                  <a:pt x="1160890" y="2385391"/>
                </a:lnTo>
                <a:lnTo>
                  <a:pt x="1192695" y="2504661"/>
                </a:lnTo>
                <a:lnTo>
                  <a:pt x="1240403" y="2584174"/>
                </a:lnTo>
                <a:lnTo>
                  <a:pt x="1264257" y="2639833"/>
                </a:lnTo>
                <a:lnTo>
                  <a:pt x="1343770" y="2711395"/>
                </a:lnTo>
                <a:lnTo>
                  <a:pt x="1439186" y="2743200"/>
                </a:lnTo>
                <a:lnTo>
                  <a:pt x="1470991" y="2782957"/>
                </a:lnTo>
                <a:lnTo>
                  <a:pt x="1470991" y="2814762"/>
                </a:lnTo>
              </a:path>
            </a:pathLst>
          </a:custGeom>
          <a:noFill/>
          <a:ln>
            <a:solidFill>
              <a:schemeClr val="bg1"/>
            </a:solidFill>
            <a:prstDash val="dash"/>
          </a:ln>
          <a:effectLst>
            <a:outerShdw blurRad="50800" dist="38100" dir="10800000" algn="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CuadroTexto 11">
            <a:extLst>
              <a:ext uri="{FF2B5EF4-FFF2-40B4-BE49-F238E27FC236}">
                <a16:creationId xmlns:a16="http://schemas.microsoft.com/office/drawing/2014/main" id="{27B78272-DB26-45F9-BFD5-A2EC364EB3B0}"/>
              </a:ext>
            </a:extLst>
          </p:cNvPr>
          <p:cNvSpPr txBox="1"/>
          <p:nvPr/>
        </p:nvSpPr>
        <p:spPr>
          <a:xfrm>
            <a:off x="2653737" y="2170706"/>
            <a:ext cx="1150143" cy="461665"/>
          </a:xfrm>
          <a:prstGeom prst="rect">
            <a:avLst/>
          </a:prstGeom>
          <a:noFill/>
        </p:spPr>
        <p:txBody>
          <a:bodyPr wrap="square" rtlCol="0">
            <a:spAutoFit/>
          </a:bodyPr>
          <a:lstStyle/>
          <a:p>
            <a:pPr algn="r"/>
            <a:r>
              <a:rPr lang="en-GB" sz="1200" dirty="0">
                <a:solidFill>
                  <a:schemeClr val="bg1">
                    <a:lumMod val="95000"/>
                  </a:schemeClr>
                </a:solidFill>
                <a:effectLst>
                  <a:outerShdw blurRad="38100" dist="38100" dir="2700000" algn="tl">
                    <a:srgbClr val="000000">
                      <a:alpha val="43137"/>
                    </a:srgbClr>
                  </a:outerShdw>
                </a:effectLst>
                <a:latin typeface="+mj-lt"/>
              </a:rPr>
              <a:t>Travertine</a:t>
            </a:r>
          </a:p>
          <a:p>
            <a:pPr algn="r"/>
            <a:r>
              <a:rPr lang="en-GB" sz="1200" dirty="0">
                <a:solidFill>
                  <a:schemeClr val="bg1">
                    <a:lumMod val="95000"/>
                  </a:schemeClr>
                </a:solidFill>
                <a:effectLst>
                  <a:outerShdw blurRad="38100" dist="38100" dir="2700000" algn="tl">
                    <a:srgbClr val="000000">
                      <a:alpha val="43137"/>
                    </a:srgbClr>
                  </a:outerShdw>
                </a:effectLst>
                <a:latin typeface="+mj-lt"/>
              </a:rPr>
              <a:t>platform 2</a:t>
            </a:r>
          </a:p>
        </p:txBody>
      </p:sp>
    </p:spTree>
    <p:extLst>
      <p:ext uri="{BB962C8B-B14F-4D97-AF65-F5344CB8AC3E}">
        <p14:creationId xmlns:p14="http://schemas.microsoft.com/office/powerpoint/2010/main" val="371936628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40741" y="487882"/>
            <a:ext cx="801823" cy="369332"/>
          </a:xfrm>
          <a:prstGeom prst="rect">
            <a:avLst/>
          </a:prstGeom>
          <a:noFill/>
        </p:spPr>
        <p:txBody>
          <a:bodyPr wrap="none" rtlCol="0">
            <a:spAutoFit/>
          </a:bodyPr>
          <a:lstStyle/>
          <a:p>
            <a:r>
              <a:rPr lang="en-GB" dirty="0"/>
              <a:t>Fig. AF</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4" name="Imagen 3" descr="Imagen que contiene suelo, pared, edificio, rock&#10;&#10;Descripción generada automáticamente">
            <a:extLst>
              <a:ext uri="{FF2B5EF4-FFF2-40B4-BE49-F238E27FC236}">
                <a16:creationId xmlns:a16="http://schemas.microsoft.com/office/drawing/2014/main" id="{150DA7CA-6E43-4A29-AC71-73234715272E}"/>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491417"/>
            <a:ext cx="8878765" cy="5935261"/>
          </a:xfrm>
          <a:prstGeom prst="rect">
            <a:avLst/>
          </a:prstGeom>
        </p:spPr>
      </p:pic>
      <p:sp>
        <p:nvSpPr>
          <p:cNvPr id="8" name="CuadroTexto 7">
            <a:extLst>
              <a:ext uri="{FF2B5EF4-FFF2-40B4-BE49-F238E27FC236}">
                <a16:creationId xmlns:a16="http://schemas.microsoft.com/office/drawing/2014/main" id="{2D8BC870-F351-4427-9FD4-55A292C95640}"/>
              </a:ext>
            </a:extLst>
          </p:cNvPr>
          <p:cNvSpPr txBox="1"/>
          <p:nvPr/>
        </p:nvSpPr>
        <p:spPr>
          <a:xfrm>
            <a:off x="9140741" y="1084988"/>
            <a:ext cx="2743200" cy="1169551"/>
          </a:xfrm>
          <a:prstGeom prst="rect">
            <a:avLst/>
          </a:prstGeom>
          <a:noFill/>
        </p:spPr>
        <p:txBody>
          <a:bodyPr wrap="square" rtlCol="0">
            <a:spAutoFit/>
          </a:bodyPr>
          <a:lstStyle/>
          <a:p>
            <a:pPr algn="just"/>
            <a:r>
              <a:rPr lang="en-GB" sz="1400" dirty="0"/>
              <a:t>Reference section at the end of the excavation of the Unit IV at the excavation hall.</a:t>
            </a:r>
          </a:p>
          <a:p>
            <a:pPr algn="just"/>
            <a:endParaRPr lang="en-GB" sz="1400" dirty="0"/>
          </a:p>
          <a:p>
            <a:pPr algn="just"/>
            <a:r>
              <a:rPr lang="en-GB" sz="1400" dirty="0"/>
              <a:t>Photo 2015</a:t>
            </a:r>
          </a:p>
        </p:txBody>
      </p:sp>
      <p:sp>
        <p:nvSpPr>
          <p:cNvPr id="9" name="Marcador de número de diapositiva 1">
            <a:extLst>
              <a:ext uri="{FF2B5EF4-FFF2-40B4-BE49-F238E27FC236}">
                <a16:creationId xmlns:a16="http://schemas.microsoft.com/office/drawing/2014/main" id="{081303DA-866A-46D8-B619-5DC727929BC0}"/>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2</a:t>
            </a:fld>
            <a:endParaRPr lang="en-GB" sz="1800" dirty="0">
              <a:latin typeface="+mj-lt"/>
            </a:endParaRPr>
          </a:p>
        </p:txBody>
      </p:sp>
      <p:cxnSp>
        <p:nvCxnSpPr>
          <p:cNvPr id="10" name="Conector recto 9">
            <a:extLst>
              <a:ext uri="{FF2B5EF4-FFF2-40B4-BE49-F238E27FC236}">
                <a16:creationId xmlns:a16="http://schemas.microsoft.com/office/drawing/2014/main" id="{F5C2737C-1C92-4A79-BDEE-337229D13F61}"/>
              </a:ext>
            </a:extLst>
          </p:cNvPr>
          <p:cNvCxnSpPr>
            <a:cxnSpLocks/>
          </p:cNvCxnSpPr>
          <p:nvPr/>
        </p:nvCxnSpPr>
        <p:spPr>
          <a:xfrm>
            <a:off x="9256143" y="995756"/>
            <a:ext cx="2501661"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25978714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40483" y="509341"/>
            <a:ext cx="821507" cy="369332"/>
          </a:xfrm>
          <a:prstGeom prst="rect">
            <a:avLst/>
          </a:prstGeom>
          <a:noFill/>
        </p:spPr>
        <p:txBody>
          <a:bodyPr wrap="none" rtlCol="0">
            <a:spAutoFit/>
          </a:bodyPr>
          <a:lstStyle/>
          <a:p>
            <a:r>
              <a:rPr lang="en-GB" b="1" dirty="0">
                <a:latin typeface="+mj-lt"/>
              </a:rPr>
              <a:t>Fig. AG</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3" name="Imagen 2" descr="Imagen que contiene suelo, rock, edificio, naturaleza&#10;&#10;Descripción generada automáticamente">
            <a:extLst>
              <a:ext uri="{FF2B5EF4-FFF2-40B4-BE49-F238E27FC236}">
                <a16:creationId xmlns:a16="http://schemas.microsoft.com/office/drawing/2014/main" id="{8D680E04-A22B-4648-8EA4-A0B1398BA986}"/>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05332"/>
            <a:ext cx="8776528" cy="5851018"/>
          </a:xfrm>
          <a:prstGeom prst="rect">
            <a:avLst/>
          </a:prstGeom>
        </p:spPr>
      </p:pic>
      <p:sp>
        <p:nvSpPr>
          <p:cNvPr id="8" name="CuadroTexto 7">
            <a:extLst>
              <a:ext uri="{FF2B5EF4-FFF2-40B4-BE49-F238E27FC236}">
                <a16:creationId xmlns:a16="http://schemas.microsoft.com/office/drawing/2014/main" id="{84FA2D41-437B-4182-AC42-214CDA44B2C6}"/>
              </a:ext>
            </a:extLst>
          </p:cNvPr>
          <p:cNvSpPr txBox="1"/>
          <p:nvPr/>
        </p:nvSpPr>
        <p:spPr>
          <a:xfrm>
            <a:off x="9040483" y="1162625"/>
            <a:ext cx="2812212" cy="1169551"/>
          </a:xfrm>
          <a:prstGeom prst="rect">
            <a:avLst/>
          </a:prstGeom>
          <a:noFill/>
        </p:spPr>
        <p:txBody>
          <a:bodyPr wrap="square" rtlCol="0">
            <a:spAutoFit/>
          </a:bodyPr>
          <a:lstStyle/>
          <a:p>
            <a:pPr algn="just"/>
            <a:r>
              <a:rPr lang="en-GB" sz="1400" dirty="0"/>
              <a:t>Section showing the Unit IV preserved and sealed by the Travertine </a:t>
            </a:r>
            <a:r>
              <a:rPr lang="en-GB" sz="1400" dirty="0" err="1"/>
              <a:t>Platftorm</a:t>
            </a:r>
            <a:r>
              <a:rPr lang="en-GB" sz="1400" dirty="0"/>
              <a:t> 2.</a:t>
            </a:r>
          </a:p>
          <a:p>
            <a:pPr algn="just"/>
            <a:endParaRPr lang="en-GB" sz="1400" dirty="0"/>
          </a:p>
          <a:p>
            <a:pPr algn="just"/>
            <a:r>
              <a:rPr lang="en-GB" sz="1400" dirty="0"/>
              <a:t>Photo 2015</a:t>
            </a:r>
          </a:p>
        </p:txBody>
      </p:sp>
      <p:cxnSp>
        <p:nvCxnSpPr>
          <p:cNvPr id="9" name="Conector recto 8">
            <a:extLst>
              <a:ext uri="{FF2B5EF4-FFF2-40B4-BE49-F238E27FC236}">
                <a16:creationId xmlns:a16="http://schemas.microsoft.com/office/drawing/2014/main" id="{C66E8842-8194-4A12-9FF7-BE9131D1BC1C}"/>
              </a:ext>
            </a:extLst>
          </p:cNvPr>
          <p:cNvCxnSpPr>
            <a:cxnSpLocks/>
          </p:cNvCxnSpPr>
          <p:nvPr/>
        </p:nvCxnSpPr>
        <p:spPr>
          <a:xfrm>
            <a:off x="9126747" y="1030260"/>
            <a:ext cx="2631057"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96A3EF06-0516-4207-BD43-0545840F3045}"/>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3</a:t>
            </a:fld>
            <a:endParaRPr lang="en-GB" sz="1800" dirty="0">
              <a:latin typeface="+mj-lt"/>
            </a:endParaRPr>
          </a:p>
        </p:txBody>
      </p:sp>
    </p:spTree>
    <p:extLst>
      <p:ext uri="{BB962C8B-B14F-4D97-AF65-F5344CB8AC3E}">
        <p14:creationId xmlns:p14="http://schemas.microsoft.com/office/powerpoint/2010/main" val="206706301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8610600" y="466605"/>
            <a:ext cx="819455" cy="369332"/>
          </a:xfrm>
          <a:prstGeom prst="rect">
            <a:avLst/>
          </a:prstGeom>
          <a:noFill/>
        </p:spPr>
        <p:txBody>
          <a:bodyPr wrap="none" rtlCol="0">
            <a:spAutoFit/>
          </a:bodyPr>
          <a:lstStyle/>
          <a:p>
            <a:r>
              <a:rPr lang="en-GB" b="1" dirty="0">
                <a:latin typeface="+mj-lt"/>
              </a:rPr>
              <a:t>Fig. AH</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10" name="Imagen 9" descr="Imagen que contiene rock, persona, exterior, suelo&#10;&#10;Descripción generada automáticamente">
            <a:extLst>
              <a:ext uri="{FF2B5EF4-FFF2-40B4-BE49-F238E27FC236}">
                <a16:creationId xmlns:a16="http://schemas.microsoft.com/office/drawing/2014/main" id="{0BF55DCF-498F-48B0-846D-EA6C0552DE53}"/>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466605"/>
            <a:ext cx="8288345" cy="6254869"/>
          </a:xfrm>
          <a:prstGeom prst="rect">
            <a:avLst/>
          </a:prstGeom>
        </p:spPr>
      </p:pic>
      <p:sp>
        <p:nvSpPr>
          <p:cNvPr id="11" name="CuadroTexto 10">
            <a:extLst>
              <a:ext uri="{FF2B5EF4-FFF2-40B4-BE49-F238E27FC236}">
                <a16:creationId xmlns:a16="http://schemas.microsoft.com/office/drawing/2014/main" id="{18ABB3C5-A9F4-4EA5-B159-A395292479B3}"/>
              </a:ext>
            </a:extLst>
          </p:cNvPr>
          <p:cNvSpPr txBox="1"/>
          <p:nvPr/>
        </p:nvSpPr>
        <p:spPr>
          <a:xfrm>
            <a:off x="8610600" y="990097"/>
            <a:ext cx="3198962" cy="954107"/>
          </a:xfrm>
          <a:prstGeom prst="rect">
            <a:avLst/>
          </a:prstGeom>
          <a:noFill/>
        </p:spPr>
        <p:txBody>
          <a:bodyPr wrap="square" rtlCol="0">
            <a:spAutoFit/>
          </a:bodyPr>
          <a:lstStyle/>
          <a:p>
            <a:pPr algn="just"/>
            <a:r>
              <a:rPr lang="en-GB" sz="1400" dirty="0"/>
              <a:t>Dismantling the Travertine </a:t>
            </a:r>
            <a:r>
              <a:rPr lang="en-GB" sz="1400" dirty="0" err="1"/>
              <a:t>Platftorm</a:t>
            </a:r>
            <a:r>
              <a:rPr lang="en-GB" sz="1400" dirty="0"/>
              <a:t> 2 for the 2017 field season.</a:t>
            </a:r>
          </a:p>
          <a:p>
            <a:pPr algn="just"/>
            <a:endParaRPr lang="en-GB" sz="1400" dirty="0"/>
          </a:p>
          <a:p>
            <a:pPr algn="just"/>
            <a:r>
              <a:rPr lang="en-GB" sz="1400" dirty="0"/>
              <a:t>Photo 2017</a:t>
            </a:r>
          </a:p>
        </p:txBody>
      </p:sp>
      <p:sp>
        <p:nvSpPr>
          <p:cNvPr id="8" name="Marcador de número de diapositiva 1">
            <a:extLst>
              <a:ext uri="{FF2B5EF4-FFF2-40B4-BE49-F238E27FC236}">
                <a16:creationId xmlns:a16="http://schemas.microsoft.com/office/drawing/2014/main" id="{05A17267-1F7A-45CF-8E7B-CABE36EC0EB0}"/>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4</a:t>
            </a:fld>
            <a:endParaRPr lang="en-GB" sz="1800" dirty="0">
              <a:latin typeface="+mj-lt"/>
            </a:endParaRPr>
          </a:p>
        </p:txBody>
      </p:sp>
      <p:cxnSp>
        <p:nvCxnSpPr>
          <p:cNvPr id="9" name="Conector recto 8">
            <a:extLst>
              <a:ext uri="{FF2B5EF4-FFF2-40B4-BE49-F238E27FC236}">
                <a16:creationId xmlns:a16="http://schemas.microsoft.com/office/drawing/2014/main" id="{D12AEFB2-526C-4E03-8120-5526C886C846}"/>
              </a:ext>
            </a:extLst>
          </p:cNvPr>
          <p:cNvCxnSpPr>
            <a:cxnSpLocks/>
          </p:cNvCxnSpPr>
          <p:nvPr/>
        </p:nvCxnSpPr>
        <p:spPr>
          <a:xfrm>
            <a:off x="8721306" y="926743"/>
            <a:ext cx="296748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56432707"/>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4440907" y="493622"/>
            <a:ext cx="736099" cy="369332"/>
          </a:xfrm>
          <a:prstGeom prst="rect">
            <a:avLst/>
          </a:prstGeom>
          <a:noFill/>
        </p:spPr>
        <p:txBody>
          <a:bodyPr wrap="none" rtlCol="0">
            <a:spAutoFit/>
          </a:bodyPr>
          <a:lstStyle/>
          <a:p>
            <a:r>
              <a:rPr lang="en-GB" b="1" dirty="0">
                <a:latin typeface="+mj-lt"/>
              </a:rPr>
              <a:t>Fig. AI</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4" name="Imagen 3" descr="Imagen que contiene pared, edificio, rock&#10;&#10;Descripción generada automáticamente">
            <a:extLst>
              <a:ext uri="{FF2B5EF4-FFF2-40B4-BE49-F238E27FC236}">
                <a16:creationId xmlns:a16="http://schemas.microsoft.com/office/drawing/2014/main" id="{1845252F-D0D1-469C-A121-4C7FF51727FE}"/>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rot="16200000">
            <a:off x="-917060" y="1687632"/>
            <a:ext cx="6132575" cy="4073128"/>
          </a:xfrm>
          <a:prstGeom prst="rect">
            <a:avLst/>
          </a:prstGeom>
        </p:spPr>
      </p:pic>
      <p:pic>
        <p:nvPicPr>
          <p:cNvPr id="8" name="Imagen 7" descr="Imagen que contiene rock, suelo, naturaleza, edificio&#10;&#10;Descripción generada automáticamente">
            <a:extLst>
              <a:ext uri="{FF2B5EF4-FFF2-40B4-BE49-F238E27FC236}">
                <a16:creationId xmlns:a16="http://schemas.microsoft.com/office/drawing/2014/main" id="{4F3B2E5D-254C-4F91-8AD7-5DDEB853154B}"/>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4841536" y="2318437"/>
            <a:ext cx="6733194" cy="4472047"/>
          </a:xfrm>
          <a:prstGeom prst="rect">
            <a:avLst/>
          </a:prstGeom>
        </p:spPr>
      </p:pic>
      <p:sp>
        <p:nvSpPr>
          <p:cNvPr id="9" name="CuadroTexto 8">
            <a:extLst>
              <a:ext uri="{FF2B5EF4-FFF2-40B4-BE49-F238E27FC236}">
                <a16:creationId xmlns:a16="http://schemas.microsoft.com/office/drawing/2014/main" id="{33D585DD-375C-4CAF-B641-DB5E9CA4A457}"/>
              </a:ext>
            </a:extLst>
          </p:cNvPr>
          <p:cNvSpPr txBox="1"/>
          <p:nvPr/>
        </p:nvSpPr>
        <p:spPr>
          <a:xfrm>
            <a:off x="4440907" y="966470"/>
            <a:ext cx="7196134" cy="1169551"/>
          </a:xfrm>
          <a:prstGeom prst="rect">
            <a:avLst/>
          </a:prstGeom>
          <a:noFill/>
        </p:spPr>
        <p:txBody>
          <a:bodyPr wrap="square" rtlCol="0">
            <a:spAutoFit/>
          </a:bodyPr>
          <a:lstStyle/>
          <a:p>
            <a:pPr algn="just"/>
            <a:r>
              <a:rPr lang="en-GB" sz="1400" dirty="0"/>
              <a:t>Section showing the sedimentary sequence preserved below the Travertine Platform 2 after its removal. A thin grey layer of sediments infiltrated through the travertine fissures is deposited at the top of the Unit IV. Fig 35a, frontal view. Fig.35b, top view.</a:t>
            </a:r>
          </a:p>
          <a:p>
            <a:pPr algn="just"/>
            <a:endParaRPr lang="en-GB" sz="1400" dirty="0"/>
          </a:p>
          <a:p>
            <a:pPr algn="just"/>
            <a:r>
              <a:rPr lang="en-GB" sz="1400" dirty="0"/>
              <a:t>Photo 2017</a:t>
            </a:r>
          </a:p>
        </p:txBody>
      </p:sp>
      <p:sp>
        <p:nvSpPr>
          <p:cNvPr id="10" name="CuadroTexto 9">
            <a:extLst>
              <a:ext uri="{FF2B5EF4-FFF2-40B4-BE49-F238E27FC236}">
                <a16:creationId xmlns:a16="http://schemas.microsoft.com/office/drawing/2014/main" id="{AFE97465-2EF0-4923-93FD-87AC08C2897B}"/>
              </a:ext>
            </a:extLst>
          </p:cNvPr>
          <p:cNvSpPr txBox="1"/>
          <p:nvPr/>
        </p:nvSpPr>
        <p:spPr>
          <a:xfrm>
            <a:off x="112663" y="288576"/>
            <a:ext cx="379044" cy="369332"/>
          </a:xfrm>
          <a:prstGeom prst="rect">
            <a:avLst/>
          </a:prstGeom>
          <a:noFill/>
        </p:spPr>
        <p:txBody>
          <a:bodyPr wrap="square" rtlCol="0">
            <a:spAutoFit/>
          </a:bodyPr>
          <a:lstStyle/>
          <a:p>
            <a:r>
              <a:rPr lang="en-GB" b="1" dirty="0">
                <a:latin typeface="+mj-lt"/>
              </a:rPr>
              <a:t>a)</a:t>
            </a:r>
          </a:p>
        </p:txBody>
      </p:sp>
      <p:sp>
        <p:nvSpPr>
          <p:cNvPr id="11" name="CuadroTexto 10">
            <a:extLst>
              <a:ext uri="{FF2B5EF4-FFF2-40B4-BE49-F238E27FC236}">
                <a16:creationId xmlns:a16="http://schemas.microsoft.com/office/drawing/2014/main" id="{7AB0F571-40A0-487A-8D67-2AB2005BC8C3}"/>
              </a:ext>
            </a:extLst>
          </p:cNvPr>
          <p:cNvSpPr txBox="1"/>
          <p:nvPr/>
        </p:nvSpPr>
        <p:spPr>
          <a:xfrm>
            <a:off x="4440907" y="2318437"/>
            <a:ext cx="480108" cy="369332"/>
          </a:xfrm>
          <a:prstGeom prst="rect">
            <a:avLst/>
          </a:prstGeom>
          <a:noFill/>
        </p:spPr>
        <p:txBody>
          <a:bodyPr wrap="square" rtlCol="0">
            <a:spAutoFit/>
          </a:bodyPr>
          <a:lstStyle/>
          <a:p>
            <a:r>
              <a:rPr lang="en-GB" b="1" dirty="0">
                <a:latin typeface="+mj-lt"/>
              </a:rPr>
              <a:t>b)</a:t>
            </a:r>
          </a:p>
        </p:txBody>
      </p:sp>
      <p:cxnSp>
        <p:nvCxnSpPr>
          <p:cNvPr id="12" name="Conector recto 11">
            <a:extLst>
              <a:ext uri="{FF2B5EF4-FFF2-40B4-BE49-F238E27FC236}">
                <a16:creationId xmlns:a16="http://schemas.microsoft.com/office/drawing/2014/main" id="{9368683B-5349-4A5A-9590-D4749059C79B}"/>
              </a:ext>
            </a:extLst>
          </p:cNvPr>
          <p:cNvCxnSpPr>
            <a:cxnSpLocks/>
          </p:cNvCxnSpPr>
          <p:nvPr/>
        </p:nvCxnSpPr>
        <p:spPr>
          <a:xfrm>
            <a:off x="4562947" y="923336"/>
            <a:ext cx="7011783"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4" name="Marcador de número de diapositiva 1">
            <a:extLst>
              <a:ext uri="{FF2B5EF4-FFF2-40B4-BE49-F238E27FC236}">
                <a16:creationId xmlns:a16="http://schemas.microsoft.com/office/drawing/2014/main" id="{09F83329-A670-4A97-A249-DA292D63B4E6}"/>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5</a:t>
            </a:fld>
            <a:endParaRPr lang="en-GB" sz="1800" dirty="0">
              <a:latin typeface="+mj-lt"/>
            </a:endParaRPr>
          </a:p>
        </p:txBody>
      </p:sp>
    </p:spTree>
    <p:extLst>
      <p:ext uri="{BB962C8B-B14F-4D97-AF65-F5344CB8AC3E}">
        <p14:creationId xmlns:p14="http://schemas.microsoft.com/office/powerpoint/2010/main" val="675220642"/>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8950960" y="563880"/>
            <a:ext cx="752770" cy="369332"/>
          </a:xfrm>
          <a:prstGeom prst="rect">
            <a:avLst/>
          </a:prstGeom>
          <a:noFill/>
        </p:spPr>
        <p:txBody>
          <a:bodyPr wrap="none" rtlCol="0">
            <a:spAutoFit/>
          </a:bodyPr>
          <a:lstStyle/>
          <a:p>
            <a:r>
              <a:rPr lang="en-GB" b="1" dirty="0">
                <a:latin typeface="+mj-lt"/>
              </a:rPr>
              <a:t>Fig. AJ</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3" name="Imagen 2" descr="Imagen que contiene rock, piedra, pared, edificio&#10;&#10;Descripción generada automáticamente">
            <a:extLst>
              <a:ext uri="{FF2B5EF4-FFF2-40B4-BE49-F238E27FC236}">
                <a16:creationId xmlns:a16="http://schemas.microsoft.com/office/drawing/2014/main" id="{EED52761-81AA-4DD0-88F5-42FCC081844A}"/>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563880"/>
            <a:ext cx="8721247" cy="5792470"/>
          </a:xfrm>
          <a:prstGeom prst="rect">
            <a:avLst/>
          </a:prstGeom>
        </p:spPr>
      </p:pic>
      <p:sp>
        <p:nvSpPr>
          <p:cNvPr id="10" name="CuadroTexto 9">
            <a:extLst>
              <a:ext uri="{FF2B5EF4-FFF2-40B4-BE49-F238E27FC236}">
                <a16:creationId xmlns:a16="http://schemas.microsoft.com/office/drawing/2014/main" id="{000CE656-61E1-4832-89D0-8E0E5FB37D12}"/>
              </a:ext>
            </a:extLst>
          </p:cNvPr>
          <p:cNvSpPr txBox="1"/>
          <p:nvPr/>
        </p:nvSpPr>
        <p:spPr>
          <a:xfrm>
            <a:off x="8950961" y="1171251"/>
            <a:ext cx="3022503" cy="1384995"/>
          </a:xfrm>
          <a:prstGeom prst="rect">
            <a:avLst/>
          </a:prstGeom>
          <a:noFill/>
        </p:spPr>
        <p:txBody>
          <a:bodyPr wrap="square" rtlCol="0">
            <a:spAutoFit/>
          </a:bodyPr>
          <a:lstStyle/>
          <a:p>
            <a:pPr algn="just"/>
            <a:r>
              <a:rPr lang="en-GB" sz="1400" dirty="0"/>
              <a:t>Top of the Unit IV preserved under the Travertine Platform 2 after the excavation of the percolated sediments and the emptying of the burrows.</a:t>
            </a:r>
          </a:p>
          <a:p>
            <a:pPr algn="just"/>
            <a:endParaRPr lang="en-GB" sz="1400" dirty="0"/>
          </a:p>
          <a:p>
            <a:pPr algn="just"/>
            <a:r>
              <a:rPr lang="en-GB" sz="1400" dirty="0"/>
              <a:t>Photo 2017</a:t>
            </a:r>
          </a:p>
        </p:txBody>
      </p:sp>
      <p:sp>
        <p:nvSpPr>
          <p:cNvPr id="8" name="Marcador de número de diapositiva 1">
            <a:extLst>
              <a:ext uri="{FF2B5EF4-FFF2-40B4-BE49-F238E27FC236}">
                <a16:creationId xmlns:a16="http://schemas.microsoft.com/office/drawing/2014/main" id="{34EF155D-84C3-451C-B33E-AD9E7AF859F6}"/>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6</a:t>
            </a:fld>
            <a:endParaRPr lang="en-GB" sz="1800" dirty="0">
              <a:latin typeface="+mj-lt"/>
            </a:endParaRPr>
          </a:p>
        </p:txBody>
      </p:sp>
      <p:cxnSp>
        <p:nvCxnSpPr>
          <p:cNvPr id="9" name="Conector recto 8">
            <a:extLst>
              <a:ext uri="{FF2B5EF4-FFF2-40B4-BE49-F238E27FC236}">
                <a16:creationId xmlns:a16="http://schemas.microsoft.com/office/drawing/2014/main" id="{94C60FF4-19B9-49F1-9C0B-1B85F7DBBBC7}"/>
              </a:ext>
            </a:extLst>
          </p:cNvPr>
          <p:cNvCxnSpPr>
            <a:cxnSpLocks/>
          </p:cNvCxnSpPr>
          <p:nvPr/>
        </p:nvCxnSpPr>
        <p:spPr>
          <a:xfrm>
            <a:off x="9027765" y="1056139"/>
            <a:ext cx="283355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1" name="Forma libre: forma 10">
            <a:extLst>
              <a:ext uri="{FF2B5EF4-FFF2-40B4-BE49-F238E27FC236}">
                <a16:creationId xmlns:a16="http://schemas.microsoft.com/office/drawing/2014/main" id="{6BCDA7AF-1797-4784-9F6A-A3EF11BEEAB7}"/>
              </a:ext>
            </a:extLst>
          </p:cNvPr>
          <p:cNvSpPr/>
          <p:nvPr/>
        </p:nvSpPr>
        <p:spPr>
          <a:xfrm>
            <a:off x="5064981" y="2806810"/>
            <a:ext cx="2743200" cy="2083242"/>
          </a:xfrm>
          <a:custGeom>
            <a:avLst/>
            <a:gdLst>
              <a:gd name="connsiteX0" fmla="*/ 2743200 w 2743200"/>
              <a:gd name="connsiteY0" fmla="*/ 1152940 h 2083242"/>
              <a:gd name="connsiteX1" fmla="*/ 2520563 w 2743200"/>
              <a:gd name="connsiteY1" fmla="*/ 1200647 h 2083242"/>
              <a:gd name="connsiteX2" fmla="*/ 2361537 w 2743200"/>
              <a:gd name="connsiteY2" fmla="*/ 1232453 h 2083242"/>
              <a:gd name="connsiteX3" fmla="*/ 2226365 w 2743200"/>
              <a:gd name="connsiteY3" fmla="*/ 1192696 h 2083242"/>
              <a:gd name="connsiteX4" fmla="*/ 2035534 w 2743200"/>
              <a:gd name="connsiteY4" fmla="*/ 1009816 h 2083242"/>
              <a:gd name="connsiteX5" fmla="*/ 1868556 w 2743200"/>
              <a:gd name="connsiteY5" fmla="*/ 914400 h 2083242"/>
              <a:gd name="connsiteX6" fmla="*/ 1709530 w 2743200"/>
              <a:gd name="connsiteY6" fmla="*/ 771277 h 2083242"/>
              <a:gd name="connsiteX7" fmla="*/ 1486894 w 2743200"/>
              <a:gd name="connsiteY7" fmla="*/ 556592 h 2083242"/>
              <a:gd name="connsiteX8" fmla="*/ 1367624 w 2743200"/>
              <a:gd name="connsiteY8" fmla="*/ 373712 h 2083242"/>
              <a:gd name="connsiteX9" fmla="*/ 1311965 w 2743200"/>
              <a:gd name="connsiteY9" fmla="*/ 230588 h 2083242"/>
              <a:gd name="connsiteX10" fmla="*/ 1192696 w 2743200"/>
              <a:gd name="connsiteY10" fmla="*/ 55660 h 2083242"/>
              <a:gd name="connsiteX11" fmla="*/ 922351 w 2743200"/>
              <a:gd name="connsiteY11" fmla="*/ 7952 h 2083242"/>
              <a:gd name="connsiteX12" fmla="*/ 652007 w 2743200"/>
              <a:gd name="connsiteY12" fmla="*/ 0 h 2083242"/>
              <a:gd name="connsiteX13" fmla="*/ 485029 w 2743200"/>
              <a:gd name="connsiteY13" fmla="*/ 0 h 2083242"/>
              <a:gd name="connsiteX14" fmla="*/ 230588 w 2743200"/>
              <a:gd name="connsiteY14" fmla="*/ 55660 h 2083242"/>
              <a:gd name="connsiteX15" fmla="*/ 39756 w 2743200"/>
              <a:gd name="connsiteY15" fmla="*/ 143124 h 2083242"/>
              <a:gd name="connsiteX16" fmla="*/ 0 w 2743200"/>
              <a:gd name="connsiteY16" fmla="*/ 222637 h 2083242"/>
              <a:gd name="connsiteX17" fmla="*/ 23854 w 2743200"/>
              <a:gd name="connsiteY17" fmla="*/ 413468 h 2083242"/>
              <a:gd name="connsiteX18" fmla="*/ 47708 w 2743200"/>
              <a:gd name="connsiteY18" fmla="*/ 532738 h 2083242"/>
              <a:gd name="connsiteX19" fmla="*/ 111318 w 2743200"/>
              <a:gd name="connsiteY19" fmla="*/ 628153 h 2083242"/>
              <a:gd name="connsiteX20" fmla="*/ 238539 w 2743200"/>
              <a:gd name="connsiteY20" fmla="*/ 795131 h 2083242"/>
              <a:gd name="connsiteX21" fmla="*/ 365760 w 2743200"/>
              <a:gd name="connsiteY21" fmla="*/ 1009816 h 2083242"/>
              <a:gd name="connsiteX22" fmla="*/ 453224 w 2743200"/>
              <a:gd name="connsiteY22" fmla="*/ 1160891 h 2083242"/>
              <a:gd name="connsiteX23" fmla="*/ 604299 w 2743200"/>
              <a:gd name="connsiteY23" fmla="*/ 1232453 h 2083242"/>
              <a:gd name="connsiteX24" fmla="*/ 763325 w 2743200"/>
              <a:gd name="connsiteY24" fmla="*/ 1311966 h 2083242"/>
              <a:gd name="connsiteX25" fmla="*/ 866692 w 2743200"/>
              <a:gd name="connsiteY25" fmla="*/ 1407381 h 2083242"/>
              <a:gd name="connsiteX26" fmla="*/ 970059 w 2743200"/>
              <a:gd name="connsiteY26" fmla="*/ 1542553 h 2083242"/>
              <a:gd name="connsiteX27" fmla="*/ 1097280 w 2743200"/>
              <a:gd name="connsiteY27" fmla="*/ 1693628 h 2083242"/>
              <a:gd name="connsiteX28" fmla="*/ 1240403 w 2743200"/>
              <a:gd name="connsiteY28" fmla="*/ 1844703 h 2083242"/>
              <a:gd name="connsiteX29" fmla="*/ 1415332 w 2743200"/>
              <a:gd name="connsiteY29" fmla="*/ 1924216 h 2083242"/>
              <a:gd name="connsiteX30" fmla="*/ 1542553 w 2743200"/>
              <a:gd name="connsiteY30" fmla="*/ 2027583 h 2083242"/>
              <a:gd name="connsiteX31" fmla="*/ 1757238 w 2743200"/>
              <a:gd name="connsiteY31" fmla="*/ 2083242 h 2083242"/>
              <a:gd name="connsiteX32" fmla="*/ 1765189 w 2743200"/>
              <a:gd name="connsiteY32" fmla="*/ 2083242 h 20832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Lst>
            <a:rect l="l" t="t" r="r" b="b"/>
            <a:pathLst>
              <a:path w="2743200" h="2083242">
                <a:moveTo>
                  <a:pt x="2743200" y="1152940"/>
                </a:moveTo>
                <a:lnTo>
                  <a:pt x="2520563" y="1200647"/>
                </a:lnTo>
                <a:lnTo>
                  <a:pt x="2361537" y="1232453"/>
                </a:lnTo>
                <a:lnTo>
                  <a:pt x="2226365" y="1192696"/>
                </a:lnTo>
                <a:lnTo>
                  <a:pt x="2035534" y="1009816"/>
                </a:lnTo>
                <a:lnTo>
                  <a:pt x="1868556" y="914400"/>
                </a:lnTo>
                <a:lnTo>
                  <a:pt x="1709530" y="771277"/>
                </a:lnTo>
                <a:lnTo>
                  <a:pt x="1486894" y="556592"/>
                </a:lnTo>
                <a:lnTo>
                  <a:pt x="1367624" y="373712"/>
                </a:lnTo>
                <a:lnTo>
                  <a:pt x="1311965" y="230588"/>
                </a:lnTo>
                <a:lnTo>
                  <a:pt x="1192696" y="55660"/>
                </a:lnTo>
                <a:lnTo>
                  <a:pt x="922351" y="7952"/>
                </a:lnTo>
                <a:lnTo>
                  <a:pt x="652007" y="0"/>
                </a:lnTo>
                <a:lnTo>
                  <a:pt x="485029" y="0"/>
                </a:lnTo>
                <a:lnTo>
                  <a:pt x="230588" y="55660"/>
                </a:lnTo>
                <a:lnTo>
                  <a:pt x="39756" y="143124"/>
                </a:lnTo>
                <a:lnTo>
                  <a:pt x="0" y="222637"/>
                </a:lnTo>
                <a:lnTo>
                  <a:pt x="23854" y="413468"/>
                </a:lnTo>
                <a:lnTo>
                  <a:pt x="47708" y="532738"/>
                </a:lnTo>
                <a:lnTo>
                  <a:pt x="111318" y="628153"/>
                </a:lnTo>
                <a:lnTo>
                  <a:pt x="238539" y="795131"/>
                </a:lnTo>
                <a:lnTo>
                  <a:pt x="365760" y="1009816"/>
                </a:lnTo>
                <a:lnTo>
                  <a:pt x="453224" y="1160891"/>
                </a:lnTo>
                <a:lnTo>
                  <a:pt x="604299" y="1232453"/>
                </a:lnTo>
                <a:lnTo>
                  <a:pt x="763325" y="1311966"/>
                </a:lnTo>
                <a:lnTo>
                  <a:pt x="866692" y="1407381"/>
                </a:lnTo>
                <a:lnTo>
                  <a:pt x="970059" y="1542553"/>
                </a:lnTo>
                <a:lnTo>
                  <a:pt x="1097280" y="1693628"/>
                </a:lnTo>
                <a:lnTo>
                  <a:pt x="1240403" y="1844703"/>
                </a:lnTo>
                <a:lnTo>
                  <a:pt x="1415332" y="1924216"/>
                </a:lnTo>
                <a:lnTo>
                  <a:pt x="1542553" y="2027583"/>
                </a:lnTo>
                <a:lnTo>
                  <a:pt x="1757238" y="2083242"/>
                </a:lnTo>
                <a:lnTo>
                  <a:pt x="1765189" y="2083242"/>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CuadroTexto 11">
            <a:extLst>
              <a:ext uri="{FF2B5EF4-FFF2-40B4-BE49-F238E27FC236}">
                <a16:creationId xmlns:a16="http://schemas.microsoft.com/office/drawing/2014/main" id="{DE339264-DFB1-4EF0-A8AE-E6D9A8BDA6E1}"/>
              </a:ext>
            </a:extLst>
          </p:cNvPr>
          <p:cNvSpPr txBox="1"/>
          <p:nvPr/>
        </p:nvSpPr>
        <p:spPr>
          <a:xfrm>
            <a:off x="5064980" y="2806810"/>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Burrow</a:t>
            </a:r>
          </a:p>
        </p:txBody>
      </p:sp>
      <p:sp>
        <p:nvSpPr>
          <p:cNvPr id="13" name="CuadroTexto 12">
            <a:extLst>
              <a:ext uri="{FF2B5EF4-FFF2-40B4-BE49-F238E27FC236}">
                <a16:creationId xmlns:a16="http://schemas.microsoft.com/office/drawing/2014/main" id="{51A18196-9D06-4D6C-AE83-620DFE8D7F1F}"/>
              </a:ext>
            </a:extLst>
          </p:cNvPr>
          <p:cNvSpPr txBox="1"/>
          <p:nvPr/>
        </p:nvSpPr>
        <p:spPr>
          <a:xfrm>
            <a:off x="5064980" y="2529811"/>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Unit IV</a:t>
            </a:r>
          </a:p>
        </p:txBody>
      </p:sp>
    </p:spTree>
    <p:extLst>
      <p:ext uri="{BB962C8B-B14F-4D97-AF65-F5344CB8AC3E}">
        <p14:creationId xmlns:p14="http://schemas.microsoft.com/office/powerpoint/2010/main" val="1679503701"/>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8528265" y="494868"/>
            <a:ext cx="793807" cy="369332"/>
          </a:xfrm>
          <a:prstGeom prst="rect">
            <a:avLst/>
          </a:prstGeom>
          <a:noFill/>
        </p:spPr>
        <p:txBody>
          <a:bodyPr wrap="none" rtlCol="0">
            <a:spAutoFit/>
          </a:bodyPr>
          <a:lstStyle/>
          <a:p>
            <a:r>
              <a:rPr lang="en-GB" b="1" dirty="0">
                <a:latin typeface="+mj-lt"/>
              </a:rPr>
              <a:t>Fig. AK</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2" name="Imagen 1">
            <a:extLst>
              <a:ext uri="{FF2B5EF4-FFF2-40B4-BE49-F238E27FC236}">
                <a16:creationId xmlns:a16="http://schemas.microsoft.com/office/drawing/2014/main" id="{FB297ACE-61F0-4AC9-9795-B3DFD1A034D7}"/>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494868"/>
            <a:ext cx="8093112" cy="6069834"/>
          </a:xfrm>
          <a:prstGeom prst="rect">
            <a:avLst/>
          </a:prstGeom>
        </p:spPr>
      </p:pic>
      <p:sp>
        <p:nvSpPr>
          <p:cNvPr id="5" name="CuadroTexto 4">
            <a:extLst>
              <a:ext uri="{FF2B5EF4-FFF2-40B4-BE49-F238E27FC236}">
                <a16:creationId xmlns:a16="http://schemas.microsoft.com/office/drawing/2014/main" id="{59C4574D-3277-443D-B441-971BBE9E7CA3}"/>
              </a:ext>
            </a:extLst>
          </p:cNvPr>
          <p:cNvSpPr txBox="1"/>
          <p:nvPr/>
        </p:nvSpPr>
        <p:spPr>
          <a:xfrm>
            <a:off x="8528265" y="1188505"/>
            <a:ext cx="3289924" cy="954107"/>
          </a:xfrm>
          <a:prstGeom prst="rect">
            <a:avLst/>
          </a:prstGeom>
          <a:noFill/>
        </p:spPr>
        <p:txBody>
          <a:bodyPr wrap="square" rtlCol="0">
            <a:spAutoFit/>
          </a:bodyPr>
          <a:lstStyle/>
          <a:p>
            <a:pPr algn="just"/>
            <a:r>
              <a:rPr lang="en-GB" sz="1400" dirty="0"/>
              <a:t>Excavation process of the Unit IV preserved under the Travertine Platform 2.</a:t>
            </a:r>
          </a:p>
          <a:p>
            <a:pPr algn="just"/>
            <a:endParaRPr lang="en-GB" sz="1400" dirty="0"/>
          </a:p>
          <a:p>
            <a:pPr algn="just"/>
            <a:r>
              <a:rPr lang="en-GB" sz="1400" dirty="0"/>
              <a:t>Photo 2017</a:t>
            </a:r>
          </a:p>
        </p:txBody>
      </p:sp>
      <p:cxnSp>
        <p:nvCxnSpPr>
          <p:cNvPr id="8" name="Conector recto 7">
            <a:extLst>
              <a:ext uri="{FF2B5EF4-FFF2-40B4-BE49-F238E27FC236}">
                <a16:creationId xmlns:a16="http://schemas.microsoft.com/office/drawing/2014/main" id="{EDBC4A76-6320-45A4-8855-915C7E96212D}"/>
              </a:ext>
            </a:extLst>
          </p:cNvPr>
          <p:cNvCxnSpPr>
            <a:cxnSpLocks/>
          </p:cNvCxnSpPr>
          <p:nvPr/>
        </p:nvCxnSpPr>
        <p:spPr>
          <a:xfrm>
            <a:off x="8609162" y="1030260"/>
            <a:ext cx="3209027"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BAF0D997-977F-463B-8F68-2AD985514F49}"/>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7</a:t>
            </a:fld>
            <a:endParaRPr lang="en-GB" sz="1800" dirty="0">
              <a:latin typeface="+mj-lt"/>
            </a:endParaRPr>
          </a:p>
        </p:txBody>
      </p:sp>
    </p:spTree>
    <p:extLst>
      <p:ext uri="{BB962C8B-B14F-4D97-AF65-F5344CB8AC3E}">
        <p14:creationId xmlns:p14="http://schemas.microsoft.com/office/powerpoint/2010/main" val="3289139080"/>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445903" y="4949481"/>
            <a:ext cx="774571" cy="369332"/>
          </a:xfrm>
          <a:prstGeom prst="rect">
            <a:avLst/>
          </a:prstGeom>
          <a:noFill/>
        </p:spPr>
        <p:txBody>
          <a:bodyPr wrap="none" rtlCol="0">
            <a:spAutoFit/>
          </a:bodyPr>
          <a:lstStyle/>
          <a:p>
            <a:r>
              <a:rPr lang="en-GB" b="1" dirty="0">
                <a:latin typeface="+mj-lt"/>
              </a:rPr>
              <a:t>Fig. AL</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382354" cy="338554"/>
          </a:xfrm>
          <a:prstGeom prst="rect">
            <a:avLst/>
          </a:prstGeom>
          <a:noFill/>
        </p:spPr>
        <p:txBody>
          <a:bodyPr wrap="none" rtlCol="0">
            <a:spAutoFit/>
          </a:bodyPr>
          <a:lstStyle/>
          <a:p>
            <a:r>
              <a:rPr lang="en-GB" sz="1600" b="1" dirty="0">
                <a:latin typeface="+mj-lt"/>
              </a:rPr>
              <a:t>Supporting Information 1 – Excavation of the Unit IV</a:t>
            </a:r>
          </a:p>
        </p:txBody>
      </p:sp>
      <p:pic>
        <p:nvPicPr>
          <p:cNvPr id="4" name="Imagen 3">
            <a:extLst>
              <a:ext uri="{FF2B5EF4-FFF2-40B4-BE49-F238E27FC236}">
                <a16:creationId xmlns:a16="http://schemas.microsoft.com/office/drawing/2014/main" id="{538BB008-A466-432B-88AB-DC4EDAC7F87E}"/>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33365" y="878960"/>
            <a:ext cx="5920841" cy="3932499"/>
          </a:xfrm>
          <a:prstGeom prst="rect">
            <a:avLst/>
          </a:prstGeom>
        </p:spPr>
      </p:pic>
      <p:pic>
        <p:nvPicPr>
          <p:cNvPr id="8" name="Imagen 7" descr="Imagen que contiene suelo, edificio, piedra, interior&#10;&#10;Descripción generada automáticamente">
            <a:extLst>
              <a:ext uri="{FF2B5EF4-FFF2-40B4-BE49-F238E27FC236}">
                <a16:creationId xmlns:a16="http://schemas.microsoft.com/office/drawing/2014/main" id="{55201F6A-5E21-47AB-AD5E-D6D4C62F9E97}"/>
              </a:ext>
            </a:extLst>
          </p:cNvPr>
          <p:cNvPicPr>
            <a:picLocks noChangeAspect="1"/>
          </p:cNvPicPr>
          <p:nvPr/>
        </p:nvPicPr>
        <p:blipFill>
          <a:blip r:embed="rId3" cstate="screen">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a:ext>
            </a:extLst>
          </a:blip>
          <a:stretch>
            <a:fillRect/>
          </a:stretch>
        </p:blipFill>
        <p:spPr>
          <a:xfrm>
            <a:off x="6122643" y="878960"/>
            <a:ext cx="5920841" cy="3932499"/>
          </a:xfrm>
          <a:prstGeom prst="rect">
            <a:avLst/>
          </a:prstGeom>
        </p:spPr>
      </p:pic>
      <p:sp>
        <p:nvSpPr>
          <p:cNvPr id="9" name="CuadroTexto 8">
            <a:extLst>
              <a:ext uri="{FF2B5EF4-FFF2-40B4-BE49-F238E27FC236}">
                <a16:creationId xmlns:a16="http://schemas.microsoft.com/office/drawing/2014/main" id="{99D74BF8-BCF3-477D-9B87-105CBFD01B56}"/>
              </a:ext>
            </a:extLst>
          </p:cNvPr>
          <p:cNvSpPr txBox="1"/>
          <p:nvPr/>
        </p:nvSpPr>
        <p:spPr>
          <a:xfrm>
            <a:off x="134192" y="483102"/>
            <a:ext cx="365806" cy="369332"/>
          </a:xfrm>
          <a:prstGeom prst="rect">
            <a:avLst/>
          </a:prstGeom>
          <a:noFill/>
        </p:spPr>
        <p:txBody>
          <a:bodyPr wrap="none" rtlCol="0">
            <a:spAutoFit/>
          </a:bodyPr>
          <a:lstStyle/>
          <a:p>
            <a:r>
              <a:rPr lang="en-GB" b="1" dirty="0">
                <a:latin typeface="+mj-lt"/>
              </a:rPr>
              <a:t>a)</a:t>
            </a:r>
          </a:p>
        </p:txBody>
      </p:sp>
      <p:sp>
        <p:nvSpPr>
          <p:cNvPr id="10" name="CuadroTexto 9">
            <a:extLst>
              <a:ext uri="{FF2B5EF4-FFF2-40B4-BE49-F238E27FC236}">
                <a16:creationId xmlns:a16="http://schemas.microsoft.com/office/drawing/2014/main" id="{7632FFA2-8DE8-4508-B137-AE5C8CC874D0}"/>
              </a:ext>
            </a:extLst>
          </p:cNvPr>
          <p:cNvSpPr txBox="1"/>
          <p:nvPr/>
        </p:nvSpPr>
        <p:spPr>
          <a:xfrm>
            <a:off x="6147783" y="483102"/>
            <a:ext cx="480108" cy="369332"/>
          </a:xfrm>
          <a:prstGeom prst="rect">
            <a:avLst/>
          </a:prstGeom>
          <a:noFill/>
        </p:spPr>
        <p:txBody>
          <a:bodyPr wrap="square" rtlCol="0">
            <a:spAutoFit/>
          </a:bodyPr>
          <a:lstStyle/>
          <a:p>
            <a:r>
              <a:rPr lang="en-GB" b="1" dirty="0">
                <a:latin typeface="+mj-lt"/>
              </a:rPr>
              <a:t>b)</a:t>
            </a:r>
          </a:p>
        </p:txBody>
      </p:sp>
      <p:sp>
        <p:nvSpPr>
          <p:cNvPr id="11" name="CuadroTexto 10">
            <a:extLst>
              <a:ext uri="{FF2B5EF4-FFF2-40B4-BE49-F238E27FC236}">
                <a16:creationId xmlns:a16="http://schemas.microsoft.com/office/drawing/2014/main" id="{DDC0A09C-820E-4301-8712-B4A148B03DA5}"/>
              </a:ext>
            </a:extLst>
          </p:cNvPr>
          <p:cNvSpPr txBox="1"/>
          <p:nvPr/>
        </p:nvSpPr>
        <p:spPr>
          <a:xfrm>
            <a:off x="445903" y="5507382"/>
            <a:ext cx="10878589" cy="954107"/>
          </a:xfrm>
          <a:prstGeom prst="rect">
            <a:avLst/>
          </a:prstGeom>
          <a:noFill/>
        </p:spPr>
        <p:txBody>
          <a:bodyPr wrap="square" rtlCol="0">
            <a:spAutoFit/>
          </a:bodyPr>
          <a:lstStyle/>
          <a:p>
            <a:pPr algn="just"/>
            <a:r>
              <a:rPr lang="en-GB" sz="1400" dirty="0"/>
              <a:t>Archaeological materials appearing at Unit IV below the Travertine Platform 2. Fig. 38a, Châtelperronian point (Fig. 16.2  of the manuscript). Fig. 38b show a damaged mandible of a neonate </a:t>
            </a:r>
            <a:r>
              <a:rPr lang="en-GB" sz="1400" i="1" dirty="0" err="1"/>
              <a:t>Ursus</a:t>
            </a:r>
            <a:r>
              <a:rPr lang="en-GB" sz="1400" i="1" dirty="0"/>
              <a:t> </a:t>
            </a:r>
            <a:r>
              <a:rPr lang="en-GB" sz="1400" dirty="0" err="1"/>
              <a:t>sp</a:t>
            </a:r>
            <a:r>
              <a:rPr lang="en-GB" sz="1400" dirty="0"/>
              <a:t> and other faunal remains.</a:t>
            </a:r>
          </a:p>
          <a:p>
            <a:pPr algn="just"/>
            <a:endParaRPr lang="en-GB" sz="1400" dirty="0"/>
          </a:p>
          <a:p>
            <a:pPr algn="just"/>
            <a:r>
              <a:rPr lang="en-GB" sz="1400" dirty="0"/>
              <a:t>Photo 2017</a:t>
            </a:r>
          </a:p>
        </p:txBody>
      </p:sp>
      <p:sp>
        <p:nvSpPr>
          <p:cNvPr id="17" name="Marcador de número de diapositiva 1">
            <a:extLst>
              <a:ext uri="{FF2B5EF4-FFF2-40B4-BE49-F238E27FC236}">
                <a16:creationId xmlns:a16="http://schemas.microsoft.com/office/drawing/2014/main" id="{7BEBC3C2-68A3-4550-B043-66B014BD66A1}"/>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8</a:t>
            </a:fld>
            <a:endParaRPr lang="en-GB" sz="1800" dirty="0">
              <a:latin typeface="+mj-lt"/>
            </a:endParaRPr>
          </a:p>
        </p:txBody>
      </p:sp>
      <p:cxnSp>
        <p:nvCxnSpPr>
          <p:cNvPr id="18" name="Conector recto 17">
            <a:extLst>
              <a:ext uri="{FF2B5EF4-FFF2-40B4-BE49-F238E27FC236}">
                <a16:creationId xmlns:a16="http://schemas.microsoft.com/office/drawing/2014/main" id="{744238B8-AABC-4AAA-A6F6-33777CEF7FAE}"/>
              </a:ext>
            </a:extLst>
          </p:cNvPr>
          <p:cNvCxnSpPr>
            <a:cxnSpLocks/>
          </p:cNvCxnSpPr>
          <p:nvPr/>
        </p:nvCxnSpPr>
        <p:spPr>
          <a:xfrm>
            <a:off x="499998" y="5429748"/>
            <a:ext cx="10710194"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917180100"/>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92242" y="563880"/>
            <a:ext cx="870751" cy="369332"/>
          </a:xfrm>
          <a:prstGeom prst="rect">
            <a:avLst/>
          </a:prstGeom>
          <a:noFill/>
        </p:spPr>
        <p:txBody>
          <a:bodyPr wrap="none" rtlCol="0">
            <a:spAutoFit/>
          </a:bodyPr>
          <a:lstStyle/>
          <a:p>
            <a:r>
              <a:rPr lang="en-GB" b="1" dirty="0">
                <a:latin typeface="+mj-lt"/>
              </a:rPr>
              <a:t>Fig. AM</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910319" cy="338554"/>
          </a:xfrm>
          <a:prstGeom prst="rect">
            <a:avLst/>
          </a:prstGeom>
          <a:noFill/>
        </p:spPr>
        <p:txBody>
          <a:bodyPr wrap="none" rtlCol="0">
            <a:spAutoFit/>
          </a:bodyPr>
          <a:lstStyle/>
          <a:p>
            <a:r>
              <a:rPr lang="en-GB" sz="1600" b="1" dirty="0">
                <a:latin typeface="+mj-lt"/>
              </a:rPr>
              <a:t>Supporting Information 1 – Excavation of the lower terrace</a:t>
            </a:r>
          </a:p>
        </p:txBody>
      </p:sp>
      <p:pic>
        <p:nvPicPr>
          <p:cNvPr id="3" name="Imagen 2" descr="Imagen que contiene suelo, exterior, rock, árbol&#10;&#10;Descripción generada automáticamente">
            <a:extLst>
              <a:ext uri="{FF2B5EF4-FFF2-40B4-BE49-F238E27FC236}">
                <a16:creationId xmlns:a16="http://schemas.microsoft.com/office/drawing/2014/main" id="{AD49A6B9-D26B-4748-AFE5-FBE61E71FD39}"/>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09574" y="563880"/>
            <a:ext cx="8840125" cy="5871426"/>
          </a:xfrm>
          <a:prstGeom prst="rect">
            <a:avLst/>
          </a:prstGeom>
        </p:spPr>
      </p:pic>
      <p:sp>
        <p:nvSpPr>
          <p:cNvPr id="8" name="CuadroTexto 7">
            <a:extLst>
              <a:ext uri="{FF2B5EF4-FFF2-40B4-BE49-F238E27FC236}">
                <a16:creationId xmlns:a16="http://schemas.microsoft.com/office/drawing/2014/main" id="{DEB89286-3441-477D-9EAD-981B3F2E55C9}"/>
              </a:ext>
            </a:extLst>
          </p:cNvPr>
          <p:cNvSpPr txBox="1"/>
          <p:nvPr/>
        </p:nvSpPr>
        <p:spPr>
          <a:xfrm>
            <a:off x="9092242" y="1142483"/>
            <a:ext cx="2861632" cy="954107"/>
          </a:xfrm>
          <a:prstGeom prst="rect">
            <a:avLst/>
          </a:prstGeom>
          <a:noFill/>
        </p:spPr>
        <p:txBody>
          <a:bodyPr wrap="square" rtlCol="0">
            <a:spAutoFit/>
          </a:bodyPr>
          <a:lstStyle/>
          <a:p>
            <a:pPr algn="just"/>
            <a:r>
              <a:rPr lang="en-GB" sz="1400" dirty="0"/>
              <a:t>View of the Lower Entrance and the beginning of the terrace’s excavation </a:t>
            </a:r>
          </a:p>
          <a:p>
            <a:pPr algn="just"/>
            <a:endParaRPr lang="en-GB" sz="1400" dirty="0"/>
          </a:p>
          <a:p>
            <a:pPr algn="just"/>
            <a:r>
              <a:rPr lang="en-GB" sz="1400" dirty="0"/>
              <a:t>Photo 2014</a:t>
            </a:r>
          </a:p>
        </p:txBody>
      </p:sp>
      <p:cxnSp>
        <p:nvCxnSpPr>
          <p:cNvPr id="9" name="Conector recto 8">
            <a:extLst>
              <a:ext uri="{FF2B5EF4-FFF2-40B4-BE49-F238E27FC236}">
                <a16:creationId xmlns:a16="http://schemas.microsoft.com/office/drawing/2014/main" id="{6EDD7B0A-E579-4D21-B3D8-41EBDEC4358C}"/>
              </a:ext>
            </a:extLst>
          </p:cNvPr>
          <p:cNvCxnSpPr>
            <a:cxnSpLocks/>
          </p:cNvCxnSpPr>
          <p:nvPr/>
        </p:nvCxnSpPr>
        <p:spPr>
          <a:xfrm>
            <a:off x="9169879" y="1037847"/>
            <a:ext cx="2674189"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1" name="Marcador de número de diapositiva 1">
            <a:extLst>
              <a:ext uri="{FF2B5EF4-FFF2-40B4-BE49-F238E27FC236}">
                <a16:creationId xmlns:a16="http://schemas.microsoft.com/office/drawing/2014/main" id="{AB20E61C-3781-40C5-AF1E-1B9280A4CEBA}"/>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39</a:t>
            </a:fld>
            <a:endParaRPr lang="en-GB" sz="1800" dirty="0">
              <a:latin typeface="+mj-lt"/>
            </a:endParaRPr>
          </a:p>
        </p:txBody>
      </p:sp>
    </p:spTree>
    <p:extLst>
      <p:ext uri="{BB962C8B-B14F-4D97-AF65-F5344CB8AC3E}">
        <p14:creationId xmlns:p14="http://schemas.microsoft.com/office/powerpoint/2010/main" val="8441937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67934" y="563880"/>
            <a:ext cx="689612" cy="369332"/>
          </a:xfrm>
          <a:prstGeom prst="rect">
            <a:avLst/>
          </a:prstGeom>
          <a:noFill/>
        </p:spPr>
        <p:txBody>
          <a:bodyPr wrap="none" rtlCol="0">
            <a:spAutoFit/>
          </a:bodyPr>
          <a:lstStyle/>
          <a:p>
            <a:r>
              <a:rPr lang="en-GB" b="1" dirty="0">
                <a:latin typeface="+mj-lt"/>
              </a:rPr>
              <a:t>Fig. D</a:t>
            </a:r>
          </a:p>
        </p:txBody>
      </p:sp>
      <p:pic>
        <p:nvPicPr>
          <p:cNvPr id="3" name="Imagen 2" descr="Imagen que contiene exterior, suelo, edificio&#10;&#10;Descripción generada automáticamente">
            <a:extLst>
              <a:ext uri="{FF2B5EF4-FFF2-40B4-BE49-F238E27FC236}">
                <a16:creationId xmlns:a16="http://schemas.microsoft.com/office/drawing/2014/main" id="{A14D5CAF-C05F-4C2C-8980-EC3AE1C06621}"/>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563879"/>
            <a:ext cx="8934411" cy="5940433"/>
          </a:xfrm>
          <a:prstGeom prst="rect">
            <a:avLst/>
          </a:prstGeom>
        </p:spPr>
      </p:pic>
      <p:sp>
        <p:nvSpPr>
          <p:cNvPr id="7" name="CuadroTexto 6">
            <a:extLst>
              <a:ext uri="{FF2B5EF4-FFF2-40B4-BE49-F238E27FC236}">
                <a16:creationId xmlns:a16="http://schemas.microsoft.com/office/drawing/2014/main" id="{766ECB2A-8DB9-4799-BB7D-A07CC7D0C2F7}"/>
              </a:ext>
            </a:extLst>
          </p:cNvPr>
          <p:cNvSpPr txBox="1"/>
          <p:nvPr/>
        </p:nvSpPr>
        <p:spPr>
          <a:xfrm>
            <a:off x="0" y="0"/>
            <a:ext cx="5150834" cy="338554"/>
          </a:xfrm>
          <a:prstGeom prst="rect">
            <a:avLst/>
          </a:prstGeom>
          <a:noFill/>
        </p:spPr>
        <p:txBody>
          <a:bodyPr wrap="none" rtlCol="0">
            <a:spAutoFit/>
          </a:bodyPr>
          <a:lstStyle/>
          <a:p>
            <a:r>
              <a:rPr lang="en-GB" sz="1600" b="1" dirty="0">
                <a:latin typeface="+mj-lt"/>
              </a:rPr>
              <a:t>Supporting Information 1 – Excavation of the Holocene Layers</a:t>
            </a:r>
          </a:p>
        </p:txBody>
      </p:sp>
      <p:sp>
        <p:nvSpPr>
          <p:cNvPr id="9" name="CuadroTexto 8">
            <a:extLst>
              <a:ext uri="{FF2B5EF4-FFF2-40B4-BE49-F238E27FC236}">
                <a16:creationId xmlns:a16="http://schemas.microsoft.com/office/drawing/2014/main" id="{013EE160-E546-4ACE-904C-636B94A6056F}"/>
              </a:ext>
            </a:extLst>
          </p:cNvPr>
          <p:cNvSpPr txBox="1"/>
          <p:nvPr/>
        </p:nvSpPr>
        <p:spPr>
          <a:xfrm>
            <a:off x="9167934" y="1223010"/>
            <a:ext cx="2743201" cy="1815882"/>
          </a:xfrm>
          <a:prstGeom prst="rect">
            <a:avLst/>
          </a:prstGeom>
          <a:noFill/>
        </p:spPr>
        <p:txBody>
          <a:bodyPr wrap="square" rtlCol="0">
            <a:spAutoFit/>
          </a:bodyPr>
          <a:lstStyle/>
          <a:p>
            <a:pPr algn="just"/>
            <a:r>
              <a:rPr lang="en-GB" sz="1400" dirty="0"/>
              <a:t>Layer I under excavation.  The top of the sedimentation reaches the travertine slope at the right of the photo. At the left, the SW Gallery is completely full filled by archaeological sediments. </a:t>
            </a:r>
          </a:p>
          <a:p>
            <a:pPr algn="just"/>
            <a:endParaRPr lang="en-GB" sz="1400" dirty="0"/>
          </a:p>
          <a:p>
            <a:pPr algn="just"/>
            <a:r>
              <a:rPr lang="en-GB" sz="1400" dirty="0"/>
              <a:t>Photo 2006</a:t>
            </a:r>
          </a:p>
        </p:txBody>
      </p:sp>
      <p:sp>
        <p:nvSpPr>
          <p:cNvPr id="8" name="Marcador de número de diapositiva 1">
            <a:extLst>
              <a:ext uri="{FF2B5EF4-FFF2-40B4-BE49-F238E27FC236}">
                <a16:creationId xmlns:a16="http://schemas.microsoft.com/office/drawing/2014/main" id="{53051414-886E-40F7-8E69-44C3E4C00C0F}"/>
              </a:ext>
            </a:extLst>
          </p:cNvPr>
          <p:cNvSpPr>
            <a:spLocks noGrp="1"/>
          </p:cNvSpPr>
          <p:nvPr>
            <p:ph type="sldNum" sz="quarter" idx="12"/>
          </p:nvPr>
        </p:nvSpPr>
        <p:spPr>
          <a:xfrm>
            <a:off x="11696697" y="6371729"/>
            <a:ext cx="315806" cy="365125"/>
          </a:xfrm>
        </p:spPr>
        <p:txBody>
          <a:bodyPr/>
          <a:lstStyle/>
          <a:p>
            <a:fld id="{192579BF-C6FD-43AD-A8B9-573B46B983AA}" type="slidenum">
              <a:rPr lang="en-GB" sz="1800" smtClean="0">
                <a:latin typeface="+mj-lt"/>
              </a:rPr>
              <a:t>4</a:t>
            </a:fld>
            <a:endParaRPr lang="en-GB" sz="1800" dirty="0">
              <a:latin typeface="+mj-lt"/>
            </a:endParaRPr>
          </a:p>
        </p:txBody>
      </p:sp>
      <p:cxnSp>
        <p:nvCxnSpPr>
          <p:cNvPr id="10" name="Conector recto 9">
            <a:extLst>
              <a:ext uri="{FF2B5EF4-FFF2-40B4-BE49-F238E27FC236}">
                <a16:creationId xmlns:a16="http://schemas.microsoft.com/office/drawing/2014/main" id="{CFADF02D-D71B-4FC5-9360-E31588B2D927}"/>
              </a:ext>
            </a:extLst>
          </p:cNvPr>
          <p:cNvCxnSpPr>
            <a:cxnSpLocks/>
          </p:cNvCxnSpPr>
          <p:nvPr/>
        </p:nvCxnSpPr>
        <p:spPr>
          <a:xfrm>
            <a:off x="9256469" y="1064188"/>
            <a:ext cx="2517863"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cxnSp>
        <p:nvCxnSpPr>
          <p:cNvPr id="12" name="Conector recto de flecha 11">
            <a:extLst>
              <a:ext uri="{FF2B5EF4-FFF2-40B4-BE49-F238E27FC236}">
                <a16:creationId xmlns:a16="http://schemas.microsoft.com/office/drawing/2014/main" id="{08C949C9-5643-4267-8F9C-60B9F8B67413}"/>
              </a:ext>
            </a:extLst>
          </p:cNvPr>
          <p:cNvCxnSpPr>
            <a:cxnSpLocks/>
          </p:cNvCxnSpPr>
          <p:nvPr/>
        </p:nvCxnSpPr>
        <p:spPr>
          <a:xfrm flipH="1">
            <a:off x="2398290" y="2372490"/>
            <a:ext cx="1026397" cy="0"/>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sp>
        <p:nvSpPr>
          <p:cNvPr id="15" name="CuadroTexto 14">
            <a:extLst>
              <a:ext uri="{FF2B5EF4-FFF2-40B4-BE49-F238E27FC236}">
                <a16:creationId xmlns:a16="http://schemas.microsoft.com/office/drawing/2014/main" id="{6F1964DC-D81F-4BD8-9B12-AEEE4A23F1CC}"/>
              </a:ext>
            </a:extLst>
          </p:cNvPr>
          <p:cNvSpPr txBox="1"/>
          <p:nvPr/>
        </p:nvSpPr>
        <p:spPr>
          <a:xfrm>
            <a:off x="2336416" y="2064713"/>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SW gallery</a:t>
            </a:r>
          </a:p>
        </p:txBody>
      </p:sp>
      <p:sp>
        <p:nvSpPr>
          <p:cNvPr id="16" name="Forma libre: forma 15">
            <a:extLst>
              <a:ext uri="{FF2B5EF4-FFF2-40B4-BE49-F238E27FC236}">
                <a16:creationId xmlns:a16="http://schemas.microsoft.com/office/drawing/2014/main" id="{2EA3C95D-3C18-4358-A224-75DED656F4BF}"/>
              </a:ext>
            </a:extLst>
          </p:cNvPr>
          <p:cNvSpPr/>
          <p:nvPr/>
        </p:nvSpPr>
        <p:spPr>
          <a:xfrm>
            <a:off x="6193465" y="1770321"/>
            <a:ext cx="2562447" cy="882502"/>
          </a:xfrm>
          <a:custGeom>
            <a:avLst/>
            <a:gdLst>
              <a:gd name="connsiteX0" fmla="*/ 0 w 2562447"/>
              <a:gd name="connsiteY0" fmla="*/ 233916 h 882502"/>
              <a:gd name="connsiteX1" fmla="*/ 74428 w 2562447"/>
              <a:gd name="connsiteY1" fmla="*/ 329609 h 882502"/>
              <a:gd name="connsiteX2" fmla="*/ 143540 w 2562447"/>
              <a:gd name="connsiteY2" fmla="*/ 457200 h 882502"/>
              <a:gd name="connsiteX3" fmla="*/ 281763 w 2562447"/>
              <a:gd name="connsiteY3" fmla="*/ 536944 h 882502"/>
              <a:gd name="connsiteX4" fmla="*/ 451884 w 2562447"/>
              <a:gd name="connsiteY4" fmla="*/ 590107 h 882502"/>
              <a:gd name="connsiteX5" fmla="*/ 590107 w 2562447"/>
              <a:gd name="connsiteY5" fmla="*/ 627321 h 882502"/>
              <a:gd name="connsiteX6" fmla="*/ 712382 w 2562447"/>
              <a:gd name="connsiteY6" fmla="*/ 669851 h 882502"/>
              <a:gd name="connsiteX7" fmla="*/ 792126 w 2562447"/>
              <a:gd name="connsiteY7" fmla="*/ 723014 h 882502"/>
              <a:gd name="connsiteX8" fmla="*/ 829340 w 2562447"/>
              <a:gd name="connsiteY8" fmla="*/ 738963 h 882502"/>
              <a:gd name="connsiteX9" fmla="*/ 877186 w 2562447"/>
              <a:gd name="connsiteY9" fmla="*/ 717698 h 882502"/>
              <a:gd name="connsiteX10" fmla="*/ 940982 w 2562447"/>
              <a:gd name="connsiteY10" fmla="*/ 685800 h 882502"/>
              <a:gd name="connsiteX11" fmla="*/ 1010093 w 2562447"/>
              <a:gd name="connsiteY11" fmla="*/ 685800 h 882502"/>
              <a:gd name="connsiteX12" fmla="*/ 1057940 w 2562447"/>
              <a:gd name="connsiteY12" fmla="*/ 685800 h 882502"/>
              <a:gd name="connsiteX13" fmla="*/ 1137684 w 2562447"/>
              <a:gd name="connsiteY13" fmla="*/ 728330 h 882502"/>
              <a:gd name="connsiteX14" fmla="*/ 1180214 w 2562447"/>
              <a:gd name="connsiteY14" fmla="*/ 765544 h 882502"/>
              <a:gd name="connsiteX15" fmla="*/ 1275907 w 2562447"/>
              <a:gd name="connsiteY15" fmla="*/ 802758 h 882502"/>
              <a:gd name="connsiteX16" fmla="*/ 1360968 w 2562447"/>
              <a:gd name="connsiteY16" fmla="*/ 834656 h 882502"/>
              <a:gd name="connsiteX17" fmla="*/ 1488558 w 2562447"/>
              <a:gd name="connsiteY17" fmla="*/ 855921 h 882502"/>
              <a:gd name="connsiteX18" fmla="*/ 1663995 w 2562447"/>
              <a:gd name="connsiteY18" fmla="*/ 882502 h 882502"/>
              <a:gd name="connsiteX19" fmla="*/ 1780954 w 2562447"/>
              <a:gd name="connsiteY19" fmla="*/ 882502 h 882502"/>
              <a:gd name="connsiteX20" fmla="*/ 1823484 w 2562447"/>
              <a:gd name="connsiteY20" fmla="*/ 866553 h 882502"/>
              <a:gd name="connsiteX21" fmla="*/ 1850065 w 2562447"/>
              <a:gd name="connsiteY21" fmla="*/ 792126 h 882502"/>
              <a:gd name="connsiteX22" fmla="*/ 1871330 w 2562447"/>
              <a:gd name="connsiteY22" fmla="*/ 733646 h 882502"/>
              <a:gd name="connsiteX23" fmla="*/ 1881963 w 2562447"/>
              <a:gd name="connsiteY23" fmla="*/ 669851 h 882502"/>
              <a:gd name="connsiteX24" fmla="*/ 1892595 w 2562447"/>
              <a:gd name="connsiteY24" fmla="*/ 590107 h 882502"/>
              <a:gd name="connsiteX25" fmla="*/ 1908544 w 2562447"/>
              <a:gd name="connsiteY25" fmla="*/ 499730 h 882502"/>
              <a:gd name="connsiteX26" fmla="*/ 1940442 w 2562447"/>
              <a:gd name="connsiteY26" fmla="*/ 419986 h 882502"/>
              <a:gd name="connsiteX27" fmla="*/ 1977656 w 2562447"/>
              <a:gd name="connsiteY27" fmla="*/ 356191 h 882502"/>
              <a:gd name="connsiteX28" fmla="*/ 2036135 w 2562447"/>
              <a:gd name="connsiteY28" fmla="*/ 308344 h 882502"/>
              <a:gd name="connsiteX29" fmla="*/ 2105247 w 2562447"/>
              <a:gd name="connsiteY29" fmla="*/ 265814 h 882502"/>
              <a:gd name="connsiteX30" fmla="*/ 2211572 w 2562447"/>
              <a:gd name="connsiteY30" fmla="*/ 217967 h 882502"/>
              <a:gd name="connsiteX31" fmla="*/ 2264735 w 2562447"/>
              <a:gd name="connsiteY31" fmla="*/ 170121 h 882502"/>
              <a:gd name="connsiteX32" fmla="*/ 2323214 w 2562447"/>
              <a:gd name="connsiteY32" fmla="*/ 127591 h 882502"/>
              <a:gd name="connsiteX33" fmla="*/ 2402958 w 2562447"/>
              <a:gd name="connsiteY33" fmla="*/ 95693 h 882502"/>
              <a:gd name="connsiteX34" fmla="*/ 2493335 w 2562447"/>
              <a:gd name="connsiteY34" fmla="*/ 37214 h 882502"/>
              <a:gd name="connsiteX35" fmla="*/ 2562447 w 2562447"/>
              <a:gd name="connsiteY35" fmla="*/ 0 h 88250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2562447" h="882502">
                <a:moveTo>
                  <a:pt x="0" y="233916"/>
                </a:moveTo>
                <a:lnTo>
                  <a:pt x="74428" y="329609"/>
                </a:lnTo>
                <a:lnTo>
                  <a:pt x="143540" y="457200"/>
                </a:lnTo>
                <a:lnTo>
                  <a:pt x="281763" y="536944"/>
                </a:lnTo>
                <a:lnTo>
                  <a:pt x="451884" y="590107"/>
                </a:lnTo>
                <a:lnTo>
                  <a:pt x="590107" y="627321"/>
                </a:lnTo>
                <a:lnTo>
                  <a:pt x="712382" y="669851"/>
                </a:lnTo>
                <a:lnTo>
                  <a:pt x="792126" y="723014"/>
                </a:lnTo>
                <a:lnTo>
                  <a:pt x="829340" y="738963"/>
                </a:lnTo>
                <a:lnTo>
                  <a:pt x="877186" y="717698"/>
                </a:lnTo>
                <a:lnTo>
                  <a:pt x="940982" y="685800"/>
                </a:lnTo>
                <a:lnTo>
                  <a:pt x="1010093" y="685800"/>
                </a:lnTo>
                <a:lnTo>
                  <a:pt x="1057940" y="685800"/>
                </a:lnTo>
                <a:lnTo>
                  <a:pt x="1137684" y="728330"/>
                </a:lnTo>
                <a:lnTo>
                  <a:pt x="1180214" y="765544"/>
                </a:lnTo>
                <a:lnTo>
                  <a:pt x="1275907" y="802758"/>
                </a:lnTo>
                <a:lnTo>
                  <a:pt x="1360968" y="834656"/>
                </a:lnTo>
                <a:lnTo>
                  <a:pt x="1488558" y="855921"/>
                </a:lnTo>
                <a:lnTo>
                  <a:pt x="1663995" y="882502"/>
                </a:lnTo>
                <a:lnTo>
                  <a:pt x="1780954" y="882502"/>
                </a:lnTo>
                <a:lnTo>
                  <a:pt x="1823484" y="866553"/>
                </a:lnTo>
                <a:lnTo>
                  <a:pt x="1850065" y="792126"/>
                </a:lnTo>
                <a:lnTo>
                  <a:pt x="1871330" y="733646"/>
                </a:lnTo>
                <a:lnTo>
                  <a:pt x="1881963" y="669851"/>
                </a:lnTo>
                <a:lnTo>
                  <a:pt x="1892595" y="590107"/>
                </a:lnTo>
                <a:lnTo>
                  <a:pt x="1908544" y="499730"/>
                </a:lnTo>
                <a:lnTo>
                  <a:pt x="1940442" y="419986"/>
                </a:lnTo>
                <a:lnTo>
                  <a:pt x="1977656" y="356191"/>
                </a:lnTo>
                <a:lnTo>
                  <a:pt x="2036135" y="308344"/>
                </a:lnTo>
                <a:lnTo>
                  <a:pt x="2105247" y="265814"/>
                </a:lnTo>
                <a:lnTo>
                  <a:pt x="2211572" y="217967"/>
                </a:lnTo>
                <a:lnTo>
                  <a:pt x="2264735" y="170121"/>
                </a:lnTo>
                <a:lnTo>
                  <a:pt x="2323214" y="127591"/>
                </a:lnTo>
                <a:lnTo>
                  <a:pt x="2402958" y="95693"/>
                </a:lnTo>
                <a:lnTo>
                  <a:pt x="2493335" y="37214"/>
                </a:lnTo>
                <a:lnTo>
                  <a:pt x="2562447" y="0"/>
                </a:lnTo>
              </a:path>
            </a:pathLst>
          </a:custGeom>
          <a:noFill/>
          <a:ln>
            <a:solidFill>
              <a:schemeClr val="bg1"/>
            </a:solidFill>
            <a:prstDash val="dash"/>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effectLst>
                <a:outerShdw blurRad="38100" dist="38100" dir="2700000" algn="tl">
                  <a:srgbClr val="000000">
                    <a:alpha val="43137"/>
                  </a:srgbClr>
                </a:outerShdw>
              </a:effectLst>
            </a:endParaRPr>
          </a:p>
        </p:txBody>
      </p:sp>
      <p:sp>
        <p:nvSpPr>
          <p:cNvPr id="17" name="Forma libre: forma 16">
            <a:extLst>
              <a:ext uri="{FF2B5EF4-FFF2-40B4-BE49-F238E27FC236}">
                <a16:creationId xmlns:a16="http://schemas.microsoft.com/office/drawing/2014/main" id="{9E69EB91-F6B1-45FD-BF18-4B6B63788FFD}"/>
              </a:ext>
            </a:extLst>
          </p:cNvPr>
          <p:cNvSpPr/>
          <p:nvPr/>
        </p:nvSpPr>
        <p:spPr>
          <a:xfrm>
            <a:off x="5380075" y="4747437"/>
            <a:ext cx="1706526" cy="520996"/>
          </a:xfrm>
          <a:custGeom>
            <a:avLst/>
            <a:gdLst>
              <a:gd name="connsiteX0" fmla="*/ 0 w 1706526"/>
              <a:gd name="connsiteY0" fmla="*/ 520996 h 520996"/>
              <a:gd name="connsiteX1" fmla="*/ 122275 w 1706526"/>
              <a:gd name="connsiteY1" fmla="*/ 451884 h 520996"/>
              <a:gd name="connsiteX2" fmla="*/ 228600 w 1706526"/>
              <a:gd name="connsiteY2" fmla="*/ 414670 h 520996"/>
              <a:gd name="connsiteX3" fmla="*/ 372140 w 1706526"/>
              <a:gd name="connsiteY3" fmla="*/ 340242 h 520996"/>
              <a:gd name="connsiteX4" fmla="*/ 515679 w 1706526"/>
              <a:gd name="connsiteY4" fmla="*/ 265814 h 520996"/>
              <a:gd name="connsiteX5" fmla="*/ 685800 w 1706526"/>
              <a:gd name="connsiteY5" fmla="*/ 202019 h 520996"/>
              <a:gd name="connsiteX6" fmla="*/ 802758 w 1706526"/>
              <a:gd name="connsiteY6" fmla="*/ 148856 h 520996"/>
              <a:gd name="connsiteX7" fmla="*/ 898451 w 1706526"/>
              <a:gd name="connsiteY7" fmla="*/ 74428 h 520996"/>
              <a:gd name="connsiteX8" fmla="*/ 1026042 w 1706526"/>
              <a:gd name="connsiteY8" fmla="*/ 10633 h 520996"/>
              <a:gd name="connsiteX9" fmla="*/ 1158949 w 1706526"/>
              <a:gd name="connsiteY9" fmla="*/ 0 h 520996"/>
              <a:gd name="connsiteX10" fmla="*/ 1238693 w 1706526"/>
              <a:gd name="connsiteY10" fmla="*/ 15949 h 520996"/>
              <a:gd name="connsiteX11" fmla="*/ 1323754 w 1706526"/>
              <a:gd name="connsiteY11" fmla="*/ 90377 h 520996"/>
              <a:gd name="connsiteX12" fmla="*/ 1392865 w 1706526"/>
              <a:gd name="connsiteY12" fmla="*/ 132907 h 520996"/>
              <a:gd name="connsiteX13" fmla="*/ 1483242 w 1706526"/>
              <a:gd name="connsiteY13" fmla="*/ 175438 h 520996"/>
              <a:gd name="connsiteX14" fmla="*/ 1552354 w 1706526"/>
              <a:gd name="connsiteY14" fmla="*/ 228600 h 520996"/>
              <a:gd name="connsiteX15" fmla="*/ 1616149 w 1706526"/>
              <a:gd name="connsiteY15" fmla="*/ 271131 h 520996"/>
              <a:gd name="connsiteX16" fmla="*/ 1669312 w 1706526"/>
              <a:gd name="connsiteY16" fmla="*/ 324294 h 520996"/>
              <a:gd name="connsiteX17" fmla="*/ 1701210 w 1706526"/>
              <a:gd name="connsiteY17" fmla="*/ 356191 h 520996"/>
              <a:gd name="connsiteX18" fmla="*/ 1706526 w 1706526"/>
              <a:gd name="connsiteY18" fmla="*/ 361507 h 5209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1706526" h="520996">
                <a:moveTo>
                  <a:pt x="0" y="520996"/>
                </a:moveTo>
                <a:lnTo>
                  <a:pt x="122275" y="451884"/>
                </a:lnTo>
                <a:lnTo>
                  <a:pt x="228600" y="414670"/>
                </a:lnTo>
                <a:lnTo>
                  <a:pt x="372140" y="340242"/>
                </a:lnTo>
                <a:lnTo>
                  <a:pt x="515679" y="265814"/>
                </a:lnTo>
                <a:lnTo>
                  <a:pt x="685800" y="202019"/>
                </a:lnTo>
                <a:lnTo>
                  <a:pt x="802758" y="148856"/>
                </a:lnTo>
                <a:lnTo>
                  <a:pt x="898451" y="74428"/>
                </a:lnTo>
                <a:lnTo>
                  <a:pt x="1026042" y="10633"/>
                </a:lnTo>
                <a:lnTo>
                  <a:pt x="1158949" y="0"/>
                </a:lnTo>
                <a:lnTo>
                  <a:pt x="1238693" y="15949"/>
                </a:lnTo>
                <a:lnTo>
                  <a:pt x="1323754" y="90377"/>
                </a:lnTo>
                <a:lnTo>
                  <a:pt x="1392865" y="132907"/>
                </a:lnTo>
                <a:lnTo>
                  <a:pt x="1483242" y="175438"/>
                </a:lnTo>
                <a:lnTo>
                  <a:pt x="1552354" y="228600"/>
                </a:lnTo>
                <a:lnTo>
                  <a:pt x="1616149" y="271131"/>
                </a:lnTo>
                <a:lnTo>
                  <a:pt x="1669312" y="324294"/>
                </a:lnTo>
                <a:lnTo>
                  <a:pt x="1701210" y="356191"/>
                </a:lnTo>
                <a:lnTo>
                  <a:pt x="1706526" y="361507"/>
                </a:lnTo>
              </a:path>
            </a:pathLst>
          </a:custGeom>
          <a:noFill/>
          <a:ln>
            <a:solidFill>
              <a:schemeClr val="bg1"/>
            </a:solidFill>
            <a:prstDash val="dash"/>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CuadroTexto 17">
            <a:extLst>
              <a:ext uri="{FF2B5EF4-FFF2-40B4-BE49-F238E27FC236}">
                <a16:creationId xmlns:a16="http://schemas.microsoft.com/office/drawing/2014/main" id="{0200BBB4-95F2-4B6B-BD78-6D2EA05894F3}"/>
              </a:ext>
            </a:extLst>
          </p:cNvPr>
          <p:cNvSpPr txBox="1"/>
          <p:nvPr/>
        </p:nvSpPr>
        <p:spPr>
          <a:xfrm>
            <a:off x="7705838" y="1334057"/>
            <a:ext cx="1150143" cy="461665"/>
          </a:xfrm>
          <a:prstGeom prst="rect">
            <a:avLst/>
          </a:prstGeom>
          <a:noFill/>
        </p:spPr>
        <p:txBody>
          <a:bodyPr wrap="square" rtlCol="0">
            <a:spAutoFit/>
          </a:bodyPr>
          <a:lstStyle/>
          <a:p>
            <a:pPr algn="r"/>
            <a:r>
              <a:rPr lang="en-GB" sz="1200" dirty="0">
                <a:solidFill>
                  <a:schemeClr val="bg1">
                    <a:lumMod val="95000"/>
                  </a:schemeClr>
                </a:solidFill>
                <a:effectLst>
                  <a:outerShdw blurRad="38100" dist="38100" dir="2700000" algn="tl">
                    <a:srgbClr val="000000">
                      <a:alpha val="43137"/>
                    </a:srgbClr>
                  </a:outerShdw>
                </a:effectLst>
                <a:latin typeface="+mj-lt"/>
              </a:rPr>
              <a:t>Travertine</a:t>
            </a:r>
          </a:p>
          <a:p>
            <a:pPr algn="r"/>
            <a:r>
              <a:rPr lang="en-GB" sz="1200" dirty="0">
                <a:solidFill>
                  <a:schemeClr val="bg1">
                    <a:lumMod val="95000"/>
                  </a:schemeClr>
                </a:solidFill>
                <a:effectLst>
                  <a:outerShdw blurRad="38100" dist="38100" dir="2700000" algn="tl">
                    <a:srgbClr val="000000">
                      <a:alpha val="43137"/>
                    </a:srgbClr>
                  </a:outerShdw>
                </a:effectLst>
                <a:latin typeface="+mj-lt"/>
              </a:rPr>
              <a:t>slope</a:t>
            </a:r>
          </a:p>
        </p:txBody>
      </p:sp>
      <p:sp>
        <p:nvSpPr>
          <p:cNvPr id="19" name="CuadroTexto 18">
            <a:extLst>
              <a:ext uri="{FF2B5EF4-FFF2-40B4-BE49-F238E27FC236}">
                <a16:creationId xmlns:a16="http://schemas.microsoft.com/office/drawing/2014/main" id="{6598A243-70B5-458C-8419-B147E12528D0}"/>
              </a:ext>
            </a:extLst>
          </p:cNvPr>
          <p:cNvSpPr txBox="1"/>
          <p:nvPr/>
        </p:nvSpPr>
        <p:spPr>
          <a:xfrm>
            <a:off x="5268472" y="5262925"/>
            <a:ext cx="1150143" cy="461665"/>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Travertine</a:t>
            </a:r>
          </a:p>
          <a:p>
            <a:r>
              <a:rPr lang="en-GB" sz="1200" dirty="0">
                <a:solidFill>
                  <a:schemeClr val="bg1">
                    <a:lumMod val="95000"/>
                  </a:schemeClr>
                </a:solidFill>
                <a:effectLst>
                  <a:outerShdw blurRad="38100" dist="38100" dir="2700000" algn="tl">
                    <a:srgbClr val="000000">
                      <a:alpha val="43137"/>
                    </a:srgbClr>
                  </a:outerShdw>
                </a:effectLst>
                <a:latin typeface="+mj-lt"/>
              </a:rPr>
              <a:t>platform 2</a:t>
            </a:r>
          </a:p>
        </p:txBody>
      </p:sp>
    </p:spTree>
    <p:extLst>
      <p:ext uri="{BB962C8B-B14F-4D97-AF65-F5344CB8AC3E}">
        <p14:creationId xmlns:p14="http://schemas.microsoft.com/office/powerpoint/2010/main" val="4038468760"/>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35374" y="563880"/>
            <a:ext cx="824265" cy="369332"/>
          </a:xfrm>
          <a:prstGeom prst="rect">
            <a:avLst/>
          </a:prstGeom>
          <a:noFill/>
        </p:spPr>
        <p:txBody>
          <a:bodyPr wrap="none" rtlCol="0">
            <a:spAutoFit/>
          </a:bodyPr>
          <a:lstStyle/>
          <a:p>
            <a:r>
              <a:rPr lang="en-GB" b="1" dirty="0">
                <a:latin typeface="+mj-lt"/>
              </a:rPr>
              <a:t>Fig. AN</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910319" cy="338554"/>
          </a:xfrm>
          <a:prstGeom prst="rect">
            <a:avLst/>
          </a:prstGeom>
          <a:noFill/>
        </p:spPr>
        <p:txBody>
          <a:bodyPr wrap="none" rtlCol="0">
            <a:spAutoFit/>
          </a:bodyPr>
          <a:lstStyle/>
          <a:p>
            <a:r>
              <a:rPr lang="en-GB" sz="1600" b="1" dirty="0">
                <a:latin typeface="+mj-lt"/>
              </a:rPr>
              <a:t>Supporting Information 1 – Excavation of the lower terrace</a:t>
            </a:r>
          </a:p>
        </p:txBody>
      </p:sp>
      <p:pic>
        <p:nvPicPr>
          <p:cNvPr id="4" name="Imagen 3" descr="Imagen que contiene suelo, exterior, rock, naturaleza&#10;&#10;Descripción generada automáticamente">
            <a:extLst>
              <a:ext uri="{FF2B5EF4-FFF2-40B4-BE49-F238E27FC236}">
                <a16:creationId xmlns:a16="http://schemas.microsoft.com/office/drawing/2014/main" id="{BE8A8B02-B08D-4F25-9C67-63477ECDCF59}"/>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02484" y="563880"/>
            <a:ext cx="8892075" cy="5905931"/>
          </a:xfrm>
          <a:prstGeom prst="rect">
            <a:avLst/>
          </a:prstGeom>
        </p:spPr>
      </p:pic>
      <p:sp>
        <p:nvSpPr>
          <p:cNvPr id="8" name="CuadroTexto 7">
            <a:extLst>
              <a:ext uri="{FF2B5EF4-FFF2-40B4-BE49-F238E27FC236}">
                <a16:creationId xmlns:a16="http://schemas.microsoft.com/office/drawing/2014/main" id="{5AB50D19-F9FC-44D0-B4C9-DB5119881808}"/>
              </a:ext>
            </a:extLst>
          </p:cNvPr>
          <p:cNvSpPr txBox="1"/>
          <p:nvPr/>
        </p:nvSpPr>
        <p:spPr>
          <a:xfrm>
            <a:off x="9135374" y="1136851"/>
            <a:ext cx="2818500" cy="1384995"/>
          </a:xfrm>
          <a:prstGeom prst="rect">
            <a:avLst/>
          </a:prstGeom>
          <a:noFill/>
        </p:spPr>
        <p:txBody>
          <a:bodyPr wrap="square" rtlCol="0">
            <a:spAutoFit/>
          </a:bodyPr>
          <a:lstStyle/>
          <a:p>
            <a:pPr algn="just"/>
            <a:r>
              <a:rPr lang="en-GB" sz="1400" dirty="0"/>
              <a:t>View of the terrace’s excavation after the removal of the superficial organic sediments and delimiting the carbonated sedimentary layer.</a:t>
            </a:r>
          </a:p>
          <a:p>
            <a:pPr algn="just"/>
            <a:endParaRPr lang="en-GB" sz="1400" dirty="0"/>
          </a:p>
          <a:p>
            <a:pPr algn="just"/>
            <a:r>
              <a:rPr lang="en-GB" sz="1400" dirty="0"/>
              <a:t>Photo 2014</a:t>
            </a:r>
          </a:p>
        </p:txBody>
      </p:sp>
      <p:sp>
        <p:nvSpPr>
          <p:cNvPr id="9" name="Marcador de número de diapositiva 1">
            <a:extLst>
              <a:ext uri="{FF2B5EF4-FFF2-40B4-BE49-F238E27FC236}">
                <a16:creationId xmlns:a16="http://schemas.microsoft.com/office/drawing/2014/main" id="{12CB2B2C-94CB-49AB-AB82-D5C5F1D98DD3}"/>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40</a:t>
            </a:fld>
            <a:endParaRPr lang="en-GB" sz="1800" dirty="0">
              <a:latin typeface="+mj-lt"/>
            </a:endParaRPr>
          </a:p>
        </p:txBody>
      </p:sp>
      <p:cxnSp>
        <p:nvCxnSpPr>
          <p:cNvPr id="10" name="Conector recto 9">
            <a:extLst>
              <a:ext uri="{FF2B5EF4-FFF2-40B4-BE49-F238E27FC236}">
                <a16:creationId xmlns:a16="http://schemas.microsoft.com/office/drawing/2014/main" id="{28B23D9E-DE05-4FCA-8270-3E76EDCE8EF9}"/>
              </a:ext>
            </a:extLst>
          </p:cNvPr>
          <p:cNvCxnSpPr>
            <a:cxnSpLocks/>
          </p:cNvCxnSpPr>
          <p:nvPr/>
        </p:nvCxnSpPr>
        <p:spPr>
          <a:xfrm>
            <a:off x="9169879" y="1037847"/>
            <a:ext cx="2674189"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3" name="Forma libre: forma 2">
            <a:extLst>
              <a:ext uri="{FF2B5EF4-FFF2-40B4-BE49-F238E27FC236}">
                <a16:creationId xmlns:a16="http://schemas.microsoft.com/office/drawing/2014/main" id="{015C60F5-91B5-4B9A-B733-C2341AD2610D}"/>
              </a:ext>
            </a:extLst>
          </p:cNvPr>
          <p:cNvSpPr/>
          <p:nvPr/>
        </p:nvSpPr>
        <p:spPr>
          <a:xfrm>
            <a:off x="1956021" y="2242268"/>
            <a:ext cx="5239909" cy="739471"/>
          </a:xfrm>
          <a:custGeom>
            <a:avLst/>
            <a:gdLst>
              <a:gd name="connsiteX0" fmla="*/ 0 w 5239909"/>
              <a:gd name="connsiteY0" fmla="*/ 739471 h 739471"/>
              <a:gd name="connsiteX1" fmla="*/ 246490 w 5239909"/>
              <a:gd name="connsiteY1" fmla="*/ 659958 h 739471"/>
              <a:gd name="connsiteX2" fmla="*/ 532737 w 5239909"/>
              <a:gd name="connsiteY2" fmla="*/ 620202 h 739471"/>
              <a:gd name="connsiteX3" fmla="*/ 755374 w 5239909"/>
              <a:gd name="connsiteY3" fmla="*/ 612250 h 739471"/>
              <a:gd name="connsiteX4" fmla="*/ 1025718 w 5239909"/>
              <a:gd name="connsiteY4" fmla="*/ 604299 h 739471"/>
              <a:gd name="connsiteX5" fmla="*/ 1311965 w 5239909"/>
              <a:gd name="connsiteY5" fmla="*/ 524786 h 739471"/>
              <a:gd name="connsiteX6" fmla="*/ 1542553 w 5239909"/>
              <a:gd name="connsiteY6" fmla="*/ 477078 h 739471"/>
              <a:gd name="connsiteX7" fmla="*/ 1685676 w 5239909"/>
              <a:gd name="connsiteY7" fmla="*/ 469127 h 739471"/>
              <a:gd name="connsiteX8" fmla="*/ 1860605 w 5239909"/>
              <a:gd name="connsiteY8" fmla="*/ 469127 h 739471"/>
              <a:gd name="connsiteX9" fmla="*/ 2146852 w 5239909"/>
              <a:gd name="connsiteY9" fmla="*/ 429370 h 739471"/>
              <a:gd name="connsiteX10" fmla="*/ 2305878 w 5239909"/>
              <a:gd name="connsiteY10" fmla="*/ 365760 h 739471"/>
              <a:gd name="connsiteX11" fmla="*/ 2496709 w 5239909"/>
              <a:gd name="connsiteY11" fmla="*/ 278295 h 739471"/>
              <a:gd name="connsiteX12" fmla="*/ 2639833 w 5239909"/>
              <a:gd name="connsiteY12" fmla="*/ 270344 h 739471"/>
              <a:gd name="connsiteX13" fmla="*/ 2854518 w 5239909"/>
              <a:gd name="connsiteY13" fmla="*/ 278295 h 739471"/>
              <a:gd name="connsiteX14" fmla="*/ 3037398 w 5239909"/>
              <a:gd name="connsiteY14" fmla="*/ 278295 h 739471"/>
              <a:gd name="connsiteX15" fmla="*/ 3260035 w 5239909"/>
              <a:gd name="connsiteY15" fmla="*/ 214685 h 739471"/>
              <a:gd name="connsiteX16" fmla="*/ 3570136 w 5239909"/>
              <a:gd name="connsiteY16" fmla="*/ 159026 h 739471"/>
              <a:gd name="connsiteX17" fmla="*/ 3657600 w 5239909"/>
              <a:gd name="connsiteY17" fmla="*/ 151075 h 739471"/>
              <a:gd name="connsiteX18" fmla="*/ 3912042 w 5239909"/>
              <a:gd name="connsiteY18" fmla="*/ 143123 h 739471"/>
              <a:gd name="connsiteX19" fmla="*/ 4063116 w 5239909"/>
              <a:gd name="connsiteY19" fmla="*/ 47708 h 739471"/>
              <a:gd name="connsiteX20" fmla="*/ 4206240 w 5239909"/>
              <a:gd name="connsiteY20" fmla="*/ 0 h 739471"/>
              <a:gd name="connsiteX21" fmla="*/ 4397071 w 5239909"/>
              <a:gd name="connsiteY21" fmla="*/ 0 h 739471"/>
              <a:gd name="connsiteX22" fmla="*/ 4444779 w 5239909"/>
              <a:gd name="connsiteY22" fmla="*/ 23854 h 739471"/>
              <a:gd name="connsiteX23" fmla="*/ 4516341 w 5239909"/>
              <a:gd name="connsiteY23" fmla="*/ 103367 h 739471"/>
              <a:gd name="connsiteX24" fmla="*/ 4627659 w 5239909"/>
              <a:gd name="connsiteY24" fmla="*/ 198782 h 739471"/>
              <a:gd name="connsiteX25" fmla="*/ 4762831 w 5239909"/>
              <a:gd name="connsiteY25" fmla="*/ 222636 h 739471"/>
              <a:gd name="connsiteX26" fmla="*/ 5009322 w 5239909"/>
              <a:gd name="connsiteY26" fmla="*/ 206734 h 739471"/>
              <a:gd name="connsiteX27" fmla="*/ 5112689 w 5239909"/>
              <a:gd name="connsiteY27" fmla="*/ 190831 h 739471"/>
              <a:gd name="connsiteX28" fmla="*/ 5239909 w 5239909"/>
              <a:gd name="connsiteY28" fmla="*/ 143123 h 73947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5239909" h="739471">
                <a:moveTo>
                  <a:pt x="0" y="739471"/>
                </a:moveTo>
                <a:lnTo>
                  <a:pt x="246490" y="659958"/>
                </a:lnTo>
                <a:lnTo>
                  <a:pt x="532737" y="620202"/>
                </a:lnTo>
                <a:lnTo>
                  <a:pt x="755374" y="612250"/>
                </a:lnTo>
                <a:lnTo>
                  <a:pt x="1025718" y="604299"/>
                </a:lnTo>
                <a:lnTo>
                  <a:pt x="1311965" y="524786"/>
                </a:lnTo>
                <a:lnTo>
                  <a:pt x="1542553" y="477078"/>
                </a:lnTo>
                <a:lnTo>
                  <a:pt x="1685676" y="469127"/>
                </a:lnTo>
                <a:lnTo>
                  <a:pt x="1860605" y="469127"/>
                </a:lnTo>
                <a:lnTo>
                  <a:pt x="2146852" y="429370"/>
                </a:lnTo>
                <a:lnTo>
                  <a:pt x="2305878" y="365760"/>
                </a:lnTo>
                <a:lnTo>
                  <a:pt x="2496709" y="278295"/>
                </a:lnTo>
                <a:lnTo>
                  <a:pt x="2639833" y="270344"/>
                </a:lnTo>
                <a:lnTo>
                  <a:pt x="2854518" y="278295"/>
                </a:lnTo>
                <a:lnTo>
                  <a:pt x="3037398" y="278295"/>
                </a:lnTo>
                <a:lnTo>
                  <a:pt x="3260035" y="214685"/>
                </a:lnTo>
                <a:lnTo>
                  <a:pt x="3570136" y="159026"/>
                </a:lnTo>
                <a:lnTo>
                  <a:pt x="3657600" y="151075"/>
                </a:lnTo>
                <a:lnTo>
                  <a:pt x="3912042" y="143123"/>
                </a:lnTo>
                <a:lnTo>
                  <a:pt x="4063116" y="47708"/>
                </a:lnTo>
                <a:lnTo>
                  <a:pt x="4206240" y="0"/>
                </a:lnTo>
                <a:lnTo>
                  <a:pt x="4397071" y="0"/>
                </a:lnTo>
                <a:lnTo>
                  <a:pt x="4444779" y="23854"/>
                </a:lnTo>
                <a:lnTo>
                  <a:pt x="4516341" y="103367"/>
                </a:lnTo>
                <a:lnTo>
                  <a:pt x="4627659" y="198782"/>
                </a:lnTo>
                <a:lnTo>
                  <a:pt x="4762831" y="222636"/>
                </a:lnTo>
                <a:lnTo>
                  <a:pt x="5009322" y="206734"/>
                </a:lnTo>
                <a:lnTo>
                  <a:pt x="5112689" y="190831"/>
                </a:lnTo>
                <a:lnTo>
                  <a:pt x="5239909" y="143123"/>
                </a:lnTo>
              </a:path>
            </a:pathLst>
          </a:custGeom>
          <a:noFill/>
          <a:ln>
            <a:solidFill>
              <a:schemeClr val="bg1"/>
            </a:solidFill>
            <a:prstDash val="lgDashDot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Forma libre: forma 4">
            <a:extLst>
              <a:ext uri="{FF2B5EF4-FFF2-40B4-BE49-F238E27FC236}">
                <a16:creationId xmlns:a16="http://schemas.microsoft.com/office/drawing/2014/main" id="{7024EB5C-895F-4550-A304-CDEF6E515185}"/>
              </a:ext>
            </a:extLst>
          </p:cNvPr>
          <p:cNvSpPr/>
          <p:nvPr/>
        </p:nvSpPr>
        <p:spPr>
          <a:xfrm>
            <a:off x="1502797" y="4953663"/>
            <a:ext cx="6050942" cy="365760"/>
          </a:xfrm>
          <a:custGeom>
            <a:avLst/>
            <a:gdLst>
              <a:gd name="connsiteX0" fmla="*/ 0 w 6050942"/>
              <a:gd name="connsiteY0" fmla="*/ 278295 h 365760"/>
              <a:gd name="connsiteX1" fmla="*/ 373711 w 6050942"/>
              <a:gd name="connsiteY1" fmla="*/ 254441 h 365760"/>
              <a:gd name="connsiteX2" fmla="*/ 699714 w 6050942"/>
              <a:gd name="connsiteY2" fmla="*/ 230587 h 365760"/>
              <a:gd name="connsiteX3" fmla="*/ 993913 w 6050942"/>
              <a:gd name="connsiteY3" fmla="*/ 206734 h 365760"/>
              <a:gd name="connsiteX4" fmla="*/ 1431234 w 6050942"/>
              <a:gd name="connsiteY4" fmla="*/ 119269 h 365760"/>
              <a:gd name="connsiteX5" fmla="*/ 1820848 w 6050942"/>
              <a:gd name="connsiteY5" fmla="*/ 111318 h 365760"/>
              <a:gd name="connsiteX6" fmla="*/ 1916264 w 6050942"/>
              <a:gd name="connsiteY6" fmla="*/ 119269 h 365760"/>
              <a:gd name="connsiteX7" fmla="*/ 1963972 w 6050942"/>
              <a:gd name="connsiteY7" fmla="*/ 127220 h 365760"/>
              <a:gd name="connsiteX8" fmla="*/ 2162754 w 6050942"/>
              <a:gd name="connsiteY8" fmla="*/ 174928 h 365760"/>
              <a:gd name="connsiteX9" fmla="*/ 2544417 w 6050942"/>
              <a:gd name="connsiteY9" fmla="*/ 238539 h 365760"/>
              <a:gd name="connsiteX10" fmla="*/ 2894274 w 6050942"/>
              <a:gd name="connsiteY10" fmla="*/ 333954 h 365760"/>
              <a:gd name="connsiteX11" fmla="*/ 3164619 w 6050942"/>
              <a:gd name="connsiteY11" fmla="*/ 365760 h 365760"/>
              <a:gd name="connsiteX12" fmla="*/ 3411109 w 6050942"/>
              <a:gd name="connsiteY12" fmla="*/ 333954 h 365760"/>
              <a:gd name="connsiteX13" fmla="*/ 3713259 w 6050942"/>
              <a:gd name="connsiteY13" fmla="*/ 326003 h 365760"/>
              <a:gd name="connsiteX14" fmla="*/ 3943846 w 6050942"/>
              <a:gd name="connsiteY14" fmla="*/ 310100 h 365760"/>
              <a:gd name="connsiteX15" fmla="*/ 4166483 w 6050942"/>
              <a:gd name="connsiteY15" fmla="*/ 262393 h 365760"/>
              <a:gd name="connsiteX16" fmla="*/ 4548146 w 6050942"/>
              <a:gd name="connsiteY16" fmla="*/ 246490 h 365760"/>
              <a:gd name="connsiteX17" fmla="*/ 4715123 w 6050942"/>
              <a:gd name="connsiteY17" fmla="*/ 254441 h 365760"/>
              <a:gd name="connsiteX18" fmla="*/ 5025224 w 6050942"/>
              <a:gd name="connsiteY18" fmla="*/ 294198 h 365760"/>
              <a:gd name="connsiteX19" fmla="*/ 5255812 w 6050942"/>
              <a:gd name="connsiteY19" fmla="*/ 254441 h 365760"/>
              <a:gd name="connsiteX20" fmla="*/ 5454594 w 6050942"/>
              <a:gd name="connsiteY20" fmla="*/ 222636 h 365760"/>
              <a:gd name="connsiteX21" fmla="*/ 5732890 w 6050942"/>
              <a:gd name="connsiteY21" fmla="*/ 159026 h 365760"/>
              <a:gd name="connsiteX22" fmla="*/ 5963478 w 6050942"/>
              <a:gd name="connsiteY22" fmla="*/ 23854 h 365760"/>
              <a:gd name="connsiteX23" fmla="*/ 6050942 w 6050942"/>
              <a:gd name="connsiteY23" fmla="*/ 0 h 3657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Lst>
            <a:rect l="l" t="t" r="r" b="b"/>
            <a:pathLst>
              <a:path w="6050942" h="365760">
                <a:moveTo>
                  <a:pt x="0" y="278295"/>
                </a:moveTo>
                <a:lnTo>
                  <a:pt x="373711" y="254441"/>
                </a:lnTo>
                <a:lnTo>
                  <a:pt x="699714" y="230587"/>
                </a:lnTo>
                <a:lnTo>
                  <a:pt x="993913" y="206734"/>
                </a:lnTo>
                <a:lnTo>
                  <a:pt x="1431234" y="119269"/>
                </a:lnTo>
                <a:lnTo>
                  <a:pt x="1820848" y="111318"/>
                </a:lnTo>
                <a:cubicBezTo>
                  <a:pt x="1852653" y="113968"/>
                  <a:pt x="1884544" y="115745"/>
                  <a:pt x="1916264" y="119269"/>
                </a:cubicBezTo>
                <a:cubicBezTo>
                  <a:pt x="1932287" y="121049"/>
                  <a:pt x="1963972" y="127220"/>
                  <a:pt x="1963972" y="127220"/>
                </a:cubicBezTo>
                <a:lnTo>
                  <a:pt x="2162754" y="174928"/>
                </a:lnTo>
                <a:lnTo>
                  <a:pt x="2544417" y="238539"/>
                </a:lnTo>
                <a:lnTo>
                  <a:pt x="2894274" y="333954"/>
                </a:lnTo>
                <a:lnTo>
                  <a:pt x="3164619" y="365760"/>
                </a:lnTo>
                <a:lnTo>
                  <a:pt x="3411109" y="333954"/>
                </a:lnTo>
                <a:lnTo>
                  <a:pt x="3713259" y="326003"/>
                </a:lnTo>
                <a:lnTo>
                  <a:pt x="3943846" y="310100"/>
                </a:lnTo>
                <a:lnTo>
                  <a:pt x="4166483" y="262393"/>
                </a:lnTo>
                <a:lnTo>
                  <a:pt x="4548146" y="246490"/>
                </a:lnTo>
                <a:lnTo>
                  <a:pt x="4715123" y="254441"/>
                </a:lnTo>
                <a:lnTo>
                  <a:pt x="5025224" y="294198"/>
                </a:lnTo>
                <a:lnTo>
                  <a:pt x="5255812" y="254441"/>
                </a:lnTo>
                <a:lnTo>
                  <a:pt x="5454594" y="222636"/>
                </a:lnTo>
                <a:lnTo>
                  <a:pt x="5732890" y="159026"/>
                </a:lnTo>
                <a:lnTo>
                  <a:pt x="5963478" y="23854"/>
                </a:lnTo>
                <a:lnTo>
                  <a:pt x="6050942" y="0"/>
                </a:lnTo>
              </a:path>
            </a:pathLst>
          </a:custGeom>
          <a:noFill/>
          <a:ln>
            <a:solidFill>
              <a:schemeClr val="bg1"/>
            </a:solidFill>
            <a:prstDash val="lgDashDot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CuadroTexto 10">
            <a:extLst>
              <a:ext uri="{FF2B5EF4-FFF2-40B4-BE49-F238E27FC236}">
                <a16:creationId xmlns:a16="http://schemas.microsoft.com/office/drawing/2014/main" id="{85FEB20E-5D0D-43AA-B59C-F1CAF4F75ED5}"/>
              </a:ext>
            </a:extLst>
          </p:cNvPr>
          <p:cNvSpPr txBox="1"/>
          <p:nvPr/>
        </p:nvSpPr>
        <p:spPr>
          <a:xfrm>
            <a:off x="1361982" y="4688092"/>
            <a:ext cx="1439186" cy="461665"/>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Carbonated sedimentary layer</a:t>
            </a:r>
          </a:p>
        </p:txBody>
      </p:sp>
    </p:spTree>
    <p:extLst>
      <p:ext uri="{BB962C8B-B14F-4D97-AF65-F5344CB8AC3E}">
        <p14:creationId xmlns:p14="http://schemas.microsoft.com/office/powerpoint/2010/main" val="4185045580"/>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83614" y="563880"/>
            <a:ext cx="845744" cy="369332"/>
          </a:xfrm>
          <a:prstGeom prst="rect">
            <a:avLst/>
          </a:prstGeom>
          <a:noFill/>
        </p:spPr>
        <p:txBody>
          <a:bodyPr wrap="none" rtlCol="0">
            <a:spAutoFit/>
          </a:bodyPr>
          <a:lstStyle/>
          <a:p>
            <a:r>
              <a:rPr lang="en-GB" dirty="0"/>
              <a:t>Fig. AO</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910319" cy="338554"/>
          </a:xfrm>
          <a:prstGeom prst="rect">
            <a:avLst/>
          </a:prstGeom>
          <a:noFill/>
        </p:spPr>
        <p:txBody>
          <a:bodyPr wrap="none" rtlCol="0">
            <a:spAutoFit/>
          </a:bodyPr>
          <a:lstStyle/>
          <a:p>
            <a:r>
              <a:rPr lang="en-GB" sz="1600" b="1" dirty="0">
                <a:latin typeface="+mj-lt"/>
              </a:rPr>
              <a:t>Supporting Information 1 – Excavation of the lower terrace</a:t>
            </a:r>
          </a:p>
        </p:txBody>
      </p:sp>
      <p:pic>
        <p:nvPicPr>
          <p:cNvPr id="3" name="Imagen 2" descr="Imagen que contiene exterior, suelo, rock&#10;&#10;Descripción generada automáticamente">
            <a:extLst>
              <a:ext uri="{FF2B5EF4-FFF2-40B4-BE49-F238E27FC236}">
                <a16:creationId xmlns:a16="http://schemas.microsoft.com/office/drawing/2014/main" id="{5D57CC5A-DF7B-4ACD-9816-CD5CADB96174}"/>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19214" y="563880"/>
            <a:ext cx="8853111" cy="5880052"/>
          </a:xfrm>
          <a:prstGeom prst="rect">
            <a:avLst/>
          </a:prstGeom>
        </p:spPr>
      </p:pic>
      <p:sp>
        <p:nvSpPr>
          <p:cNvPr id="8" name="CuadroTexto 7">
            <a:extLst>
              <a:ext uri="{FF2B5EF4-FFF2-40B4-BE49-F238E27FC236}">
                <a16:creationId xmlns:a16="http://schemas.microsoft.com/office/drawing/2014/main" id="{6D727E69-1BED-438D-9B35-C7C80D017BDB}"/>
              </a:ext>
            </a:extLst>
          </p:cNvPr>
          <p:cNvSpPr txBox="1"/>
          <p:nvPr/>
        </p:nvSpPr>
        <p:spPr>
          <a:xfrm>
            <a:off x="9083614" y="1119598"/>
            <a:ext cx="2820838" cy="2031325"/>
          </a:xfrm>
          <a:prstGeom prst="rect">
            <a:avLst/>
          </a:prstGeom>
          <a:noFill/>
        </p:spPr>
        <p:txBody>
          <a:bodyPr wrap="square" rtlCol="0">
            <a:spAutoFit/>
          </a:bodyPr>
          <a:lstStyle/>
          <a:p>
            <a:pPr algn="just"/>
            <a:r>
              <a:rPr lang="en-GB" sz="1400" dirty="0"/>
              <a:t>Carbonated sedimentary layer was excavated until the bedrock is reached. </a:t>
            </a:r>
          </a:p>
          <a:p>
            <a:pPr algn="just"/>
            <a:endParaRPr lang="en-GB" sz="1400" dirty="0"/>
          </a:p>
          <a:p>
            <a:pPr algn="just"/>
            <a:r>
              <a:rPr lang="en-GB" sz="1400" dirty="0" err="1"/>
              <a:t>Paleolithic</a:t>
            </a:r>
            <a:r>
              <a:rPr lang="en-GB" sz="1400" dirty="0"/>
              <a:t> evidences were not documented during the excavation of the external sedimentation.</a:t>
            </a:r>
          </a:p>
          <a:p>
            <a:pPr algn="just"/>
            <a:endParaRPr lang="en-GB" sz="1400" dirty="0"/>
          </a:p>
          <a:p>
            <a:pPr algn="just"/>
            <a:r>
              <a:rPr lang="en-GB" sz="1400" dirty="0"/>
              <a:t>Photo 2014</a:t>
            </a:r>
          </a:p>
        </p:txBody>
      </p:sp>
      <p:cxnSp>
        <p:nvCxnSpPr>
          <p:cNvPr id="9" name="Conector recto 8">
            <a:extLst>
              <a:ext uri="{FF2B5EF4-FFF2-40B4-BE49-F238E27FC236}">
                <a16:creationId xmlns:a16="http://schemas.microsoft.com/office/drawing/2014/main" id="{D371E646-8068-499D-B31F-CA3698FE4DCF}"/>
              </a:ext>
            </a:extLst>
          </p:cNvPr>
          <p:cNvCxnSpPr>
            <a:cxnSpLocks/>
          </p:cNvCxnSpPr>
          <p:nvPr/>
        </p:nvCxnSpPr>
        <p:spPr>
          <a:xfrm>
            <a:off x="9169879" y="1037847"/>
            <a:ext cx="2674189"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7BAF04BD-31CC-448C-8FC2-24F4DB3C65A8}"/>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41</a:t>
            </a:fld>
            <a:endParaRPr lang="en-GB" sz="1800" dirty="0">
              <a:latin typeface="+mj-lt"/>
            </a:endParaRPr>
          </a:p>
        </p:txBody>
      </p:sp>
      <p:sp>
        <p:nvSpPr>
          <p:cNvPr id="4" name="Forma libre: forma 3">
            <a:extLst>
              <a:ext uri="{FF2B5EF4-FFF2-40B4-BE49-F238E27FC236}">
                <a16:creationId xmlns:a16="http://schemas.microsoft.com/office/drawing/2014/main" id="{FF21C73C-E96C-4A7B-A69E-19A7DF67AE3A}"/>
              </a:ext>
            </a:extLst>
          </p:cNvPr>
          <p:cNvSpPr/>
          <p:nvPr/>
        </p:nvSpPr>
        <p:spPr>
          <a:xfrm>
            <a:off x="2727297" y="4317558"/>
            <a:ext cx="5709037" cy="858741"/>
          </a:xfrm>
          <a:custGeom>
            <a:avLst/>
            <a:gdLst>
              <a:gd name="connsiteX0" fmla="*/ 7952 w 5709037"/>
              <a:gd name="connsiteY0" fmla="*/ 0 h 858741"/>
              <a:gd name="connsiteX1" fmla="*/ 39757 w 5709037"/>
              <a:gd name="connsiteY1" fmla="*/ 103367 h 858741"/>
              <a:gd name="connsiteX2" fmla="*/ 79513 w 5709037"/>
              <a:gd name="connsiteY2" fmla="*/ 286247 h 858741"/>
              <a:gd name="connsiteX3" fmla="*/ 47708 w 5709037"/>
              <a:gd name="connsiteY3" fmla="*/ 445273 h 858741"/>
              <a:gd name="connsiteX4" fmla="*/ 0 w 5709037"/>
              <a:gd name="connsiteY4" fmla="*/ 532738 h 858741"/>
              <a:gd name="connsiteX5" fmla="*/ 23854 w 5709037"/>
              <a:gd name="connsiteY5" fmla="*/ 572494 h 858741"/>
              <a:gd name="connsiteX6" fmla="*/ 23854 w 5709037"/>
              <a:gd name="connsiteY6" fmla="*/ 572494 h 858741"/>
              <a:gd name="connsiteX7" fmla="*/ 294199 w 5709037"/>
              <a:gd name="connsiteY7" fmla="*/ 604299 h 858741"/>
              <a:gd name="connsiteX8" fmla="*/ 556592 w 5709037"/>
              <a:gd name="connsiteY8" fmla="*/ 628153 h 858741"/>
              <a:gd name="connsiteX9" fmla="*/ 747423 w 5709037"/>
              <a:gd name="connsiteY9" fmla="*/ 644056 h 858741"/>
              <a:gd name="connsiteX10" fmla="*/ 970060 w 5709037"/>
              <a:gd name="connsiteY10" fmla="*/ 644056 h 858741"/>
              <a:gd name="connsiteX11" fmla="*/ 1160891 w 5709037"/>
              <a:gd name="connsiteY11" fmla="*/ 667910 h 858741"/>
              <a:gd name="connsiteX12" fmla="*/ 1304014 w 5709037"/>
              <a:gd name="connsiteY12" fmla="*/ 723569 h 858741"/>
              <a:gd name="connsiteX13" fmla="*/ 1701580 w 5709037"/>
              <a:gd name="connsiteY13" fmla="*/ 739472 h 858741"/>
              <a:gd name="connsiteX14" fmla="*/ 1995778 w 5709037"/>
              <a:gd name="connsiteY14" fmla="*/ 747423 h 858741"/>
              <a:gd name="connsiteX15" fmla="*/ 2441051 w 5709037"/>
              <a:gd name="connsiteY15" fmla="*/ 731520 h 858741"/>
              <a:gd name="connsiteX16" fmla="*/ 2703444 w 5709037"/>
              <a:gd name="connsiteY16" fmla="*/ 723569 h 858741"/>
              <a:gd name="connsiteX17" fmla="*/ 3013545 w 5709037"/>
              <a:gd name="connsiteY17" fmla="*/ 707666 h 858741"/>
              <a:gd name="connsiteX18" fmla="*/ 3283889 w 5709037"/>
              <a:gd name="connsiteY18" fmla="*/ 707666 h 858741"/>
              <a:gd name="connsiteX19" fmla="*/ 3800724 w 5709037"/>
              <a:gd name="connsiteY19" fmla="*/ 699715 h 858741"/>
              <a:gd name="connsiteX20" fmla="*/ 4031312 w 5709037"/>
              <a:gd name="connsiteY20" fmla="*/ 739472 h 858741"/>
              <a:gd name="connsiteX21" fmla="*/ 4238046 w 5709037"/>
              <a:gd name="connsiteY21" fmla="*/ 795131 h 858741"/>
              <a:gd name="connsiteX22" fmla="*/ 4428877 w 5709037"/>
              <a:gd name="connsiteY22" fmla="*/ 834887 h 858741"/>
              <a:gd name="connsiteX23" fmla="*/ 4945712 w 5709037"/>
              <a:gd name="connsiteY23" fmla="*/ 850790 h 858741"/>
              <a:gd name="connsiteX24" fmla="*/ 5112689 w 5709037"/>
              <a:gd name="connsiteY24" fmla="*/ 858741 h 858741"/>
              <a:gd name="connsiteX25" fmla="*/ 5319423 w 5709037"/>
              <a:gd name="connsiteY25" fmla="*/ 850790 h 858741"/>
              <a:gd name="connsiteX26" fmla="*/ 5653378 w 5709037"/>
              <a:gd name="connsiteY26" fmla="*/ 707666 h 858741"/>
              <a:gd name="connsiteX27" fmla="*/ 5709037 w 5709037"/>
              <a:gd name="connsiteY27" fmla="*/ 659959 h 8587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Lst>
            <a:rect l="l" t="t" r="r" b="b"/>
            <a:pathLst>
              <a:path w="5709037" h="858741">
                <a:moveTo>
                  <a:pt x="7952" y="0"/>
                </a:moveTo>
                <a:lnTo>
                  <a:pt x="39757" y="103367"/>
                </a:lnTo>
                <a:lnTo>
                  <a:pt x="79513" y="286247"/>
                </a:lnTo>
                <a:lnTo>
                  <a:pt x="47708" y="445273"/>
                </a:lnTo>
                <a:lnTo>
                  <a:pt x="0" y="532738"/>
                </a:lnTo>
                <a:lnTo>
                  <a:pt x="23854" y="572494"/>
                </a:lnTo>
                <a:lnTo>
                  <a:pt x="23854" y="572494"/>
                </a:lnTo>
                <a:lnTo>
                  <a:pt x="294199" y="604299"/>
                </a:lnTo>
                <a:lnTo>
                  <a:pt x="556592" y="628153"/>
                </a:lnTo>
                <a:lnTo>
                  <a:pt x="747423" y="644056"/>
                </a:lnTo>
                <a:lnTo>
                  <a:pt x="970060" y="644056"/>
                </a:lnTo>
                <a:lnTo>
                  <a:pt x="1160891" y="667910"/>
                </a:lnTo>
                <a:lnTo>
                  <a:pt x="1304014" y="723569"/>
                </a:lnTo>
                <a:lnTo>
                  <a:pt x="1701580" y="739472"/>
                </a:lnTo>
                <a:lnTo>
                  <a:pt x="1995778" y="747423"/>
                </a:lnTo>
                <a:lnTo>
                  <a:pt x="2441051" y="731520"/>
                </a:lnTo>
                <a:lnTo>
                  <a:pt x="2703444" y="723569"/>
                </a:lnTo>
                <a:lnTo>
                  <a:pt x="3013545" y="707666"/>
                </a:lnTo>
                <a:lnTo>
                  <a:pt x="3283889" y="707666"/>
                </a:lnTo>
                <a:lnTo>
                  <a:pt x="3800724" y="699715"/>
                </a:lnTo>
                <a:lnTo>
                  <a:pt x="4031312" y="739472"/>
                </a:lnTo>
                <a:lnTo>
                  <a:pt x="4238046" y="795131"/>
                </a:lnTo>
                <a:lnTo>
                  <a:pt x="4428877" y="834887"/>
                </a:lnTo>
                <a:lnTo>
                  <a:pt x="4945712" y="850790"/>
                </a:lnTo>
                <a:lnTo>
                  <a:pt x="5112689" y="858741"/>
                </a:lnTo>
                <a:lnTo>
                  <a:pt x="5319423" y="850790"/>
                </a:lnTo>
                <a:lnTo>
                  <a:pt x="5653378" y="707666"/>
                </a:lnTo>
                <a:lnTo>
                  <a:pt x="5709037" y="659959"/>
                </a:lnTo>
              </a:path>
            </a:pathLst>
          </a:custGeom>
          <a:noFill/>
          <a:ln>
            <a:solidFill>
              <a:schemeClr val="tx1">
                <a:lumMod val="85000"/>
                <a:lumOff val="15000"/>
              </a:schemeClr>
            </a:solidFill>
            <a:prstDash val="lgDashDot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CuadroTexto 10">
            <a:extLst>
              <a:ext uri="{FF2B5EF4-FFF2-40B4-BE49-F238E27FC236}">
                <a16:creationId xmlns:a16="http://schemas.microsoft.com/office/drawing/2014/main" id="{8B856E3E-5D03-4F9F-8C0D-62CE17A5284A}"/>
              </a:ext>
            </a:extLst>
          </p:cNvPr>
          <p:cNvSpPr txBox="1"/>
          <p:nvPr/>
        </p:nvSpPr>
        <p:spPr>
          <a:xfrm>
            <a:off x="2529743" y="4608428"/>
            <a:ext cx="1150143" cy="276999"/>
          </a:xfrm>
          <a:prstGeom prst="rect">
            <a:avLst/>
          </a:prstGeom>
          <a:noFill/>
        </p:spPr>
        <p:txBody>
          <a:bodyPr wrap="square" rtlCol="0">
            <a:spAutoFit/>
          </a:bodyPr>
          <a:lstStyle/>
          <a:p>
            <a:pPr algn="ctr"/>
            <a:r>
              <a:rPr lang="en-GB" sz="1200" dirty="0">
                <a:solidFill>
                  <a:schemeClr val="tx1">
                    <a:lumMod val="95000"/>
                    <a:lumOff val="5000"/>
                  </a:schemeClr>
                </a:solidFill>
                <a:latin typeface="+mj-lt"/>
              </a:rPr>
              <a:t>Bedrock</a:t>
            </a:r>
          </a:p>
        </p:txBody>
      </p:sp>
      <p:sp>
        <p:nvSpPr>
          <p:cNvPr id="12" name="CuadroTexto 11">
            <a:extLst>
              <a:ext uri="{FF2B5EF4-FFF2-40B4-BE49-F238E27FC236}">
                <a16:creationId xmlns:a16="http://schemas.microsoft.com/office/drawing/2014/main" id="{B8A9FEC5-68CA-4F62-BB42-253BADF72929}"/>
              </a:ext>
            </a:extLst>
          </p:cNvPr>
          <p:cNvSpPr txBox="1"/>
          <p:nvPr/>
        </p:nvSpPr>
        <p:spPr>
          <a:xfrm>
            <a:off x="2727297" y="4958969"/>
            <a:ext cx="1325314" cy="461665"/>
          </a:xfrm>
          <a:prstGeom prst="rect">
            <a:avLst/>
          </a:prstGeom>
          <a:noFill/>
        </p:spPr>
        <p:txBody>
          <a:bodyPr wrap="square" rtlCol="0">
            <a:spAutoFit/>
          </a:bodyPr>
          <a:lstStyle/>
          <a:p>
            <a:r>
              <a:rPr lang="en-GB" sz="1200" dirty="0">
                <a:solidFill>
                  <a:schemeClr val="tx1">
                    <a:lumMod val="95000"/>
                    <a:lumOff val="5000"/>
                  </a:schemeClr>
                </a:solidFill>
                <a:latin typeface="+mj-lt"/>
              </a:rPr>
              <a:t>Carbonated sedimentary layer</a:t>
            </a:r>
          </a:p>
        </p:txBody>
      </p:sp>
    </p:spTree>
    <p:extLst>
      <p:ext uri="{BB962C8B-B14F-4D97-AF65-F5344CB8AC3E}">
        <p14:creationId xmlns:p14="http://schemas.microsoft.com/office/powerpoint/2010/main" val="196933938"/>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118122" y="499741"/>
            <a:ext cx="795411" cy="369332"/>
          </a:xfrm>
          <a:prstGeom prst="rect">
            <a:avLst/>
          </a:prstGeom>
          <a:noFill/>
        </p:spPr>
        <p:txBody>
          <a:bodyPr wrap="none" rtlCol="0">
            <a:spAutoFit/>
          </a:bodyPr>
          <a:lstStyle/>
          <a:p>
            <a:r>
              <a:rPr lang="en-GB" b="1" dirty="0">
                <a:latin typeface="+mj-lt"/>
              </a:rPr>
              <a:t>Fig. AP</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910319" cy="338554"/>
          </a:xfrm>
          <a:prstGeom prst="rect">
            <a:avLst/>
          </a:prstGeom>
          <a:noFill/>
        </p:spPr>
        <p:txBody>
          <a:bodyPr wrap="none" rtlCol="0">
            <a:spAutoFit/>
          </a:bodyPr>
          <a:lstStyle/>
          <a:p>
            <a:r>
              <a:rPr lang="en-GB" sz="1600" b="1" dirty="0">
                <a:latin typeface="+mj-lt"/>
              </a:rPr>
              <a:t>Supporting Information 1 – Excavation of the lower terrace</a:t>
            </a:r>
          </a:p>
        </p:txBody>
      </p:sp>
      <p:pic>
        <p:nvPicPr>
          <p:cNvPr id="4" name="Imagen 3" descr="Imagen que contiene suelo, exterior, rojo, suciedad&#10;&#10;Descripción generada automáticamente">
            <a:extLst>
              <a:ext uri="{FF2B5EF4-FFF2-40B4-BE49-F238E27FC236}">
                <a16:creationId xmlns:a16="http://schemas.microsoft.com/office/drawing/2014/main" id="{EC207DFA-202B-4233-A7B5-6EEF8B0A7D61}"/>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52400" y="493762"/>
            <a:ext cx="8733123" cy="5800358"/>
          </a:xfrm>
          <a:prstGeom prst="rect">
            <a:avLst/>
          </a:prstGeom>
        </p:spPr>
      </p:pic>
      <p:sp>
        <p:nvSpPr>
          <p:cNvPr id="8" name="CuadroTexto 7">
            <a:extLst>
              <a:ext uri="{FF2B5EF4-FFF2-40B4-BE49-F238E27FC236}">
                <a16:creationId xmlns:a16="http://schemas.microsoft.com/office/drawing/2014/main" id="{8663CA8F-A2AD-42C8-A80A-0FC1F8F3C867}"/>
              </a:ext>
            </a:extLst>
          </p:cNvPr>
          <p:cNvSpPr txBox="1"/>
          <p:nvPr/>
        </p:nvSpPr>
        <p:spPr>
          <a:xfrm>
            <a:off x="9118122" y="1076468"/>
            <a:ext cx="2743200" cy="1600438"/>
          </a:xfrm>
          <a:prstGeom prst="rect">
            <a:avLst/>
          </a:prstGeom>
          <a:noFill/>
        </p:spPr>
        <p:txBody>
          <a:bodyPr wrap="square" rtlCol="0">
            <a:spAutoFit/>
          </a:bodyPr>
          <a:lstStyle/>
          <a:p>
            <a:pPr algn="just"/>
            <a:r>
              <a:rPr lang="en-GB" sz="1400" dirty="0"/>
              <a:t>Section of the excavation at the terrace of the Lower Entrance. The stratigraphy is formed by i) superficial sediments, ii) carbonated layer, iii) bedrock.</a:t>
            </a:r>
          </a:p>
          <a:p>
            <a:pPr algn="just"/>
            <a:endParaRPr lang="en-GB" sz="1400" dirty="0"/>
          </a:p>
          <a:p>
            <a:pPr algn="just"/>
            <a:r>
              <a:rPr lang="en-GB" sz="1400" dirty="0"/>
              <a:t>Photo 2014</a:t>
            </a:r>
          </a:p>
        </p:txBody>
      </p:sp>
      <p:sp>
        <p:nvSpPr>
          <p:cNvPr id="9" name="Marcador de número de diapositiva 1">
            <a:extLst>
              <a:ext uri="{FF2B5EF4-FFF2-40B4-BE49-F238E27FC236}">
                <a16:creationId xmlns:a16="http://schemas.microsoft.com/office/drawing/2014/main" id="{77ABDC1B-939B-4EFE-9B68-5D864367B400}"/>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42</a:t>
            </a:fld>
            <a:endParaRPr lang="en-GB" sz="1800" dirty="0">
              <a:latin typeface="+mj-lt"/>
            </a:endParaRPr>
          </a:p>
        </p:txBody>
      </p:sp>
      <p:cxnSp>
        <p:nvCxnSpPr>
          <p:cNvPr id="10" name="Conector recto 9">
            <a:extLst>
              <a:ext uri="{FF2B5EF4-FFF2-40B4-BE49-F238E27FC236}">
                <a16:creationId xmlns:a16="http://schemas.microsoft.com/office/drawing/2014/main" id="{84E31BA5-1813-4A36-998D-E9B851FC1B64}"/>
              </a:ext>
            </a:extLst>
          </p:cNvPr>
          <p:cNvCxnSpPr>
            <a:cxnSpLocks/>
          </p:cNvCxnSpPr>
          <p:nvPr/>
        </p:nvCxnSpPr>
        <p:spPr>
          <a:xfrm>
            <a:off x="9187133" y="968835"/>
            <a:ext cx="2536165"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5" name="Forma libre: forma 4">
            <a:extLst>
              <a:ext uri="{FF2B5EF4-FFF2-40B4-BE49-F238E27FC236}">
                <a16:creationId xmlns:a16="http://schemas.microsoft.com/office/drawing/2014/main" id="{26585A5A-29F9-49B0-9380-0901B04D494C}"/>
              </a:ext>
            </a:extLst>
          </p:cNvPr>
          <p:cNvSpPr/>
          <p:nvPr/>
        </p:nvSpPr>
        <p:spPr>
          <a:xfrm>
            <a:off x="1669774" y="1924216"/>
            <a:ext cx="5231958" cy="1828800"/>
          </a:xfrm>
          <a:custGeom>
            <a:avLst/>
            <a:gdLst>
              <a:gd name="connsiteX0" fmla="*/ 5231958 w 5231958"/>
              <a:gd name="connsiteY0" fmla="*/ 850789 h 1828800"/>
              <a:gd name="connsiteX1" fmla="*/ 4882101 w 5231958"/>
              <a:gd name="connsiteY1" fmla="*/ 659958 h 1828800"/>
              <a:gd name="connsiteX2" fmla="*/ 4627659 w 5231958"/>
              <a:gd name="connsiteY2" fmla="*/ 461175 h 1828800"/>
              <a:gd name="connsiteX3" fmla="*/ 4317558 w 5231958"/>
              <a:gd name="connsiteY3" fmla="*/ 437321 h 1828800"/>
              <a:gd name="connsiteX4" fmla="*/ 4007457 w 5231958"/>
              <a:gd name="connsiteY4" fmla="*/ 397565 h 1828800"/>
              <a:gd name="connsiteX5" fmla="*/ 3697356 w 5231958"/>
              <a:gd name="connsiteY5" fmla="*/ 318052 h 1828800"/>
              <a:gd name="connsiteX6" fmla="*/ 3617843 w 5231958"/>
              <a:gd name="connsiteY6" fmla="*/ 294198 h 1828800"/>
              <a:gd name="connsiteX7" fmla="*/ 3331596 w 5231958"/>
              <a:gd name="connsiteY7" fmla="*/ 190831 h 1828800"/>
              <a:gd name="connsiteX8" fmla="*/ 3037398 w 5231958"/>
              <a:gd name="connsiteY8" fmla="*/ 87464 h 1828800"/>
              <a:gd name="connsiteX9" fmla="*/ 2671638 w 5231958"/>
              <a:gd name="connsiteY9" fmla="*/ 0 h 1828800"/>
              <a:gd name="connsiteX10" fmla="*/ 2456953 w 5231958"/>
              <a:gd name="connsiteY10" fmla="*/ 55659 h 1828800"/>
              <a:gd name="connsiteX11" fmla="*/ 2122998 w 5231958"/>
              <a:gd name="connsiteY11" fmla="*/ 198782 h 1828800"/>
              <a:gd name="connsiteX12" fmla="*/ 2051436 w 5231958"/>
              <a:gd name="connsiteY12" fmla="*/ 246490 h 1828800"/>
              <a:gd name="connsiteX13" fmla="*/ 1757238 w 5231958"/>
              <a:gd name="connsiteY13" fmla="*/ 357808 h 1828800"/>
              <a:gd name="connsiteX14" fmla="*/ 1653871 w 5231958"/>
              <a:gd name="connsiteY14" fmla="*/ 397565 h 1828800"/>
              <a:gd name="connsiteX15" fmla="*/ 1359673 w 5231958"/>
              <a:gd name="connsiteY15" fmla="*/ 524786 h 1828800"/>
              <a:gd name="connsiteX16" fmla="*/ 1288111 w 5231958"/>
              <a:gd name="connsiteY16" fmla="*/ 532737 h 1828800"/>
              <a:gd name="connsiteX17" fmla="*/ 1017767 w 5231958"/>
              <a:gd name="connsiteY17" fmla="*/ 580445 h 1828800"/>
              <a:gd name="connsiteX18" fmla="*/ 771276 w 5231958"/>
              <a:gd name="connsiteY18" fmla="*/ 699714 h 1828800"/>
              <a:gd name="connsiteX19" fmla="*/ 683812 w 5231958"/>
              <a:gd name="connsiteY19" fmla="*/ 771276 h 1828800"/>
              <a:gd name="connsiteX20" fmla="*/ 588396 w 5231958"/>
              <a:gd name="connsiteY20" fmla="*/ 985961 h 1828800"/>
              <a:gd name="connsiteX21" fmla="*/ 485029 w 5231958"/>
              <a:gd name="connsiteY21" fmla="*/ 1208598 h 1828800"/>
              <a:gd name="connsiteX22" fmla="*/ 405516 w 5231958"/>
              <a:gd name="connsiteY22" fmla="*/ 1550504 h 1828800"/>
              <a:gd name="connsiteX23" fmla="*/ 318052 w 5231958"/>
              <a:gd name="connsiteY23" fmla="*/ 1685676 h 1828800"/>
              <a:gd name="connsiteX24" fmla="*/ 127221 w 5231958"/>
              <a:gd name="connsiteY24" fmla="*/ 1828800 h 1828800"/>
              <a:gd name="connsiteX25" fmla="*/ 0 w 5231958"/>
              <a:gd name="connsiteY25" fmla="*/ 1828800 h 18288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Lst>
            <a:rect l="l" t="t" r="r" b="b"/>
            <a:pathLst>
              <a:path w="5231958" h="1828800">
                <a:moveTo>
                  <a:pt x="5231958" y="850789"/>
                </a:moveTo>
                <a:lnTo>
                  <a:pt x="4882101" y="659958"/>
                </a:lnTo>
                <a:lnTo>
                  <a:pt x="4627659" y="461175"/>
                </a:lnTo>
                <a:lnTo>
                  <a:pt x="4317558" y="437321"/>
                </a:lnTo>
                <a:lnTo>
                  <a:pt x="4007457" y="397565"/>
                </a:lnTo>
                <a:lnTo>
                  <a:pt x="3697356" y="318052"/>
                </a:lnTo>
                <a:cubicBezTo>
                  <a:pt x="3628783" y="292337"/>
                  <a:pt x="3656391" y="294198"/>
                  <a:pt x="3617843" y="294198"/>
                </a:cubicBezTo>
                <a:lnTo>
                  <a:pt x="3331596" y="190831"/>
                </a:lnTo>
                <a:lnTo>
                  <a:pt x="3037398" y="87464"/>
                </a:lnTo>
                <a:lnTo>
                  <a:pt x="2671638" y="0"/>
                </a:lnTo>
                <a:lnTo>
                  <a:pt x="2456953" y="55659"/>
                </a:lnTo>
                <a:lnTo>
                  <a:pt x="2122998" y="198782"/>
                </a:lnTo>
                <a:cubicBezTo>
                  <a:pt x="2056209" y="240526"/>
                  <a:pt x="2077070" y="220860"/>
                  <a:pt x="2051436" y="246490"/>
                </a:cubicBezTo>
                <a:lnTo>
                  <a:pt x="1757238" y="357808"/>
                </a:lnTo>
                <a:lnTo>
                  <a:pt x="1653871" y="397565"/>
                </a:lnTo>
                <a:lnTo>
                  <a:pt x="1359673" y="524786"/>
                </a:lnTo>
                <a:lnTo>
                  <a:pt x="1288111" y="532737"/>
                </a:lnTo>
                <a:lnTo>
                  <a:pt x="1017767" y="580445"/>
                </a:lnTo>
                <a:lnTo>
                  <a:pt x="771276" y="699714"/>
                </a:lnTo>
                <a:lnTo>
                  <a:pt x="683812" y="771276"/>
                </a:lnTo>
                <a:lnTo>
                  <a:pt x="588396" y="985961"/>
                </a:lnTo>
                <a:lnTo>
                  <a:pt x="485029" y="1208598"/>
                </a:lnTo>
                <a:lnTo>
                  <a:pt x="405516" y="1550504"/>
                </a:lnTo>
                <a:lnTo>
                  <a:pt x="318052" y="1685676"/>
                </a:lnTo>
                <a:lnTo>
                  <a:pt x="127221" y="1828800"/>
                </a:lnTo>
                <a:lnTo>
                  <a:pt x="0" y="1828800"/>
                </a:lnTo>
              </a:path>
            </a:pathLst>
          </a:custGeom>
          <a:noFill/>
          <a:ln>
            <a:solidFill>
              <a:schemeClr val="bg1"/>
            </a:solidFill>
            <a:prstDash val="lgDashDot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Forma libre: forma 10">
            <a:extLst>
              <a:ext uri="{FF2B5EF4-FFF2-40B4-BE49-F238E27FC236}">
                <a16:creationId xmlns:a16="http://schemas.microsoft.com/office/drawing/2014/main" id="{3445D7AE-85FE-4E99-906B-B9F9C9C3F7AC}"/>
              </a:ext>
            </a:extLst>
          </p:cNvPr>
          <p:cNvSpPr/>
          <p:nvPr/>
        </p:nvSpPr>
        <p:spPr>
          <a:xfrm>
            <a:off x="3514477" y="3148717"/>
            <a:ext cx="3593989" cy="3140765"/>
          </a:xfrm>
          <a:custGeom>
            <a:avLst/>
            <a:gdLst>
              <a:gd name="connsiteX0" fmla="*/ 3593989 w 3593989"/>
              <a:gd name="connsiteY0" fmla="*/ 0 h 3140765"/>
              <a:gd name="connsiteX1" fmla="*/ 3299791 w 3593989"/>
              <a:gd name="connsiteY1" fmla="*/ 55659 h 3140765"/>
              <a:gd name="connsiteX2" fmla="*/ 3005593 w 3593989"/>
              <a:gd name="connsiteY2" fmla="*/ 127220 h 3140765"/>
              <a:gd name="connsiteX3" fmla="*/ 2886323 w 3593989"/>
              <a:gd name="connsiteY3" fmla="*/ 246490 h 3140765"/>
              <a:gd name="connsiteX4" fmla="*/ 2584173 w 3593989"/>
              <a:gd name="connsiteY4" fmla="*/ 397565 h 3140765"/>
              <a:gd name="connsiteX5" fmla="*/ 2488758 w 3593989"/>
              <a:gd name="connsiteY5" fmla="*/ 485029 h 3140765"/>
              <a:gd name="connsiteX6" fmla="*/ 2329732 w 3593989"/>
              <a:gd name="connsiteY6" fmla="*/ 580445 h 3140765"/>
              <a:gd name="connsiteX7" fmla="*/ 2250219 w 3593989"/>
              <a:gd name="connsiteY7" fmla="*/ 612250 h 3140765"/>
              <a:gd name="connsiteX8" fmla="*/ 2051436 w 3593989"/>
              <a:gd name="connsiteY8" fmla="*/ 667909 h 3140765"/>
              <a:gd name="connsiteX9" fmla="*/ 1741335 w 3593989"/>
              <a:gd name="connsiteY9" fmla="*/ 763325 h 3140765"/>
              <a:gd name="connsiteX10" fmla="*/ 1534601 w 3593989"/>
              <a:gd name="connsiteY10" fmla="*/ 866692 h 3140765"/>
              <a:gd name="connsiteX11" fmla="*/ 1343770 w 3593989"/>
              <a:gd name="connsiteY11" fmla="*/ 970059 h 3140765"/>
              <a:gd name="connsiteX12" fmla="*/ 962107 w 3593989"/>
              <a:gd name="connsiteY12" fmla="*/ 1089328 h 3140765"/>
              <a:gd name="connsiteX13" fmla="*/ 834886 w 3593989"/>
              <a:gd name="connsiteY13" fmla="*/ 1137036 h 3140765"/>
              <a:gd name="connsiteX14" fmla="*/ 683812 w 3593989"/>
              <a:gd name="connsiteY14" fmla="*/ 1184744 h 3140765"/>
              <a:gd name="connsiteX15" fmla="*/ 421419 w 3593989"/>
              <a:gd name="connsiteY15" fmla="*/ 1327867 h 3140765"/>
              <a:gd name="connsiteX16" fmla="*/ 166977 w 3593989"/>
              <a:gd name="connsiteY16" fmla="*/ 1470991 h 3140765"/>
              <a:gd name="connsiteX17" fmla="*/ 0 w 3593989"/>
              <a:gd name="connsiteY17" fmla="*/ 1550504 h 3140765"/>
              <a:gd name="connsiteX18" fmla="*/ 0 w 3593989"/>
              <a:gd name="connsiteY18" fmla="*/ 1590260 h 3140765"/>
              <a:gd name="connsiteX19" fmla="*/ 39756 w 3593989"/>
              <a:gd name="connsiteY19" fmla="*/ 1693627 h 3140765"/>
              <a:gd name="connsiteX20" fmla="*/ 222636 w 3593989"/>
              <a:gd name="connsiteY20" fmla="*/ 1828800 h 3140765"/>
              <a:gd name="connsiteX21" fmla="*/ 326003 w 3593989"/>
              <a:gd name="connsiteY21" fmla="*/ 1892410 h 3140765"/>
              <a:gd name="connsiteX22" fmla="*/ 492980 w 3593989"/>
              <a:gd name="connsiteY22" fmla="*/ 1995777 h 3140765"/>
              <a:gd name="connsiteX23" fmla="*/ 556591 w 3593989"/>
              <a:gd name="connsiteY23" fmla="*/ 2138900 h 3140765"/>
              <a:gd name="connsiteX24" fmla="*/ 580445 w 3593989"/>
              <a:gd name="connsiteY24" fmla="*/ 2289975 h 3140765"/>
              <a:gd name="connsiteX25" fmla="*/ 540688 w 3593989"/>
              <a:gd name="connsiteY25" fmla="*/ 2528514 h 3140765"/>
              <a:gd name="connsiteX26" fmla="*/ 492980 w 3593989"/>
              <a:gd name="connsiteY26" fmla="*/ 2647784 h 3140765"/>
              <a:gd name="connsiteX27" fmla="*/ 461175 w 3593989"/>
              <a:gd name="connsiteY27" fmla="*/ 2775005 h 3140765"/>
              <a:gd name="connsiteX28" fmla="*/ 413467 w 3593989"/>
              <a:gd name="connsiteY28" fmla="*/ 2934031 h 3140765"/>
              <a:gd name="connsiteX29" fmla="*/ 365760 w 3593989"/>
              <a:gd name="connsiteY29" fmla="*/ 3045349 h 3140765"/>
              <a:gd name="connsiteX30" fmla="*/ 341906 w 3593989"/>
              <a:gd name="connsiteY30" fmla="*/ 3140765 h 314076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Lst>
            <a:rect l="l" t="t" r="r" b="b"/>
            <a:pathLst>
              <a:path w="3593989" h="3140765">
                <a:moveTo>
                  <a:pt x="3593989" y="0"/>
                </a:moveTo>
                <a:lnTo>
                  <a:pt x="3299791" y="55659"/>
                </a:lnTo>
                <a:lnTo>
                  <a:pt x="3005593" y="127220"/>
                </a:lnTo>
                <a:lnTo>
                  <a:pt x="2886323" y="246490"/>
                </a:lnTo>
                <a:lnTo>
                  <a:pt x="2584173" y="397565"/>
                </a:lnTo>
                <a:lnTo>
                  <a:pt x="2488758" y="485029"/>
                </a:lnTo>
                <a:lnTo>
                  <a:pt x="2329732" y="580445"/>
                </a:lnTo>
                <a:cubicBezTo>
                  <a:pt x="2261380" y="614621"/>
                  <a:pt x="2289827" y="612250"/>
                  <a:pt x="2250219" y="612250"/>
                </a:cubicBezTo>
                <a:lnTo>
                  <a:pt x="2051436" y="667909"/>
                </a:lnTo>
                <a:lnTo>
                  <a:pt x="1741335" y="763325"/>
                </a:lnTo>
                <a:lnTo>
                  <a:pt x="1534601" y="866692"/>
                </a:lnTo>
                <a:lnTo>
                  <a:pt x="1343770" y="970059"/>
                </a:lnTo>
                <a:lnTo>
                  <a:pt x="962107" y="1089328"/>
                </a:lnTo>
                <a:lnTo>
                  <a:pt x="834886" y="1137036"/>
                </a:lnTo>
                <a:lnTo>
                  <a:pt x="683812" y="1184744"/>
                </a:lnTo>
                <a:lnTo>
                  <a:pt x="421419" y="1327867"/>
                </a:lnTo>
                <a:lnTo>
                  <a:pt x="166977" y="1470991"/>
                </a:lnTo>
                <a:lnTo>
                  <a:pt x="0" y="1550504"/>
                </a:lnTo>
                <a:lnTo>
                  <a:pt x="0" y="1590260"/>
                </a:lnTo>
                <a:lnTo>
                  <a:pt x="39756" y="1693627"/>
                </a:lnTo>
                <a:lnTo>
                  <a:pt x="222636" y="1828800"/>
                </a:lnTo>
                <a:lnTo>
                  <a:pt x="326003" y="1892410"/>
                </a:lnTo>
                <a:lnTo>
                  <a:pt x="492980" y="1995777"/>
                </a:lnTo>
                <a:lnTo>
                  <a:pt x="556591" y="2138900"/>
                </a:lnTo>
                <a:lnTo>
                  <a:pt x="580445" y="2289975"/>
                </a:lnTo>
                <a:lnTo>
                  <a:pt x="540688" y="2528514"/>
                </a:lnTo>
                <a:lnTo>
                  <a:pt x="492980" y="2647784"/>
                </a:lnTo>
                <a:lnTo>
                  <a:pt x="461175" y="2775005"/>
                </a:lnTo>
                <a:lnTo>
                  <a:pt x="413467" y="2934031"/>
                </a:lnTo>
                <a:lnTo>
                  <a:pt x="365760" y="3045349"/>
                </a:lnTo>
                <a:lnTo>
                  <a:pt x="341906" y="3140765"/>
                </a:lnTo>
              </a:path>
            </a:pathLst>
          </a:custGeom>
          <a:noFill/>
          <a:ln>
            <a:solidFill>
              <a:schemeClr val="bg1"/>
            </a:solidFill>
            <a:prstDash val="lgDashDot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CuadroTexto 11">
            <a:extLst>
              <a:ext uri="{FF2B5EF4-FFF2-40B4-BE49-F238E27FC236}">
                <a16:creationId xmlns:a16="http://schemas.microsoft.com/office/drawing/2014/main" id="{5C917C7B-3F51-421E-AF8A-8501F1943E3E}"/>
              </a:ext>
            </a:extLst>
          </p:cNvPr>
          <p:cNvSpPr txBox="1"/>
          <p:nvPr/>
        </p:nvSpPr>
        <p:spPr>
          <a:xfrm>
            <a:off x="5534057" y="1856652"/>
            <a:ext cx="1150143" cy="461665"/>
          </a:xfrm>
          <a:prstGeom prst="rect">
            <a:avLst/>
          </a:prstGeom>
          <a:noFill/>
        </p:spPr>
        <p:txBody>
          <a:bodyPr wrap="square" rtlCol="0">
            <a:spAutoFit/>
          </a:bodyPr>
          <a:lstStyle/>
          <a:p>
            <a:pPr algn="r"/>
            <a:r>
              <a:rPr lang="en-GB" sz="1200" dirty="0">
                <a:solidFill>
                  <a:schemeClr val="bg1"/>
                </a:solidFill>
                <a:effectLst>
                  <a:outerShdw blurRad="38100" dist="38100" dir="2700000" algn="tl">
                    <a:srgbClr val="000000">
                      <a:alpha val="43137"/>
                    </a:srgbClr>
                  </a:outerShdw>
                </a:effectLst>
                <a:latin typeface="+mj-lt"/>
              </a:rPr>
              <a:t>Superficial sediments</a:t>
            </a:r>
          </a:p>
        </p:txBody>
      </p:sp>
      <p:sp>
        <p:nvSpPr>
          <p:cNvPr id="13" name="CuadroTexto 12">
            <a:extLst>
              <a:ext uri="{FF2B5EF4-FFF2-40B4-BE49-F238E27FC236}">
                <a16:creationId xmlns:a16="http://schemas.microsoft.com/office/drawing/2014/main" id="{2942AA86-A4D0-4C8D-B46B-11BA7FA21224}"/>
              </a:ext>
            </a:extLst>
          </p:cNvPr>
          <p:cNvSpPr txBox="1"/>
          <p:nvPr/>
        </p:nvSpPr>
        <p:spPr>
          <a:xfrm>
            <a:off x="5534057" y="2682414"/>
            <a:ext cx="1150143" cy="461665"/>
          </a:xfrm>
          <a:prstGeom prst="rect">
            <a:avLst/>
          </a:prstGeom>
          <a:noFill/>
        </p:spPr>
        <p:txBody>
          <a:bodyPr wrap="square" rtlCol="0">
            <a:spAutoFit/>
          </a:bodyPr>
          <a:lstStyle/>
          <a:p>
            <a:pPr algn="r"/>
            <a:r>
              <a:rPr lang="en-GB" sz="1200" dirty="0">
                <a:solidFill>
                  <a:schemeClr val="bg1"/>
                </a:solidFill>
                <a:effectLst>
                  <a:outerShdw blurRad="38100" dist="38100" dir="2700000" algn="tl">
                    <a:srgbClr val="000000">
                      <a:alpha val="43137"/>
                    </a:srgbClr>
                  </a:outerShdw>
                </a:effectLst>
                <a:latin typeface="+mj-lt"/>
              </a:rPr>
              <a:t>Carbonated layer</a:t>
            </a:r>
          </a:p>
        </p:txBody>
      </p:sp>
      <p:sp>
        <p:nvSpPr>
          <p:cNvPr id="14" name="CuadroTexto 13">
            <a:extLst>
              <a:ext uri="{FF2B5EF4-FFF2-40B4-BE49-F238E27FC236}">
                <a16:creationId xmlns:a16="http://schemas.microsoft.com/office/drawing/2014/main" id="{631191F1-150C-47BB-8C6A-8AC317E41FB5}"/>
              </a:ext>
            </a:extLst>
          </p:cNvPr>
          <p:cNvSpPr txBox="1"/>
          <p:nvPr/>
        </p:nvSpPr>
        <p:spPr>
          <a:xfrm>
            <a:off x="5534057" y="3589747"/>
            <a:ext cx="1150143" cy="276999"/>
          </a:xfrm>
          <a:prstGeom prst="rect">
            <a:avLst/>
          </a:prstGeom>
          <a:noFill/>
        </p:spPr>
        <p:txBody>
          <a:bodyPr wrap="square" rtlCol="0">
            <a:spAutoFit/>
          </a:bodyPr>
          <a:lstStyle/>
          <a:p>
            <a:pPr algn="r"/>
            <a:r>
              <a:rPr lang="en-GB" sz="1200" dirty="0">
                <a:solidFill>
                  <a:schemeClr val="bg1"/>
                </a:solidFill>
                <a:effectLst>
                  <a:outerShdw blurRad="38100" dist="38100" dir="2700000" algn="tl">
                    <a:srgbClr val="000000">
                      <a:alpha val="43137"/>
                    </a:srgbClr>
                  </a:outerShdw>
                </a:effectLst>
                <a:latin typeface="+mj-lt"/>
              </a:rPr>
              <a:t>Bedrock</a:t>
            </a:r>
          </a:p>
        </p:txBody>
      </p:sp>
    </p:spTree>
    <p:extLst>
      <p:ext uri="{BB962C8B-B14F-4D97-AF65-F5344CB8AC3E}">
        <p14:creationId xmlns:p14="http://schemas.microsoft.com/office/powerpoint/2010/main" val="1099329530"/>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4176098" y="544830"/>
            <a:ext cx="828432" cy="369332"/>
          </a:xfrm>
          <a:prstGeom prst="rect">
            <a:avLst/>
          </a:prstGeom>
          <a:noFill/>
        </p:spPr>
        <p:txBody>
          <a:bodyPr wrap="none" rtlCol="0">
            <a:spAutoFit/>
          </a:bodyPr>
          <a:lstStyle/>
          <a:p>
            <a:r>
              <a:rPr lang="en-GB" b="1" dirty="0">
                <a:latin typeface="+mj-lt"/>
              </a:rPr>
              <a:t>Fig. AQ</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922886" cy="338554"/>
          </a:xfrm>
          <a:prstGeom prst="rect">
            <a:avLst/>
          </a:prstGeom>
          <a:noFill/>
        </p:spPr>
        <p:txBody>
          <a:bodyPr wrap="none" rtlCol="0">
            <a:spAutoFit/>
          </a:bodyPr>
          <a:lstStyle/>
          <a:p>
            <a:r>
              <a:rPr lang="en-GB" sz="1600" b="1" dirty="0">
                <a:latin typeface="+mj-lt"/>
              </a:rPr>
              <a:t>Supporting Information 1 – Excavation of the upper test pit</a:t>
            </a:r>
          </a:p>
        </p:txBody>
      </p:sp>
      <p:pic>
        <p:nvPicPr>
          <p:cNvPr id="3" name="Imagen 2" descr="Imagen que contiene rock, cueva, naturaleza&#10;&#10;Descripción generada automáticamente">
            <a:extLst>
              <a:ext uri="{FF2B5EF4-FFF2-40B4-BE49-F238E27FC236}">
                <a16:creationId xmlns:a16="http://schemas.microsoft.com/office/drawing/2014/main" id="{5C6F3008-949E-4471-8863-E7F14E2CBCAB}"/>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09787" y="817293"/>
            <a:ext cx="3858364" cy="5763728"/>
          </a:xfrm>
          <a:prstGeom prst="rect">
            <a:avLst/>
          </a:prstGeom>
        </p:spPr>
      </p:pic>
      <p:pic>
        <p:nvPicPr>
          <p:cNvPr id="8" name="Imagen 7" descr="Imagen que contiene suelo, rock, exterior&#10;&#10;Descripción generada automáticamente">
            <a:extLst>
              <a:ext uri="{FF2B5EF4-FFF2-40B4-BE49-F238E27FC236}">
                <a16:creationId xmlns:a16="http://schemas.microsoft.com/office/drawing/2014/main" id="{6EC943B3-F34A-447C-A08E-4F0E3DE47AD7}"/>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4572242" y="2175789"/>
            <a:ext cx="6625468" cy="4405231"/>
          </a:xfrm>
          <a:prstGeom prst="rect">
            <a:avLst/>
          </a:prstGeom>
        </p:spPr>
      </p:pic>
      <p:sp>
        <p:nvSpPr>
          <p:cNvPr id="9" name="CuadroTexto 8">
            <a:extLst>
              <a:ext uri="{FF2B5EF4-FFF2-40B4-BE49-F238E27FC236}">
                <a16:creationId xmlns:a16="http://schemas.microsoft.com/office/drawing/2014/main" id="{0981753A-0D42-4CF9-A501-675A0578C2F3}"/>
              </a:ext>
            </a:extLst>
          </p:cNvPr>
          <p:cNvSpPr txBox="1"/>
          <p:nvPr/>
        </p:nvSpPr>
        <p:spPr>
          <a:xfrm>
            <a:off x="4176098" y="1120438"/>
            <a:ext cx="7021612" cy="954107"/>
          </a:xfrm>
          <a:prstGeom prst="rect">
            <a:avLst/>
          </a:prstGeom>
          <a:noFill/>
        </p:spPr>
        <p:txBody>
          <a:bodyPr wrap="square" rtlCol="0">
            <a:spAutoFit/>
          </a:bodyPr>
          <a:lstStyle/>
          <a:p>
            <a:pPr algn="just"/>
            <a:r>
              <a:rPr lang="en-GB" sz="1400" dirty="0"/>
              <a:t>View of the upper test pit on the travertine slope leading to the Upper Entrance, visible in Fig. 43a. Below the travertines the </a:t>
            </a:r>
            <a:r>
              <a:rPr lang="en-GB" sz="1400" dirty="0" err="1"/>
              <a:t>archeo</a:t>
            </a:r>
            <a:r>
              <a:rPr lang="en-GB" sz="1400" dirty="0"/>
              <a:t>-paleontological unit documented.</a:t>
            </a:r>
          </a:p>
          <a:p>
            <a:pPr algn="just"/>
            <a:endParaRPr lang="en-GB" sz="1400" dirty="0"/>
          </a:p>
          <a:p>
            <a:pPr algn="just"/>
            <a:r>
              <a:rPr lang="en-GB" sz="1400" dirty="0"/>
              <a:t>Photo 2006</a:t>
            </a:r>
          </a:p>
        </p:txBody>
      </p:sp>
      <p:sp>
        <p:nvSpPr>
          <p:cNvPr id="10" name="CuadroTexto 9">
            <a:extLst>
              <a:ext uri="{FF2B5EF4-FFF2-40B4-BE49-F238E27FC236}">
                <a16:creationId xmlns:a16="http://schemas.microsoft.com/office/drawing/2014/main" id="{45875173-497E-4728-B1D9-7BD8087A2752}"/>
              </a:ext>
            </a:extLst>
          </p:cNvPr>
          <p:cNvSpPr txBox="1"/>
          <p:nvPr/>
        </p:nvSpPr>
        <p:spPr>
          <a:xfrm>
            <a:off x="109787" y="447961"/>
            <a:ext cx="425051" cy="369332"/>
          </a:xfrm>
          <a:prstGeom prst="rect">
            <a:avLst/>
          </a:prstGeom>
          <a:noFill/>
        </p:spPr>
        <p:txBody>
          <a:bodyPr wrap="square" rtlCol="0">
            <a:spAutoFit/>
          </a:bodyPr>
          <a:lstStyle/>
          <a:p>
            <a:r>
              <a:rPr lang="en-GB" b="1" dirty="0">
                <a:latin typeface="+mj-lt"/>
              </a:rPr>
              <a:t>a)</a:t>
            </a:r>
          </a:p>
        </p:txBody>
      </p:sp>
      <p:sp>
        <p:nvSpPr>
          <p:cNvPr id="11" name="CuadroTexto 10">
            <a:extLst>
              <a:ext uri="{FF2B5EF4-FFF2-40B4-BE49-F238E27FC236}">
                <a16:creationId xmlns:a16="http://schemas.microsoft.com/office/drawing/2014/main" id="{89D06B29-3E48-4FB5-ADDE-0998D8603A46}"/>
              </a:ext>
            </a:extLst>
          </p:cNvPr>
          <p:cNvSpPr txBox="1"/>
          <p:nvPr/>
        </p:nvSpPr>
        <p:spPr>
          <a:xfrm>
            <a:off x="4176098" y="2175789"/>
            <a:ext cx="480108" cy="369332"/>
          </a:xfrm>
          <a:prstGeom prst="rect">
            <a:avLst/>
          </a:prstGeom>
          <a:noFill/>
        </p:spPr>
        <p:txBody>
          <a:bodyPr wrap="square" rtlCol="0">
            <a:spAutoFit/>
          </a:bodyPr>
          <a:lstStyle/>
          <a:p>
            <a:r>
              <a:rPr lang="en-GB" dirty="0"/>
              <a:t>b)</a:t>
            </a:r>
          </a:p>
        </p:txBody>
      </p:sp>
      <p:cxnSp>
        <p:nvCxnSpPr>
          <p:cNvPr id="12" name="Conector recto 11">
            <a:extLst>
              <a:ext uri="{FF2B5EF4-FFF2-40B4-BE49-F238E27FC236}">
                <a16:creationId xmlns:a16="http://schemas.microsoft.com/office/drawing/2014/main" id="{0812B251-DCF2-4E4D-8480-C40CC654686F}"/>
              </a:ext>
            </a:extLst>
          </p:cNvPr>
          <p:cNvCxnSpPr>
            <a:cxnSpLocks/>
          </p:cNvCxnSpPr>
          <p:nvPr/>
        </p:nvCxnSpPr>
        <p:spPr>
          <a:xfrm>
            <a:off x="4261448" y="1011968"/>
            <a:ext cx="6806243"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3" name="Marcador de número de diapositiva 1">
            <a:extLst>
              <a:ext uri="{FF2B5EF4-FFF2-40B4-BE49-F238E27FC236}">
                <a16:creationId xmlns:a16="http://schemas.microsoft.com/office/drawing/2014/main" id="{42672886-5704-4B05-8F75-A7119B6F0CFD}"/>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43</a:t>
            </a:fld>
            <a:endParaRPr lang="en-GB" sz="1800" dirty="0">
              <a:latin typeface="+mj-lt"/>
            </a:endParaRPr>
          </a:p>
        </p:txBody>
      </p:sp>
    </p:spTree>
    <p:extLst>
      <p:ext uri="{BB962C8B-B14F-4D97-AF65-F5344CB8AC3E}">
        <p14:creationId xmlns:p14="http://schemas.microsoft.com/office/powerpoint/2010/main" val="763850688"/>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4648740" y="711889"/>
            <a:ext cx="800219" cy="369332"/>
          </a:xfrm>
          <a:prstGeom prst="rect">
            <a:avLst/>
          </a:prstGeom>
          <a:noFill/>
        </p:spPr>
        <p:txBody>
          <a:bodyPr wrap="none" rtlCol="0">
            <a:spAutoFit/>
          </a:bodyPr>
          <a:lstStyle/>
          <a:p>
            <a:r>
              <a:rPr lang="en-GB" b="1" dirty="0">
                <a:latin typeface="+mj-lt"/>
              </a:rPr>
              <a:t>Fig. AR</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532" y="0"/>
            <a:ext cx="4922886" cy="338554"/>
          </a:xfrm>
          <a:prstGeom prst="rect">
            <a:avLst/>
          </a:prstGeom>
          <a:noFill/>
        </p:spPr>
        <p:txBody>
          <a:bodyPr wrap="none" rtlCol="0">
            <a:spAutoFit/>
          </a:bodyPr>
          <a:lstStyle/>
          <a:p>
            <a:r>
              <a:rPr lang="en-GB" sz="1600" b="1" dirty="0">
                <a:latin typeface="+mj-lt"/>
              </a:rPr>
              <a:t>Supporting Information 1 – Excavation of the upper test pit</a:t>
            </a:r>
          </a:p>
        </p:txBody>
      </p:sp>
      <p:pic>
        <p:nvPicPr>
          <p:cNvPr id="4" name="Imagen 3" descr="Imagen que contiene rock, exterior, naturaleza&#10;&#10;Descripción generada automáticamente">
            <a:extLst>
              <a:ext uri="{FF2B5EF4-FFF2-40B4-BE49-F238E27FC236}">
                <a16:creationId xmlns:a16="http://schemas.microsoft.com/office/drawing/2014/main" id="{D4B8587A-AAC7-4847-8AA6-C3BDD6C051AA}"/>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rot="16200000">
            <a:off x="-902605" y="1499116"/>
            <a:ext cx="6289067" cy="4177067"/>
          </a:xfrm>
          <a:prstGeom prst="rect">
            <a:avLst/>
          </a:prstGeom>
        </p:spPr>
      </p:pic>
      <p:sp>
        <p:nvSpPr>
          <p:cNvPr id="9" name="CuadroTexto 8">
            <a:extLst>
              <a:ext uri="{FF2B5EF4-FFF2-40B4-BE49-F238E27FC236}">
                <a16:creationId xmlns:a16="http://schemas.microsoft.com/office/drawing/2014/main" id="{16D7E6A9-FA7E-4302-9B84-051B18617E98}"/>
              </a:ext>
            </a:extLst>
          </p:cNvPr>
          <p:cNvSpPr txBox="1"/>
          <p:nvPr/>
        </p:nvSpPr>
        <p:spPr>
          <a:xfrm>
            <a:off x="4648740" y="1330023"/>
            <a:ext cx="6822953" cy="2462213"/>
          </a:xfrm>
          <a:prstGeom prst="rect">
            <a:avLst/>
          </a:prstGeom>
          <a:noFill/>
        </p:spPr>
        <p:txBody>
          <a:bodyPr wrap="square" rtlCol="0">
            <a:spAutoFit/>
          </a:bodyPr>
          <a:lstStyle/>
          <a:p>
            <a:pPr algn="just"/>
            <a:r>
              <a:rPr lang="en-GB" sz="1400" dirty="0"/>
              <a:t>The excavation of the upper test pit was started over in 2017 together with the exploration of the Upper Entrance. </a:t>
            </a:r>
          </a:p>
          <a:p>
            <a:pPr algn="just"/>
            <a:endParaRPr lang="en-GB" sz="1400" dirty="0"/>
          </a:p>
          <a:p>
            <a:pPr algn="just"/>
            <a:r>
              <a:rPr lang="en-GB" sz="1400" dirty="0"/>
              <a:t>The 2006 – 2007 excavation of this area reported mainly remains of lynx together with thousands of rabbit and bird remains indicating the use of this space as a lynx den. During the excavation several anthropogenic remains were recovered, including some burned bones and lithic remains. </a:t>
            </a:r>
          </a:p>
          <a:p>
            <a:pPr algn="just"/>
            <a:endParaRPr lang="en-GB" sz="1400" dirty="0"/>
          </a:p>
          <a:p>
            <a:pPr algn="just"/>
            <a:r>
              <a:rPr lang="en-GB" sz="1400" dirty="0"/>
              <a:t>The chronology of this deposit is still unknown.</a:t>
            </a:r>
          </a:p>
          <a:p>
            <a:pPr algn="just"/>
            <a:endParaRPr lang="en-GB" sz="1400" dirty="0"/>
          </a:p>
          <a:p>
            <a:pPr algn="just"/>
            <a:r>
              <a:rPr lang="en-GB" sz="1400" dirty="0"/>
              <a:t>Photo 2017</a:t>
            </a:r>
          </a:p>
        </p:txBody>
      </p:sp>
      <p:sp>
        <p:nvSpPr>
          <p:cNvPr id="8" name="Marcador de número de diapositiva 1">
            <a:extLst>
              <a:ext uri="{FF2B5EF4-FFF2-40B4-BE49-F238E27FC236}">
                <a16:creationId xmlns:a16="http://schemas.microsoft.com/office/drawing/2014/main" id="{06787BD6-E0C3-4AAC-A06E-684AC025AACE}"/>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44</a:t>
            </a:fld>
            <a:endParaRPr lang="en-GB" sz="1800" dirty="0">
              <a:latin typeface="+mj-lt"/>
            </a:endParaRPr>
          </a:p>
        </p:txBody>
      </p:sp>
      <p:cxnSp>
        <p:nvCxnSpPr>
          <p:cNvPr id="10" name="Conector recto 9">
            <a:extLst>
              <a:ext uri="{FF2B5EF4-FFF2-40B4-BE49-F238E27FC236}">
                <a16:creationId xmlns:a16="http://schemas.microsoft.com/office/drawing/2014/main" id="{40627A17-3B33-4DF6-9655-97C7B9CA42D5}"/>
              </a:ext>
            </a:extLst>
          </p:cNvPr>
          <p:cNvCxnSpPr>
            <a:cxnSpLocks/>
          </p:cNvCxnSpPr>
          <p:nvPr/>
        </p:nvCxnSpPr>
        <p:spPr>
          <a:xfrm>
            <a:off x="4724153" y="1201750"/>
            <a:ext cx="6619583"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884365357"/>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54476" y="563880"/>
            <a:ext cx="782587" cy="369332"/>
          </a:xfrm>
          <a:prstGeom prst="rect">
            <a:avLst/>
          </a:prstGeom>
          <a:noFill/>
        </p:spPr>
        <p:txBody>
          <a:bodyPr wrap="none" rtlCol="0">
            <a:spAutoFit/>
          </a:bodyPr>
          <a:lstStyle/>
          <a:p>
            <a:r>
              <a:rPr lang="en-GB" b="1" dirty="0">
                <a:latin typeface="+mj-lt"/>
              </a:rPr>
              <a:t>Fig. AS</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5096075" cy="338554"/>
          </a:xfrm>
          <a:prstGeom prst="rect">
            <a:avLst/>
          </a:prstGeom>
          <a:noFill/>
        </p:spPr>
        <p:txBody>
          <a:bodyPr wrap="none" rtlCol="0">
            <a:spAutoFit/>
          </a:bodyPr>
          <a:lstStyle/>
          <a:p>
            <a:r>
              <a:rPr lang="en-GB" sz="1600" b="1" dirty="0">
                <a:latin typeface="+mj-lt"/>
              </a:rPr>
              <a:t>Supporting Information 1 – Excavation of the Upper Entrance</a:t>
            </a:r>
          </a:p>
        </p:txBody>
      </p:sp>
      <p:pic>
        <p:nvPicPr>
          <p:cNvPr id="3" name="Imagen 2" descr="Imagen que contiene árbol, exterior, hierba, animal&#10;&#10;Descripción generada automáticamente">
            <a:extLst>
              <a:ext uri="{FF2B5EF4-FFF2-40B4-BE49-F238E27FC236}">
                <a16:creationId xmlns:a16="http://schemas.microsoft.com/office/drawing/2014/main" id="{0E02B3D0-EB94-41C7-83A5-700FAD8198F6}"/>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689" y="563880"/>
            <a:ext cx="8721247" cy="5792470"/>
          </a:xfrm>
          <a:prstGeom prst="rect">
            <a:avLst/>
          </a:prstGeom>
        </p:spPr>
      </p:pic>
      <p:sp>
        <p:nvSpPr>
          <p:cNvPr id="9" name="CuadroTexto 8">
            <a:extLst>
              <a:ext uri="{FF2B5EF4-FFF2-40B4-BE49-F238E27FC236}">
                <a16:creationId xmlns:a16="http://schemas.microsoft.com/office/drawing/2014/main" id="{877F6B3A-E689-45DC-B284-585BE4A68C4B}"/>
              </a:ext>
            </a:extLst>
          </p:cNvPr>
          <p:cNvSpPr txBox="1"/>
          <p:nvPr/>
        </p:nvSpPr>
        <p:spPr>
          <a:xfrm>
            <a:off x="9054476" y="1200628"/>
            <a:ext cx="2743200" cy="1384995"/>
          </a:xfrm>
          <a:prstGeom prst="rect">
            <a:avLst/>
          </a:prstGeom>
          <a:noFill/>
        </p:spPr>
        <p:txBody>
          <a:bodyPr wrap="square" rtlCol="0">
            <a:spAutoFit/>
          </a:bodyPr>
          <a:lstStyle/>
          <a:p>
            <a:pPr algn="just"/>
            <a:r>
              <a:rPr lang="en-GB" sz="1400" dirty="0"/>
              <a:t>View of the Upper Entrance of the cave leading to the travertine platform after clearing the vegetation.</a:t>
            </a:r>
          </a:p>
          <a:p>
            <a:pPr algn="just"/>
            <a:endParaRPr lang="en-GB" sz="1400" dirty="0"/>
          </a:p>
          <a:p>
            <a:pPr algn="just"/>
            <a:r>
              <a:rPr lang="en-GB" sz="1400" dirty="0"/>
              <a:t>Photo 2017</a:t>
            </a:r>
          </a:p>
        </p:txBody>
      </p:sp>
      <p:cxnSp>
        <p:nvCxnSpPr>
          <p:cNvPr id="8" name="Conector recto 7">
            <a:extLst>
              <a:ext uri="{FF2B5EF4-FFF2-40B4-BE49-F238E27FC236}">
                <a16:creationId xmlns:a16="http://schemas.microsoft.com/office/drawing/2014/main" id="{256078D3-33A4-41DA-A447-8FA330D8E9D8}"/>
              </a:ext>
            </a:extLst>
          </p:cNvPr>
          <p:cNvCxnSpPr>
            <a:cxnSpLocks/>
          </p:cNvCxnSpPr>
          <p:nvPr/>
        </p:nvCxnSpPr>
        <p:spPr>
          <a:xfrm>
            <a:off x="9118121" y="1055100"/>
            <a:ext cx="2587924"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7FA25657-6C1A-4C80-9976-BC46596CA20F}"/>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45</a:t>
            </a:fld>
            <a:endParaRPr lang="en-GB" sz="1800" dirty="0">
              <a:latin typeface="+mj-lt"/>
            </a:endParaRPr>
          </a:p>
        </p:txBody>
      </p:sp>
    </p:spTree>
    <p:extLst>
      <p:ext uri="{BB962C8B-B14F-4D97-AF65-F5344CB8AC3E}">
        <p14:creationId xmlns:p14="http://schemas.microsoft.com/office/powerpoint/2010/main" val="1605343243"/>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8950960" y="520185"/>
            <a:ext cx="770980" cy="369332"/>
          </a:xfrm>
          <a:prstGeom prst="rect">
            <a:avLst/>
          </a:prstGeom>
          <a:noFill/>
        </p:spPr>
        <p:txBody>
          <a:bodyPr wrap="none" rtlCol="0">
            <a:spAutoFit/>
          </a:bodyPr>
          <a:lstStyle/>
          <a:p>
            <a:r>
              <a:rPr lang="en-GB" b="1" dirty="0">
                <a:latin typeface="+mj-lt"/>
              </a:rPr>
              <a:t>Fig. AT</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5096075" cy="338554"/>
          </a:xfrm>
          <a:prstGeom prst="rect">
            <a:avLst/>
          </a:prstGeom>
          <a:noFill/>
        </p:spPr>
        <p:txBody>
          <a:bodyPr wrap="none" rtlCol="0">
            <a:spAutoFit/>
          </a:bodyPr>
          <a:lstStyle/>
          <a:p>
            <a:r>
              <a:rPr lang="en-GB" sz="1600" b="1" dirty="0">
                <a:latin typeface="+mj-lt"/>
              </a:rPr>
              <a:t>Supporting Information 1 – Excavation of the Upper Entrance</a:t>
            </a:r>
          </a:p>
        </p:txBody>
      </p:sp>
      <p:pic>
        <p:nvPicPr>
          <p:cNvPr id="4" name="Imagen 3" descr="Imagen que contiene rock, exterior, rocoso, naturaleza&#10;&#10;Descripción generada automáticamente">
            <a:extLst>
              <a:ext uri="{FF2B5EF4-FFF2-40B4-BE49-F238E27FC236}">
                <a16:creationId xmlns:a16="http://schemas.microsoft.com/office/drawing/2014/main" id="{2B30E957-0296-4BC4-B4B1-B375313B4E7D}"/>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rot="16200000">
            <a:off x="-722242" y="1550737"/>
            <a:ext cx="6137500" cy="4076399"/>
          </a:xfrm>
          <a:prstGeom prst="rect">
            <a:avLst/>
          </a:prstGeom>
        </p:spPr>
      </p:pic>
      <p:pic>
        <p:nvPicPr>
          <p:cNvPr id="8" name="Imagen 7" descr="Imagen que contiene rock, exterior, árbol, suelo&#10;&#10;Descripción generada automáticamente">
            <a:extLst>
              <a:ext uri="{FF2B5EF4-FFF2-40B4-BE49-F238E27FC236}">
                <a16:creationId xmlns:a16="http://schemas.microsoft.com/office/drawing/2014/main" id="{D3072460-E821-4D22-922B-6D5EE6E05901}"/>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rot="16200000">
            <a:off x="3738045" y="1550736"/>
            <a:ext cx="6137501" cy="4076400"/>
          </a:xfrm>
          <a:prstGeom prst="rect">
            <a:avLst/>
          </a:prstGeom>
        </p:spPr>
      </p:pic>
      <p:sp>
        <p:nvSpPr>
          <p:cNvPr id="9" name="CuadroTexto 8">
            <a:extLst>
              <a:ext uri="{FF2B5EF4-FFF2-40B4-BE49-F238E27FC236}">
                <a16:creationId xmlns:a16="http://schemas.microsoft.com/office/drawing/2014/main" id="{20F1951C-AAC5-4D70-A6A2-A39579AFC792}"/>
              </a:ext>
            </a:extLst>
          </p:cNvPr>
          <p:cNvSpPr txBox="1"/>
          <p:nvPr/>
        </p:nvSpPr>
        <p:spPr>
          <a:xfrm>
            <a:off x="8950960" y="1080037"/>
            <a:ext cx="3082889" cy="1384995"/>
          </a:xfrm>
          <a:prstGeom prst="rect">
            <a:avLst/>
          </a:prstGeom>
          <a:noFill/>
        </p:spPr>
        <p:txBody>
          <a:bodyPr wrap="square" rtlCol="0">
            <a:spAutoFit/>
          </a:bodyPr>
          <a:lstStyle/>
          <a:p>
            <a:pPr algn="just"/>
            <a:r>
              <a:rPr lang="en-GB" sz="1400" dirty="0"/>
              <a:t>Large rockfall documented in front of the Upper Entrance presumably related to an ancient collapse of a larger entrance.</a:t>
            </a:r>
          </a:p>
          <a:p>
            <a:pPr algn="just"/>
            <a:endParaRPr lang="en-GB" sz="1400" dirty="0"/>
          </a:p>
          <a:p>
            <a:pPr algn="just"/>
            <a:r>
              <a:rPr lang="en-GB" sz="1400" dirty="0"/>
              <a:t>Photo 2017</a:t>
            </a:r>
          </a:p>
        </p:txBody>
      </p:sp>
      <p:sp>
        <p:nvSpPr>
          <p:cNvPr id="10" name="CuadroTexto 9">
            <a:extLst>
              <a:ext uri="{FF2B5EF4-FFF2-40B4-BE49-F238E27FC236}">
                <a16:creationId xmlns:a16="http://schemas.microsoft.com/office/drawing/2014/main" id="{FB2B3B35-0C82-4B59-9E60-8A2BB8681DE7}"/>
              </a:ext>
            </a:extLst>
          </p:cNvPr>
          <p:cNvSpPr txBox="1"/>
          <p:nvPr/>
        </p:nvSpPr>
        <p:spPr>
          <a:xfrm>
            <a:off x="0" y="520185"/>
            <a:ext cx="365806" cy="369332"/>
          </a:xfrm>
          <a:prstGeom prst="rect">
            <a:avLst/>
          </a:prstGeom>
          <a:noFill/>
        </p:spPr>
        <p:txBody>
          <a:bodyPr wrap="none" rtlCol="0">
            <a:spAutoFit/>
          </a:bodyPr>
          <a:lstStyle/>
          <a:p>
            <a:r>
              <a:rPr lang="en-GB" b="1" dirty="0">
                <a:latin typeface="+mj-lt"/>
              </a:rPr>
              <a:t>a)</a:t>
            </a:r>
          </a:p>
        </p:txBody>
      </p:sp>
      <p:sp>
        <p:nvSpPr>
          <p:cNvPr id="11" name="CuadroTexto 10">
            <a:extLst>
              <a:ext uri="{FF2B5EF4-FFF2-40B4-BE49-F238E27FC236}">
                <a16:creationId xmlns:a16="http://schemas.microsoft.com/office/drawing/2014/main" id="{0636E990-A41C-459E-A11B-335B7C607036}"/>
              </a:ext>
            </a:extLst>
          </p:cNvPr>
          <p:cNvSpPr txBox="1"/>
          <p:nvPr/>
        </p:nvSpPr>
        <p:spPr>
          <a:xfrm>
            <a:off x="4454398" y="520185"/>
            <a:ext cx="377026" cy="369332"/>
          </a:xfrm>
          <a:prstGeom prst="rect">
            <a:avLst/>
          </a:prstGeom>
          <a:noFill/>
        </p:spPr>
        <p:txBody>
          <a:bodyPr wrap="none" rtlCol="0">
            <a:spAutoFit/>
          </a:bodyPr>
          <a:lstStyle/>
          <a:p>
            <a:r>
              <a:rPr lang="en-GB" b="1" dirty="0">
                <a:latin typeface="+mj-lt"/>
              </a:rPr>
              <a:t>b)</a:t>
            </a:r>
          </a:p>
        </p:txBody>
      </p:sp>
      <p:sp>
        <p:nvSpPr>
          <p:cNvPr id="12" name="Marcador de número de diapositiva 1">
            <a:extLst>
              <a:ext uri="{FF2B5EF4-FFF2-40B4-BE49-F238E27FC236}">
                <a16:creationId xmlns:a16="http://schemas.microsoft.com/office/drawing/2014/main" id="{45DB0502-9C8B-4EFC-B62B-70094DE09A78}"/>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46</a:t>
            </a:fld>
            <a:endParaRPr lang="en-GB" sz="1800" dirty="0">
              <a:latin typeface="+mj-lt"/>
            </a:endParaRPr>
          </a:p>
        </p:txBody>
      </p:sp>
      <p:cxnSp>
        <p:nvCxnSpPr>
          <p:cNvPr id="13" name="Conector recto 12">
            <a:extLst>
              <a:ext uri="{FF2B5EF4-FFF2-40B4-BE49-F238E27FC236}">
                <a16:creationId xmlns:a16="http://schemas.microsoft.com/office/drawing/2014/main" id="{1EFBF37F-2B43-49DD-BF65-F03DF882F61F}"/>
              </a:ext>
            </a:extLst>
          </p:cNvPr>
          <p:cNvCxnSpPr>
            <a:cxnSpLocks/>
          </p:cNvCxnSpPr>
          <p:nvPr/>
        </p:nvCxnSpPr>
        <p:spPr>
          <a:xfrm>
            <a:off x="9031857" y="1003344"/>
            <a:ext cx="2898475"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990729078"/>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magen 8" descr="Imagen que contiene rock, exterior, rocoso, naturaleza&#10;&#10;Descripción generada automáticamente">
            <a:extLst>
              <a:ext uri="{FF2B5EF4-FFF2-40B4-BE49-F238E27FC236}">
                <a16:creationId xmlns:a16="http://schemas.microsoft.com/office/drawing/2014/main" id="{B0271AAD-030F-46FE-B049-4898A6887D22}"/>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6831389" y="3297595"/>
            <a:ext cx="5360610" cy="3560405"/>
          </a:xfrm>
          <a:prstGeom prst="rect">
            <a:avLst/>
          </a:prstGeom>
        </p:spPr>
      </p:pic>
      <p:sp>
        <p:nvSpPr>
          <p:cNvPr id="6" name="CuadroTexto 5">
            <a:extLst>
              <a:ext uri="{FF2B5EF4-FFF2-40B4-BE49-F238E27FC236}">
                <a16:creationId xmlns:a16="http://schemas.microsoft.com/office/drawing/2014/main" id="{74AF234C-E168-4284-B2E9-FEA4C9837CB3}"/>
              </a:ext>
            </a:extLst>
          </p:cNvPr>
          <p:cNvSpPr txBox="1"/>
          <p:nvPr/>
        </p:nvSpPr>
        <p:spPr>
          <a:xfrm>
            <a:off x="6951383" y="480089"/>
            <a:ext cx="839910" cy="369332"/>
          </a:xfrm>
          <a:prstGeom prst="rect">
            <a:avLst/>
          </a:prstGeom>
          <a:noFill/>
        </p:spPr>
        <p:txBody>
          <a:bodyPr wrap="none" rtlCol="0">
            <a:spAutoFit/>
          </a:bodyPr>
          <a:lstStyle/>
          <a:p>
            <a:r>
              <a:rPr lang="en-GB" dirty="0"/>
              <a:t>Fig. AU</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5096075" cy="338554"/>
          </a:xfrm>
          <a:prstGeom prst="rect">
            <a:avLst/>
          </a:prstGeom>
          <a:noFill/>
        </p:spPr>
        <p:txBody>
          <a:bodyPr wrap="none" rtlCol="0">
            <a:spAutoFit/>
          </a:bodyPr>
          <a:lstStyle/>
          <a:p>
            <a:r>
              <a:rPr lang="en-GB" sz="1600" b="1" dirty="0">
                <a:latin typeface="+mj-lt"/>
              </a:rPr>
              <a:t>Supporting Information 1 – Excavation of the Upper Entrance</a:t>
            </a:r>
          </a:p>
        </p:txBody>
      </p:sp>
      <p:pic>
        <p:nvPicPr>
          <p:cNvPr id="3" name="Imagen 2" descr="Imagen que contiene árbol, rock, exterior, suelo&#10;&#10;Descripción generada automáticamente">
            <a:extLst>
              <a:ext uri="{FF2B5EF4-FFF2-40B4-BE49-F238E27FC236}">
                <a16:creationId xmlns:a16="http://schemas.microsoft.com/office/drawing/2014/main" id="{9E62EA8B-824B-4822-A76B-7F3E5C378310}"/>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25331" y="689515"/>
            <a:ext cx="6806057" cy="4520441"/>
          </a:xfrm>
          <a:prstGeom prst="rect">
            <a:avLst/>
          </a:prstGeom>
        </p:spPr>
      </p:pic>
      <p:sp>
        <p:nvSpPr>
          <p:cNvPr id="10" name="CuadroTexto 9">
            <a:extLst>
              <a:ext uri="{FF2B5EF4-FFF2-40B4-BE49-F238E27FC236}">
                <a16:creationId xmlns:a16="http://schemas.microsoft.com/office/drawing/2014/main" id="{C420651C-9D4E-4C3F-BC35-13B3E78338FD}"/>
              </a:ext>
            </a:extLst>
          </p:cNvPr>
          <p:cNvSpPr txBox="1"/>
          <p:nvPr/>
        </p:nvSpPr>
        <p:spPr>
          <a:xfrm>
            <a:off x="25331" y="338554"/>
            <a:ext cx="365806" cy="369332"/>
          </a:xfrm>
          <a:prstGeom prst="rect">
            <a:avLst/>
          </a:prstGeom>
          <a:noFill/>
        </p:spPr>
        <p:txBody>
          <a:bodyPr wrap="none" rtlCol="0">
            <a:spAutoFit/>
          </a:bodyPr>
          <a:lstStyle/>
          <a:p>
            <a:r>
              <a:rPr lang="en-GB" dirty="0"/>
              <a:t>a)</a:t>
            </a:r>
          </a:p>
        </p:txBody>
      </p:sp>
      <p:sp>
        <p:nvSpPr>
          <p:cNvPr id="11" name="CuadroTexto 10">
            <a:extLst>
              <a:ext uri="{FF2B5EF4-FFF2-40B4-BE49-F238E27FC236}">
                <a16:creationId xmlns:a16="http://schemas.microsoft.com/office/drawing/2014/main" id="{6CDEC527-AEA4-4C91-AD16-986A7B4586E1}"/>
              </a:ext>
            </a:extLst>
          </p:cNvPr>
          <p:cNvSpPr txBox="1"/>
          <p:nvPr/>
        </p:nvSpPr>
        <p:spPr>
          <a:xfrm>
            <a:off x="6454363" y="5284551"/>
            <a:ext cx="377026" cy="369332"/>
          </a:xfrm>
          <a:prstGeom prst="rect">
            <a:avLst/>
          </a:prstGeom>
          <a:noFill/>
        </p:spPr>
        <p:txBody>
          <a:bodyPr wrap="none" rtlCol="0">
            <a:spAutoFit/>
          </a:bodyPr>
          <a:lstStyle/>
          <a:p>
            <a:r>
              <a:rPr lang="en-GB" dirty="0"/>
              <a:t>b)</a:t>
            </a:r>
          </a:p>
        </p:txBody>
      </p:sp>
      <p:sp>
        <p:nvSpPr>
          <p:cNvPr id="12" name="CuadroTexto 11">
            <a:extLst>
              <a:ext uri="{FF2B5EF4-FFF2-40B4-BE49-F238E27FC236}">
                <a16:creationId xmlns:a16="http://schemas.microsoft.com/office/drawing/2014/main" id="{81BE89C7-89CA-430E-82E1-745377F58AB4}"/>
              </a:ext>
            </a:extLst>
          </p:cNvPr>
          <p:cNvSpPr txBox="1"/>
          <p:nvPr/>
        </p:nvSpPr>
        <p:spPr>
          <a:xfrm>
            <a:off x="6951383" y="921195"/>
            <a:ext cx="5120621" cy="2246769"/>
          </a:xfrm>
          <a:prstGeom prst="rect">
            <a:avLst/>
          </a:prstGeom>
          <a:noFill/>
        </p:spPr>
        <p:txBody>
          <a:bodyPr wrap="square" rtlCol="0">
            <a:spAutoFit/>
          </a:bodyPr>
          <a:lstStyle/>
          <a:p>
            <a:pPr algn="just"/>
            <a:r>
              <a:rPr lang="en-GB" sz="1400" dirty="0"/>
              <a:t>Expanding the excavation of the Upper Entrance lead to document more large boulders and even documenting the continuity of the inner travertine slope outside the actual cavity. </a:t>
            </a:r>
          </a:p>
          <a:p>
            <a:pPr algn="just"/>
            <a:endParaRPr lang="en-GB" sz="1400" dirty="0"/>
          </a:p>
          <a:p>
            <a:pPr algn="just"/>
            <a:r>
              <a:rPr lang="en-GB" sz="1400" dirty="0"/>
              <a:t>No fieldwork was done in 2018 to finish the studies of the 2013 – 2017 excavation period. Fieldwork season in 2019 will be focused in this sector of the cave to detect if sealed galleries containing archaeological sequence exist below the travertine formation</a:t>
            </a:r>
          </a:p>
          <a:p>
            <a:pPr algn="just"/>
            <a:endParaRPr lang="en-GB" sz="1400" dirty="0"/>
          </a:p>
          <a:p>
            <a:pPr algn="just"/>
            <a:r>
              <a:rPr lang="en-GB" sz="1400" dirty="0"/>
              <a:t>Photo 2017</a:t>
            </a:r>
          </a:p>
        </p:txBody>
      </p:sp>
      <p:sp>
        <p:nvSpPr>
          <p:cNvPr id="13" name="CuadroTexto 12">
            <a:extLst>
              <a:ext uri="{FF2B5EF4-FFF2-40B4-BE49-F238E27FC236}">
                <a16:creationId xmlns:a16="http://schemas.microsoft.com/office/drawing/2014/main" id="{EBE4BA38-1600-4D87-A3A4-4534CBD9C640}"/>
              </a:ext>
            </a:extLst>
          </p:cNvPr>
          <p:cNvSpPr txBox="1"/>
          <p:nvPr/>
        </p:nvSpPr>
        <p:spPr>
          <a:xfrm>
            <a:off x="1678014" y="5653883"/>
            <a:ext cx="4711829" cy="1169551"/>
          </a:xfrm>
          <a:prstGeom prst="rect">
            <a:avLst/>
          </a:prstGeom>
          <a:noFill/>
        </p:spPr>
        <p:txBody>
          <a:bodyPr wrap="square" rtlCol="0">
            <a:spAutoFit/>
          </a:bodyPr>
          <a:lstStyle/>
          <a:p>
            <a:pPr algn="just"/>
            <a:r>
              <a:rPr lang="en-GB" sz="1400" dirty="0"/>
              <a:t>View of the travertine slope from the upper test pit facing outwards. The continuity of the travertines to the exterior of the cave can be seen below the two boulders of the entrance.</a:t>
            </a:r>
          </a:p>
          <a:p>
            <a:pPr algn="just"/>
            <a:endParaRPr lang="en-GB" sz="1400" dirty="0"/>
          </a:p>
          <a:p>
            <a:pPr algn="just"/>
            <a:r>
              <a:rPr lang="en-GB" sz="1400" dirty="0"/>
              <a:t>Photo 2017</a:t>
            </a:r>
          </a:p>
        </p:txBody>
      </p:sp>
      <p:sp>
        <p:nvSpPr>
          <p:cNvPr id="2" name="Marcador de número de diapositiva 1">
            <a:extLst>
              <a:ext uri="{FF2B5EF4-FFF2-40B4-BE49-F238E27FC236}">
                <a16:creationId xmlns:a16="http://schemas.microsoft.com/office/drawing/2014/main" id="{2E828E31-6540-4ED2-BC13-2010B27B8BBA}"/>
              </a:ext>
            </a:extLst>
          </p:cNvPr>
          <p:cNvSpPr>
            <a:spLocks noGrp="1"/>
          </p:cNvSpPr>
          <p:nvPr>
            <p:ph type="sldNum" sz="quarter" idx="12"/>
          </p:nvPr>
        </p:nvSpPr>
        <p:spPr/>
        <p:txBody>
          <a:bodyPr/>
          <a:lstStyle/>
          <a:p>
            <a:fld id="{192579BF-C6FD-43AD-A8B9-573B46B983AA}" type="slidenum">
              <a:rPr lang="en-GB" smtClean="0"/>
              <a:t>47</a:t>
            </a:fld>
            <a:endParaRPr lang="en-GB"/>
          </a:p>
        </p:txBody>
      </p:sp>
      <p:cxnSp>
        <p:nvCxnSpPr>
          <p:cNvPr id="14" name="Conector recto 13">
            <a:extLst>
              <a:ext uri="{FF2B5EF4-FFF2-40B4-BE49-F238E27FC236}">
                <a16:creationId xmlns:a16="http://schemas.microsoft.com/office/drawing/2014/main" id="{B2392F34-2C2E-4B0E-ACC7-FCBD184A529C}"/>
              </a:ext>
            </a:extLst>
          </p:cNvPr>
          <p:cNvCxnSpPr>
            <a:cxnSpLocks/>
          </p:cNvCxnSpPr>
          <p:nvPr/>
        </p:nvCxnSpPr>
        <p:spPr>
          <a:xfrm>
            <a:off x="7021902" y="886691"/>
            <a:ext cx="4934309"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5" name="Marcador de número de diapositiva 1">
            <a:extLst>
              <a:ext uri="{FF2B5EF4-FFF2-40B4-BE49-F238E27FC236}">
                <a16:creationId xmlns:a16="http://schemas.microsoft.com/office/drawing/2014/main" id="{EBB101E6-DF4E-4DCF-B8B0-9379853D4FA5}"/>
              </a:ext>
            </a:extLst>
          </p:cNvPr>
          <p:cNvSpPr txBox="1">
            <a:spLocks/>
          </p:cNvSpPr>
          <p:nvPr/>
        </p:nvSpPr>
        <p:spPr>
          <a:xfrm>
            <a:off x="11556274" y="6371729"/>
            <a:ext cx="456229"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solidFill>
                  <a:schemeClr val="bg1"/>
                </a:solidFill>
                <a:latin typeface="+mj-lt"/>
              </a:rPr>
              <a:pPr/>
              <a:t>47</a:t>
            </a:fld>
            <a:endParaRPr lang="en-GB" sz="1800" dirty="0">
              <a:solidFill>
                <a:schemeClr val="bg1"/>
              </a:solidFill>
              <a:latin typeface="+mj-lt"/>
            </a:endParaRPr>
          </a:p>
        </p:txBody>
      </p:sp>
      <p:sp>
        <p:nvSpPr>
          <p:cNvPr id="16" name="CuadroTexto 15">
            <a:extLst>
              <a:ext uri="{FF2B5EF4-FFF2-40B4-BE49-F238E27FC236}">
                <a16:creationId xmlns:a16="http://schemas.microsoft.com/office/drawing/2014/main" id="{0B7B9B79-A1B7-4739-BDAE-A53C53DD7CF7}"/>
              </a:ext>
            </a:extLst>
          </p:cNvPr>
          <p:cNvSpPr txBox="1"/>
          <p:nvPr/>
        </p:nvSpPr>
        <p:spPr>
          <a:xfrm>
            <a:off x="5967673" y="2787209"/>
            <a:ext cx="924750" cy="276999"/>
          </a:xfrm>
          <a:prstGeom prst="rect">
            <a:avLst/>
          </a:prstGeom>
          <a:noFill/>
        </p:spPr>
        <p:txBody>
          <a:bodyPr wrap="square" rtlCol="0">
            <a:spAutoFit/>
          </a:bodyPr>
          <a:lstStyle/>
          <a:p>
            <a:pPr algn="ctr"/>
            <a:r>
              <a:rPr lang="en-GB" sz="1200" dirty="0">
                <a:solidFill>
                  <a:schemeClr val="bg1"/>
                </a:solidFill>
                <a:effectLst>
                  <a:outerShdw blurRad="38100" dist="38100" dir="2700000" algn="tl">
                    <a:srgbClr val="000000">
                      <a:alpha val="43137"/>
                    </a:srgbClr>
                  </a:outerShdw>
                </a:effectLst>
                <a:latin typeface="+mj-lt"/>
              </a:rPr>
              <a:t>Travertine</a:t>
            </a:r>
          </a:p>
        </p:txBody>
      </p:sp>
      <p:sp>
        <p:nvSpPr>
          <p:cNvPr id="8" name="Forma libre: forma 7">
            <a:extLst>
              <a:ext uri="{FF2B5EF4-FFF2-40B4-BE49-F238E27FC236}">
                <a16:creationId xmlns:a16="http://schemas.microsoft.com/office/drawing/2014/main" id="{A34936DD-5326-487F-89EE-00362857635A}"/>
              </a:ext>
            </a:extLst>
          </p:cNvPr>
          <p:cNvSpPr/>
          <p:nvPr/>
        </p:nvSpPr>
        <p:spPr>
          <a:xfrm>
            <a:off x="8134350" y="4876800"/>
            <a:ext cx="3987800" cy="895350"/>
          </a:xfrm>
          <a:custGeom>
            <a:avLst/>
            <a:gdLst>
              <a:gd name="connsiteX0" fmla="*/ 3987800 w 3987800"/>
              <a:gd name="connsiteY0" fmla="*/ 895350 h 895350"/>
              <a:gd name="connsiteX1" fmla="*/ 3860800 w 3987800"/>
              <a:gd name="connsiteY1" fmla="*/ 800100 h 895350"/>
              <a:gd name="connsiteX2" fmla="*/ 3784600 w 3987800"/>
              <a:gd name="connsiteY2" fmla="*/ 742950 h 895350"/>
              <a:gd name="connsiteX3" fmla="*/ 3663950 w 3987800"/>
              <a:gd name="connsiteY3" fmla="*/ 673100 h 895350"/>
              <a:gd name="connsiteX4" fmla="*/ 3460750 w 3987800"/>
              <a:gd name="connsiteY4" fmla="*/ 590550 h 895350"/>
              <a:gd name="connsiteX5" fmla="*/ 3314700 w 3987800"/>
              <a:gd name="connsiteY5" fmla="*/ 539750 h 895350"/>
              <a:gd name="connsiteX6" fmla="*/ 3136900 w 3987800"/>
              <a:gd name="connsiteY6" fmla="*/ 412750 h 895350"/>
              <a:gd name="connsiteX7" fmla="*/ 3003550 w 3987800"/>
              <a:gd name="connsiteY7" fmla="*/ 273050 h 895350"/>
              <a:gd name="connsiteX8" fmla="*/ 2838450 w 3987800"/>
              <a:gd name="connsiteY8" fmla="*/ 196850 h 895350"/>
              <a:gd name="connsiteX9" fmla="*/ 2660650 w 3987800"/>
              <a:gd name="connsiteY9" fmla="*/ 120650 h 895350"/>
              <a:gd name="connsiteX10" fmla="*/ 2482850 w 3987800"/>
              <a:gd name="connsiteY10" fmla="*/ 57150 h 895350"/>
              <a:gd name="connsiteX11" fmla="*/ 2235200 w 3987800"/>
              <a:gd name="connsiteY11" fmla="*/ 12700 h 895350"/>
              <a:gd name="connsiteX12" fmla="*/ 1974850 w 3987800"/>
              <a:gd name="connsiteY12" fmla="*/ 0 h 895350"/>
              <a:gd name="connsiteX13" fmla="*/ 1809750 w 3987800"/>
              <a:gd name="connsiteY13" fmla="*/ 44450 h 895350"/>
              <a:gd name="connsiteX14" fmla="*/ 1708150 w 3987800"/>
              <a:gd name="connsiteY14" fmla="*/ 107950 h 895350"/>
              <a:gd name="connsiteX15" fmla="*/ 1530350 w 3987800"/>
              <a:gd name="connsiteY15" fmla="*/ 171450 h 895350"/>
              <a:gd name="connsiteX16" fmla="*/ 1320800 w 3987800"/>
              <a:gd name="connsiteY16" fmla="*/ 171450 h 895350"/>
              <a:gd name="connsiteX17" fmla="*/ 1136650 w 3987800"/>
              <a:gd name="connsiteY17" fmla="*/ 146050 h 895350"/>
              <a:gd name="connsiteX18" fmla="*/ 844550 w 3987800"/>
              <a:gd name="connsiteY18" fmla="*/ 107950 h 895350"/>
              <a:gd name="connsiteX19" fmla="*/ 647700 w 3987800"/>
              <a:gd name="connsiteY19" fmla="*/ 63500 h 895350"/>
              <a:gd name="connsiteX20" fmla="*/ 412750 w 3987800"/>
              <a:gd name="connsiteY20" fmla="*/ 57150 h 895350"/>
              <a:gd name="connsiteX21" fmla="*/ 412750 w 3987800"/>
              <a:gd name="connsiteY21" fmla="*/ 57150 h 895350"/>
              <a:gd name="connsiteX22" fmla="*/ 285750 w 3987800"/>
              <a:gd name="connsiteY22" fmla="*/ 57150 h 895350"/>
              <a:gd name="connsiteX23" fmla="*/ 171450 w 3987800"/>
              <a:gd name="connsiteY23" fmla="*/ 76200 h 895350"/>
              <a:gd name="connsiteX24" fmla="*/ 50800 w 3987800"/>
              <a:gd name="connsiteY24" fmla="*/ 76200 h 895350"/>
              <a:gd name="connsiteX25" fmla="*/ 0 w 3987800"/>
              <a:gd name="connsiteY25" fmla="*/ 69850 h 8953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Lst>
            <a:rect l="l" t="t" r="r" b="b"/>
            <a:pathLst>
              <a:path w="3987800" h="895350">
                <a:moveTo>
                  <a:pt x="3987800" y="895350"/>
                </a:moveTo>
                <a:lnTo>
                  <a:pt x="3860800" y="800100"/>
                </a:lnTo>
                <a:lnTo>
                  <a:pt x="3784600" y="742950"/>
                </a:lnTo>
                <a:lnTo>
                  <a:pt x="3663950" y="673100"/>
                </a:lnTo>
                <a:lnTo>
                  <a:pt x="3460750" y="590550"/>
                </a:lnTo>
                <a:lnTo>
                  <a:pt x="3314700" y="539750"/>
                </a:lnTo>
                <a:lnTo>
                  <a:pt x="3136900" y="412750"/>
                </a:lnTo>
                <a:lnTo>
                  <a:pt x="3003550" y="273050"/>
                </a:lnTo>
                <a:lnTo>
                  <a:pt x="2838450" y="196850"/>
                </a:lnTo>
                <a:lnTo>
                  <a:pt x="2660650" y="120650"/>
                </a:lnTo>
                <a:lnTo>
                  <a:pt x="2482850" y="57150"/>
                </a:lnTo>
                <a:lnTo>
                  <a:pt x="2235200" y="12700"/>
                </a:lnTo>
                <a:lnTo>
                  <a:pt x="1974850" y="0"/>
                </a:lnTo>
                <a:lnTo>
                  <a:pt x="1809750" y="44450"/>
                </a:lnTo>
                <a:lnTo>
                  <a:pt x="1708150" y="107950"/>
                </a:lnTo>
                <a:lnTo>
                  <a:pt x="1530350" y="171450"/>
                </a:lnTo>
                <a:lnTo>
                  <a:pt x="1320800" y="171450"/>
                </a:lnTo>
                <a:lnTo>
                  <a:pt x="1136650" y="146050"/>
                </a:lnTo>
                <a:lnTo>
                  <a:pt x="844550" y="107950"/>
                </a:lnTo>
                <a:lnTo>
                  <a:pt x="647700" y="63500"/>
                </a:lnTo>
                <a:lnTo>
                  <a:pt x="412750" y="57150"/>
                </a:lnTo>
                <a:lnTo>
                  <a:pt x="412750" y="57150"/>
                </a:lnTo>
                <a:lnTo>
                  <a:pt x="285750" y="57150"/>
                </a:lnTo>
                <a:lnTo>
                  <a:pt x="171450" y="76200"/>
                </a:lnTo>
                <a:lnTo>
                  <a:pt x="50800" y="76200"/>
                </a:lnTo>
                <a:lnTo>
                  <a:pt x="0" y="69850"/>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Forma libre: forma 16">
            <a:extLst>
              <a:ext uri="{FF2B5EF4-FFF2-40B4-BE49-F238E27FC236}">
                <a16:creationId xmlns:a16="http://schemas.microsoft.com/office/drawing/2014/main" id="{427AC440-1214-40F4-941C-DA5C8CB86494}"/>
              </a:ext>
            </a:extLst>
          </p:cNvPr>
          <p:cNvSpPr/>
          <p:nvPr/>
        </p:nvSpPr>
        <p:spPr>
          <a:xfrm>
            <a:off x="8750300" y="5886450"/>
            <a:ext cx="2762250" cy="558800"/>
          </a:xfrm>
          <a:custGeom>
            <a:avLst/>
            <a:gdLst>
              <a:gd name="connsiteX0" fmla="*/ 2762250 w 2762250"/>
              <a:gd name="connsiteY0" fmla="*/ 552450 h 558800"/>
              <a:gd name="connsiteX1" fmla="*/ 2533650 w 2762250"/>
              <a:gd name="connsiteY1" fmla="*/ 558800 h 558800"/>
              <a:gd name="connsiteX2" fmla="*/ 2343150 w 2762250"/>
              <a:gd name="connsiteY2" fmla="*/ 476250 h 558800"/>
              <a:gd name="connsiteX3" fmla="*/ 1949450 w 2762250"/>
              <a:gd name="connsiteY3" fmla="*/ 342900 h 558800"/>
              <a:gd name="connsiteX4" fmla="*/ 1816100 w 2762250"/>
              <a:gd name="connsiteY4" fmla="*/ 203200 h 558800"/>
              <a:gd name="connsiteX5" fmla="*/ 1562100 w 2762250"/>
              <a:gd name="connsiteY5" fmla="*/ 76200 h 558800"/>
              <a:gd name="connsiteX6" fmla="*/ 1327150 w 2762250"/>
              <a:gd name="connsiteY6" fmla="*/ 44450 h 558800"/>
              <a:gd name="connsiteX7" fmla="*/ 1085850 w 2762250"/>
              <a:gd name="connsiteY7" fmla="*/ 19050 h 558800"/>
              <a:gd name="connsiteX8" fmla="*/ 838200 w 2762250"/>
              <a:gd name="connsiteY8" fmla="*/ 0 h 558800"/>
              <a:gd name="connsiteX9" fmla="*/ 577850 w 2762250"/>
              <a:gd name="connsiteY9" fmla="*/ 0 h 558800"/>
              <a:gd name="connsiteX10" fmla="*/ 355600 w 2762250"/>
              <a:gd name="connsiteY10" fmla="*/ 38100 h 558800"/>
              <a:gd name="connsiteX11" fmla="*/ 184150 w 2762250"/>
              <a:gd name="connsiteY11" fmla="*/ 127000 h 558800"/>
              <a:gd name="connsiteX12" fmla="*/ 31750 w 2762250"/>
              <a:gd name="connsiteY12" fmla="*/ 215900 h 558800"/>
              <a:gd name="connsiteX13" fmla="*/ 0 w 2762250"/>
              <a:gd name="connsiteY13" fmla="*/ 247650 h 5588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2762250" h="558800">
                <a:moveTo>
                  <a:pt x="2762250" y="552450"/>
                </a:moveTo>
                <a:lnTo>
                  <a:pt x="2533650" y="558800"/>
                </a:lnTo>
                <a:lnTo>
                  <a:pt x="2343150" y="476250"/>
                </a:lnTo>
                <a:lnTo>
                  <a:pt x="1949450" y="342900"/>
                </a:lnTo>
                <a:lnTo>
                  <a:pt x="1816100" y="203200"/>
                </a:lnTo>
                <a:lnTo>
                  <a:pt x="1562100" y="76200"/>
                </a:lnTo>
                <a:lnTo>
                  <a:pt x="1327150" y="44450"/>
                </a:lnTo>
                <a:lnTo>
                  <a:pt x="1085850" y="19050"/>
                </a:lnTo>
                <a:lnTo>
                  <a:pt x="838200" y="0"/>
                </a:lnTo>
                <a:lnTo>
                  <a:pt x="577850" y="0"/>
                </a:lnTo>
                <a:lnTo>
                  <a:pt x="355600" y="38100"/>
                </a:lnTo>
                <a:lnTo>
                  <a:pt x="184150" y="127000"/>
                </a:lnTo>
                <a:lnTo>
                  <a:pt x="31750" y="215900"/>
                </a:lnTo>
                <a:lnTo>
                  <a:pt x="0" y="247650"/>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CuadroTexto 17">
            <a:extLst>
              <a:ext uri="{FF2B5EF4-FFF2-40B4-BE49-F238E27FC236}">
                <a16:creationId xmlns:a16="http://schemas.microsoft.com/office/drawing/2014/main" id="{7DF5A122-84C8-404D-A24B-0161178254E3}"/>
              </a:ext>
            </a:extLst>
          </p:cNvPr>
          <p:cNvSpPr txBox="1"/>
          <p:nvPr/>
        </p:nvSpPr>
        <p:spPr>
          <a:xfrm>
            <a:off x="8064501" y="4905971"/>
            <a:ext cx="924750" cy="461665"/>
          </a:xfrm>
          <a:prstGeom prst="rect">
            <a:avLst/>
          </a:prstGeom>
          <a:noFill/>
        </p:spPr>
        <p:txBody>
          <a:bodyPr wrap="square" rtlCol="0">
            <a:spAutoFit/>
          </a:bodyPr>
          <a:lstStyle/>
          <a:p>
            <a:r>
              <a:rPr lang="en-GB" sz="1200" dirty="0">
                <a:solidFill>
                  <a:schemeClr val="bg1"/>
                </a:solidFill>
                <a:effectLst>
                  <a:outerShdw blurRad="38100" dist="38100" dir="2700000" algn="tl">
                    <a:srgbClr val="000000">
                      <a:alpha val="43137"/>
                    </a:srgbClr>
                  </a:outerShdw>
                </a:effectLst>
                <a:latin typeface="+mj-lt"/>
              </a:rPr>
              <a:t>Travertine slope</a:t>
            </a:r>
          </a:p>
        </p:txBody>
      </p:sp>
      <p:sp>
        <p:nvSpPr>
          <p:cNvPr id="19" name="Forma libre: forma 18">
            <a:extLst>
              <a:ext uri="{FF2B5EF4-FFF2-40B4-BE49-F238E27FC236}">
                <a16:creationId xmlns:a16="http://schemas.microsoft.com/office/drawing/2014/main" id="{A1B62D1E-5AC3-4856-ACCF-5F68C28986CA}"/>
              </a:ext>
            </a:extLst>
          </p:cNvPr>
          <p:cNvSpPr/>
          <p:nvPr/>
        </p:nvSpPr>
        <p:spPr>
          <a:xfrm>
            <a:off x="4288389" y="2787209"/>
            <a:ext cx="2484039" cy="1491401"/>
          </a:xfrm>
          <a:custGeom>
            <a:avLst/>
            <a:gdLst>
              <a:gd name="connsiteX0" fmla="*/ 1882589 w 2484039"/>
              <a:gd name="connsiteY0" fmla="*/ 0 h 1491401"/>
              <a:gd name="connsiteX1" fmla="*/ 1740783 w 2484039"/>
              <a:gd name="connsiteY1" fmla="*/ 14669 h 1491401"/>
              <a:gd name="connsiteX2" fmla="*/ 1677215 w 2484039"/>
              <a:gd name="connsiteY2" fmla="*/ 88017 h 1491401"/>
              <a:gd name="connsiteX3" fmla="*/ 1603868 w 2484039"/>
              <a:gd name="connsiteY3" fmla="*/ 176034 h 1491401"/>
              <a:gd name="connsiteX4" fmla="*/ 1383825 w 2484039"/>
              <a:gd name="connsiteY4" fmla="*/ 283610 h 1491401"/>
              <a:gd name="connsiteX5" fmla="*/ 1232240 w 2484039"/>
              <a:gd name="connsiteY5" fmla="*/ 396077 h 1491401"/>
              <a:gd name="connsiteX6" fmla="*/ 1051316 w 2484039"/>
              <a:gd name="connsiteY6" fmla="*/ 503653 h 1491401"/>
              <a:gd name="connsiteX7" fmla="*/ 841053 w 2484039"/>
              <a:gd name="connsiteY7" fmla="*/ 532992 h 1491401"/>
              <a:gd name="connsiteX8" fmla="*/ 665018 w 2484039"/>
              <a:gd name="connsiteY8" fmla="*/ 611230 h 1491401"/>
              <a:gd name="connsiteX9" fmla="*/ 449866 w 2484039"/>
              <a:gd name="connsiteY9" fmla="*/ 694357 h 1491401"/>
              <a:gd name="connsiteX10" fmla="*/ 239602 w 2484039"/>
              <a:gd name="connsiteY10" fmla="*/ 748145 h 1491401"/>
              <a:gd name="connsiteX11" fmla="*/ 63568 w 2484039"/>
              <a:gd name="connsiteY11" fmla="*/ 787264 h 1491401"/>
              <a:gd name="connsiteX12" fmla="*/ 9780 w 2484039"/>
              <a:gd name="connsiteY12" fmla="*/ 894840 h 1491401"/>
              <a:gd name="connsiteX13" fmla="*/ 0 w 2484039"/>
              <a:gd name="connsiteY13" fmla="*/ 1021976 h 1491401"/>
              <a:gd name="connsiteX14" fmla="*/ 4890 w 2484039"/>
              <a:gd name="connsiteY14" fmla="*/ 1193120 h 1491401"/>
              <a:gd name="connsiteX15" fmla="*/ 83128 w 2484039"/>
              <a:gd name="connsiteY15" fmla="*/ 1330036 h 1491401"/>
              <a:gd name="connsiteX16" fmla="*/ 171145 w 2484039"/>
              <a:gd name="connsiteY16" fmla="*/ 1437612 h 1491401"/>
              <a:gd name="connsiteX17" fmla="*/ 337399 w 2484039"/>
              <a:gd name="connsiteY17" fmla="*/ 1491401 h 1491401"/>
              <a:gd name="connsiteX18" fmla="*/ 400967 w 2484039"/>
              <a:gd name="connsiteY18" fmla="*/ 1462062 h 1491401"/>
              <a:gd name="connsiteX19" fmla="*/ 513433 w 2484039"/>
              <a:gd name="connsiteY19" fmla="*/ 1349595 h 1491401"/>
              <a:gd name="connsiteX20" fmla="*/ 606340 w 2484039"/>
              <a:gd name="connsiteY20" fmla="*/ 1256688 h 1491401"/>
              <a:gd name="connsiteX21" fmla="*/ 669908 w 2484039"/>
              <a:gd name="connsiteY21" fmla="*/ 1222459 h 1491401"/>
              <a:gd name="connsiteX22" fmla="*/ 816604 w 2484039"/>
              <a:gd name="connsiteY22" fmla="*/ 1212680 h 1491401"/>
              <a:gd name="connsiteX23" fmla="*/ 889951 w 2484039"/>
              <a:gd name="connsiteY23" fmla="*/ 1212680 h 1491401"/>
              <a:gd name="connsiteX24" fmla="*/ 938850 w 2484039"/>
              <a:gd name="connsiteY24" fmla="*/ 1173561 h 1491401"/>
              <a:gd name="connsiteX25" fmla="*/ 987748 w 2484039"/>
              <a:gd name="connsiteY25" fmla="*/ 1114883 h 1491401"/>
              <a:gd name="connsiteX26" fmla="*/ 1075765 w 2484039"/>
              <a:gd name="connsiteY26" fmla="*/ 1046425 h 1491401"/>
              <a:gd name="connsiteX27" fmla="*/ 1124663 w 2484039"/>
              <a:gd name="connsiteY27" fmla="*/ 987747 h 1491401"/>
              <a:gd name="connsiteX28" fmla="*/ 1178452 w 2484039"/>
              <a:gd name="connsiteY28" fmla="*/ 929069 h 1491401"/>
              <a:gd name="connsiteX29" fmla="*/ 1281138 w 2484039"/>
              <a:gd name="connsiteY29" fmla="*/ 929069 h 1491401"/>
              <a:gd name="connsiteX30" fmla="*/ 1403384 w 2484039"/>
              <a:gd name="connsiteY30" fmla="*/ 943739 h 1491401"/>
              <a:gd name="connsiteX31" fmla="*/ 1520740 w 2484039"/>
              <a:gd name="connsiteY31" fmla="*/ 963298 h 1491401"/>
              <a:gd name="connsiteX32" fmla="*/ 1559859 w 2484039"/>
              <a:gd name="connsiteY32" fmla="*/ 973078 h 1491401"/>
              <a:gd name="connsiteX33" fmla="*/ 1623427 w 2484039"/>
              <a:gd name="connsiteY33" fmla="*/ 973078 h 1491401"/>
              <a:gd name="connsiteX34" fmla="*/ 1672325 w 2484039"/>
              <a:gd name="connsiteY34" fmla="*/ 938849 h 1491401"/>
              <a:gd name="connsiteX35" fmla="*/ 1721224 w 2484039"/>
              <a:gd name="connsiteY35" fmla="*/ 889950 h 1491401"/>
              <a:gd name="connsiteX36" fmla="*/ 1799461 w 2484039"/>
              <a:gd name="connsiteY36" fmla="*/ 787264 h 1491401"/>
              <a:gd name="connsiteX37" fmla="*/ 2029284 w 2484039"/>
              <a:gd name="connsiteY37" fmla="*/ 645458 h 1491401"/>
              <a:gd name="connsiteX38" fmla="*/ 2195538 w 2484039"/>
              <a:gd name="connsiteY38" fmla="*/ 557441 h 1491401"/>
              <a:gd name="connsiteX39" fmla="*/ 2415581 w 2484039"/>
              <a:gd name="connsiteY39" fmla="*/ 484094 h 1491401"/>
              <a:gd name="connsiteX40" fmla="*/ 2484039 w 2484039"/>
              <a:gd name="connsiteY40" fmla="*/ 425416 h 14914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Lst>
            <a:rect l="l" t="t" r="r" b="b"/>
            <a:pathLst>
              <a:path w="2484039" h="1491401">
                <a:moveTo>
                  <a:pt x="1882589" y="0"/>
                </a:moveTo>
                <a:lnTo>
                  <a:pt x="1740783" y="14669"/>
                </a:lnTo>
                <a:lnTo>
                  <a:pt x="1677215" y="88017"/>
                </a:lnTo>
                <a:lnTo>
                  <a:pt x="1603868" y="176034"/>
                </a:lnTo>
                <a:lnTo>
                  <a:pt x="1383825" y="283610"/>
                </a:lnTo>
                <a:lnTo>
                  <a:pt x="1232240" y="396077"/>
                </a:lnTo>
                <a:lnTo>
                  <a:pt x="1051316" y="503653"/>
                </a:lnTo>
                <a:lnTo>
                  <a:pt x="841053" y="532992"/>
                </a:lnTo>
                <a:lnTo>
                  <a:pt x="665018" y="611230"/>
                </a:lnTo>
                <a:lnTo>
                  <a:pt x="449866" y="694357"/>
                </a:lnTo>
                <a:lnTo>
                  <a:pt x="239602" y="748145"/>
                </a:lnTo>
                <a:lnTo>
                  <a:pt x="63568" y="787264"/>
                </a:lnTo>
                <a:lnTo>
                  <a:pt x="9780" y="894840"/>
                </a:lnTo>
                <a:lnTo>
                  <a:pt x="0" y="1021976"/>
                </a:lnTo>
                <a:lnTo>
                  <a:pt x="4890" y="1193120"/>
                </a:lnTo>
                <a:lnTo>
                  <a:pt x="83128" y="1330036"/>
                </a:lnTo>
                <a:lnTo>
                  <a:pt x="171145" y="1437612"/>
                </a:lnTo>
                <a:lnTo>
                  <a:pt x="337399" y="1491401"/>
                </a:lnTo>
                <a:lnTo>
                  <a:pt x="400967" y="1462062"/>
                </a:lnTo>
                <a:lnTo>
                  <a:pt x="513433" y="1349595"/>
                </a:lnTo>
                <a:lnTo>
                  <a:pt x="606340" y="1256688"/>
                </a:lnTo>
                <a:lnTo>
                  <a:pt x="669908" y="1222459"/>
                </a:lnTo>
                <a:lnTo>
                  <a:pt x="816604" y="1212680"/>
                </a:lnTo>
                <a:lnTo>
                  <a:pt x="889951" y="1212680"/>
                </a:lnTo>
                <a:lnTo>
                  <a:pt x="938850" y="1173561"/>
                </a:lnTo>
                <a:lnTo>
                  <a:pt x="987748" y="1114883"/>
                </a:lnTo>
                <a:lnTo>
                  <a:pt x="1075765" y="1046425"/>
                </a:lnTo>
                <a:lnTo>
                  <a:pt x="1124663" y="987747"/>
                </a:lnTo>
                <a:lnTo>
                  <a:pt x="1178452" y="929069"/>
                </a:lnTo>
                <a:lnTo>
                  <a:pt x="1281138" y="929069"/>
                </a:lnTo>
                <a:lnTo>
                  <a:pt x="1403384" y="943739"/>
                </a:lnTo>
                <a:lnTo>
                  <a:pt x="1520740" y="963298"/>
                </a:lnTo>
                <a:lnTo>
                  <a:pt x="1559859" y="973078"/>
                </a:lnTo>
                <a:lnTo>
                  <a:pt x="1623427" y="973078"/>
                </a:lnTo>
                <a:lnTo>
                  <a:pt x="1672325" y="938849"/>
                </a:lnTo>
                <a:lnTo>
                  <a:pt x="1721224" y="889950"/>
                </a:lnTo>
                <a:lnTo>
                  <a:pt x="1799461" y="787264"/>
                </a:lnTo>
                <a:lnTo>
                  <a:pt x="2029284" y="645458"/>
                </a:lnTo>
                <a:lnTo>
                  <a:pt x="2195538" y="557441"/>
                </a:lnTo>
                <a:lnTo>
                  <a:pt x="2415581" y="484094"/>
                </a:lnTo>
                <a:lnTo>
                  <a:pt x="2484039" y="425416"/>
                </a:lnTo>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24961617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descr="Imagen que contiene rock, exterior, suelo, árbol&#10;&#10;Descripción generada automáticamente">
            <a:extLst>
              <a:ext uri="{FF2B5EF4-FFF2-40B4-BE49-F238E27FC236}">
                <a16:creationId xmlns:a16="http://schemas.microsoft.com/office/drawing/2014/main" id="{764D70CB-042A-497F-82BB-4E2C5C4E65CD}"/>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684962"/>
            <a:ext cx="8701403" cy="5785507"/>
          </a:xfrm>
          <a:prstGeom prst="rect">
            <a:avLst/>
          </a:prstGeom>
        </p:spPr>
      </p:pic>
      <p:sp>
        <p:nvSpPr>
          <p:cNvPr id="12" name="CuadroTexto 11">
            <a:extLst>
              <a:ext uri="{FF2B5EF4-FFF2-40B4-BE49-F238E27FC236}">
                <a16:creationId xmlns:a16="http://schemas.microsoft.com/office/drawing/2014/main" id="{5EB1B846-AD90-4985-BBF1-AEF43E165621}"/>
              </a:ext>
            </a:extLst>
          </p:cNvPr>
          <p:cNvSpPr txBox="1"/>
          <p:nvPr/>
        </p:nvSpPr>
        <p:spPr>
          <a:xfrm>
            <a:off x="6718961" y="2662756"/>
            <a:ext cx="1150143" cy="276999"/>
          </a:xfrm>
          <a:prstGeom prst="rect">
            <a:avLst/>
          </a:prstGeom>
          <a:noFill/>
        </p:spPr>
        <p:txBody>
          <a:bodyPr wrap="square" rtlCol="0">
            <a:spAutoFit/>
          </a:bodyPr>
          <a:lstStyle/>
          <a:p>
            <a:pPr algn="ctr"/>
            <a:r>
              <a:rPr lang="en-GB" sz="1200" dirty="0">
                <a:solidFill>
                  <a:schemeClr val="bg1">
                    <a:lumMod val="95000"/>
                  </a:schemeClr>
                </a:solidFill>
                <a:effectLst>
                  <a:outerShdw blurRad="38100" dist="38100" dir="2700000" algn="tl">
                    <a:srgbClr val="000000">
                      <a:alpha val="43137"/>
                    </a:srgbClr>
                  </a:outerShdw>
                </a:effectLst>
                <a:latin typeface="+mj-lt"/>
              </a:rPr>
              <a:t>SW gallery</a:t>
            </a:r>
          </a:p>
        </p:txBody>
      </p:sp>
      <p:sp>
        <p:nvSpPr>
          <p:cNvPr id="6" name="CuadroTexto 5">
            <a:extLst>
              <a:ext uri="{FF2B5EF4-FFF2-40B4-BE49-F238E27FC236}">
                <a16:creationId xmlns:a16="http://schemas.microsoft.com/office/drawing/2014/main" id="{74AF234C-E168-4284-B2E9-FEA4C9837CB3}"/>
              </a:ext>
            </a:extLst>
          </p:cNvPr>
          <p:cNvSpPr txBox="1"/>
          <p:nvPr/>
        </p:nvSpPr>
        <p:spPr>
          <a:xfrm>
            <a:off x="9090300" y="684962"/>
            <a:ext cx="662361" cy="369332"/>
          </a:xfrm>
          <a:prstGeom prst="rect">
            <a:avLst/>
          </a:prstGeom>
          <a:noFill/>
        </p:spPr>
        <p:txBody>
          <a:bodyPr wrap="none" rtlCol="0">
            <a:spAutoFit/>
          </a:bodyPr>
          <a:lstStyle/>
          <a:p>
            <a:r>
              <a:rPr lang="en-GB" b="1" dirty="0">
                <a:latin typeface="+mj-lt"/>
              </a:rPr>
              <a:t>Fig. E</a:t>
            </a:r>
          </a:p>
        </p:txBody>
      </p:sp>
      <p:sp>
        <p:nvSpPr>
          <p:cNvPr id="7" name="CuadroTexto 6">
            <a:extLst>
              <a:ext uri="{FF2B5EF4-FFF2-40B4-BE49-F238E27FC236}">
                <a16:creationId xmlns:a16="http://schemas.microsoft.com/office/drawing/2014/main" id="{4527CC34-38A6-4810-B205-C3B5C4C608F7}"/>
              </a:ext>
            </a:extLst>
          </p:cNvPr>
          <p:cNvSpPr txBox="1"/>
          <p:nvPr/>
        </p:nvSpPr>
        <p:spPr>
          <a:xfrm>
            <a:off x="0" y="0"/>
            <a:ext cx="5150834" cy="338554"/>
          </a:xfrm>
          <a:prstGeom prst="rect">
            <a:avLst/>
          </a:prstGeom>
          <a:noFill/>
        </p:spPr>
        <p:txBody>
          <a:bodyPr wrap="none" rtlCol="0">
            <a:spAutoFit/>
          </a:bodyPr>
          <a:lstStyle/>
          <a:p>
            <a:r>
              <a:rPr lang="en-GB" sz="1600" b="1" dirty="0">
                <a:latin typeface="+mj-lt"/>
              </a:rPr>
              <a:t>Supporting Information 1 – Excavation of the Holocene Layers</a:t>
            </a:r>
          </a:p>
        </p:txBody>
      </p:sp>
      <p:sp>
        <p:nvSpPr>
          <p:cNvPr id="9" name="CuadroTexto 8">
            <a:extLst>
              <a:ext uri="{FF2B5EF4-FFF2-40B4-BE49-F238E27FC236}">
                <a16:creationId xmlns:a16="http://schemas.microsoft.com/office/drawing/2014/main" id="{AE454E46-DA61-456A-888C-3F1642D57E3C}"/>
              </a:ext>
            </a:extLst>
          </p:cNvPr>
          <p:cNvSpPr txBox="1"/>
          <p:nvPr/>
        </p:nvSpPr>
        <p:spPr>
          <a:xfrm>
            <a:off x="9090300" y="1310098"/>
            <a:ext cx="2579186" cy="1169551"/>
          </a:xfrm>
          <a:prstGeom prst="rect">
            <a:avLst/>
          </a:prstGeom>
          <a:noFill/>
        </p:spPr>
        <p:txBody>
          <a:bodyPr wrap="square" rtlCol="0">
            <a:spAutoFit/>
          </a:bodyPr>
          <a:lstStyle/>
          <a:p>
            <a:pPr algn="just"/>
            <a:r>
              <a:rPr lang="en-GB" sz="1400" dirty="0"/>
              <a:t>Excavation of Level I (Holocene layers). Opposite view of the Fig. 1.4</a:t>
            </a:r>
          </a:p>
          <a:p>
            <a:pPr algn="just"/>
            <a:endParaRPr lang="en-GB" sz="1400" dirty="0"/>
          </a:p>
          <a:p>
            <a:pPr algn="just"/>
            <a:r>
              <a:rPr lang="en-GB" sz="1400" dirty="0"/>
              <a:t>Photo 2006</a:t>
            </a:r>
          </a:p>
        </p:txBody>
      </p:sp>
      <p:cxnSp>
        <p:nvCxnSpPr>
          <p:cNvPr id="8" name="Conector recto 7">
            <a:extLst>
              <a:ext uri="{FF2B5EF4-FFF2-40B4-BE49-F238E27FC236}">
                <a16:creationId xmlns:a16="http://schemas.microsoft.com/office/drawing/2014/main" id="{1CA457DB-7B43-4F1A-97BF-1CFA2B5033D5}"/>
              </a:ext>
            </a:extLst>
          </p:cNvPr>
          <p:cNvCxnSpPr>
            <a:cxnSpLocks/>
          </p:cNvCxnSpPr>
          <p:nvPr/>
        </p:nvCxnSpPr>
        <p:spPr>
          <a:xfrm>
            <a:off x="9196251" y="1159986"/>
            <a:ext cx="2351315"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69560316-06BB-486B-9BC5-B33EC01814C9}"/>
              </a:ext>
            </a:extLst>
          </p:cNvPr>
          <p:cNvSpPr>
            <a:spLocks noGrp="1"/>
          </p:cNvSpPr>
          <p:nvPr>
            <p:ph type="sldNum" sz="quarter" idx="12"/>
          </p:nvPr>
        </p:nvSpPr>
        <p:spPr>
          <a:xfrm>
            <a:off x="11696697" y="6371729"/>
            <a:ext cx="315806" cy="365125"/>
          </a:xfrm>
        </p:spPr>
        <p:txBody>
          <a:bodyPr/>
          <a:lstStyle/>
          <a:p>
            <a:fld id="{192579BF-C6FD-43AD-A8B9-573B46B983AA}" type="slidenum">
              <a:rPr lang="en-GB" sz="1800" smtClean="0">
                <a:latin typeface="+mj-lt"/>
              </a:rPr>
              <a:t>5</a:t>
            </a:fld>
            <a:endParaRPr lang="en-GB" sz="1800" dirty="0">
              <a:latin typeface="+mj-lt"/>
            </a:endParaRPr>
          </a:p>
        </p:txBody>
      </p:sp>
      <p:cxnSp>
        <p:nvCxnSpPr>
          <p:cNvPr id="11" name="Conector recto de flecha 10">
            <a:extLst>
              <a:ext uri="{FF2B5EF4-FFF2-40B4-BE49-F238E27FC236}">
                <a16:creationId xmlns:a16="http://schemas.microsoft.com/office/drawing/2014/main" id="{B4A3112D-EE8D-4895-9B05-FED4AEA0DA4A}"/>
              </a:ext>
            </a:extLst>
          </p:cNvPr>
          <p:cNvCxnSpPr>
            <a:cxnSpLocks/>
          </p:cNvCxnSpPr>
          <p:nvPr/>
        </p:nvCxnSpPr>
        <p:spPr>
          <a:xfrm>
            <a:off x="6841067" y="2939755"/>
            <a:ext cx="905932" cy="0"/>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sp>
        <p:nvSpPr>
          <p:cNvPr id="15" name="Forma libre: forma 14">
            <a:extLst>
              <a:ext uri="{FF2B5EF4-FFF2-40B4-BE49-F238E27FC236}">
                <a16:creationId xmlns:a16="http://schemas.microsoft.com/office/drawing/2014/main" id="{DFDE7708-61C3-40AB-8460-E262C1E97BBB}"/>
              </a:ext>
            </a:extLst>
          </p:cNvPr>
          <p:cNvSpPr/>
          <p:nvPr/>
        </p:nvSpPr>
        <p:spPr>
          <a:xfrm>
            <a:off x="144684" y="3206187"/>
            <a:ext cx="2187615" cy="1759352"/>
          </a:xfrm>
          <a:custGeom>
            <a:avLst/>
            <a:gdLst>
              <a:gd name="connsiteX0" fmla="*/ 0 w 2187615"/>
              <a:gd name="connsiteY0" fmla="*/ 1672542 h 1759352"/>
              <a:gd name="connsiteX1" fmla="*/ 196769 w 2187615"/>
              <a:gd name="connsiteY1" fmla="*/ 1724628 h 1759352"/>
              <a:gd name="connsiteX2" fmla="*/ 312516 w 2187615"/>
              <a:gd name="connsiteY2" fmla="*/ 1759352 h 1759352"/>
              <a:gd name="connsiteX3" fmla="*/ 491924 w 2187615"/>
              <a:gd name="connsiteY3" fmla="*/ 1724628 h 1759352"/>
              <a:gd name="connsiteX4" fmla="*/ 596096 w 2187615"/>
              <a:gd name="connsiteY4" fmla="*/ 1678329 h 1759352"/>
              <a:gd name="connsiteX5" fmla="*/ 694481 w 2187615"/>
              <a:gd name="connsiteY5" fmla="*/ 1614669 h 1759352"/>
              <a:gd name="connsiteX6" fmla="*/ 902825 w 2187615"/>
              <a:gd name="connsiteY6" fmla="*/ 1533646 h 1759352"/>
              <a:gd name="connsiteX7" fmla="*/ 989635 w 2187615"/>
              <a:gd name="connsiteY7" fmla="*/ 1435261 h 1759352"/>
              <a:gd name="connsiteX8" fmla="*/ 1012784 w 2187615"/>
              <a:gd name="connsiteY8" fmla="*/ 1406324 h 1759352"/>
              <a:gd name="connsiteX9" fmla="*/ 1122744 w 2187615"/>
              <a:gd name="connsiteY9" fmla="*/ 1354238 h 1759352"/>
              <a:gd name="connsiteX10" fmla="*/ 1307939 w 2187615"/>
              <a:gd name="connsiteY10" fmla="*/ 1319514 h 1759352"/>
              <a:gd name="connsiteX11" fmla="*/ 1487346 w 2187615"/>
              <a:gd name="connsiteY11" fmla="*/ 1238491 h 1759352"/>
              <a:gd name="connsiteX12" fmla="*/ 1574157 w 2187615"/>
              <a:gd name="connsiteY12" fmla="*/ 1145894 h 1759352"/>
              <a:gd name="connsiteX13" fmla="*/ 1643605 w 2187615"/>
              <a:gd name="connsiteY13" fmla="*/ 1041722 h 1759352"/>
              <a:gd name="connsiteX14" fmla="*/ 1840374 w 2187615"/>
              <a:gd name="connsiteY14" fmla="*/ 914400 h 1759352"/>
              <a:gd name="connsiteX15" fmla="*/ 2013994 w 2187615"/>
              <a:gd name="connsiteY15" fmla="*/ 844952 h 1759352"/>
              <a:gd name="connsiteX16" fmla="*/ 2095017 w 2187615"/>
              <a:gd name="connsiteY16" fmla="*/ 746567 h 1759352"/>
              <a:gd name="connsiteX17" fmla="*/ 2187615 w 2187615"/>
              <a:gd name="connsiteY17" fmla="*/ 665545 h 1759352"/>
              <a:gd name="connsiteX18" fmla="*/ 2187615 w 2187615"/>
              <a:gd name="connsiteY18" fmla="*/ 601884 h 1759352"/>
              <a:gd name="connsiteX19" fmla="*/ 2135529 w 2187615"/>
              <a:gd name="connsiteY19" fmla="*/ 555585 h 1759352"/>
              <a:gd name="connsiteX20" fmla="*/ 2071868 w 2187615"/>
              <a:gd name="connsiteY20" fmla="*/ 503499 h 1759352"/>
              <a:gd name="connsiteX21" fmla="*/ 2037144 w 2187615"/>
              <a:gd name="connsiteY21" fmla="*/ 353028 h 1759352"/>
              <a:gd name="connsiteX22" fmla="*/ 2037144 w 2187615"/>
              <a:gd name="connsiteY22" fmla="*/ 254643 h 1759352"/>
              <a:gd name="connsiteX23" fmla="*/ 2048719 w 2187615"/>
              <a:gd name="connsiteY23" fmla="*/ 138897 h 1759352"/>
              <a:gd name="connsiteX24" fmla="*/ 2054506 w 2187615"/>
              <a:gd name="connsiteY24" fmla="*/ 52086 h 1759352"/>
              <a:gd name="connsiteX25" fmla="*/ 2060293 w 2187615"/>
              <a:gd name="connsiteY25" fmla="*/ 0 h 1759352"/>
              <a:gd name="connsiteX26" fmla="*/ 2060293 w 2187615"/>
              <a:gd name="connsiteY26" fmla="*/ 0 h 17593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Lst>
            <a:rect l="l" t="t" r="r" b="b"/>
            <a:pathLst>
              <a:path w="2187615" h="1759352">
                <a:moveTo>
                  <a:pt x="0" y="1672542"/>
                </a:moveTo>
                <a:lnTo>
                  <a:pt x="196769" y="1724628"/>
                </a:lnTo>
                <a:lnTo>
                  <a:pt x="312516" y="1759352"/>
                </a:lnTo>
                <a:lnTo>
                  <a:pt x="491924" y="1724628"/>
                </a:lnTo>
                <a:lnTo>
                  <a:pt x="596096" y="1678329"/>
                </a:lnTo>
                <a:lnTo>
                  <a:pt x="694481" y="1614669"/>
                </a:lnTo>
                <a:lnTo>
                  <a:pt x="902825" y="1533646"/>
                </a:lnTo>
                <a:lnTo>
                  <a:pt x="989635" y="1435261"/>
                </a:lnTo>
                <a:lnTo>
                  <a:pt x="1012784" y="1406324"/>
                </a:lnTo>
                <a:lnTo>
                  <a:pt x="1122744" y="1354238"/>
                </a:lnTo>
                <a:lnTo>
                  <a:pt x="1307939" y="1319514"/>
                </a:lnTo>
                <a:lnTo>
                  <a:pt x="1487346" y="1238491"/>
                </a:lnTo>
                <a:lnTo>
                  <a:pt x="1574157" y="1145894"/>
                </a:lnTo>
                <a:lnTo>
                  <a:pt x="1643605" y="1041722"/>
                </a:lnTo>
                <a:lnTo>
                  <a:pt x="1840374" y="914400"/>
                </a:lnTo>
                <a:lnTo>
                  <a:pt x="2013994" y="844952"/>
                </a:lnTo>
                <a:lnTo>
                  <a:pt x="2095017" y="746567"/>
                </a:lnTo>
                <a:lnTo>
                  <a:pt x="2187615" y="665545"/>
                </a:lnTo>
                <a:lnTo>
                  <a:pt x="2187615" y="601884"/>
                </a:lnTo>
                <a:lnTo>
                  <a:pt x="2135529" y="555585"/>
                </a:lnTo>
                <a:lnTo>
                  <a:pt x="2071868" y="503499"/>
                </a:lnTo>
                <a:lnTo>
                  <a:pt x="2037144" y="353028"/>
                </a:lnTo>
                <a:lnTo>
                  <a:pt x="2037144" y="254643"/>
                </a:lnTo>
                <a:lnTo>
                  <a:pt x="2048719" y="138897"/>
                </a:lnTo>
                <a:lnTo>
                  <a:pt x="2054506" y="52086"/>
                </a:lnTo>
                <a:lnTo>
                  <a:pt x="2060293" y="0"/>
                </a:lnTo>
                <a:lnTo>
                  <a:pt x="2060293" y="0"/>
                </a:lnTo>
              </a:path>
            </a:pathLst>
          </a:custGeom>
          <a:noFill/>
          <a:ln>
            <a:solidFill>
              <a:schemeClr val="bg1"/>
            </a:solidFill>
            <a:prstDash val="dash"/>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 name="CuadroTexto 15">
            <a:extLst>
              <a:ext uri="{FF2B5EF4-FFF2-40B4-BE49-F238E27FC236}">
                <a16:creationId xmlns:a16="http://schemas.microsoft.com/office/drawing/2014/main" id="{B812FB45-80C1-4428-82BF-9EA1B9915666}"/>
              </a:ext>
            </a:extLst>
          </p:cNvPr>
          <p:cNvSpPr txBox="1"/>
          <p:nvPr/>
        </p:nvSpPr>
        <p:spPr>
          <a:xfrm>
            <a:off x="1100390" y="2859779"/>
            <a:ext cx="1150143" cy="461665"/>
          </a:xfrm>
          <a:prstGeom prst="rect">
            <a:avLst/>
          </a:prstGeom>
          <a:noFill/>
        </p:spPr>
        <p:txBody>
          <a:bodyPr wrap="square" rtlCol="0">
            <a:spAutoFit/>
          </a:bodyPr>
          <a:lstStyle/>
          <a:p>
            <a:pPr algn="r"/>
            <a:r>
              <a:rPr lang="en-GB" sz="1200" dirty="0">
                <a:solidFill>
                  <a:schemeClr val="bg1">
                    <a:lumMod val="95000"/>
                  </a:schemeClr>
                </a:solidFill>
                <a:effectLst>
                  <a:outerShdw blurRad="38100" dist="38100" dir="2700000" algn="tl">
                    <a:srgbClr val="000000">
                      <a:alpha val="43137"/>
                    </a:srgbClr>
                  </a:outerShdw>
                </a:effectLst>
                <a:latin typeface="+mj-lt"/>
              </a:rPr>
              <a:t>Travertine</a:t>
            </a:r>
          </a:p>
          <a:p>
            <a:pPr algn="r"/>
            <a:r>
              <a:rPr lang="en-GB" sz="1200" dirty="0">
                <a:solidFill>
                  <a:schemeClr val="bg1">
                    <a:lumMod val="95000"/>
                  </a:schemeClr>
                </a:solidFill>
                <a:effectLst>
                  <a:outerShdw blurRad="38100" dist="38100" dir="2700000" algn="tl">
                    <a:srgbClr val="000000">
                      <a:alpha val="43137"/>
                    </a:srgbClr>
                  </a:outerShdw>
                </a:effectLst>
                <a:latin typeface="+mj-lt"/>
              </a:rPr>
              <a:t>platform 2</a:t>
            </a:r>
          </a:p>
        </p:txBody>
      </p:sp>
    </p:spTree>
    <p:extLst>
      <p:ext uri="{BB962C8B-B14F-4D97-AF65-F5344CB8AC3E}">
        <p14:creationId xmlns:p14="http://schemas.microsoft.com/office/powerpoint/2010/main" val="15104017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46758" y="572589"/>
            <a:ext cx="655949" cy="369332"/>
          </a:xfrm>
          <a:prstGeom prst="rect">
            <a:avLst/>
          </a:prstGeom>
          <a:noFill/>
        </p:spPr>
        <p:txBody>
          <a:bodyPr wrap="none" rtlCol="0">
            <a:spAutoFit/>
          </a:bodyPr>
          <a:lstStyle/>
          <a:p>
            <a:r>
              <a:rPr lang="en-GB" b="1" dirty="0">
                <a:latin typeface="+mj-lt"/>
              </a:rPr>
              <a:t>Fig. F</a:t>
            </a:r>
          </a:p>
        </p:txBody>
      </p:sp>
      <p:pic>
        <p:nvPicPr>
          <p:cNvPr id="3" name="Imagen 2" descr="Imagen que contiene exterior, suelo, árbol, rock&#10;&#10;Descripción generada automáticamente">
            <a:extLst>
              <a:ext uri="{FF2B5EF4-FFF2-40B4-BE49-F238E27FC236}">
                <a16:creationId xmlns:a16="http://schemas.microsoft.com/office/drawing/2014/main" id="{7F588E98-A309-429E-9F4E-51D78CC775B4}"/>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563880"/>
            <a:ext cx="8721247" cy="5792470"/>
          </a:xfrm>
          <a:prstGeom prst="rect">
            <a:avLst/>
          </a:prstGeom>
        </p:spPr>
      </p:pic>
      <p:sp>
        <p:nvSpPr>
          <p:cNvPr id="7" name="CuadroTexto 6">
            <a:extLst>
              <a:ext uri="{FF2B5EF4-FFF2-40B4-BE49-F238E27FC236}">
                <a16:creationId xmlns:a16="http://schemas.microsoft.com/office/drawing/2014/main" id="{3889C81A-620C-4189-B492-56CFEFEAB80F}"/>
              </a:ext>
            </a:extLst>
          </p:cNvPr>
          <p:cNvSpPr txBox="1"/>
          <p:nvPr/>
        </p:nvSpPr>
        <p:spPr>
          <a:xfrm>
            <a:off x="0" y="0"/>
            <a:ext cx="5150834" cy="338554"/>
          </a:xfrm>
          <a:prstGeom prst="rect">
            <a:avLst/>
          </a:prstGeom>
          <a:noFill/>
        </p:spPr>
        <p:txBody>
          <a:bodyPr wrap="none" rtlCol="0">
            <a:spAutoFit/>
          </a:bodyPr>
          <a:lstStyle/>
          <a:p>
            <a:r>
              <a:rPr lang="en-GB" sz="1600" b="1" dirty="0">
                <a:latin typeface="+mj-lt"/>
              </a:rPr>
              <a:t>Supporting Information 1 – Excavation of the Holocene Layers</a:t>
            </a:r>
          </a:p>
        </p:txBody>
      </p:sp>
      <p:sp>
        <p:nvSpPr>
          <p:cNvPr id="9" name="CuadroTexto 8">
            <a:extLst>
              <a:ext uri="{FF2B5EF4-FFF2-40B4-BE49-F238E27FC236}">
                <a16:creationId xmlns:a16="http://schemas.microsoft.com/office/drawing/2014/main" id="{0981F98B-0002-41C2-AA66-886706413658}"/>
              </a:ext>
            </a:extLst>
          </p:cNvPr>
          <p:cNvSpPr txBox="1"/>
          <p:nvPr/>
        </p:nvSpPr>
        <p:spPr>
          <a:xfrm>
            <a:off x="9046758" y="1231719"/>
            <a:ext cx="2849154" cy="3323987"/>
          </a:xfrm>
          <a:prstGeom prst="rect">
            <a:avLst/>
          </a:prstGeom>
          <a:noFill/>
        </p:spPr>
        <p:txBody>
          <a:bodyPr wrap="square" rtlCol="0">
            <a:spAutoFit/>
          </a:bodyPr>
          <a:lstStyle/>
          <a:p>
            <a:pPr algn="just"/>
            <a:r>
              <a:rPr lang="en-GB" sz="1400" dirty="0"/>
              <a:t>Progress of the excavation of the Holocene layers. The Travertine Platform 2 starts to appear mainly at squares D6 – D7</a:t>
            </a:r>
          </a:p>
          <a:p>
            <a:pPr algn="just"/>
            <a:endParaRPr lang="en-GB" sz="1400" dirty="0"/>
          </a:p>
          <a:p>
            <a:pPr algn="just"/>
            <a:r>
              <a:rPr lang="en-GB" sz="1400" dirty="0"/>
              <a:t>The contact between Layer I and Layer II is visible by the sediments colour change on squares E6 – E7. Nevertheless the abundance of burrowing, and probably, the activities related to the Late Neolithic funerary dynamics affected severely the preservation of Layer II.</a:t>
            </a:r>
          </a:p>
          <a:p>
            <a:pPr algn="just"/>
            <a:endParaRPr lang="en-GB" sz="1400" dirty="0"/>
          </a:p>
          <a:p>
            <a:pPr algn="just"/>
            <a:r>
              <a:rPr lang="en-GB" sz="1400" dirty="0"/>
              <a:t>Photo 2010</a:t>
            </a:r>
          </a:p>
        </p:txBody>
      </p:sp>
      <p:sp>
        <p:nvSpPr>
          <p:cNvPr id="10" name="Marcador de número de diapositiva 1">
            <a:extLst>
              <a:ext uri="{FF2B5EF4-FFF2-40B4-BE49-F238E27FC236}">
                <a16:creationId xmlns:a16="http://schemas.microsoft.com/office/drawing/2014/main" id="{2C828704-8319-4699-99BE-4FA0C5C6F513}"/>
              </a:ext>
            </a:extLst>
          </p:cNvPr>
          <p:cNvSpPr txBox="1">
            <a:spLocks/>
          </p:cNvSpPr>
          <p:nvPr/>
        </p:nvSpPr>
        <p:spPr>
          <a:xfrm>
            <a:off x="11696697" y="6371729"/>
            <a:ext cx="315806"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6</a:t>
            </a:fld>
            <a:endParaRPr lang="en-GB" sz="1800" dirty="0">
              <a:latin typeface="+mj-lt"/>
            </a:endParaRPr>
          </a:p>
        </p:txBody>
      </p:sp>
      <p:cxnSp>
        <p:nvCxnSpPr>
          <p:cNvPr id="11" name="Conector recto 10">
            <a:extLst>
              <a:ext uri="{FF2B5EF4-FFF2-40B4-BE49-F238E27FC236}">
                <a16:creationId xmlns:a16="http://schemas.microsoft.com/office/drawing/2014/main" id="{BCBE9B93-DD0E-4EF2-B6FA-365B5BD54ABF}"/>
              </a:ext>
            </a:extLst>
          </p:cNvPr>
          <p:cNvCxnSpPr>
            <a:cxnSpLocks/>
          </p:cNvCxnSpPr>
          <p:nvPr/>
        </p:nvCxnSpPr>
        <p:spPr>
          <a:xfrm>
            <a:off x="9144000" y="1090316"/>
            <a:ext cx="2621280"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2" name="Forma libre: forma 11">
            <a:extLst>
              <a:ext uri="{FF2B5EF4-FFF2-40B4-BE49-F238E27FC236}">
                <a16:creationId xmlns:a16="http://schemas.microsoft.com/office/drawing/2014/main" id="{3054E874-51CC-435F-8541-AD418EA18A7E}"/>
              </a:ext>
            </a:extLst>
          </p:cNvPr>
          <p:cNvSpPr/>
          <p:nvPr/>
        </p:nvSpPr>
        <p:spPr>
          <a:xfrm>
            <a:off x="1261730" y="2778642"/>
            <a:ext cx="3182679" cy="2941674"/>
          </a:xfrm>
          <a:custGeom>
            <a:avLst/>
            <a:gdLst>
              <a:gd name="connsiteX0" fmla="*/ 0 w 3182679"/>
              <a:gd name="connsiteY0" fmla="*/ 2764465 h 2941674"/>
              <a:gd name="connsiteX1" fmla="*/ 198475 w 3182679"/>
              <a:gd name="connsiteY1" fmla="*/ 2771553 h 2941674"/>
              <a:gd name="connsiteX2" fmla="*/ 439479 w 3182679"/>
              <a:gd name="connsiteY2" fmla="*/ 2814084 h 2941674"/>
              <a:gd name="connsiteX3" fmla="*/ 659219 w 3182679"/>
              <a:gd name="connsiteY3" fmla="*/ 2870791 h 2941674"/>
              <a:gd name="connsiteX4" fmla="*/ 985284 w 3182679"/>
              <a:gd name="connsiteY4" fmla="*/ 2941674 h 2941674"/>
              <a:gd name="connsiteX5" fmla="*/ 1275907 w 3182679"/>
              <a:gd name="connsiteY5" fmla="*/ 2899144 h 2941674"/>
              <a:gd name="connsiteX6" fmla="*/ 1438940 w 3182679"/>
              <a:gd name="connsiteY6" fmla="*/ 2799907 h 2941674"/>
              <a:gd name="connsiteX7" fmla="*/ 1538177 w 3182679"/>
              <a:gd name="connsiteY7" fmla="*/ 2658139 h 2941674"/>
              <a:gd name="connsiteX8" fmla="*/ 1594884 w 3182679"/>
              <a:gd name="connsiteY8" fmla="*/ 2544725 h 2941674"/>
              <a:gd name="connsiteX9" fmla="*/ 1644503 w 3182679"/>
              <a:gd name="connsiteY9" fmla="*/ 2402958 h 2941674"/>
              <a:gd name="connsiteX10" fmla="*/ 1694121 w 3182679"/>
              <a:gd name="connsiteY10" fmla="*/ 2268279 h 2941674"/>
              <a:gd name="connsiteX11" fmla="*/ 1920949 w 3182679"/>
              <a:gd name="connsiteY11" fmla="*/ 2048539 h 2941674"/>
              <a:gd name="connsiteX12" fmla="*/ 2069805 w 3182679"/>
              <a:gd name="connsiteY12" fmla="*/ 1949302 h 2941674"/>
              <a:gd name="connsiteX13" fmla="*/ 2303721 w 3182679"/>
              <a:gd name="connsiteY13" fmla="*/ 1864242 h 2941674"/>
              <a:gd name="connsiteX14" fmla="*/ 2523461 w 3182679"/>
              <a:gd name="connsiteY14" fmla="*/ 1807535 h 2941674"/>
              <a:gd name="connsiteX15" fmla="*/ 2757377 w 3182679"/>
              <a:gd name="connsiteY15" fmla="*/ 1772093 h 2941674"/>
              <a:gd name="connsiteX16" fmla="*/ 2906233 w 3182679"/>
              <a:gd name="connsiteY16" fmla="*/ 1736651 h 2941674"/>
              <a:gd name="connsiteX17" fmla="*/ 3019647 w 3182679"/>
              <a:gd name="connsiteY17" fmla="*/ 1672856 h 2941674"/>
              <a:gd name="connsiteX18" fmla="*/ 3097619 w 3182679"/>
              <a:gd name="connsiteY18" fmla="*/ 1566530 h 2941674"/>
              <a:gd name="connsiteX19" fmla="*/ 3118884 w 3182679"/>
              <a:gd name="connsiteY19" fmla="*/ 1396409 h 2941674"/>
              <a:gd name="connsiteX20" fmla="*/ 3125972 w 3182679"/>
              <a:gd name="connsiteY20" fmla="*/ 1318437 h 2941674"/>
              <a:gd name="connsiteX21" fmla="*/ 3125972 w 3182679"/>
              <a:gd name="connsiteY21" fmla="*/ 1318437 h 2941674"/>
              <a:gd name="connsiteX22" fmla="*/ 3125972 w 3182679"/>
              <a:gd name="connsiteY22" fmla="*/ 1318437 h 2941674"/>
              <a:gd name="connsiteX23" fmla="*/ 3147237 w 3182679"/>
              <a:gd name="connsiteY23" fmla="*/ 1233377 h 2941674"/>
              <a:gd name="connsiteX24" fmla="*/ 3182679 w 3182679"/>
              <a:gd name="connsiteY24" fmla="*/ 1070344 h 2941674"/>
              <a:gd name="connsiteX25" fmla="*/ 3182679 w 3182679"/>
              <a:gd name="connsiteY25" fmla="*/ 942753 h 2941674"/>
              <a:gd name="connsiteX26" fmla="*/ 3090530 w 3182679"/>
              <a:gd name="connsiteY26" fmla="*/ 822251 h 2941674"/>
              <a:gd name="connsiteX27" fmla="*/ 3055089 w 3182679"/>
              <a:gd name="connsiteY27" fmla="*/ 701749 h 2941674"/>
              <a:gd name="connsiteX28" fmla="*/ 2977117 w 3182679"/>
              <a:gd name="connsiteY28" fmla="*/ 574158 h 2941674"/>
              <a:gd name="connsiteX29" fmla="*/ 2899144 w 3182679"/>
              <a:gd name="connsiteY29" fmla="*/ 496186 h 2941674"/>
              <a:gd name="connsiteX30" fmla="*/ 2764465 w 3182679"/>
              <a:gd name="connsiteY30" fmla="*/ 474921 h 2941674"/>
              <a:gd name="connsiteX31" fmla="*/ 2651051 w 3182679"/>
              <a:gd name="connsiteY31" fmla="*/ 446567 h 2941674"/>
              <a:gd name="connsiteX32" fmla="*/ 2495107 w 3182679"/>
              <a:gd name="connsiteY32" fmla="*/ 368595 h 2941674"/>
              <a:gd name="connsiteX33" fmla="*/ 2438400 w 3182679"/>
              <a:gd name="connsiteY33" fmla="*/ 318977 h 2941674"/>
              <a:gd name="connsiteX34" fmla="*/ 2410047 w 3182679"/>
              <a:gd name="connsiteY34" fmla="*/ 290623 h 2941674"/>
              <a:gd name="connsiteX35" fmla="*/ 2332075 w 3182679"/>
              <a:gd name="connsiteY35" fmla="*/ 219739 h 2941674"/>
              <a:gd name="connsiteX36" fmla="*/ 2261191 w 3182679"/>
              <a:gd name="connsiteY36" fmla="*/ 170121 h 2941674"/>
              <a:gd name="connsiteX37" fmla="*/ 2169042 w 3182679"/>
              <a:gd name="connsiteY37" fmla="*/ 99237 h 2941674"/>
              <a:gd name="connsiteX38" fmla="*/ 2083982 w 3182679"/>
              <a:gd name="connsiteY38" fmla="*/ 28353 h 2941674"/>
              <a:gd name="connsiteX39" fmla="*/ 2013098 w 3182679"/>
              <a:gd name="connsiteY39" fmla="*/ 28353 h 2941674"/>
              <a:gd name="connsiteX40" fmla="*/ 2013098 w 3182679"/>
              <a:gd name="connsiteY40" fmla="*/ 28353 h 2941674"/>
              <a:gd name="connsiteX41" fmla="*/ 1885507 w 3182679"/>
              <a:gd name="connsiteY41" fmla="*/ 7088 h 2941674"/>
              <a:gd name="connsiteX42" fmla="*/ 1779182 w 3182679"/>
              <a:gd name="connsiteY42" fmla="*/ 0 h 2941674"/>
              <a:gd name="connsiteX43" fmla="*/ 1679944 w 3182679"/>
              <a:gd name="connsiteY43" fmla="*/ 0 h 2941674"/>
              <a:gd name="connsiteX44" fmla="*/ 1616149 w 3182679"/>
              <a:gd name="connsiteY44" fmla="*/ 7088 h 294167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Lst>
            <a:rect l="l" t="t" r="r" b="b"/>
            <a:pathLst>
              <a:path w="3182679" h="2941674">
                <a:moveTo>
                  <a:pt x="0" y="2764465"/>
                </a:moveTo>
                <a:lnTo>
                  <a:pt x="198475" y="2771553"/>
                </a:lnTo>
                <a:lnTo>
                  <a:pt x="439479" y="2814084"/>
                </a:lnTo>
                <a:lnTo>
                  <a:pt x="659219" y="2870791"/>
                </a:lnTo>
                <a:lnTo>
                  <a:pt x="985284" y="2941674"/>
                </a:lnTo>
                <a:lnTo>
                  <a:pt x="1275907" y="2899144"/>
                </a:lnTo>
                <a:lnTo>
                  <a:pt x="1438940" y="2799907"/>
                </a:lnTo>
                <a:lnTo>
                  <a:pt x="1538177" y="2658139"/>
                </a:lnTo>
                <a:lnTo>
                  <a:pt x="1594884" y="2544725"/>
                </a:lnTo>
                <a:lnTo>
                  <a:pt x="1644503" y="2402958"/>
                </a:lnTo>
                <a:lnTo>
                  <a:pt x="1694121" y="2268279"/>
                </a:lnTo>
                <a:lnTo>
                  <a:pt x="1920949" y="2048539"/>
                </a:lnTo>
                <a:lnTo>
                  <a:pt x="2069805" y="1949302"/>
                </a:lnTo>
                <a:lnTo>
                  <a:pt x="2303721" y="1864242"/>
                </a:lnTo>
                <a:lnTo>
                  <a:pt x="2523461" y="1807535"/>
                </a:lnTo>
                <a:lnTo>
                  <a:pt x="2757377" y="1772093"/>
                </a:lnTo>
                <a:lnTo>
                  <a:pt x="2906233" y="1736651"/>
                </a:lnTo>
                <a:lnTo>
                  <a:pt x="3019647" y="1672856"/>
                </a:lnTo>
                <a:lnTo>
                  <a:pt x="3097619" y="1566530"/>
                </a:lnTo>
                <a:lnTo>
                  <a:pt x="3118884" y="1396409"/>
                </a:lnTo>
                <a:lnTo>
                  <a:pt x="3125972" y="1318437"/>
                </a:lnTo>
                <a:lnTo>
                  <a:pt x="3125972" y="1318437"/>
                </a:lnTo>
                <a:lnTo>
                  <a:pt x="3125972" y="1318437"/>
                </a:lnTo>
                <a:lnTo>
                  <a:pt x="3147237" y="1233377"/>
                </a:lnTo>
                <a:lnTo>
                  <a:pt x="3182679" y="1070344"/>
                </a:lnTo>
                <a:lnTo>
                  <a:pt x="3182679" y="942753"/>
                </a:lnTo>
                <a:lnTo>
                  <a:pt x="3090530" y="822251"/>
                </a:lnTo>
                <a:lnTo>
                  <a:pt x="3055089" y="701749"/>
                </a:lnTo>
                <a:lnTo>
                  <a:pt x="2977117" y="574158"/>
                </a:lnTo>
                <a:lnTo>
                  <a:pt x="2899144" y="496186"/>
                </a:lnTo>
                <a:lnTo>
                  <a:pt x="2764465" y="474921"/>
                </a:lnTo>
                <a:lnTo>
                  <a:pt x="2651051" y="446567"/>
                </a:lnTo>
                <a:lnTo>
                  <a:pt x="2495107" y="368595"/>
                </a:lnTo>
                <a:lnTo>
                  <a:pt x="2438400" y="318977"/>
                </a:lnTo>
                <a:lnTo>
                  <a:pt x="2410047" y="290623"/>
                </a:lnTo>
                <a:lnTo>
                  <a:pt x="2332075" y="219739"/>
                </a:lnTo>
                <a:lnTo>
                  <a:pt x="2261191" y="170121"/>
                </a:lnTo>
                <a:lnTo>
                  <a:pt x="2169042" y="99237"/>
                </a:lnTo>
                <a:lnTo>
                  <a:pt x="2083982" y="28353"/>
                </a:lnTo>
                <a:lnTo>
                  <a:pt x="2013098" y="28353"/>
                </a:lnTo>
                <a:lnTo>
                  <a:pt x="2013098" y="28353"/>
                </a:lnTo>
                <a:lnTo>
                  <a:pt x="1885507" y="7088"/>
                </a:lnTo>
                <a:lnTo>
                  <a:pt x="1779182" y="0"/>
                </a:lnTo>
                <a:lnTo>
                  <a:pt x="1679944" y="0"/>
                </a:lnTo>
                <a:lnTo>
                  <a:pt x="1616149" y="7088"/>
                </a:lnTo>
              </a:path>
            </a:pathLst>
          </a:custGeom>
          <a:noFill/>
          <a:ln w="9525">
            <a:solidFill>
              <a:schemeClr val="bg1"/>
            </a:solidFill>
            <a:prstDash val="dash"/>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Forma libre: forma 12">
            <a:extLst>
              <a:ext uri="{FF2B5EF4-FFF2-40B4-BE49-F238E27FC236}">
                <a16:creationId xmlns:a16="http://schemas.microsoft.com/office/drawing/2014/main" id="{A28A4DF3-4E61-41A3-AE25-F26B07BBC505}"/>
              </a:ext>
            </a:extLst>
          </p:cNvPr>
          <p:cNvSpPr/>
          <p:nvPr/>
        </p:nvSpPr>
        <p:spPr>
          <a:xfrm>
            <a:off x="3990753" y="2261191"/>
            <a:ext cx="1878419" cy="1282995"/>
          </a:xfrm>
          <a:custGeom>
            <a:avLst/>
            <a:gdLst>
              <a:gd name="connsiteX0" fmla="*/ 0 w 1878419"/>
              <a:gd name="connsiteY0" fmla="*/ 0 h 1282995"/>
              <a:gd name="connsiteX1" fmla="*/ 70884 w 1878419"/>
              <a:gd name="connsiteY1" fmla="*/ 56707 h 1282995"/>
              <a:gd name="connsiteX2" fmla="*/ 219740 w 1878419"/>
              <a:gd name="connsiteY2" fmla="*/ 120502 h 1282995"/>
              <a:gd name="connsiteX3" fmla="*/ 283535 w 1878419"/>
              <a:gd name="connsiteY3" fmla="*/ 148856 h 1282995"/>
              <a:gd name="connsiteX4" fmla="*/ 340242 w 1878419"/>
              <a:gd name="connsiteY4" fmla="*/ 198474 h 1282995"/>
              <a:gd name="connsiteX5" fmla="*/ 446568 w 1878419"/>
              <a:gd name="connsiteY5" fmla="*/ 269358 h 1282995"/>
              <a:gd name="connsiteX6" fmla="*/ 531628 w 1878419"/>
              <a:gd name="connsiteY6" fmla="*/ 262269 h 1282995"/>
              <a:gd name="connsiteX7" fmla="*/ 723014 w 1878419"/>
              <a:gd name="connsiteY7" fmla="*/ 262269 h 1282995"/>
              <a:gd name="connsiteX8" fmla="*/ 971107 w 1878419"/>
              <a:gd name="connsiteY8" fmla="*/ 276446 h 1282995"/>
              <a:gd name="connsiteX9" fmla="*/ 1155405 w 1878419"/>
              <a:gd name="connsiteY9" fmla="*/ 304800 h 1282995"/>
              <a:gd name="connsiteX10" fmla="*/ 1304261 w 1878419"/>
              <a:gd name="connsiteY10" fmla="*/ 318976 h 1282995"/>
              <a:gd name="connsiteX11" fmla="*/ 1396410 w 1878419"/>
              <a:gd name="connsiteY11" fmla="*/ 304800 h 1282995"/>
              <a:gd name="connsiteX12" fmla="*/ 1516912 w 1878419"/>
              <a:gd name="connsiteY12" fmla="*/ 290623 h 1282995"/>
              <a:gd name="connsiteX13" fmla="*/ 1630326 w 1878419"/>
              <a:gd name="connsiteY13" fmla="*/ 290623 h 1282995"/>
              <a:gd name="connsiteX14" fmla="*/ 1772094 w 1878419"/>
              <a:gd name="connsiteY14" fmla="*/ 361507 h 1282995"/>
              <a:gd name="connsiteX15" fmla="*/ 1835889 w 1878419"/>
              <a:gd name="connsiteY15" fmla="*/ 418214 h 1282995"/>
              <a:gd name="connsiteX16" fmla="*/ 1878419 w 1878419"/>
              <a:gd name="connsiteY16" fmla="*/ 503274 h 1282995"/>
              <a:gd name="connsiteX17" fmla="*/ 1878419 w 1878419"/>
              <a:gd name="connsiteY17" fmla="*/ 567069 h 1282995"/>
              <a:gd name="connsiteX18" fmla="*/ 1807535 w 1878419"/>
              <a:gd name="connsiteY18" fmla="*/ 609600 h 1282995"/>
              <a:gd name="connsiteX19" fmla="*/ 1807535 w 1878419"/>
              <a:gd name="connsiteY19" fmla="*/ 609600 h 1282995"/>
              <a:gd name="connsiteX20" fmla="*/ 1708298 w 1878419"/>
              <a:gd name="connsiteY20" fmla="*/ 673395 h 1282995"/>
              <a:gd name="connsiteX21" fmla="*/ 1594884 w 1878419"/>
              <a:gd name="connsiteY21" fmla="*/ 730102 h 1282995"/>
              <a:gd name="connsiteX22" fmla="*/ 1552354 w 1878419"/>
              <a:gd name="connsiteY22" fmla="*/ 772632 h 1282995"/>
              <a:gd name="connsiteX23" fmla="*/ 1516912 w 1878419"/>
              <a:gd name="connsiteY23" fmla="*/ 857693 h 1282995"/>
              <a:gd name="connsiteX24" fmla="*/ 1502735 w 1878419"/>
              <a:gd name="connsiteY24" fmla="*/ 921488 h 1282995"/>
              <a:gd name="connsiteX25" fmla="*/ 1481470 w 1878419"/>
              <a:gd name="connsiteY25" fmla="*/ 985283 h 1282995"/>
              <a:gd name="connsiteX26" fmla="*/ 1460205 w 1878419"/>
              <a:gd name="connsiteY26" fmla="*/ 1063256 h 1282995"/>
              <a:gd name="connsiteX27" fmla="*/ 1446028 w 1878419"/>
              <a:gd name="connsiteY27" fmla="*/ 1155404 h 1282995"/>
              <a:gd name="connsiteX28" fmla="*/ 1446028 w 1878419"/>
              <a:gd name="connsiteY28" fmla="*/ 1155404 h 1282995"/>
              <a:gd name="connsiteX29" fmla="*/ 1410587 w 1878419"/>
              <a:gd name="connsiteY29" fmla="*/ 1219200 h 1282995"/>
              <a:gd name="connsiteX30" fmla="*/ 1360968 w 1878419"/>
              <a:gd name="connsiteY30" fmla="*/ 1240465 h 1282995"/>
              <a:gd name="connsiteX31" fmla="*/ 1219200 w 1878419"/>
              <a:gd name="connsiteY31" fmla="*/ 1233376 h 1282995"/>
              <a:gd name="connsiteX32" fmla="*/ 1112875 w 1878419"/>
              <a:gd name="connsiteY32" fmla="*/ 1233376 h 1282995"/>
              <a:gd name="connsiteX33" fmla="*/ 1105787 w 1878419"/>
              <a:gd name="connsiteY33" fmla="*/ 1233376 h 1282995"/>
              <a:gd name="connsiteX34" fmla="*/ 1034903 w 1878419"/>
              <a:gd name="connsiteY34" fmla="*/ 1169581 h 1282995"/>
              <a:gd name="connsiteX35" fmla="*/ 964019 w 1878419"/>
              <a:gd name="connsiteY35" fmla="*/ 1098697 h 1282995"/>
              <a:gd name="connsiteX36" fmla="*/ 758456 w 1878419"/>
              <a:gd name="connsiteY36" fmla="*/ 1084521 h 1282995"/>
              <a:gd name="connsiteX37" fmla="*/ 687573 w 1878419"/>
              <a:gd name="connsiteY37" fmla="*/ 1141228 h 1282995"/>
              <a:gd name="connsiteX38" fmla="*/ 559982 w 1878419"/>
              <a:gd name="connsiteY38" fmla="*/ 1183758 h 1282995"/>
              <a:gd name="connsiteX39" fmla="*/ 503275 w 1878419"/>
              <a:gd name="connsiteY39" fmla="*/ 1226288 h 1282995"/>
              <a:gd name="connsiteX40" fmla="*/ 425303 w 1878419"/>
              <a:gd name="connsiteY40" fmla="*/ 1268818 h 1282995"/>
              <a:gd name="connsiteX41" fmla="*/ 354419 w 1878419"/>
              <a:gd name="connsiteY41" fmla="*/ 1282995 h 128299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Lst>
            <a:rect l="l" t="t" r="r" b="b"/>
            <a:pathLst>
              <a:path w="1878419" h="1282995">
                <a:moveTo>
                  <a:pt x="0" y="0"/>
                </a:moveTo>
                <a:lnTo>
                  <a:pt x="70884" y="56707"/>
                </a:lnTo>
                <a:lnTo>
                  <a:pt x="219740" y="120502"/>
                </a:lnTo>
                <a:lnTo>
                  <a:pt x="283535" y="148856"/>
                </a:lnTo>
                <a:lnTo>
                  <a:pt x="340242" y="198474"/>
                </a:lnTo>
                <a:lnTo>
                  <a:pt x="446568" y="269358"/>
                </a:lnTo>
                <a:lnTo>
                  <a:pt x="531628" y="262269"/>
                </a:lnTo>
                <a:lnTo>
                  <a:pt x="723014" y="262269"/>
                </a:lnTo>
                <a:lnTo>
                  <a:pt x="971107" y="276446"/>
                </a:lnTo>
                <a:lnTo>
                  <a:pt x="1155405" y="304800"/>
                </a:lnTo>
                <a:lnTo>
                  <a:pt x="1304261" y="318976"/>
                </a:lnTo>
                <a:lnTo>
                  <a:pt x="1396410" y="304800"/>
                </a:lnTo>
                <a:lnTo>
                  <a:pt x="1516912" y="290623"/>
                </a:lnTo>
                <a:lnTo>
                  <a:pt x="1630326" y="290623"/>
                </a:lnTo>
                <a:lnTo>
                  <a:pt x="1772094" y="361507"/>
                </a:lnTo>
                <a:lnTo>
                  <a:pt x="1835889" y="418214"/>
                </a:lnTo>
                <a:lnTo>
                  <a:pt x="1878419" y="503274"/>
                </a:lnTo>
                <a:lnTo>
                  <a:pt x="1878419" y="567069"/>
                </a:lnTo>
                <a:lnTo>
                  <a:pt x="1807535" y="609600"/>
                </a:lnTo>
                <a:lnTo>
                  <a:pt x="1807535" y="609600"/>
                </a:lnTo>
                <a:lnTo>
                  <a:pt x="1708298" y="673395"/>
                </a:lnTo>
                <a:lnTo>
                  <a:pt x="1594884" y="730102"/>
                </a:lnTo>
                <a:lnTo>
                  <a:pt x="1552354" y="772632"/>
                </a:lnTo>
                <a:lnTo>
                  <a:pt x="1516912" y="857693"/>
                </a:lnTo>
                <a:lnTo>
                  <a:pt x="1502735" y="921488"/>
                </a:lnTo>
                <a:lnTo>
                  <a:pt x="1481470" y="985283"/>
                </a:lnTo>
                <a:lnTo>
                  <a:pt x="1460205" y="1063256"/>
                </a:lnTo>
                <a:lnTo>
                  <a:pt x="1446028" y="1155404"/>
                </a:lnTo>
                <a:lnTo>
                  <a:pt x="1446028" y="1155404"/>
                </a:lnTo>
                <a:lnTo>
                  <a:pt x="1410587" y="1219200"/>
                </a:lnTo>
                <a:lnTo>
                  <a:pt x="1360968" y="1240465"/>
                </a:lnTo>
                <a:lnTo>
                  <a:pt x="1219200" y="1233376"/>
                </a:lnTo>
                <a:lnTo>
                  <a:pt x="1112875" y="1233376"/>
                </a:lnTo>
                <a:lnTo>
                  <a:pt x="1105787" y="1233376"/>
                </a:lnTo>
                <a:lnTo>
                  <a:pt x="1034903" y="1169581"/>
                </a:lnTo>
                <a:lnTo>
                  <a:pt x="964019" y="1098697"/>
                </a:lnTo>
                <a:lnTo>
                  <a:pt x="758456" y="1084521"/>
                </a:lnTo>
                <a:lnTo>
                  <a:pt x="687573" y="1141228"/>
                </a:lnTo>
                <a:lnTo>
                  <a:pt x="559982" y="1183758"/>
                </a:lnTo>
                <a:lnTo>
                  <a:pt x="503275" y="1226288"/>
                </a:lnTo>
                <a:lnTo>
                  <a:pt x="425303" y="1268818"/>
                </a:lnTo>
                <a:lnTo>
                  <a:pt x="354419" y="1282995"/>
                </a:lnTo>
              </a:path>
            </a:pathLst>
          </a:custGeom>
          <a:noFill/>
          <a:ln>
            <a:solidFill>
              <a:schemeClr val="bg1"/>
            </a:solidFill>
            <a:prstDash val="lgDashDotDot"/>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CuadroTexto 13">
            <a:extLst>
              <a:ext uri="{FF2B5EF4-FFF2-40B4-BE49-F238E27FC236}">
                <a16:creationId xmlns:a16="http://schemas.microsoft.com/office/drawing/2014/main" id="{F7FC30E6-88C7-4574-849E-56687F08A67F}"/>
              </a:ext>
            </a:extLst>
          </p:cNvPr>
          <p:cNvSpPr txBox="1"/>
          <p:nvPr/>
        </p:nvSpPr>
        <p:spPr>
          <a:xfrm>
            <a:off x="1547129" y="5021732"/>
            <a:ext cx="1150143" cy="461665"/>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Travertine</a:t>
            </a:r>
          </a:p>
          <a:p>
            <a:r>
              <a:rPr lang="en-GB" sz="1200" dirty="0">
                <a:solidFill>
                  <a:schemeClr val="bg1">
                    <a:lumMod val="95000"/>
                  </a:schemeClr>
                </a:solidFill>
                <a:effectLst>
                  <a:outerShdw blurRad="38100" dist="38100" dir="2700000" algn="tl">
                    <a:srgbClr val="000000">
                      <a:alpha val="43137"/>
                    </a:srgbClr>
                  </a:outerShdw>
                </a:effectLst>
                <a:latin typeface="+mj-lt"/>
              </a:rPr>
              <a:t>platform 2</a:t>
            </a:r>
          </a:p>
        </p:txBody>
      </p:sp>
      <p:sp>
        <p:nvSpPr>
          <p:cNvPr id="15" name="CuadroTexto 14">
            <a:extLst>
              <a:ext uri="{FF2B5EF4-FFF2-40B4-BE49-F238E27FC236}">
                <a16:creationId xmlns:a16="http://schemas.microsoft.com/office/drawing/2014/main" id="{0246C265-0678-441D-AC29-28F97598177B}"/>
              </a:ext>
            </a:extLst>
          </p:cNvPr>
          <p:cNvSpPr txBox="1"/>
          <p:nvPr/>
        </p:nvSpPr>
        <p:spPr>
          <a:xfrm>
            <a:off x="4054970" y="2104418"/>
            <a:ext cx="1150143" cy="276999"/>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Layer I</a:t>
            </a:r>
          </a:p>
        </p:txBody>
      </p:sp>
      <p:sp>
        <p:nvSpPr>
          <p:cNvPr id="16" name="CuadroTexto 15">
            <a:extLst>
              <a:ext uri="{FF2B5EF4-FFF2-40B4-BE49-F238E27FC236}">
                <a16:creationId xmlns:a16="http://schemas.microsoft.com/office/drawing/2014/main" id="{64071408-3598-4B1E-9772-109689A32B24}"/>
              </a:ext>
            </a:extLst>
          </p:cNvPr>
          <p:cNvSpPr txBox="1"/>
          <p:nvPr/>
        </p:nvSpPr>
        <p:spPr>
          <a:xfrm>
            <a:off x="3294266" y="2441530"/>
            <a:ext cx="1150143" cy="276999"/>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Layer II</a:t>
            </a:r>
          </a:p>
        </p:txBody>
      </p:sp>
    </p:spTree>
    <p:extLst>
      <p:ext uri="{BB962C8B-B14F-4D97-AF65-F5344CB8AC3E}">
        <p14:creationId xmlns:p14="http://schemas.microsoft.com/office/powerpoint/2010/main" val="29938316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55468" y="711931"/>
            <a:ext cx="694421" cy="369332"/>
          </a:xfrm>
          <a:prstGeom prst="rect">
            <a:avLst/>
          </a:prstGeom>
          <a:noFill/>
        </p:spPr>
        <p:txBody>
          <a:bodyPr wrap="none" rtlCol="0">
            <a:spAutoFit/>
          </a:bodyPr>
          <a:lstStyle/>
          <a:p>
            <a:r>
              <a:rPr lang="en-GB" b="1" dirty="0">
                <a:latin typeface="+mj-lt"/>
              </a:rPr>
              <a:t>Fig. G</a:t>
            </a:r>
          </a:p>
        </p:txBody>
      </p:sp>
      <p:pic>
        <p:nvPicPr>
          <p:cNvPr id="4" name="Imagen 3" descr="Imagen que contiene edificio, suelo, exterior&#10;&#10;Descripción generada automáticamente">
            <a:extLst>
              <a:ext uri="{FF2B5EF4-FFF2-40B4-BE49-F238E27FC236}">
                <a16:creationId xmlns:a16="http://schemas.microsoft.com/office/drawing/2014/main" id="{771965AC-BAEC-4A59-B9F7-70CE59104C90}"/>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676622"/>
            <a:ext cx="8740141" cy="5811264"/>
          </a:xfrm>
          <a:prstGeom prst="rect">
            <a:avLst/>
          </a:prstGeom>
        </p:spPr>
      </p:pic>
      <p:sp>
        <p:nvSpPr>
          <p:cNvPr id="7" name="CuadroTexto 6">
            <a:extLst>
              <a:ext uri="{FF2B5EF4-FFF2-40B4-BE49-F238E27FC236}">
                <a16:creationId xmlns:a16="http://schemas.microsoft.com/office/drawing/2014/main" id="{DC555233-CE3B-4FB2-9E30-61F323E981F8}"/>
              </a:ext>
            </a:extLst>
          </p:cNvPr>
          <p:cNvSpPr txBox="1"/>
          <p:nvPr/>
        </p:nvSpPr>
        <p:spPr>
          <a:xfrm>
            <a:off x="0" y="0"/>
            <a:ext cx="5150834" cy="338554"/>
          </a:xfrm>
          <a:prstGeom prst="rect">
            <a:avLst/>
          </a:prstGeom>
          <a:noFill/>
        </p:spPr>
        <p:txBody>
          <a:bodyPr wrap="none" rtlCol="0">
            <a:spAutoFit/>
          </a:bodyPr>
          <a:lstStyle/>
          <a:p>
            <a:r>
              <a:rPr lang="en-GB" sz="1600" b="1" dirty="0">
                <a:latin typeface="+mj-lt"/>
              </a:rPr>
              <a:t>Supporting Information 1 – Excavation of the Holocene Layers</a:t>
            </a:r>
          </a:p>
        </p:txBody>
      </p:sp>
      <p:sp>
        <p:nvSpPr>
          <p:cNvPr id="9" name="CuadroTexto 8">
            <a:extLst>
              <a:ext uri="{FF2B5EF4-FFF2-40B4-BE49-F238E27FC236}">
                <a16:creationId xmlns:a16="http://schemas.microsoft.com/office/drawing/2014/main" id="{7BBD13A1-B0A8-479D-B525-F6975AFA4CFE}"/>
              </a:ext>
            </a:extLst>
          </p:cNvPr>
          <p:cNvSpPr txBox="1"/>
          <p:nvPr/>
        </p:nvSpPr>
        <p:spPr>
          <a:xfrm>
            <a:off x="9055468" y="1371061"/>
            <a:ext cx="2840446" cy="4401205"/>
          </a:xfrm>
          <a:prstGeom prst="rect">
            <a:avLst/>
          </a:prstGeom>
          <a:noFill/>
        </p:spPr>
        <p:txBody>
          <a:bodyPr wrap="square" rtlCol="0">
            <a:spAutoFit/>
          </a:bodyPr>
          <a:lstStyle/>
          <a:p>
            <a:pPr algn="just"/>
            <a:r>
              <a:rPr lang="en-GB" sz="1400" dirty="0"/>
              <a:t>The excavation works of Layer II finished in 2012. </a:t>
            </a:r>
          </a:p>
          <a:p>
            <a:pPr algn="just"/>
            <a:endParaRPr lang="en-GB" sz="1400" dirty="0"/>
          </a:p>
          <a:p>
            <a:pPr algn="just"/>
            <a:r>
              <a:rPr lang="en-GB" sz="1400" dirty="0"/>
              <a:t>The surface of Travertine Platform 2 expanded, appearing also  in squares E6, C 6-7 and B6.</a:t>
            </a:r>
          </a:p>
          <a:p>
            <a:pPr algn="just"/>
            <a:endParaRPr lang="en-GB" sz="1400" dirty="0"/>
          </a:p>
          <a:p>
            <a:pPr algn="just"/>
            <a:r>
              <a:rPr lang="en-GB" sz="1400" dirty="0"/>
              <a:t>Below the slate board appears the top of the Unit III (squares E9 – D9), posteriorly divided into layers </a:t>
            </a:r>
            <a:r>
              <a:rPr lang="en-GB" sz="1400" dirty="0" err="1"/>
              <a:t>IIIn</a:t>
            </a:r>
            <a:r>
              <a:rPr lang="en-GB" sz="1400" dirty="0"/>
              <a:t>, </a:t>
            </a:r>
            <a:r>
              <a:rPr lang="en-GB" sz="1400" dirty="0" err="1"/>
              <a:t>IIIg</a:t>
            </a:r>
            <a:r>
              <a:rPr lang="en-GB" sz="1400" dirty="0"/>
              <a:t> and IIIc. </a:t>
            </a:r>
          </a:p>
          <a:p>
            <a:pPr algn="just"/>
            <a:endParaRPr lang="en-GB" sz="1400" dirty="0"/>
          </a:p>
          <a:p>
            <a:pPr algn="just"/>
            <a:r>
              <a:rPr lang="en-GB" sz="1400" dirty="0"/>
              <a:t>The effects of the erosive processes affecting the top of Unit III can be seen in squares E7-8 and F8-9, where the yellowish sediment of the Unit III is starting to be uncovered at a much lower depth than in E9 – D9. </a:t>
            </a:r>
          </a:p>
          <a:p>
            <a:pPr algn="just"/>
            <a:endParaRPr lang="en-GB" sz="1400" dirty="0"/>
          </a:p>
          <a:p>
            <a:pPr algn="just"/>
            <a:r>
              <a:rPr lang="en-GB" sz="1400" dirty="0"/>
              <a:t>Photo 2012</a:t>
            </a:r>
          </a:p>
        </p:txBody>
      </p:sp>
      <p:cxnSp>
        <p:nvCxnSpPr>
          <p:cNvPr id="8" name="Conector recto 7">
            <a:extLst>
              <a:ext uri="{FF2B5EF4-FFF2-40B4-BE49-F238E27FC236}">
                <a16:creationId xmlns:a16="http://schemas.microsoft.com/office/drawing/2014/main" id="{09E83849-1623-46CD-8BCA-A8ACB4275A54}"/>
              </a:ext>
            </a:extLst>
          </p:cNvPr>
          <p:cNvCxnSpPr>
            <a:cxnSpLocks/>
          </p:cNvCxnSpPr>
          <p:nvPr/>
        </p:nvCxnSpPr>
        <p:spPr>
          <a:xfrm>
            <a:off x="9126583" y="1238364"/>
            <a:ext cx="2682240"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0" name="Marcador de número de diapositiva 1">
            <a:extLst>
              <a:ext uri="{FF2B5EF4-FFF2-40B4-BE49-F238E27FC236}">
                <a16:creationId xmlns:a16="http://schemas.microsoft.com/office/drawing/2014/main" id="{CCF3B6D4-5EE9-49F9-BC61-DBC9E3C82E86}"/>
              </a:ext>
            </a:extLst>
          </p:cNvPr>
          <p:cNvSpPr txBox="1">
            <a:spLocks/>
          </p:cNvSpPr>
          <p:nvPr/>
        </p:nvSpPr>
        <p:spPr>
          <a:xfrm>
            <a:off x="11696697" y="6371729"/>
            <a:ext cx="315806"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7</a:t>
            </a:fld>
            <a:endParaRPr lang="en-GB" sz="1800" dirty="0">
              <a:latin typeface="+mj-lt"/>
            </a:endParaRPr>
          </a:p>
        </p:txBody>
      </p:sp>
      <p:sp>
        <p:nvSpPr>
          <p:cNvPr id="15" name="Forma libre: forma 14">
            <a:extLst>
              <a:ext uri="{FF2B5EF4-FFF2-40B4-BE49-F238E27FC236}">
                <a16:creationId xmlns:a16="http://schemas.microsoft.com/office/drawing/2014/main" id="{35DFB923-79DD-4333-B0DE-367B6456557B}"/>
              </a:ext>
            </a:extLst>
          </p:cNvPr>
          <p:cNvSpPr/>
          <p:nvPr/>
        </p:nvSpPr>
        <p:spPr>
          <a:xfrm>
            <a:off x="4253948" y="3601941"/>
            <a:ext cx="4476584" cy="2862469"/>
          </a:xfrm>
          <a:custGeom>
            <a:avLst/>
            <a:gdLst>
              <a:gd name="connsiteX0" fmla="*/ 4476584 w 4476584"/>
              <a:gd name="connsiteY0" fmla="*/ 1200647 h 2862469"/>
              <a:gd name="connsiteX1" fmla="*/ 4309607 w 4476584"/>
              <a:gd name="connsiteY1" fmla="*/ 1152939 h 2862469"/>
              <a:gd name="connsiteX2" fmla="*/ 4110824 w 4476584"/>
              <a:gd name="connsiteY2" fmla="*/ 1041621 h 2862469"/>
              <a:gd name="connsiteX3" fmla="*/ 3935895 w 4476584"/>
              <a:gd name="connsiteY3" fmla="*/ 914400 h 2862469"/>
              <a:gd name="connsiteX4" fmla="*/ 3800723 w 4476584"/>
              <a:gd name="connsiteY4" fmla="*/ 874643 h 2862469"/>
              <a:gd name="connsiteX5" fmla="*/ 3617843 w 4476584"/>
              <a:gd name="connsiteY5" fmla="*/ 811033 h 2862469"/>
              <a:gd name="connsiteX6" fmla="*/ 3434963 w 4476584"/>
              <a:gd name="connsiteY6" fmla="*/ 747422 h 2862469"/>
              <a:gd name="connsiteX7" fmla="*/ 3252083 w 4476584"/>
              <a:gd name="connsiteY7" fmla="*/ 683812 h 2862469"/>
              <a:gd name="connsiteX8" fmla="*/ 3108960 w 4476584"/>
              <a:gd name="connsiteY8" fmla="*/ 588396 h 2862469"/>
              <a:gd name="connsiteX9" fmla="*/ 2973788 w 4476584"/>
              <a:gd name="connsiteY9" fmla="*/ 500932 h 2862469"/>
              <a:gd name="connsiteX10" fmla="*/ 2775005 w 4476584"/>
              <a:gd name="connsiteY10" fmla="*/ 326003 h 2862469"/>
              <a:gd name="connsiteX11" fmla="*/ 2639833 w 4476584"/>
              <a:gd name="connsiteY11" fmla="*/ 214685 h 2862469"/>
              <a:gd name="connsiteX12" fmla="*/ 2592125 w 4476584"/>
              <a:gd name="connsiteY12" fmla="*/ 135172 h 2862469"/>
              <a:gd name="connsiteX13" fmla="*/ 2496709 w 4476584"/>
              <a:gd name="connsiteY13" fmla="*/ 79513 h 2862469"/>
              <a:gd name="connsiteX14" fmla="*/ 2361537 w 4476584"/>
              <a:gd name="connsiteY14" fmla="*/ 0 h 2862469"/>
              <a:gd name="connsiteX15" fmla="*/ 2258170 w 4476584"/>
              <a:gd name="connsiteY15" fmla="*/ 7951 h 2862469"/>
              <a:gd name="connsiteX16" fmla="*/ 2170706 w 4476584"/>
              <a:gd name="connsiteY16" fmla="*/ 23854 h 2862469"/>
              <a:gd name="connsiteX17" fmla="*/ 2115047 w 4476584"/>
              <a:gd name="connsiteY17" fmla="*/ 39756 h 2862469"/>
              <a:gd name="connsiteX18" fmla="*/ 2011680 w 4476584"/>
              <a:gd name="connsiteY18" fmla="*/ 15902 h 2862469"/>
              <a:gd name="connsiteX19" fmla="*/ 1860605 w 4476584"/>
              <a:gd name="connsiteY19" fmla="*/ 0 h 2862469"/>
              <a:gd name="connsiteX20" fmla="*/ 1812897 w 4476584"/>
              <a:gd name="connsiteY20" fmla="*/ 7951 h 2862469"/>
              <a:gd name="connsiteX21" fmla="*/ 1741335 w 4476584"/>
              <a:gd name="connsiteY21" fmla="*/ 55659 h 2862469"/>
              <a:gd name="connsiteX22" fmla="*/ 1677725 w 4476584"/>
              <a:gd name="connsiteY22" fmla="*/ 127221 h 2862469"/>
              <a:gd name="connsiteX23" fmla="*/ 1669774 w 4476584"/>
              <a:gd name="connsiteY23" fmla="*/ 238539 h 2862469"/>
              <a:gd name="connsiteX24" fmla="*/ 1661822 w 4476584"/>
              <a:gd name="connsiteY24" fmla="*/ 365760 h 2862469"/>
              <a:gd name="connsiteX25" fmla="*/ 1582309 w 4476584"/>
              <a:gd name="connsiteY25" fmla="*/ 405516 h 2862469"/>
              <a:gd name="connsiteX26" fmla="*/ 1470991 w 4476584"/>
              <a:gd name="connsiteY26" fmla="*/ 373711 h 2862469"/>
              <a:gd name="connsiteX27" fmla="*/ 1359673 w 4476584"/>
              <a:gd name="connsiteY27" fmla="*/ 326003 h 2862469"/>
              <a:gd name="connsiteX28" fmla="*/ 1224501 w 4476584"/>
              <a:gd name="connsiteY28" fmla="*/ 318052 h 2862469"/>
              <a:gd name="connsiteX29" fmla="*/ 1168842 w 4476584"/>
              <a:gd name="connsiteY29" fmla="*/ 357809 h 2862469"/>
              <a:gd name="connsiteX30" fmla="*/ 1105231 w 4476584"/>
              <a:gd name="connsiteY30" fmla="*/ 389614 h 2862469"/>
              <a:gd name="connsiteX31" fmla="*/ 962108 w 4476584"/>
              <a:gd name="connsiteY31" fmla="*/ 389614 h 2862469"/>
              <a:gd name="connsiteX32" fmla="*/ 850789 w 4476584"/>
              <a:gd name="connsiteY32" fmla="*/ 413468 h 2862469"/>
              <a:gd name="connsiteX33" fmla="*/ 667909 w 4476584"/>
              <a:gd name="connsiteY33" fmla="*/ 413468 h 2862469"/>
              <a:gd name="connsiteX34" fmla="*/ 492981 w 4476584"/>
              <a:gd name="connsiteY34" fmla="*/ 485029 h 2862469"/>
              <a:gd name="connsiteX35" fmla="*/ 294198 w 4476584"/>
              <a:gd name="connsiteY35" fmla="*/ 556591 h 2862469"/>
              <a:gd name="connsiteX36" fmla="*/ 127221 w 4476584"/>
              <a:gd name="connsiteY36" fmla="*/ 652007 h 2862469"/>
              <a:gd name="connsiteX37" fmla="*/ 55659 w 4476584"/>
              <a:gd name="connsiteY37" fmla="*/ 779228 h 2862469"/>
              <a:gd name="connsiteX38" fmla="*/ 95415 w 4476584"/>
              <a:gd name="connsiteY38" fmla="*/ 874643 h 2862469"/>
              <a:gd name="connsiteX39" fmla="*/ 174929 w 4476584"/>
              <a:gd name="connsiteY39" fmla="*/ 1049572 h 2862469"/>
              <a:gd name="connsiteX40" fmla="*/ 222636 w 4476584"/>
              <a:gd name="connsiteY40" fmla="*/ 1152939 h 2862469"/>
              <a:gd name="connsiteX41" fmla="*/ 254442 w 4476584"/>
              <a:gd name="connsiteY41" fmla="*/ 1327868 h 2862469"/>
              <a:gd name="connsiteX42" fmla="*/ 333955 w 4476584"/>
              <a:gd name="connsiteY42" fmla="*/ 1439186 h 2862469"/>
              <a:gd name="connsiteX43" fmla="*/ 445273 w 4476584"/>
              <a:gd name="connsiteY43" fmla="*/ 1534602 h 2862469"/>
              <a:gd name="connsiteX44" fmla="*/ 516835 w 4476584"/>
              <a:gd name="connsiteY44" fmla="*/ 1630017 h 2862469"/>
              <a:gd name="connsiteX45" fmla="*/ 652007 w 4476584"/>
              <a:gd name="connsiteY45" fmla="*/ 1757238 h 2862469"/>
              <a:gd name="connsiteX46" fmla="*/ 652007 w 4476584"/>
              <a:gd name="connsiteY46" fmla="*/ 1820849 h 2862469"/>
              <a:gd name="connsiteX47" fmla="*/ 628153 w 4476584"/>
              <a:gd name="connsiteY47" fmla="*/ 1892410 h 2862469"/>
              <a:gd name="connsiteX48" fmla="*/ 556591 w 4476584"/>
              <a:gd name="connsiteY48" fmla="*/ 1987826 h 2862469"/>
              <a:gd name="connsiteX49" fmla="*/ 429370 w 4476584"/>
              <a:gd name="connsiteY49" fmla="*/ 2035534 h 2862469"/>
              <a:gd name="connsiteX50" fmla="*/ 302149 w 4476584"/>
              <a:gd name="connsiteY50" fmla="*/ 2091193 h 2862469"/>
              <a:gd name="connsiteX51" fmla="*/ 254442 w 4476584"/>
              <a:gd name="connsiteY51" fmla="*/ 2154803 h 2862469"/>
              <a:gd name="connsiteX52" fmla="*/ 238539 w 4476584"/>
              <a:gd name="connsiteY52" fmla="*/ 2210462 h 2862469"/>
              <a:gd name="connsiteX53" fmla="*/ 182880 w 4476584"/>
              <a:gd name="connsiteY53" fmla="*/ 2321781 h 2862469"/>
              <a:gd name="connsiteX54" fmla="*/ 127221 w 4476584"/>
              <a:gd name="connsiteY54" fmla="*/ 2441050 h 2862469"/>
              <a:gd name="connsiteX55" fmla="*/ 31805 w 4476584"/>
              <a:gd name="connsiteY55" fmla="*/ 2496709 h 2862469"/>
              <a:gd name="connsiteX56" fmla="*/ 0 w 4476584"/>
              <a:gd name="connsiteY56" fmla="*/ 2631882 h 2862469"/>
              <a:gd name="connsiteX57" fmla="*/ 39756 w 4476584"/>
              <a:gd name="connsiteY57" fmla="*/ 2775005 h 2862469"/>
              <a:gd name="connsiteX58" fmla="*/ 63610 w 4476584"/>
              <a:gd name="connsiteY58" fmla="*/ 2862469 h 286246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Lst>
            <a:rect l="l" t="t" r="r" b="b"/>
            <a:pathLst>
              <a:path w="4476584" h="2862469">
                <a:moveTo>
                  <a:pt x="4476584" y="1200647"/>
                </a:moveTo>
                <a:lnTo>
                  <a:pt x="4309607" y="1152939"/>
                </a:lnTo>
                <a:lnTo>
                  <a:pt x="4110824" y="1041621"/>
                </a:lnTo>
                <a:lnTo>
                  <a:pt x="3935895" y="914400"/>
                </a:lnTo>
                <a:lnTo>
                  <a:pt x="3800723" y="874643"/>
                </a:lnTo>
                <a:lnTo>
                  <a:pt x="3617843" y="811033"/>
                </a:lnTo>
                <a:lnTo>
                  <a:pt x="3434963" y="747422"/>
                </a:lnTo>
                <a:lnTo>
                  <a:pt x="3252083" y="683812"/>
                </a:lnTo>
                <a:lnTo>
                  <a:pt x="3108960" y="588396"/>
                </a:lnTo>
                <a:lnTo>
                  <a:pt x="2973788" y="500932"/>
                </a:lnTo>
                <a:lnTo>
                  <a:pt x="2775005" y="326003"/>
                </a:lnTo>
                <a:lnTo>
                  <a:pt x="2639833" y="214685"/>
                </a:lnTo>
                <a:lnTo>
                  <a:pt x="2592125" y="135172"/>
                </a:lnTo>
                <a:lnTo>
                  <a:pt x="2496709" y="79513"/>
                </a:lnTo>
                <a:lnTo>
                  <a:pt x="2361537" y="0"/>
                </a:lnTo>
                <a:lnTo>
                  <a:pt x="2258170" y="7951"/>
                </a:lnTo>
                <a:lnTo>
                  <a:pt x="2170706" y="23854"/>
                </a:lnTo>
                <a:lnTo>
                  <a:pt x="2115047" y="39756"/>
                </a:lnTo>
                <a:lnTo>
                  <a:pt x="2011680" y="15902"/>
                </a:lnTo>
                <a:lnTo>
                  <a:pt x="1860605" y="0"/>
                </a:lnTo>
                <a:lnTo>
                  <a:pt x="1812897" y="7951"/>
                </a:lnTo>
                <a:lnTo>
                  <a:pt x="1741335" y="55659"/>
                </a:lnTo>
                <a:lnTo>
                  <a:pt x="1677725" y="127221"/>
                </a:lnTo>
                <a:lnTo>
                  <a:pt x="1669774" y="238539"/>
                </a:lnTo>
                <a:lnTo>
                  <a:pt x="1661822" y="365760"/>
                </a:lnTo>
                <a:lnTo>
                  <a:pt x="1582309" y="405516"/>
                </a:lnTo>
                <a:lnTo>
                  <a:pt x="1470991" y="373711"/>
                </a:lnTo>
                <a:lnTo>
                  <a:pt x="1359673" y="326003"/>
                </a:lnTo>
                <a:lnTo>
                  <a:pt x="1224501" y="318052"/>
                </a:lnTo>
                <a:lnTo>
                  <a:pt x="1168842" y="357809"/>
                </a:lnTo>
                <a:lnTo>
                  <a:pt x="1105231" y="389614"/>
                </a:lnTo>
                <a:lnTo>
                  <a:pt x="962108" y="389614"/>
                </a:lnTo>
                <a:lnTo>
                  <a:pt x="850789" y="413468"/>
                </a:lnTo>
                <a:lnTo>
                  <a:pt x="667909" y="413468"/>
                </a:lnTo>
                <a:lnTo>
                  <a:pt x="492981" y="485029"/>
                </a:lnTo>
                <a:lnTo>
                  <a:pt x="294198" y="556591"/>
                </a:lnTo>
                <a:lnTo>
                  <a:pt x="127221" y="652007"/>
                </a:lnTo>
                <a:lnTo>
                  <a:pt x="55659" y="779228"/>
                </a:lnTo>
                <a:lnTo>
                  <a:pt x="95415" y="874643"/>
                </a:lnTo>
                <a:lnTo>
                  <a:pt x="174929" y="1049572"/>
                </a:lnTo>
                <a:lnTo>
                  <a:pt x="222636" y="1152939"/>
                </a:lnTo>
                <a:lnTo>
                  <a:pt x="254442" y="1327868"/>
                </a:lnTo>
                <a:lnTo>
                  <a:pt x="333955" y="1439186"/>
                </a:lnTo>
                <a:lnTo>
                  <a:pt x="445273" y="1534602"/>
                </a:lnTo>
                <a:lnTo>
                  <a:pt x="516835" y="1630017"/>
                </a:lnTo>
                <a:lnTo>
                  <a:pt x="652007" y="1757238"/>
                </a:lnTo>
                <a:lnTo>
                  <a:pt x="652007" y="1820849"/>
                </a:lnTo>
                <a:lnTo>
                  <a:pt x="628153" y="1892410"/>
                </a:lnTo>
                <a:lnTo>
                  <a:pt x="556591" y="1987826"/>
                </a:lnTo>
                <a:lnTo>
                  <a:pt x="429370" y="2035534"/>
                </a:lnTo>
                <a:lnTo>
                  <a:pt x="302149" y="2091193"/>
                </a:lnTo>
                <a:lnTo>
                  <a:pt x="254442" y="2154803"/>
                </a:lnTo>
                <a:lnTo>
                  <a:pt x="238539" y="2210462"/>
                </a:lnTo>
                <a:lnTo>
                  <a:pt x="182880" y="2321781"/>
                </a:lnTo>
                <a:lnTo>
                  <a:pt x="127221" y="2441050"/>
                </a:lnTo>
                <a:lnTo>
                  <a:pt x="31805" y="2496709"/>
                </a:lnTo>
                <a:lnTo>
                  <a:pt x="0" y="2631882"/>
                </a:lnTo>
                <a:lnTo>
                  <a:pt x="39756" y="2775005"/>
                </a:lnTo>
                <a:lnTo>
                  <a:pt x="63610" y="2862469"/>
                </a:lnTo>
              </a:path>
            </a:pathLst>
          </a:custGeom>
          <a:noFill/>
          <a:ln>
            <a:solidFill>
              <a:schemeClr val="bg1"/>
            </a:solidFill>
            <a:prstDash val="dash"/>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 name="CuadroTexto 15">
            <a:extLst>
              <a:ext uri="{FF2B5EF4-FFF2-40B4-BE49-F238E27FC236}">
                <a16:creationId xmlns:a16="http://schemas.microsoft.com/office/drawing/2014/main" id="{B812D20B-9F63-44A5-BFD8-A7B13761FA60}"/>
              </a:ext>
            </a:extLst>
          </p:cNvPr>
          <p:cNvSpPr txBox="1"/>
          <p:nvPr/>
        </p:nvSpPr>
        <p:spPr>
          <a:xfrm>
            <a:off x="4336552" y="6026221"/>
            <a:ext cx="1150143" cy="461665"/>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Travertine</a:t>
            </a:r>
          </a:p>
          <a:p>
            <a:r>
              <a:rPr lang="en-GB" sz="1200" dirty="0">
                <a:solidFill>
                  <a:schemeClr val="bg1">
                    <a:lumMod val="95000"/>
                  </a:schemeClr>
                </a:solidFill>
                <a:effectLst>
                  <a:outerShdw blurRad="38100" dist="38100" dir="2700000" algn="tl">
                    <a:srgbClr val="000000">
                      <a:alpha val="43137"/>
                    </a:srgbClr>
                  </a:outerShdw>
                </a:effectLst>
                <a:latin typeface="+mj-lt"/>
              </a:rPr>
              <a:t>platform 2</a:t>
            </a:r>
          </a:p>
        </p:txBody>
      </p:sp>
      <p:cxnSp>
        <p:nvCxnSpPr>
          <p:cNvPr id="17" name="Conector recto de flecha 16">
            <a:extLst>
              <a:ext uri="{FF2B5EF4-FFF2-40B4-BE49-F238E27FC236}">
                <a16:creationId xmlns:a16="http://schemas.microsoft.com/office/drawing/2014/main" id="{823360A3-5F5E-4EDB-8159-99417C03D636}"/>
              </a:ext>
            </a:extLst>
          </p:cNvPr>
          <p:cNvCxnSpPr>
            <a:cxnSpLocks/>
          </p:cNvCxnSpPr>
          <p:nvPr/>
        </p:nvCxnSpPr>
        <p:spPr>
          <a:xfrm flipH="1">
            <a:off x="5326912" y="2277924"/>
            <a:ext cx="493430" cy="356338"/>
          </a:xfrm>
          <a:prstGeom prst="straightConnector1">
            <a:avLst/>
          </a:prstGeom>
          <a:ln w="15875">
            <a:solidFill>
              <a:schemeClr val="bg1"/>
            </a:solidFill>
            <a:tailEnd type="stealth"/>
          </a:ln>
          <a:effectLst>
            <a:outerShdw blurRad="50800" dist="38100" dir="5400000" algn="t" rotWithShape="0">
              <a:prstClr val="black">
                <a:alpha val="40000"/>
              </a:prstClr>
            </a:outerShdw>
          </a:effectLst>
        </p:spPr>
        <p:style>
          <a:lnRef idx="1">
            <a:schemeClr val="accent1"/>
          </a:lnRef>
          <a:fillRef idx="0">
            <a:schemeClr val="accent1"/>
          </a:fillRef>
          <a:effectRef idx="0">
            <a:schemeClr val="accent1"/>
          </a:effectRef>
          <a:fontRef idx="minor">
            <a:schemeClr val="tx1"/>
          </a:fontRef>
        </p:style>
      </p:cxnSp>
      <p:sp>
        <p:nvSpPr>
          <p:cNvPr id="19" name="CuadroTexto 18">
            <a:extLst>
              <a:ext uri="{FF2B5EF4-FFF2-40B4-BE49-F238E27FC236}">
                <a16:creationId xmlns:a16="http://schemas.microsoft.com/office/drawing/2014/main" id="{2EAEEE7E-21EC-44FC-963C-9D1D190F116D}"/>
              </a:ext>
            </a:extLst>
          </p:cNvPr>
          <p:cNvSpPr txBox="1"/>
          <p:nvPr/>
        </p:nvSpPr>
        <p:spPr>
          <a:xfrm>
            <a:off x="5615986" y="2020416"/>
            <a:ext cx="1150143" cy="276999"/>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Unit III</a:t>
            </a:r>
          </a:p>
        </p:txBody>
      </p:sp>
    </p:spTree>
    <p:extLst>
      <p:ext uri="{BB962C8B-B14F-4D97-AF65-F5344CB8AC3E}">
        <p14:creationId xmlns:p14="http://schemas.microsoft.com/office/powerpoint/2010/main" val="15816461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11923" y="694512"/>
            <a:ext cx="707245" cy="369332"/>
          </a:xfrm>
          <a:prstGeom prst="rect">
            <a:avLst/>
          </a:prstGeom>
          <a:noFill/>
        </p:spPr>
        <p:txBody>
          <a:bodyPr wrap="none" rtlCol="0">
            <a:spAutoFit/>
          </a:bodyPr>
          <a:lstStyle/>
          <a:p>
            <a:r>
              <a:rPr lang="en-GB" dirty="0"/>
              <a:t>Fig. H</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560159" cy="338554"/>
          </a:xfrm>
          <a:prstGeom prst="rect">
            <a:avLst/>
          </a:prstGeom>
          <a:noFill/>
        </p:spPr>
        <p:txBody>
          <a:bodyPr wrap="none" rtlCol="0">
            <a:spAutoFit/>
          </a:bodyPr>
          <a:lstStyle/>
          <a:p>
            <a:r>
              <a:rPr lang="en-GB" sz="1600" b="1" dirty="0">
                <a:latin typeface="+mj-lt"/>
              </a:rPr>
              <a:t>Supporting Information 1 – Excavation of the Layer </a:t>
            </a:r>
            <a:r>
              <a:rPr lang="en-GB" sz="1600" b="1" dirty="0" err="1">
                <a:latin typeface="+mj-lt"/>
              </a:rPr>
              <a:t>IIIn</a:t>
            </a:r>
            <a:endParaRPr lang="en-GB" sz="1600" b="1" dirty="0">
              <a:latin typeface="+mj-lt"/>
            </a:endParaRPr>
          </a:p>
        </p:txBody>
      </p:sp>
      <p:pic>
        <p:nvPicPr>
          <p:cNvPr id="8" name="Imagen 7" descr="Imagen que contiene suelo, amarillo, edificio&#10;&#10;Descripción generada automáticamente">
            <a:extLst>
              <a:ext uri="{FF2B5EF4-FFF2-40B4-BE49-F238E27FC236}">
                <a16:creationId xmlns:a16="http://schemas.microsoft.com/office/drawing/2014/main" id="{562495C4-875B-467B-8170-8B54B5C61A17}"/>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20" y="666749"/>
            <a:ext cx="8689500" cy="5777593"/>
          </a:xfrm>
          <a:prstGeom prst="rect">
            <a:avLst/>
          </a:prstGeom>
        </p:spPr>
      </p:pic>
      <p:sp>
        <p:nvSpPr>
          <p:cNvPr id="9" name="CuadroTexto 8">
            <a:extLst>
              <a:ext uri="{FF2B5EF4-FFF2-40B4-BE49-F238E27FC236}">
                <a16:creationId xmlns:a16="http://schemas.microsoft.com/office/drawing/2014/main" id="{01A6CE1A-B9C3-46CB-AF34-D950C2B6415D}"/>
              </a:ext>
            </a:extLst>
          </p:cNvPr>
          <p:cNvSpPr txBox="1"/>
          <p:nvPr/>
        </p:nvSpPr>
        <p:spPr>
          <a:xfrm>
            <a:off x="9011923" y="1353642"/>
            <a:ext cx="2918823" cy="3108543"/>
          </a:xfrm>
          <a:prstGeom prst="rect">
            <a:avLst/>
          </a:prstGeom>
          <a:noFill/>
        </p:spPr>
        <p:txBody>
          <a:bodyPr wrap="square" rtlCol="0">
            <a:spAutoFit/>
          </a:bodyPr>
          <a:lstStyle/>
          <a:p>
            <a:pPr algn="just"/>
            <a:r>
              <a:rPr lang="en-GB" sz="1400" dirty="0"/>
              <a:t>Following  the lateral continuity of the Unit III top lead to the identification of Layer </a:t>
            </a:r>
            <a:r>
              <a:rPr lang="en-GB" sz="1400" dirty="0" err="1"/>
              <a:t>IIIn</a:t>
            </a:r>
            <a:r>
              <a:rPr lang="en-GB" sz="1400" dirty="0"/>
              <a:t> at the NE area of the excavation hall. </a:t>
            </a:r>
          </a:p>
          <a:p>
            <a:pPr algn="just"/>
            <a:endParaRPr lang="en-GB" sz="1400" dirty="0"/>
          </a:p>
          <a:p>
            <a:pPr algn="just"/>
            <a:r>
              <a:rPr lang="en-GB" sz="1400" dirty="0"/>
              <a:t>Layer </a:t>
            </a:r>
            <a:r>
              <a:rPr lang="en-GB" sz="1400" dirty="0" err="1"/>
              <a:t>IIIn</a:t>
            </a:r>
            <a:r>
              <a:rPr lang="en-GB" sz="1400" dirty="0"/>
              <a:t> was preserved exclusively in squares B6-7 and C6-7. In the rest of excavation surface it identification was impossible,  due to erosive dynamics and the sediments mixing during the Holocene occupations later deposited.</a:t>
            </a:r>
          </a:p>
          <a:p>
            <a:pPr algn="just"/>
            <a:endParaRPr lang="en-GB" sz="1400" dirty="0"/>
          </a:p>
          <a:p>
            <a:pPr algn="just"/>
            <a:r>
              <a:rPr lang="en-GB" sz="1400" dirty="0"/>
              <a:t>Photo 2012</a:t>
            </a:r>
          </a:p>
        </p:txBody>
      </p:sp>
      <p:sp>
        <p:nvSpPr>
          <p:cNvPr id="10" name="Marcador de número de diapositiva 1">
            <a:extLst>
              <a:ext uri="{FF2B5EF4-FFF2-40B4-BE49-F238E27FC236}">
                <a16:creationId xmlns:a16="http://schemas.microsoft.com/office/drawing/2014/main" id="{0B6870E2-06F0-4726-8519-F7D34E9BAFE1}"/>
              </a:ext>
            </a:extLst>
          </p:cNvPr>
          <p:cNvSpPr txBox="1">
            <a:spLocks/>
          </p:cNvSpPr>
          <p:nvPr/>
        </p:nvSpPr>
        <p:spPr>
          <a:xfrm>
            <a:off x="11696697" y="6371729"/>
            <a:ext cx="315806"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8</a:t>
            </a:fld>
            <a:endParaRPr lang="en-GB" sz="1800" dirty="0">
              <a:latin typeface="+mj-lt"/>
            </a:endParaRPr>
          </a:p>
        </p:txBody>
      </p:sp>
      <p:cxnSp>
        <p:nvCxnSpPr>
          <p:cNvPr id="11" name="Conector recto 10">
            <a:extLst>
              <a:ext uri="{FF2B5EF4-FFF2-40B4-BE49-F238E27FC236}">
                <a16:creationId xmlns:a16="http://schemas.microsoft.com/office/drawing/2014/main" id="{1F004A3C-5D85-483E-A3C3-7E5841784D29}"/>
              </a:ext>
            </a:extLst>
          </p:cNvPr>
          <p:cNvCxnSpPr>
            <a:cxnSpLocks/>
          </p:cNvCxnSpPr>
          <p:nvPr/>
        </p:nvCxnSpPr>
        <p:spPr>
          <a:xfrm>
            <a:off x="9100457" y="1229655"/>
            <a:ext cx="2725783"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174192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74AF234C-E168-4284-B2E9-FEA4C9837CB3}"/>
              </a:ext>
            </a:extLst>
          </p:cNvPr>
          <p:cNvSpPr txBox="1"/>
          <p:nvPr/>
        </p:nvSpPr>
        <p:spPr>
          <a:xfrm>
            <a:off x="9038047" y="581298"/>
            <a:ext cx="607859" cy="369332"/>
          </a:xfrm>
          <a:prstGeom prst="rect">
            <a:avLst/>
          </a:prstGeom>
          <a:noFill/>
        </p:spPr>
        <p:txBody>
          <a:bodyPr wrap="none" rtlCol="0">
            <a:spAutoFit/>
          </a:bodyPr>
          <a:lstStyle/>
          <a:p>
            <a:r>
              <a:rPr lang="en-GB" b="1" dirty="0">
                <a:latin typeface="+mj-lt"/>
              </a:rPr>
              <a:t>Fig. I</a:t>
            </a:r>
          </a:p>
        </p:txBody>
      </p:sp>
      <p:sp>
        <p:nvSpPr>
          <p:cNvPr id="7" name="CuadroTexto 6">
            <a:extLst>
              <a:ext uri="{FF2B5EF4-FFF2-40B4-BE49-F238E27FC236}">
                <a16:creationId xmlns:a16="http://schemas.microsoft.com/office/drawing/2014/main" id="{DC555233-CE3B-4FB2-9E30-61F323E981F8}"/>
              </a:ext>
            </a:extLst>
          </p:cNvPr>
          <p:cNvSpPr txBox="1"/>
          <p:nvPr/>
        </p:nvSpPr>
        <p:spPr>
          <a:xfrm>
            <a:off x="0" y="0"/>
            <a:ext cx="4560159" cy="338554"/>
          </a:xfrm>
          <a:prstGeom prst="rect">
            <a:avLst/>
          </a:prstGeom>
          <a:noFill/>
        </p:spPr>
        <p:txBody>
          <a:bodyPr wrap="none" rtlCol="0">
            <a:spAutoFit/>
          </a:bodyPr>
          <a:lstStyle/>
          <a:p>
            <a:r>
              <a:rPr lang="en-GB" sz="1600" b="1" dirty="0">
                <a:latin typeface="+mj-lt"/>
              </a:rPr>
              <a:t>Supporting Information 1 – Excavation of the Layer </a:t>
            </a:r>
            <a:r>
              <a:rPr lang="en-GB" sz="1600" b="1" dirty="0" err="1">
                <a:latin typeface="+mj-lt"/>
              </a:rPr>
              <a:t>IIIn</a:t>
            </a:r>
            <a:endParaRPr lang="en-GB" sz="1600" b="1" dirty="0">
              <a:latin typeface="+mj-lt"/>
            </a:endParaRPr>
          </a:p>
        </p:txBody>
      </p:sp>
      <p:pic>
        <p:nvPicPr>
          <p:cNvPr id="3" name="Imagen 2" descr="Imagen que contiene suelo, rock, exterior, edificio&#10;&#10;Descripción generada automáticamente">
            <a:extLst>
              <a:ext uri="{FF2B5EF4-FFF2-40B4-BE49-F238E27FC236}">
                <a16:creationId xmlns:a16="http://schemas.microsoft.com/office/drawing/2014/main" id="{C31431B0-5014-4ACF-B6A0-AA7474B64E17}"/>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1919" y="563880"/>
            <a:ext cx="8721247" cy="5792470"/>
          </a:xfrm>
          <a:prstGeom prst="rect">
            <a:avLst/>
          </a:prstGeom>
        </p:spPr>
      </p:pic>
      <p:sp>
        <p:nvSpPr>
          <p:cNvPr id="5" name="CuadroTexto 4">
            <a:extLst>
              <a:ext uri="{FF2B5EF4-FFF2-40B4-BE49-F238E27FC236}">
                <a16:creationId xmlns:a16="http://schemas.microsoft.com/office/drawing/2014/main" id="{5E76E90C-BBB2-4CE1-9A27-E9517BFB79D5}"/>
              </a:ext>
            </a:extLst>
          </p:cNvPr>
          <p:cNvSpPr txBox="1"/>
          <p:nvPr/>
        </p:nvSpPr>
        <p:spPr>
          <a:xfrm>
            <a:off x="9038047" y="1240428"/>
            <a:ext cx="2962366" cy="2677656"/>
          </a:xfrm>
          <a:prstGeom prst="rect">
            <a:avLst/>
          </a:prstGeom>
          <a:noFill/>
        </p:spPr>
        <p:txBody>
          <a:bodyPr wrap="square" rtlCol="0">
            <a:spAutoFit/>
          </a:bodyPr>
          <a:lstStyle/>
          <a:p>
            <a:pPr algn="just"/>
            <a:r>
              <a:rPr lang="en-GB" sz="1400" dirty="0"/>
              <a:t>Layer </a:t>
            </a:r>
            <a:r>
              <a:rPr lang="en-GB" sz="1400" dirty="0" err="1"/>
              <a:t>IIIn</a:t>
            </a:r>
            <a:r>
              <a:rPr lang="en-GB" sz="1400" dirty="0"/>
              <a:t> almost excavated. The slope of the calcarenite slab-like  fragments indicates a marked dipping to the East.</a:t>
            </a:r>
          </a:p>
          <a:p>
            <a:pPr algn="just"/>
            <a:endParaRPr lang="en-GB" sz="1400" dirty="0"/>
          </a:p>
          <a:p>
            <a:pPr algn="just"/>
            <a:r>
              <a:rPr lang="en-GB" sz="1400" dirty="0"/>
              <a:t>At the left of the image, extreme of the horizontal rod stick, the top of Layer IIIc is already visible. The hammer and chisels stands on the Travertine Platform 2.</a:t>
            </a:r>
          </a:p>
          <a:p>
            <a:pPr algn="just"/>
            <a:endParaRPr lang="en-GB" sz="1400" dirty="0"/>
          </a:p>
          <a:p>
            <a:pPr algn="just"/>
            <a:r>
              <a:rPr lang="en-GB" sz="1400" dirty="0"/>
              <a:t>Photo 2012</a:t>
            </a:r>
          </a:p>
        </p:txBody>
      </p:sp>
      <p:cxnSp>
        <p:nvCxnSpPr>
          <p:cNvPr id="8" name="Conector recto 7">
            <a:extLst>
              <a:ext uri="{FF2B5EF4-FFF2-40B4-BE49-F238E27FC236}">
                <a16:creationId xmlns:a16="http://schemas.microsoft.com/office/drawing/2014/main" id="{31EB4C0D-0980-46C0-B165-DEB31FBB706B}"/>
              </a:ext>
            </a:extLst>
          </p:cNvPr>
          <p:cNvCxnSpPr>
            <a:cxnSpLocks/>
          </p:cNvCxnSpPr>
          <p:nvPr/>
        </p:nvCxnSpPr>
        <p:spPr>
          <a:xfrm>
            <a:off x="9126583" y="1125150"/>
            <a:ext cx="2769326"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9" name="Marcador de número de diapositiva 1">
            <a:extLst>
              <a:ext uri="{FF2B5EF4-FFF2-40B4-BE49-F238E27FC236}">
                <a16:creationId xmlns:a16="http://schemas.microsoft.com/office/drawing/2014/main" id="{D6D996ED-1045-416C-A309-475EB067D76C}"/>
              </a:ext>
            </a:extLst>
          </p:cNvPr>
          <p:cNvSpPr txBox="1">
            <a:spLocks/>
          </p:cNvSpPr>
          <p:nvPr/>
        </p:nvSpPr>
        <p:spPr>
          <a:xfrm>
            <a:off x="11696697" y="6371729"/>
            <a:ext cx="315806" cy="365125"/>
          </a:xfrm>
          <a:prstGeom prst="rect">
            <a:avLst/>
          </a:prstGeom>
        </p:spPr>
        <p:txBody>
          <a:bodyPr vert="horz" lIns="91440" tIns="45720" rIns="91440" bIns="45720" rtlCol="0" anchor="ctr"/>
          <a:lstStyle>
            <a:defPPr>
              <a:defRPr lang="es-E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192579BF-C6FD-43AD-A8B9-573B46B983AA}" type="slidenum">
              <a:rPr lang="en-GB" sz="1800" smtClean="0">
                <a:latin typeface="+mj-lt"/>
              </a:rPr>
              <a:pPr/>
              <a:t>9</a:t>
            </a:fld>
            <a:endParaRPr lang="en-GB" sz="1800" dirty="0">
              <a:latin typeface="+mj-lt"/>
            </a:endParaRPr>
          </a:p>
        </p:txBody>
      </p:sp>
      <p:sp>
        <p:nvSpPr>
          <p:cNvPr id="10" name="Forma libre: forma 9">
            <a:extLst>
              <a:ext uri="{FF2B5EF4-FFF2-40B4-BE49-F238E27FC236}">
                <a16:creationId xmlns:a16="http://schemas.microsoft.com/office/drawing/2014/main" id="{EB791B93-0942-4C60-806D-7059AE522C66}"/>
              </a:ext>
            </a:extLst>
          </p:cNvPr>
          <p:cNvSpPr/>
          <p:nvPr/>
        </p:nvSpPr>
        <p:spPr>
          <a:xfrm>
            <a:off x="3118884" y="3558363"/>
            <a:ext cx="4040372" cy="2785730"/>
          </a:xfrm>
          <a:custGeom>
            <a:avLst/>
            <a:gdLst>
              <a:gd name="connsiteX0" fmla="*/ 4040372 w 4040372"/>
              <a:gd name="connsiteY0" fmla="*/ 0 h 2785730"/>
              <a:gd name="connsiteX1" fmla="*/ 3941135 w 4040372"/>
              <a:gd name="connsiteY1" fmla="*/ 120502 h 2785730"/>
              <a:gd name="connsiteX2" fmla="*/ 3778102 w 4040372"/>
              <a:gd name="connsiteY2" fmla="*/ 304800 h 2785730"/>
              <a:gd name="connsiteX3" fmla="*/ 3756837 w 4040372"/>
              <a:gd name="connsiteY3" fmla="*/ 474921 h 2785730"/>
              <a:gd name="connsiteX4" fmla="*/ 3678865 w 4040372"/>
              <a:gd name="connsiteY4" fmla="*/ 808074 h 2785730"/>
              <a:gd name="connsiteX5" fmla="*/ 3636335 w 4040372"/>
              <a:gd name="connsiteY5" fmla="*/ 1027814 h 2785730"/>
              <a:gd name="connsiteX6" fmla="*/ 3537097 w 4040372"/>
              <a:gd name="connsiteY6" fmla="*/ 1275907 h 2785730"/>
              <a:gd name="connsiteX7" fmla="*/ 3487479 w 4040372"/>
              <a:gd name="connsiteY7" fmla="*/ 1403497 h 2785730"/>
              <a:gd name="connsiteX8" fmla="*/ 3459125 w 4040372"/>
              <a:gd name="connsiteY8" fmla="*/ 1637414 h 2785730"/>
              <a:gd name="connsiteX9" fmla="*/ 3366976 w 4040372"/>
              <a:gd name="connsiteY9" fmla="*/ 1793358 h 2785730"/>
              <a:gd name="connsiteX10" fmla="*/ 3239386 w 4040372"/>
              <a:gd name="connsiteY10" fmla="*/ 1956390 h 2785730"/>
              <a:gd name="connsiteX11" fmla="*/ 2977116 w 4040372"/>
              <a:gd name="connsiteY11" fmla="*/ 2119423 h 2785730"/>
              <a:gd name="connsiteX12" fmla="*/ 2856614 w 4040372"/>
              <a:gd name="connsiteY12" fmla="*/ 2239925 h 2785730"/>
              <a:gd name="connsiteX13" fmla="*/ 2736111 w 4040372"/>
              <a:gd name="connsiteY13" fmla="*/ 2254102 h 2785730"/>
              <a:gd name="connsiteX14" fmla="*/ 2551814 w 4040372"/>
              <a:gd name="connsiteY14" fmla="*/ 2147777 h 2785730"/>
              <a:gd name="connsiteX15" fmla="*/ 2388781 w 4040372"/>
              <a:gd name="connsiteY15" fmla="*/ 2091070 h 2785730"/>
              <a:gd name="connsiteX16" fmla="*/ 2254102 w 4040372"/>
              <a:gd name="connsiteY16" fmla="*/ 2048539 h 2785730"/>
              <a:gd name="connsiteX17" fmla="*/ 2147776 w 4040372"/>
              <a:gd name="connsiteY17" fmla="*/ 2020186 h 2785730"/>
              <a:gd name="connsiteX18" fmla="*/ 2048539 w 4040372"/>
              <a:gd name="connsiteY18" fmla="*/ 2006009 h 2785730"/>
              <a:gd name="connsiteX19" fmla="*/ 1814623 w 4040372"/>
              <a:gd name="connsiteY19" fmla="*/ 2069804 h 2785730"/>
              <a:gd name="connsiteX20" fmla="*/ 1694121 w 4040372"/>
              <a:gd name="connsiteY20" fmla="*/ 2126511 h 2785730"/>
              <a:gd name="connsiteX21" fmla="*/ 1467293 w 4040372"/>
              <a:gd name="connsiteY21" fmla="*/ 2176130 h 2785730"/>
              <a:gd name="connsiteX22" fmla="*/ 1346790 w 4040372"/>
              <a:gd name="connsiteY22" fmla="*/ 2239925 h 2785730"/>
              <a:gd name="connsiteX23" fmla="*/ 1183758 w 4040372"/>
              <a:gd name="connsiteY23" fmla="*/ 2247014 h 2785730"/>
              <a:gd name="connsiteX24" fmla="*/ 978195 w 4040372"/>
              <a:gd name="connsiteY24" fmla="*/ 2317897 h 2785730"/>
              <a:gd name="connsiteX25" fmla="*/ 574158 w 4040372"/>
              <a:gd name="connsiteY25" fmla="*/ 2402958 h 2785730"/>
              <a:gd name="connsiteX26" fmla="*/ 382772 w 4040372"/>
              <a:gd name="connsiteY26" fmla="*/ 2480930 h 2785730"/>
              <a:gd name="connsiteX27" fmla="*/ 255181 w 4040372"/>
              <a:gd name="connsiteY27" fmla="*/ 2615609 h 2785730"/>
              <a:gd name="connsiteX28" fmla="*/ 56707 w 4040372"/>
              <a:gd name="connsiteY28" fmla="*/ 2757377 h 2785730"/>
              <a:gd name="connsiteX29" fmla="*/ 0 w 4040372"/>
              <a:gd name="connsiteY29" fmla="*/ 2785730 h 27857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Lst>
            <a:rect l="l" t="t" r="r" b="b"/>
            <a:pathLst>
              <a:path w="4040372" h="2785730">
                <a:moveTo>
                  <a:pt x="4040372" y="0"/>
                </a:moveTo>
                <a:lnTo>
                  <a:pt x="3941135" y="120502"/>
                </a:lnTo>
                <a:lnTo>
                  <a:pt x="3778102" y="304800"/>
                </a:lnTo>
                <a:lnTo>
                  <a:pt x="3756837" y="474921"/>
                </a:lnTo>
                <a:lnTo>
                  <a:pt x="3678865" y="808074"/>
                </a:lnTo>
                <a:lnTo>
                  <a:pt x="3636335" y="1027814"/>
                </a:lnTo>
                <a:lnTo>
                  <a:pt x="3537097" y="1275907"/>
                </a:lnTo>
                <a:lnTo>
                  <a:pt x="3487479" y="1403497"/>
                </a:lnTo>
                <a:lnTo>
                  <a:pt x="3459125" y="1637414"/>
                </a:lnTo>
                <a:lnTo>
                  <a:pt x="3366976" y="1793358"/>
                </a:lnTo>
                <a:lnTo>
                  <a:pt x="3239386" y="1956390"/>
                </a:lnTo>
                <a:lnTo>
                  <a:pt x="2977116" y="2119423"/>
                </a:lnTo>
                <a:lnTo>
                  <a:pt x="2856614" y="2239925"/>
                </a:lnTo>
                <a:lnTo>
                  <a:pt x="2736111" y="2254102"/>
                </a:lnTo>
                <a:lnTo>
                  <a:pt x="2551814" y="2147777"/>
                </a:lnTo>
                <a:lnTo>
                  <a:pt x="2388781" y="2091070"/>
                </a:lnTo>
                <a:lnTo>
                  <a:pt x="2254102" y="2048539"/>
                </a:lnTo>
                <a:lnTo>
                  <a:pt x="2147776" y="2020186"/>
                </a:lnTo>
                <a:lnTo>
                  <a:pt x="2048539" y="2006009"/>
                </a:lnTo>
                <a:lnTo>
                  <a:pt x="1814623" y="2069804"/>
                </a:lnTo>
                <a:lnTo>
                  <a:pt x="1694121" y="2126511"/>
                </a:lnTo>
                <a:lnTo>
                  <a:pt x="1467293" y="2176130"/>
                </a:lnTo>
                <a:lnTo>
                  <a:pt x="1346790" y="2239925"/>
                </a:lnTo>
                <a:lnTo>
                  <a:pt x="1183758" y="2247014"/>
                </a:lnTo>
                <a:lnTo>
                  <a:pt x="978195" y="2317897"/>
                </a:lnTo>
                <a:lnTo>
                  <a:pt x="574158" y="2402958"/>
                </a:lnTo>
                <a:lnTo>
                  <a:pt x="382772" y="2480930"/>
                </a:lnTo>
                <a:lnTo>
                  <a:pt x="255181" y="2615609"/>
                </a:lnTo>
                <a:lnTo>
                  <a:pt x="56707" y="2757377"/>
                </a:lnTo>
                <a:lnTo>
                  <a:pt x="0" y="2785730"/>
                </a:lnTo>
              </a:path>
            </a:pathLst>
          </a:custGeom>
          <a:noFill/>
          <a:ln>
            <a:solidFill>
              <a:schemeClr val="bg1"/>
            </a:solidFill>
            <a:prstDash val="dash"/>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Forma libre: forma 11">
            <a:extLst>
              <a:ext uri="{FF2B5EF4-FFF2-40B4-BE49-F238E27FC236}">
                <a16:creationId xmlns:a16="http://schemas.microsoft.com/office/drawing/2014/main" id="{120FECE9-5228-4A9E-A814-FA2CCCBD20CD}"/>
              </a:ext>
            </a:extLst>
          </p:cNvPr>
          <p:cNvSpPr/>
          <p:nvPr/>
        </p:nvSpPr>
        <p:spPr>
          <a:xfrm>
            <a:off x="3643423" y="3650512"/>
            <a:ext cx="1056168" cy="2041451"/>
          </a:xfrm>
          <a:custGeom>
            <a:avLst/>
            <a:gdLst>
              <a:gd name="connsiteX0" fmla="*/ 212651 w 1056168"/>
              <a:gd name="connsiteY0" fmla="*/ 0 h 2041451"/>
              <a:gd name="connsiteX1" fmla="*/ 148856 w 1056168"/>
              <a:gd name="connsiteY1" fmla="*/ 226828 h 2041451"/>
              <a:gd name="connsiteX2" fmla="*/ 99237 w 1056168"/>
              <a:gd name="connsiteY2" fmla="*/ 425302 h 2041451"/>
              <a:gd name="connsiteX3" fmla="*/ 63796 w 1056168"/>
              <a:gd name="connsiteY3" fmla="*/ 623776 h 2041451"/>
              <a:gd name="connsiteX4" fmla="*/ 0 w 1056168"/>
              <a:gd name="connsiteY4" fmla="*/ 836428 h 2041451"/>
              <a:gd name="connsiteX5" fmla="*/ 0 w 1056168"/>
              <a:gd name="connsiteY5" fmla="*/ 1027814 h 2041451"/>
              <a:gd name="connsiteX6" fmla="*/ 7089 w 1056168"/>
              <a:gd name="connsiteY6" fmla="*/ 1155404 h 2041451"/>
              <a:gd name="connsiteX7" fmla="*/ 113414 w 1056168"/>
              <a:gd name="connsiteY7" fmla="*/ 1261730 h 2041451"/>
              <a:gd name="connsiteX8" fmla="*/ 311889 w 1056168"/>
              <a:gd name="connsiteY8" fmla="*/ 1318437 h 2041451"/>
              <a:gd name="connsiteX9" fmla="*/ 517451 w 1056168"/>
              <a:gd name="connsiteY9" fmla="*/ 1382232 h 2041451"/>
              <a:gd name="connsiteX10" fmla="*/ 694661 w 1056168"/>
              <a:gd name="connsiteY10" fmla="*/ 1410586 h 2041451"/>
              <a:gd name="connsiteX11" fmla="*/ 843517 w 1056168"/>
              <a:gd name="connsiteY11" fmla="*/ 1438939 h 2041451"/>
              <a:gd name="connsiteX12" fmla="*/ 964019 w 1056168"/>
              <a:gd name="connsiteY12" fmla="*/ 1495646 h 2041451"/>
              <a:gd name="connsiteX13" fmla="*/ 1056168 w 1056168"/>
              <a:gd name="connsiteY13" fmla="*/ 1616148 h 2041451"/>
              <a:gd name="connsiteX14" fmla="*/ 1049079 w 1056168"/>
              <a:gd name="connsiteY14" fmla="*/ 1750828 h 2041451"/>
              <a:gd name="connsiteX15" fmla="*/ 1034903 w 1056168"/>
              <a:gd name="connsiteY15" fmla="*/ 1864241 h 2041451"/>
              <a:gd name="connsiteX16" fmla="*/ 1034903 w 1056168"/>
              <a:gd name="connsiteY16" fmla="*/ 1935125 h 2041451"/>
              <a:gd name="connsiteX17" fmla="*/ 1034903 w 1056168"/>
              <a:gd name="connsiteY17" fmla="*/ 1935125 h 2041451"/>
              <a:gd name="connsiteX18" fmla="*/ 1034903 w 1056168"/>
              <a:gd name="connsiteY18" fmla="*/ 2041451 h 20414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1056168" h="2041451">
                <a:moveTo>
                  <a:pt x="212651" y="0"/>
                </a:moveTo>
                <a:lnTo>
                  <a:pt x="148856" y="226828"/>
                </a:lnTo>
                <a:lnTo>
                  <a:pt x="99237" y="425302"/>
                </a:lnTo>
                <a:lnTo>
                  <a:pt x="63796" y="623776"/>
                </a:lnTo>
                <a:lnTo>
                  <a:pt x="0" y="836428"/>
                </a:lnTo>
                <a:lnTo>
                  <a:pt x="0" y="1027814"/>
                </a:lnTo>
                <a:lnTo>
                  <a:pt x="7089" y="1155404"/>
                </a:lnTo>
                <a:lnTo>
                  <a:pt x="113414" y="1261730"/>
                </a:lnTo>
                <a:lnTo>
                  <a:pt x="311889" y="1318437"/>
                </a:lnTo>
                <a:lnTo>
                  <a:pt x="517451" y="1382232"/>
                </a:lnTo>
                <a:lnTo>
                  <a:pt x="694661" y="1410586"/>
                </a:lnTo>
                <a:lnTo>
                  <a:pt x="843517" y="1438939"/>
                </a:lnTo>
                <a:lnTo>
                  <a:pt x="964019" y="1495646"/>
                </a:lnTo>
                <a:lnTo>
                  <a:pt x="1056168" y="1616148"/>
                </a:lnTo>
                <a:lnTo>
                  <a:pt x="1049079" y="1750828"/>
                </a:lnTo>
                <a:lnTo>
                  <a:pt x="1034903" y="1864241"/>
                </a:lnTo>
                <a:lnTo>
                  <a:pt x="1034903" y="1935125"/>
                </a:lnTo>
                <a:lnTo>
                  <a:pt x="1034903" y="1935125"/>
                </a:lnTo>
                <a:lnTo>
                  <a:pt x="1034903" y="2041451"/>
                </a:lnTo>
              </a:path>
            </a:pathLst>
          </a:custGeom>
          <a:noFill/>
          <a:ln>
            <a:solidFill>
              <a:schemeClr val="bg1"/>
            </a:solidFill>
            <a:prstDash val="lgDashDotDot"/>
          </a:ln>
          <a:effectLst>
            <a:outerShdw blurRad="50800" dist="38100" dir="10800000" algn="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CuadroTexto 12">
            <a:extLst>
              <a:ext uri="{FF2B5EF4-FFF2-40B4-BE49-F238E27FC236}">
                <a16:creationId xmlns:a16="http://schemas.microsoft.com/office/drawing/2014/main" id="{291FC9FF-4DE7-4632-96FB-CD08EEEBE380}"/>
              </a:ext>
            </a:extLst>
          </p:cNvPr>
          <p:cNvSpPr txBox="1"/>
          <p:nvPr/>
        </p:nvSpPr>
        <p:spPr>
          <a:xfrm>
            <a:off x="7426139" y="4053629"/>
            <a:ext cx="1150143" cy="461665"/>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Travertine</a:t>
            </a:r>
          </a:p>
          <a:p>
            <a:r>
              <a:rPr lang="en-GB" sz="1200" dirty="0">
                <a:solidFill>
                  <a:schemeClr val="bg1">
                    <a:lumMod val="95000"/>
                  </a:schemeClr>
                </a:solidFill>
                <a:effectLst>
                  <a:outerShdw blurRad="38100" dist="38100" dir="2700000" algn="tl">
                    <a:srgbClr val="000000">
                      <a:alpha val="43137"/>
                    </a:srgbClr>
                  </a:outerShdw>
                </a:effectLst>
                <a:latin typeface="+mj-lt"/>
              </a:rPr>
              <a:t>platform 2</a:t>
            </a:r>
          </a:p>
        </p:txBody>
      </p:sp>
      <p:sp>
        <p:nvSpPr>
          <p:cNvPr id="14" name="CuadroTexto 13">
            <a:extLst>
              <a:ext uri="{FF2B5EF4-FFF2-40B4-BE49-F238E27FC236}">
                <a16:creationId xmlns:a16="http://schemas.microsoft.com/office/drawing/2014/main" id="{E64B709E-4162-4424-A570-E1CAD8C95267}"/>
              </a:ext>
            </a:extLst>
          </p:cNvPr>
          <p:cNvSpPr txBox="1"/>
          <p:nvPr/>
        </p:nvSpPr>
        <p:spPr>
          <a:xfrm>
            <a:off x="4164107" y="3915129"/>
            <a:ext cx="854148" cy="276999"/>
          </a:xfrm>
          <a:prstGeom prst="rect">
            <a:avLst/>
          </a:prstGeom>
          <a:noFill/>
        </p:spPr>
        <p:txBody>
          <a:bodyPr wrap="square" rtlCol="0">
            <a:spAutoFit/>
          </a:bodyPr>
          <a:lstStyle/>
          <a:p>
            <a:r>
              <a:rPr lang="en-GB" sz="1200" dirty="0">
                <a:solidFill>
                  <a:schemeClr val="bg1">
                    <a:lumMod val="95000"/>
                  </a:schemeClr>
                </a:solidFill>
                <a:effectLst>
                  <a:outerShdw blurRad="38100" dist="38100" dir="2700000" algn="tl">
                    <a:srgbClr val="000000">
                      <a:alpha val="43137"/>
                    </a:srgbClr>
                  </a:outerShdw>
                </a:effectLst>
                <a:latin typeface="+mj-lt"/>
              </a:rPr>
              <a:t>Layer </a:t>
            </a:r>
            <a:r>
              <a:rPr lang="en-GB" sz="1200" dirty="0" err="1">
                <a:solidFill>
                  <a:schemeClr val="bg1">
                    <a:lumMod val="95000"/>
                  </a:schemeClr>
                </a:solidFill>
                <a:effectLst>
                  <a:outerShdw blurRad="38100" dist="38100" dir="2700000" algn="tl">
                    <a:srgbClr val="000000">
                      <a:alpha val="43137"/>
                    </a:srgbClr>
                  </a:outerShdw>
                </a:effectLst>
                <a:latin typeface="+mj-lt"/>
              </a:rPr>
              <a:t>IIIn</a:t>
            </a:r>
            <a:endParaRPr lang="en-GB" sz="1200" dirty="0">
              <a:solidFill>
                <a:schemeClr val="bg1">
                  <a:lumMod val="95000"/>
                </a:schemeClr>
              </a:solidFill>
              <a:effectLst>
                <a:outerShdw blurRad="38100" dist="38100" dir="2700000" algn="tl">
                  <a:srgbClr val="000000">
                    <a:alpha val="43137"/>
                  </a:srgbClr>
                </a:outerShdw>
              </a:effectLst>
              <a:latin typeface="+mj-lt"/>
            </a:endParaRPr>
          </a:p>
        </p:txBody>
      </p:sp>
      <p:sp>
        <p:nvSpPr>
          <p:cNvPr id="15" name="CuadroTexto 14">
            <a:extLst>
              <a:ext uri="{FF2B5EF4-FFF2-40B4-BE49-F238E27FC236}">
                <a16:creationId xmlns:a16="http://schemas.microsoft.com/office/drawing/2014/main" id="{AC9C2A43-EEDF-4D1E-977F-D49E54119C19}"/>
              </a:ext>
            </a:extLst>
          </p:cNvPr>
          <p:cNvSpPr txBox="1"/>
          <p:nvPr/>
        </p:nvSpPr>
        <p:spPr>
          <a:xfrm>
            <a:off x="2122300" y="3776630"/>
            <a:ext cx="895574" cy="276999"/>
          </a:xfrm>
          <a:prstGeom prst="rect">
            <a:avLst/>
          </a:prstGeom>
          <a:noFill/>
        </p:spPr>
        <p:txBody>
          <a:bodyPr wrap="square" rtlCol="0">
            <a:spAutoFit/>
          </a:bodyPr>
          <a:lstStyle/>
          <a:p>
            <a:pPr algn="r"/>
            <a:r>
              <a:rPr lang="en-GB" sz="1200" dirty="0">
                <a:solidFill>
                  <a:schemeClr val="bg1">
                    <a:lumMod val="95000"/>
                  </a:schemeClr>
                </a:solidFill>
                <a:effectLst>
                  <a:outerShdw blurRad="38100" dist="38100" dir="2700000" algn="tl">
                    <a:srgbClr val="000000">
                      <a:alpha val="43137"/>
                    </a:srgbClr>
                  </a:outerShdw>
                </a:effectLst>
                <a:latin typeface="+mj-lt"/>
              </a:rPr>
              <a:t>Layer IIIc</a:t>
            </a:r>
          </a:p>
        </p:txBody>
      </p:sp>
    </p:spTree>
    <p:extLst>
      <p:ext uri="{BB962C8B-B14F-4D97-AF65-F5344CB8AC3E}">
        <p14:creationId xmlns:p14="http://schemas.microsoft.com/office/powerpoint/2010/main" val="274423081"/>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Madera</Template>
  <TotalTime>2559</TotalTime>
  <Words>2554</Words>
  <Application>Microsoft Office PowerPoint</Application>
  <PresentationFormat>Panorámica</PresentationFormat>
  <Paragraphs>413</Paragraphs>
  <Slides>47</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47</vt:i4>
      </vt:variant>
    </vt:vector>
  </HeadingPairs>
  <TitlesOfParts>
    <vt:vector size="51" baseType="lpstr">
      <vt:lpstr>Arial</vt:lpstr>
      <vt:lpstr>Calibri</vt:lpstr>
      <vt:lpstr>Calibri Light</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Juan I M</dc:creator>
  <cp:lastModifiedBy>Juan I M</cp:lastModifiedBy>
  <cp:revision>64</cp:revision>
  <dcterms:created xsi:type="dcterms:W3CDTF">2019-01-11T12:29:58Z</dcterms:created>
  <dcterms:modified xsi:type="dcterms:W3CDTF">2019-05-08T15:28:32Z</dcterms:modified>
</cp:coreProperties>
</file>